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9" r:id="rId2"/>
    <p:sldId id="281" r:id="rId3"/>
    <p:sldId id="280" r:id="rId4"/>
    <p:sldId id="286" r:id="rId5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575FE"/>
    <a:srgbClr val="5F455D"/>
    <a:srgbClr val="8F6E59"/>
    <a:srgbClr val="F9E9B2"/>
    <a:srgbClr val="C7E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3309" autoAdjust="0"/>
  </p:normalViewPr>
  <p:slideViewPr>
    <p:cSldViewPr snapToGrid="0">
      <p:cViewPr varScale="1">
        <p:scale>
          <a:sx n="71" d="100"/>
          <a:sy n="71" d="100"/>
        </p:scale>
        <p:origin x="30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F53B949-D7D1-4A4E-A15A-C1A5CE28F978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1F0F7F4-7BA3-4F94-9122-B7DFAAFF1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188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959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523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9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0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533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822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490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276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030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151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58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23D36B-A282-4CAD-8B21-F0051F6E1043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BD149A-C7F3-4F2E-8A90-49AFEDCB75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283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microsoft.com/office/2007/relationships/hdphoto" Target="../media/hdphoto2.wdp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2" Type="http://schemas.openxmlformats.org/officeDocument/2006/relationships/image" Target="../media/image1.jpeg"/><Relationship Id="rId16" Type="http://schemas.microsoft.com/office/2007/relationships/hdphoto" Target="../media/hdphoto3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jpeg"/><Relationship Id="rId5" Type="http://schemas.openxmlformats.org/officeDocument/2006/relationships/image" Target="../media/image4.png"/><Relationship Id="rId15" Type="http://schemas.openxmlformats.org/officeDocument/2006/relationships/image" Target="../media/image12.png"/><Relationship Id="rId10" Type="http://schemas.microsoft.com/office/2007/relationships/hdphoto" Target="../media/hdphoto1.wdp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3" Type="http://schemas.openxmlformats.org/officeDocument/2006/relationships/image" Target="../media/image20.sv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 descr="A blue and white cell&#10;&#10;Description automatically generated">
            <a:extLst>
              <a:ext uri="{FF2B5EF4-FFF2-40B4-BE49-F238E27FC236}">
                <a16:creationId xmlns:a16="http://schemas.microsoft.com/office/drawing/2014/main" id="{9F18AFF8-E421-09E2-6AD2-C7567954D99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91957" y="1243406"/>
            <a:ext cx="917838" cy="917838"/>
          </a:xfrm>
          <a:prstGeom prst="rect">
            <a:avLst/>
          </a:prstGeom>
        </p:spPr>
      </p:pic>
      <p:pic>
        <p:nvPicPr>
          <p:cNvPr id="33" name="Picture 32" descr="A blue and white cell&#10;&#10;Description automatically generated">
            <a:extLst>
              <a:ext uri="{FF2B5EF4-FFF2-40B4-BE49-F238E27FC236}">
                <a16:creationId xmlns:a16="http://schemas.microsoft.com/office/drawing/2014/main" id="{58A28E75-F5C9-5BD7-282D-D22A8A0669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89347" y="1243406"/>
            <a:ext cx="917838" cy="917838"/>
          </a:xfrm>
          <a:prstGeom prst="rect">
            <a:avLst/>
          </a:prstGeom>
        </p:spPr>
      </p:pic>
      <p:pic>
        <p:nvPicPr>
          <p:cNvPr id="34" name="Picture 33" descr="A blue and white cell&#10;&#10;Description automatically generated">
            <a:extLst>
              <a:ext uri="{FF2B5EF4-FFF2-40B4-BE49-F238E27FC236}">
                <a16:creationId xmlns:a16="http://schemas.microsoft.com/office/drawing/2014/main" id="{0036FC1C-95E1-DC14-CEAD-B32B0DC2535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831539" y="1243406"/>
            <a:ext cx="917838" cy="917838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8A9865C-1A72-647A-EC9F-7E5A3F7B303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978" y="2177405"/>
            <a:ext cx="920576" cy="920576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3DFB35FC-9744-92CA-B017-32B8F03218D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1957" y="2177405"/>
            <a:ext cx="920576" cy="92057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F4ED94F-09C4-4883-8E8A-E6D8E317297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1" y="2183502"/>
            <a:ext cx="920576" cy="914479"/>
          </a:xfrm>
          <a:prstGeom prst="rect">
            <a:avLst/>
          </a:prstGeom>
        </p:spPr>
      </p:pic>
      <p:pic>
        <p:nvPicPr>
          <p:cNvPr id="38" name="Picture 37" descr="A blue and white image of a cell&#10;&#10;Description automatically generated">
            <a:extLst>
              <a:ext uri="{FF2B5EF4-FFF2-40B4-BE49-F238E27FC236}">
                <a16:creationId xmlns:a16="http://schemas.microsoft.com/office/drawing/2014/main" id="{127C8801-2BD0-859F-EA48-E9159287100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98574" y="1239483"/>
            <a:ext cx="914400" cy="914400"/>
          </a:xfrm>
          <a:prstGeom prst="rect">
            <a:avLst/>
          </a:prstGeom>
        </p:spPr>
      </p:pic>
      <p:pic>
        <p:nvPicPr>
          <p:cNvPr id="39" name="Picture 38" descr="A heart shaped object with a circle in the middle&#10;&#10;Description automatically generated">
            <a:extLst>
              <a:ext uri="{FF2B5EF4-FFF2-40B4-BE49-F238E27FC236}">
                <a16:creationId xmlns:a16="http://schemas.microsoft.com/office/drawing/2014/main" id="{45CCB9CB-2245-E6AA-04B2-E3FBD3B659A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95424" y="2174791"/>
            <a:ext cx="914400" cy="914400"/>
          </a:xfrm>
          <a:prstGeom prst="rect">
            <a:avLst/>
          </a:prstGeom>
        </p:spPr>
      </p:pic>
      <p:pic>
        <p:nvPicPr>
          <p:cNvPr id="40" name="Picture 39" descr="A blue and white image of a cell&#10;&#10;Description automatically generated">
            <a:extLst>
              <a:ext uri="{FF2B5EF4-FFF2-40B4-BE49-F238E27FC236}">
                <a16:creationId xmlns:a16="http://schemas.microsoft.com/office/drawing/2014/main" id="{675602EC-A45F-E4B4-DBA8-AC2C42AD40B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86200" y="1246844"/>
            <a:ext cx="914400" cy="914400"/>
          </a:xfrm>
          <a:prstGeom prst="rect">
            <a:avLst/>
          </a:prstGeom>
        </p:spPr>
      </p:pic>
      <p:pic>
        <p:nvPicPr>
          <p:cNvPr id="41" name="Picture 40" descr="A heart shaped object with a circle in the middle&#10;&#10;Description automatically generated">
            <a:extLst>
              <a:ext uri="{FF2B5EF4-FFF2-40B4-BE49-F238E27FC236}">
                <a16:creationId xmlns:a16="http://schemas.microsoft.com/office/drawing/2014/main" id="{D4D65F20-8778-038F-1F87-95335FB40CF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79403" y="2177405"/>
            <a:ext cx="914400" cy="914400"/>
          </a:xfrm>
          <a:prstGeom prst="rect">
            <a:avLst/>
          </a:prstGeom>
        </p:spPr>
      </p:pic>
      <p:pic>
        <p:nvPicPr>
          <p:cNvPr id="42" name="Picture 41" descr="A blue and white image of a cell&#10;&#10;Description automatically generated">
            <a:extLst>
              <a:ext uri="{FF2B5EF4-FFF2-40B4-BE49-F238E27FC236}">
                <a16:creationId xmlns:a16="http://schemas.microsoft.com/office/drawing/2014/main" id="{2D6C89B5-E158-A5AA-42AA-C12DAF9F359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42387" y="1246844"/>
            <a:ext cx="914400" cy="914400"/>
          </a:xfrm>
          <a:prstGeom prst="rect">
            <a:avLst/>
          </a:prstGeom>
        </p:spPr>
      </p:pic>
      <p:pic>
        <p:nvPicPr>
          <p:cNvPr id="43" name="Picture 42" descr="A heart shaped object with a circle in the middle&#10;&#10;Description automatically generated">
            <a:extLst>
              <a:ext uri="{FF2B5EF4-FFF2-40B4-BE49-F238E27FC236}">
                <a16:creationId xmlns:a16="http://schemas.microsoft.com/office/drawing/2014/main" id="{9D7F668B-F83A-005D-553A-4442DD864AF4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42387" y="2177405"/>
            <a:ext cx="914400" cy="914400"/>
          </a:xfrm>
          <a:prstGeom prst="rect">
            <a:avLst/>
          </a:prstGeom>
        </p:spPr>
      </p:pic>
      <p:pic>
        <p:nvPicPr>
          <p:cNvPr id="44" name="Picture 43" descr="A blue and white image of a cell&#10;&#10;Description automatically generated">
            <a:extLst>
              <a:ext uri="{FF2B5EF4-FFF2-40B4-BE49-F238E27FC236}">
                <a16:creationId xmlns:a16="http://schemas.microsoft.com/office/drawing/2014/main" id="{3FEB10E0-EEBE-B420-FE65-2D0CB0328B7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alphaModFix amt="3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95424" y="2172826"/>
            <a:ext cx="914400" cy="914400"/>
          </a:xfrm>
          <a:prstGeom prst="rect">
            <a:avLst/>
          </a:prstGeom>
        </p:spPr>
      </p:pic>
      <p:pic>
        <p:nvPicPr>
          <p:cNvPr id="45" name="Picture 44" descr="A blue and white image of a cell&#10;&#10;Description automatically generated">
            <a:extLst>
              <a:ext uri="{FF2B5EF4-FFF2-40B4-BE49-F238E27FC236}">
                <a16:creationId xmlns:a16="http://schemas.microsoft.com/office/drawing/2014/main" id="{FC88DB91-13D6-2FE1-56FB-E3CDE83DA11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alphaModFix amt="3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83050" y="2180187"/>
            <a:ext cx="914400" cy="914400"/>
          </a:xfrm>
          <a:prstGeom prst="rect">
            <a:avLst/>
          </a:prstGeom>
        </p:spPr>
      </p:pic>
      <p:pic>
        <p:nvPicPr>
          <p:cNvPr id="46" name="Picture 45" descr="A blue and white image of a cell&#10;&#10;Description automatically generated">
            <a:extLst>
              <a:ext uri="{FF2B5EF4-FFF2-40B4-BE49-F238E27FC236}">
                <a16:creationId xmlns:a16="http://schemas.microsoft.com/office/drawing/2014/main" id="{6BA50160-D750-096F-DA36-2A0654104E91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alphaModFix amt="3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39237" y="2180187"/>
            <a:ext cx="914400" cy="91440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9A91C247-A8A0-C5E9-061E-4C1384151879}"/>
              </a:ext>
            </a:extLst>
          </p:cNvPr>
          <p:cNvSpPr txBox="1"/>
          <p:nvPr/>
        </p:nvSpPr>
        <p:spPr>
          <a:xfrm>
            <a:off x="896460" y="1199921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EC49BFC-09E8-FE2B-3658-E70978C26EC9}"/>
              </a:ext>
            </a:extLst>
          </p:cNvPr>
          <p:cNvSpPr txBox="1"/>
          <p:nvPr/>
        </p:nvSpPr>
        <p:spPr>
          <a:xfrm>
            <a:off x="1842876" y="11999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3D361E4-BBBD-2CEF-7C8F-7CD5240D3398}"/>
              </a:ext>
            </a:extLst>
          </p:cNvPr>
          <p:cNvSpPr txBox="1"/>
          <p:nvPr/>
        </p:nvSpPr>
        <p:spPr>
          <a:xfrm>
            <a:off x="2793151" y="1199921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BCA228C-55CE-C740-8C8D-87706EE3CE21}"/>
              </a:ext>
            </a:extLst>
          </p:cNvPr>
          <p:cNvSpPr txBox="1"/>
          <p:nvPr/>
        </p:nvSpPr>
        <p:spPr>
          <a:xfrm>
            <a:off x="1136509" y="101418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349BEA7-1ECC-D552-9711-7103625C521F}"/>
              </a:ext>
            </a:extLst>
          </p:cNvPr>
          <p:cNvSpPr txBox="1"/>
          <p:nvPr/>
        </p:nvSpPr>
        <p:spPr>
          <a:xfrm>
            <a:off x="2073091" y="101418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r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1DAEFF5-CC3D-C2B4-8A8E-DC651F69773E}"/>
              </a:ext>
            </a:extLst>
          </p:cNvPr>
          <p:cNvSpPr txBox="1"/>
          <p:nvPr/>
        </p:nvSpPr>
        <p:spPr>
          <a:xfrm>
            <a:off x="2884430" y="1014189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NG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2526BE6-6A5E-3022-0424-88368EE1C426}"/>
              </a:ext>
            </a:extLst>
          </p:cNvPr>
          <p:cNvSpPr txBox="1"/>
          <p:nvPr/>
        </p:nvSpPr>
        <p:spPr>
          <a:xfrm rot="16200000">
            <a:off x="474974" y="2031094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8F6E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l-GR" sz="1400" b="1" dirty="0">
                <a:solidFill>
                  <a:srgbClr val="8F6E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ε</a:t>
            </a:r>
            <a:endParaRPr lang="en-US" sz="1400" b="1" dirty="0">
              <a:solidFill>
                <a:srgbClr val="8F6E5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ED0039C-BDC4-DDDD-F12E-B978347589E6}"/>
              </a:ext>
            </a:extLst>
          </p:cNvPr>
          <p:cNvSpPr txBox="1"/>
          <p:nvPr/>
        </p:nvSpPr>
        <p:spPr>
          <a:xfrm rot="16200000">
            <a:off x="3540219" y="2054867"/>
            <a:ext cx="543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8F6E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2FC27AB-351A-3E9F-1376-9667B62C0FB4}"/>
              </a:ext>
            </a:extLst>
          </p:cNvPr>
          <p:cNvSpPr txBox="1"/>
          <p:nvPr/>
        </p:nvSpPr>
        <p:spPr>
          <a:xfrm>
            <a:off x="4103905" y="101909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5CA980E-47D1-2D4A-0B7B-1F414E1F1B7D}"/>
              </a:ext>
            </a:extLst>
          </p:cNvPr>
          <p:cNvSpPr txBox="1"/>
          <p:nvPr/>
        </p:nvSpPr>
        <p:spPr>
          <a:xfrm>
            <a:off x="5040487" y="101909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r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7C0AF07-ED67-462E-011A-BDF749BC62F8}"/>
              </a:ext>
            </a:extLst>
          </p:cNvPr>
          <p:cNvSpPr txBox="1"/>
          <p:nvPr/>
        </p:nvSpPr>
        <p:spPr>
          <a:xfrm>
            <a:off x="5851826" y="1019099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NG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E46F526-203E-0BB2-B1E6-A2A10A24598D}"/>
              </a:ext>
            </a:extLst>
          </p:cNvPr>
          <p:cNvSpPr txBox="1"/>
          <p:nvPr/>
        </p:nvSpPr>
        <p:spPr>
          <a:xfrm>
            <a:off x="117894" y="137778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56DC3D-6C49-8D66-FCF1-55F4C628C789}"/>
              </a:ext>
            </a:extLst>
          </p:cNvPr>
          <p:cNvSpPr txBox="1"/>
          <p:nvPr/>
        </p:nvSpPr>
        <p:spPr>
          <a:xfrm>
            <a:off x="436499" y="76500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BC8378F-0877-903B-A1D6-2C920939FDCD}"/>
              </a:ext>
            </a:extLst>
          </p:cNvPr>
          <p:cNvSpPr txBox="1"/>
          <p:nvPr/>
        </p:nvSpPr>
        <p:spPr>
          <a:xfrm>
            <a:off x="3690432" y="76500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0A4885F-6A28-0EF3-CC7C-8759CD18536C}"/>
              </a:ext>
            </a:extLst>
          </p:cNvPr>
          <p:cNvSpPr txBox="1"/>
          <p:nvPr/>
        </p:nvSpPr>
        <p:spPr>
          <a:xfrm>
            <a:off x="787877" y="3224685"/>
            <a:ext cx="5921947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Supplemental Figure 1. Ovarian localization of T-cell markers. A) Representative images of CD3</a:t>
            </a:r>
            <a:r>
              <a:rPr lang="el-GR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ε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immunolabeling 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in regions of corporal lutea (CL, </a:t>
            </a:r>
            <a:r>
              <a:rPr lang="en-US" sz="1100" dirty="0" err="1">
                <a:latin typeface="Arial" panose="020B0604020202020204" pitchFamily="34" charset="0"/>
                <a:ea typeface="Aptos" panose="020B0004020202020204" pitchFamily="34" charset="0"/>
              </a:rPr>
              <a:t>i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), stroma (Str, ii), and MNGCs (iii)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B) CD4 immunolabeling 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in regions of corporal lutea (CL, </a:t>
            </a:r>
            <a:r>
              <a:rPr lang="en-US" sz="1100" dirty="0" err="1">
                <a:latin typeface="Arial" panose="020B0604020202020204" pitchFamily="34" charset="0"/>
                <a:ea typeface="Aptos" panose="020B0004020202020204" pitchFamily="34" charset="0"/>
              </a:rPr>
              <a:t>i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), stroma (Str, ii), and MNGCs (iii)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D1BAA2-2C67-1C80-DFA7-5F7FF57D8FDB}"/>
              </a:ext>
            </a:extLst>
          </p:cNvPr>
          <p:cNvSpPr txBox="1"/>
          <p:nvPr/>
        </p:nvSpPr>
        <p:spPr>
          <a:xfrm>
            <a:off x="3856201" y="1199921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C7D4B7-BD9A-8BC8-74D3-96608780522B}"/>
              </a:ext>
            </a:extLst>
          </p:cNvPr>
          <p:cNvSpPr txBox="1"/>
          <p:nvPr/>
        </p:nvSpPr>
        <p:spPr>
          <a:xfrm>
            <a:off x="4802617" y="11999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4E407E-41FD-1CE9-D574-7BBF859CC530}"/>
              </a:ext>
            </a:extLst>
          </p:cNvPr>
          <p:cNvSpPr txBox="1"/>
          <p:nvPr/>
        </p:nvSpPr>
        <p:spPr>
          <a:xfrm>
            <a:off x="5752892" y="1199921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</p:spTree>
    <p:extLst>
      <p:ext uri="{BB962C8B-B14F-4D97-AF65-F5344CB8AC3E}">
        <p14:creationId xmlns:p14="http://schemas.microsoft.com/office/powerpoint/2010/main" val="56038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several different colored lines&#10;&#10;Description automatically generated">
            <a:extLst>
              <a:ext uri="{FF2B5EF4-FFF2-40B4-BE49-F238E27FC236}">
                <a16:creationId xmlns:a16="http://schemas.microsoft.com/office/drawing/2014/main" id="{C2220974-2F9F-3062-AA91-707FC62C22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53866" y="4988153"/>
            <a:ext cx="2962807" cy="221079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C57CFFA-8BEF-7EE2-E022-C214C1AE50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16543" y="2415078"/>
            <a:ext cx="3456124" cy="221177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2C30F1A-A0CA-8F37-C981-FCC31C935E7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03221" y="2384284"/>
            <a:ext cx="3913324" cy="2211774"/>
          </a:xfrm>
          <a:prstGeom prst="rect">
            <a:avLst/>
          </a:prstGeom>
        </p:spPr>
      </p:pic>
      <p:pic>
        <p:nvPicPr>
          <p:cNvPr id="8" name="Picture 7" descr="A graph showing the number of cells&#10;&#10;Description automatically generated">
            <a:extLst>
              <a:ext uri="{FF2B5EF4-FFF2-40B4-BE49-F238E27FC236}">
                <a16:creationId xmlns:a16="http://schemas.microsoft.com/office/drawing/2014/main" id="{684E81B4-F5E8-9063-ED24-506DD5B2C59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03222" y="4794600"/>
            <a:ext cx="4350644" cy="2840845"/>
          </a:xfrm>
          <a:prstGeom prst="rect">
            <a:avLst/>
          </a:prstGeom>
        </p:spPr>
      </p:pic>
      <p:pic>
        <p:nvPicPr>
          <p:cNvPr id="9" name="Picture 8" descr="A graph showing the number of cells&#10;&#10;Description automatically generated">
            <a:extLst>
              <a:ext uri="{FF2B5EF4-FFF2-40B4-BE49-F238E27FC236}">
                <a16:creationId xmlns:a16="http://schemas.microsoft.com/office/drawing/2014/main" id="{A8587A5D-1C5A-457D-8796-B74ED9454D0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754275" y="4820405"/>
            <a:ext cx="675686" cy="54493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A85A64D-8821-AD85-FB45-73DE04818EEA}"/>
              </a:ext>
            </a:extLst>
          </p:cNvPr>
          <p:cNvSpPr txBox="1"/>
          <p:nvPr/>
        </p:nvSpPr>
        <p:spPr>
          <a:xfrm>
            <a:off x="148964" y="21385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2269441-F9F2-EDD8-F603-962F904023BE}"/>
              </a:ext>
            </a:extLst>
          </p:cNvPr>
          <p:cNvSpPr txBox="1"/>
          <p:nvPr/>
        </p:nvSpPr>
        <p:spPr>
          <a:xfrm>
            <a:off x="4116543" y="21385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AD1CD43-B213-B96C-505C-7D8AD998F069}"/>
              </a:ext>
            </a:extLst>
          </p:cNvPr>
          <p:cNvSpPr txBox="1"/>
          <p:nvPr/>
        </p:nvSpPr>
        <p:spPr>
          <a:xfrm>
            <a:off x="148964" y="45260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0CD0B23-5BAA-A3BF-BC5C-BA685E3277D4}"/>
              </a:ext>
            </a:extLst>
          </p:cNvPr>
          <p:cNvSpPr txBox="1"/>
          <p:nvPr/>
        </p:nvSpPr>
        <p:spPr>
          <a:xfrm>
            <a:off x="4116543" y="452606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531E6B3-0713-DF83-D14D-E33F1814BEBC}"/>
              </a:ext>
            </a:extLst>
          </p:cNvPr>
          <p:cNvSpPr txBox="1"/>
          <p:nvPr/>
        </p:nvSpPr>
        <p:spPr>
          <a:xfrm>
            <a:off x="203221" y="7870253"/>
            <a:ext cx="7313452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Supplemental Figure 2. </a:t>
            </a:r>
            <a:r>
              <a:rPr lang="en-US" sz="1100" i="1" dirty="0" err="1">
                <a:latin typeface="Arial" panose="020B0604020202020204" pitchFamily="34" charset="0"/>
                <a:ea typeface="Aptos" panose="020B0004020202020204" pitchFamily="34" charset="0"/>
              </a:rPr>
              <a:t>Gpnmb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(+) macrophages display cel-to-cell interactions with Type I and Type II lymphoid cells. A) Z-stack of an &lt;40 µm MNGC. Scale=50 µm. B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UMAP plot of age-combined ovarian immune subclusters (SCLs). C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)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100" i="1" dirty="0" err="1">
                <a:latin typeface="Arial" panose="020B0604020202020204" pitchFamily="34" charset="0"/>
                <a:ea typeface="Aptos" panose="020B0004020202020204" pitchFamily="34" charset="0"/>
              </a:rPr>
              <a:t>Gpnmb</a:t>
            </a:r>
            <a:r>
              <a:rPr lang="en-US" sz="1100" i="1" dirty="0"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expression mapped to immune cell SCLs. D) </a:t>
            </a:r>
            <a:r>
              <a:rPr lang="en-US" sz="1100" i="1" dirty="0" err="1">
                <a:latin typeface="Arial" panose="020B0604020202020204" pitchFamily="34" charset="0"/>
                <a:ea typeface="Aptos" panose="020B0004020202020204" pitchFamily="34" charset="0"/>
              </a:rPr>
              <a:t>Gpnmb</a:t>
            </a:r>
            <a:r>
              <a:rPr lang="en-US" sz="1100" i="1" dirty="0"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expression across immune SCLs from reproductively young (3 month) and old (9 months) ovaries. E) </a:t>
            </a:r>
            <a:r>
              <a:rPr lang="en-US" sz="1100" dirty="0" err="1">
                <a:latin typeface="Arial" panose="020B0604020202020204" pitchFamily="34" charset="0"/>
                <a:ea typeface="Aptos" panose="020B0004020202020204" pitchFamily="34" charset="0"/>
              </a:rPr>
              <a:t>CellChat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 analysis of interaction between </a:t>
            </a:r>
            <a:r>
              <a:rPr lang="en-US" sz="1100" i="1" dirty="0" err="1">
                <a:latin typeface="Arial" panose="020B0604020202020204" pitchFamily="34" charset="0"/>
                <a:ea typeface="Aptos" panose="020B0004020202020204" pitchFamily="34" charset="0"/>
              </a:rPr>
              <a:t>Gpnmb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(+) macrophages and other immune SCLs. All analyses were derived from data </a:t>
            </a:r>
            <a:r>
              <a:rPr lang="da-DK" sz="1100" dirty="0">
                <a:latin typeface="Arial" panose="020B0604020202020204" pitchFamily="34" charset="0"/>
                <a:ea typeface="Aptos" panose="020B0004020202020204" pitchFamily="34" charset="0"/>
              </a:rPr>
              <a:t>reported by Isola et al. 2024.</a:t>
            </a:r>
            <a:endParaRPr lang="en-US" dirty="0"/>
          </a:p>
        </p:txBody>
      </p:sp>
      <p:pic>
        <p:nvPicPr>
          <p:cNvPr id="2060" name="Picture 2059">
            <a:extLst>
              <a:ext uri="{FF2B5EF4-FFF2-40B4-BE49-F238E27FC236}">
                <a16:creationId xmlns:a16="http://schemas.microsoft.com/office/drawing/2014/main" id="{DABC00E6-860E-594E-E315-FEFE9E7F461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210" b="27762"/>
          <a:stretch/>
        </p:blipFill>
        <p:spPr>
          <a:xfrm>
            <a:off x="409691" y="1373426"/>
            <a:ext cx="7162976" cy="786810"/>
          </a:xfrm>
          <a:prstGeom prst="rect">
            <a:avLst/>
          </a:prstGeom>
        </p:spPr>
      </p:pic>
      <p:sp>
        <p:nvSpPr>
          <p:cNvPr id="2067" name="TextBox 2066">
            <a:extLst>
              <a:ext uri="{FF2B5EF4-FFF2-40B4-BE49-F238E27FC236}">
                <a16:creationId xmlns:a16="http://schemas.microsoft.com/office/drawing/2014/main" id="{9834C060-2C5C-A9E6-F8D9-7BD35862374E}"/>
              </a:ext>
            </a:extLst>
          </p:cNvPr>
          <p:cNvSpPr txBox="1"/>
          <p:nvPr/>
        </p:nvSpPr>
        <p:spPr>
          <a:xfrm>
            <a:off x="203221" y="10058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2070" name="Straight Connector 2069">
            <a:extLst>
              <a:ext uri="{FF2B5EF4-FFF2-40B4-BE49-F238E27FC236}">
                <a16:creationId xmlns:a16="http://schemas.microsoft.com/office/drawing/2014/main" id="{1378CFB3-71D6-3A8A-BAF3-BDFB39154154}"/>
              </a:ext>
            </a:extLst>
          </p:cNvPr>
          <p:cNvCxnSpPr>
            <a:cxnSpLocks/>
          </p:cNvCxnSpPr>
          <p:nvPr/>
        </p:nvCxnSpPr>
        <p:spPr>
          <a:xfrm>
            <a:off x="1220552" y="2105887"/>
            <a:ext cx="57607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71" name="TextBox 2070">
            <a:extLst>
              <a:ext uri="{FF2B5EF4-FFF2-40B4-BE49-F238E27FC236}">
                <a16:creationId xmlns:a16="http://schemas.microsoft.com/office/drawing/2014/main" id="{DD49FB1A-027E-6DC4-E6D4-AFFBA1B644A8}"/>
              </a:ext>
            </a:extLst>
          </p:cNvPr>
          <p:cNvSpPr txBox="1"/>
          <p:nvPr/>
        </p:nvSpPr>
        <p:spPr>
          <a:xfrm>
            <a:off x="379155" y="1967562"/>
            <a:ext cx="4219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</a:p>
        </p:txBody>
      </p:sp>
      <p:sp>
        <p:nvSpPr>
          <p:cNvPr id="2072" name="TextBox 2071">
            <a:extLst>
              <a:ext uri="{FF2B5EF4-FFF2-40B4-BE49-F238E27FC236}">
                <a16:creationId xmlns:a16="http://schemas.microsoft.com/office/drawing/2014/main" id="{F46842A6-9245-0CBE-C39D-0C03817F421D}"/>
              </a:ext>
            </a:extLst>
          </p:cNvPr>
          <p:cNvSpPr txBox="1"/>
          <p:nvPr/>
        </p:nvSpPr>
        <p:spPr>
          <a:xfrm>
            <a:off x="1796624" y="1967562"/>
            <a:ext cx="4219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µm</a:t>
            </a:r>
          </a:p>
        </p:txBody>
      </p:sp>
      <p:sp>
        <p:nvSpPr>
          <p:cNvPr id="2073" name="TextBox 2072">
            <a:extLst>
              <a:ext uri="{FF2B5EF4-FFF2-40B4-BE49-F238E27FC236}">
                <a16:creationId xmlns:a16="http://schemas.microsoft.com/office/drawing/2014/main" id="{7759A441-9AF4-854D-5E1E-577A56C4FAFC}"/>
              </a:ext>
            </a:extLst>
          </p:cNvPr>
          <p:cNvSpPr txBox="1"/>
          <p:nvPr/>
        </p:nvSpPr>
        <p:spPr>
          <a:xfrm>
            <a:off x="3243914" y="1967562"/>
            <a:ext cx="4219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µm</a:t>
            </a:r>
          </a:p>
        </p:txBody>
      </p:sp>
      <p:sp>
        <p:nvSpPr>
          <p:cNvPr id="2074" name="TextBox 2073">
            <a:extLst>
              <a:ext uri="{FF2B5EF4-FFF2-40B4-BE49-F238E27FC236}">
                <a16:creationId xmlns:a16="http://schemas.microsoft.com/office/drawing/2014/main" id="{4DE16C47-00EC-7A2C-F0A2-DCA9BDCDC919}"/>
              </a:ext>
            </a:extLst>
          </p:cNvPr>
          <p:cNvSpPr txBox="1"/>
          <p:nvPr/>
        </p:nvSpPr>
        <p:spPr>
          <a:xfrm>
            <a:off x="4658153" y="1967562"/>
            <a:ext cx="4796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 µm</a:t>
            </a:r>
          </a:p>
        </p:txBody>
      </p:sp>
      <p:sp>
        <p:nvSpPr>
          <p:cNvPr id="2075" name="TextBox 2074">
            <a:extLst>
              <a:ext uri="{FF2B5EF4-FFF2-40B4-BE49-F238E27FC236}">
                <a16:creationId xmlns:a16="http://schemas.microsoft.com/office/drawing/2014/main" id="{66AA1DDD-E667-BD90-6286-DE5B80DBAEF6}"/>
              </a:ext>
            </a:extLst>
          </p:cNvPr>
          <p:cNvSpPr txBox="1"/>
          <p:nvPr/>
        </p:nvSpPr>
        <p:spPr>
          <a:xfrm>
            <a:off x="6106137" y="1967562"/>
            <a:ext cx="4796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 µm</a:t>
            </a:r>
          </a:p>
        </p:txBody>
      </p:sp>
      <p:sp>
        <p:nvSpPr>
          <p:cNvPr id="2076" name="Rectangle 2075">
            <a:extLst>
              <a:ext uri="{FF2B5EF4-FFF2-40B4-BE49-F238E27FC236}">
                <a16:creationId xmlns:a16="http://schemas.microsoft.com/office/drawing/2014/main" id="{4F5FC184-10DE-9E4E-2984-9D7D3AF91BF2}"/>
              </a:ext>
            </a:extLst>
          </p:cNvPr>
          <p:cNvSpPr/>
          <p:nvPr/>
        </p:nvSpPr>
        <p:spPr>
          <a:xfrm>
            <a:off x="2053694" y="1426449"/>
            <a:ext cx="457200" cy="4572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7" name="Rectangle 2076">
            <a:extLst>
              <a:ext uri="{FF2B5EF4-FFF2-40B4-BE49-F238E27FC236}">
                <a16:creationId xmlns:a16="http://schemas.microsoft.com/office/drawing/2014/main" id="{988A7CBD-61ED-5656-154D-801602B3CA57}"/>
              </a:ext>
            </a:extLst>
          </p:cNvPr>
          <p:cNvSpPr/>
          <p:nvPr/>
        </p:nvSpPr>
        <p:spPr>
          <a:xfrm>
            <a:off x="596392" y="1447859"/>
            <a:ext cx="457200" cy="4572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8" name="Rectangle 2077">
            <a:extLst>
              <a:ext uri="{FF2B5EF4-FFF2-40B4-BE49-F238E27FC236}">
                <a16:creationId xmlns:a16="http://schemas.microsoft.com/office/drawing/2014/main" id="{5888EDA8-D3CC-D56E-60C3-1713ADB91612}"/>
              </a:ext>
            </a:extLst>
          </p:cNvPr>
          <p:cNvSpPr/>
          <p:nvPr/>
        </p:nvSpPr>
        <p:spPr>
          <a:xfrm>
            <a:off x="3477126" y="1445485"/>
            <a:ext cx="457200" cy="4572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9" name="Rectangle 2078">
            <a:extLst>
              <a:ext uri="{FF2B5EF4-FFF2-40B4-BE49-F238E27FC236}">
                <a16:creationId xmlns:a16="http://schemas.microsoft.com/office/drawing/2014/main" id="{FE9199C3-E6D9-4181-65A3-616D5239229E}"/>
              </a:ext>
            </a:extLst>
          </p:cNvPr>
          <p:cNvSpPr/>
          <p:nvPr/>
        </p:nvSpPr>
        <p:spPr>
          <a:xfrm>
            <a:off x="4897962" y="1445485"/>
            <a:ext cx="457200" cy="4572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0" name="Rectangle 2079">
            <a:extLst>
              <a:ext uri="{FF2B5EF4-FFF2-40B4-BE49-F238E27FC236}">
                <a16:creationId xmlns:a16="http://schemas.microsoft.com/office/drawing/2014/main" id="{4C1CE373-30D2-EC96-F1DB-0965BC7D789A}"/>
              </a:ext>
            </a:extLst>
          </p:cNvPr>
          <p:cNvSpPr/>
          <p:nvPr/>
        </p:nvSpPr>
        <p:spPr>
          <a:xfrm>
            <a:off x="6360657" y="1442492"/>
            <a:ext cx="457200" cy="4572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1" name="TextBox 2080">
            <a:extLst>
              <a:ext uri="{FF2B5EF4-FFF2-40B4-BE49-F238E27FC236}">
                <a16:creationId xmlns:a16="http://schemas.microsoft.com/office/drawing/2014/main" id="{60282CB9-BCC9-BA8D-47C3-DAF2F2C4BAE6}"/>
              </a:ext>
            </a:extLst>
          </p:cNvPr>
          <p:cNvSpPr txBox="1"/>
          <p:nvPr/>
        </p:nvSpPr>
        <p:spPr>
          <a:xfrm>
            <a:off x="117894" y="137778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8D291BE-C28E-08BD-B5E4-8E12ECA6AA69}"/>
              </a:ext>
            </a:extLst>
          </p:cNvPr>
          <p:cNvSpPr txBox="1"/>
          <p:nvPr/>
        </p:nvSpPr>
        <p:spPr>
          <a:xfrm>
            <a:off x="5457136" y="2365084"/>
            <a:ext cx="6783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pnmb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F46874-D038-D941-A047-71C712F6DC3B}"/>
              </a:ext>
            </a:extLst>
          </p:cNvPr>
          <p:cNvSpPr txBox="1"/>
          <p:nvPr/>
        </p:nvSpPr>
        <p:spPr>
          <a:xfrm>
            <a:off x="1943098" y="4763806"/>
            <a:ext cx="6783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pnmb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5383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0E2E0E3-67B6-D192-C9AF-0BD23C33EB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7132638"/>
              </p:ext>
            </p:extLst>
          </p:nvPr>
        </p:nvGraphicFramePr>
        <p:xfrm>
          <a:off x="397201" y="4939745"/>
          <a:ext cx="6702424" cy="24629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72739">
                  <a:extLst>
                    <a:ext uri="{9D8B030D-6E8A-4147-A177-3AD203B41FA5}">
                      <a16:colId xmlns:a16="http://schemas.microsoft.com/office/drawing/2014/main" val="2540975858"/>
                    </a:ext>
                  </a:extLst>
                </a:gridCol>
                <a:gridCol w="1766242">
                  <a:extLst>
                    <a:ext uri="{9D8B030D-6E8A-4147-A177-3AD203B41FA5}">
                      <a16:colId xmlns:a16="http://schemas.microsoft.com/office/drawing/2014/main" val="228186295"/>
                    </a:ext>
                  </a:extLst>
                </a:gridCol>
                <a:gridCol w="2463443">
                  <a:extLst>
                    <a:ext uri="{9D8B030D-6E8A-4147-A177-3AD203B41FA5}">
                      <a16:colId xmlns:a16="http://schemas.microsoft.com/office/drawing/2014/main" val="1697142735"/>
                    </a:ext>
                  </a:extLst>
                </a:gridCol>
              </a:tblGrid>
              <a:tr h="1464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filte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r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lter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b"/>
                </a:tc>
                <a:extLst>
                  <a:ext uri="{0D108BD9-81ED-4DB2-BD59-A6C34878D82A}">
                    <a16:rowId xmlns:a16="http://schemas.microsoft.com/office/drawing/2014/main" val="2654442352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kocyte activ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idative phosphoryl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tumor necrosis factor produc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224506760"/>
                  </a:ext>
                </a:extLst>
              </a:tr>
              <a:tr h="272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regulatory interactions between a lymphoid and non-lymphoid ce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immune effector proces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lipoprotein particl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251108477"/>
                  </a:ext>
                </a:extLst>
              </a:tr>
              <a:tr h="272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leukocyte activ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 degranul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ergy coupled proton transmembrane transport, against electrochemical gradi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880605895"/>
                  </a:ext>
                </a:extLst>
              </a:tr>
              <a:tr h="272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ptive immune respons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P-dependent 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translational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in targeting to membran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myeloid leukocyte mediated immunit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160739716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pes simplex virus 1 infec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ory respons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leukocyte migr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598687878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gulation of immune respons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killin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phage marker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481947208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tural killer cell mediated cytotoxicit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goso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oso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208914415"/>
                  </a:ext>
                </a:extLst>
              </a:tr>
              <a:tr h="272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ocyte migr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glia pathogen phagocytosis pathwa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regulation of immune system proces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473066489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id leukocyte activ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response to chemical stres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030654041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d-Cd3g-cd3e-cd247 Complex</a:t>
                      </a:r>
                      <a:endParaRPr lang="pt-B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phagocytosis, engulf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599479262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interleukin-1 beta produc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homeostasi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4236451901"/>
                  </a:ext>
                </a:extLst>
              </a:tr>
              <a:tr h="153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atopoietic cell line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oxidative stres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2737327430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069C7F-425D-08A6-22D9-1A731F9AE3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213554"/>
              </p:ext>
            </p:extLst>
          </p:nvPr>
        </p:nvGraphicFramePr>
        <p:xfrm>
          <a:off x="397201" y="986694"/>
          <a:ext cx="6702424" cy="241373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72739">
                  <a:extLst>
                    <a:ext uri="{9D8B030D-6E8A-4147-A177-3AD203B41FA5}">
                      <a16:colId xmlns:a16="http://schemas.microsoft.com/office/drawing/2014/main" val="2116996288"/>
                    </a:ext>
                  </a:extLst>
                </a:gridCol>
                <a:gridCol w="1766242">
                  <a:extLst>
                    <a:ext uri="{9D8B030D-6E8A-4147-A177-3AD203B41FA5}">
                      <a16:colId xmlns:a16="http://schemas.microsoft.com/office/drawing/2014/main" val="1341415470"/>
                    </a:ext>
                  </a:extLst>
                </a:gridCol>
                <a:gridCol w="2463443">
                  <a:extLst>
                    <a:ext uri="{9D8B030D-6E8A-4147-A177-3AD203B41FA5}">
                      <a16:colId xmlns:a16="http://schemas.microsoft.com/office/drawing/2014/main" val="3737922011"/>
                    </a:ext>
                  </a:extLst>
                </a:gridCol>
              </a:tblGrid>
              <a:tr h="1464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filte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r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lter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b"/>
                </a:tc>
                <a:extLst>
                  <a:ext uri="{0D108BD9-81ED-4DB2-BD59-A6C34878D82A}">
                    <a16:rowId xmlns:a16="http://schemas.microsoft.com/office/drawing/2014/main" val="2470248500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P hydrolysis and joining of the 60S ribosomal subun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idative phosphory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P-dependent cotranslational protein targeting to 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2945005439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 activation, signaling, and aggreg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 degranulation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sta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2256084175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gulation of protein localiz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response to chemical 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ptive immune syste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769094319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 by Receptor tyrosine kinas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oso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on transmembrane transpor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919315368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monella infec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goso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regulation of cellular component organiz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183197368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kocyte activ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apoptotic signaling pathwa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endocytos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1438692929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rehensive IL 17A signal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regulation of immune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mononuclear cell migr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235062051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 process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gulation of cell migr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gulation of programmed cell dea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3614814273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oxidative str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extLst>
                  <a:ext uri="{0D108BD9-81ED-4DB2-BD59-A6C34878D82A}">
                    <a16:rowId xmlns:a16="http://schemas.microsoft.com/office/drawing/2014/main" val="4187655143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tumor necrosis factor produc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840087901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gen processing and presentation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extLst>
                  <a:ext uri="{0D108BD9-81ED-4DB2-BD59-A6C34878D82A}">
                    <a16:rowId xmlns:a16="http://schemas.microsoft.com/office/drawing/2014/main" val="2139873666"/>
                  </a:ext>
                </a:extLst>
              </a:tr>
              <a:tr h="146412"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homeostas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648" marR="4648" marT="4648" marB="0"/>
                </a:tc>
                <a:extLst>
                  <a:ext uri="{0D108BD9-81ED-4DB2-BD59-A6C34878D82A}">
                    <a16:rowId xmlns:a16="http://schemas.microsoft.com/office/drawing/2014/main" val="205246990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2585259-8AFD-FC8C-F417-5EC73E4F5D06}"/>
              </a:ext>
            </a:extLst>
          </p:cNvPr>
          <p:cNvSpPr txBox="1"/>
          <p:nvPr/>
        </p:nvSpPr>
        <p:spPr>
          <a:xfrm>
            <a:off x="2547717" y="780693"/>
            <a:ext cx="23070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athways analysis of top MNGC gen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D3C01AF-2613-A578-98A9-DE4F80C1EA90}"/>
              </a:ext>
            </a:extLst>
          </p:cNvPr>
          <p:cNvSpPr txBox="1"/>
          <p:nvPr/>
        </p:nvSpPr>
        <p:spPr>
          <a:xfrm>
            <a:off x="2539112" y="4733744"/>
            <a:ext cx="23839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athways analysis of upregulated DEG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358EF15-12B4-7E37-6EB1-8DAE5C9B4619}"/>
              </a:ext>
            </a:extLst>
          </p:cNvPr>
          <p:cNvSpPr txBox="1"/>
          <p:nvPr/>
        </p:nvSpPr>
        <p:spPr>
          <a:xfrm>
            <a:off x="117894" y="137778"/>
            <a:ext cx="2616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FC447CA-A5B0-B93D-49C6-A7B93BF886D4}"/>
              </a:ext>
            </a:extLst>
          </p:cNvPr>
          <p:cNvSpPr txBox="1"/>
          <p:nvPr/>
        </p:nvSpPr>
        <p:spPr>
          <a:xfrm>
            <a:off x="397201" y="3466923"/>
            <a:ext cx="6702424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Supplemental Table 1. Gene ontology analysis terms of top 1000 (pre-filter) MNGC genes compared to terms after filtering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 to remove potential infiltrating T-cell signature (filtered). 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DDC160-F025-FC24-6A38-240F65D9469C}"/>
              </a:ext>
            </a:extLst>
          </p:cNvPr>
          <p:cNvSpPr txBox="1"/>
          <p:nvPr/>
        </p:nvSpPr>
        <p:spPr>
          <a:xfrm>
            <a:off x="397201" y="7447042"/>
            <a:ext cx="6702424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Supplemental Table 2. Gene ontology analysis terms of upregulated DEGS in MNGCs compared to normal ovarian macrophages after before (p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re-filter) and after 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ltering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 (filtered) to remove potential infiltrating T-cell signature. 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EBBC119-0757-E840-4F72-76EA19045F80}"/>
              </a:ext>
            </a:extLst>
          </p:cNvPr>
          <p:cNvSpPr txBox="1"/>
          <p:nvPr/>
        </p:nvSpPr>
        <p:spPr>
          <a:xfrm>
            <a:off x="117894" y="4157586"/>
            <a:ext cx="2539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</a:p>
        </p:txBody>
      </p:sp>
    </p:spTree>
    <p:extLst>
      <p:ext uri="{BB962C8B-B14F-4D97-AF65-F5344CB8AC3E}">
        <p14:creationId xmlns:p14="http://schemas.microsoft.com/office/powerpoint/2010/main" val="13298722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F3A902-3F9B-3679-3A1D-63E493435C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6" name="Group 155">
            <a:extLst>
              <a:ext uri="{FF2B5EF4-FFF2-40B4-BE49-F238E27FC236}">
                <a16:creationId xmlns:a16="http://schemas.microsoft.com/office/drawing/2014/main" id="{CDF543D3-46EB-0ED9-AED1-B058C0F983B4}"/>
              </a:ext>
            </a:extLst>
          </p:cNvPr>
          <p:cNvGrpSpPr/>
          <p:nvPr/>
        </p:nvGrpSpPr>
        <p:grpSpPr>
          <a:xfrm>
            <a:off x="425979" y="1490173"/>
            <a:ext cx="6858002" cy="6855664"/>
            <a:chOff x="-1" y="3738"/>
            <a:chExt cx="10972802" cy="10969062"/>
          </a:xfrm>
        </p:grpSpPr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D7F338E7-3FCD-0CD5-4EFD-CDC6F331FD4F}"/>
                </a:ext>
              </a:extLst>
            </p:cNvPr>
            <p:cNvSpPr/>
            <p:nvPr/>
          </p:nvSpPr>
          <p:spPr>
            <a:xfrm>
              <a:off x="0" y="6593738"/>
              <a:ext cx="10972800" cy="4379062"/>
            </a:xfrm>
            <a:prstGeom prst="rect">
              <a:avLst/>
            </a:prstGeom>
            <a:solidFill>
              <a:srgbClr val="FDF2F1"/>
            </a:solidFill>
            <a:ln>
              <a:solidFill>
                <a:srgbClr val="FDF2F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46A9B04D-4B82-D1D8-D63F-3F6C2E85A096}"/>
                </a:ext>
              </a:extLst>
            </p:cNvPr>
            <p:cNvSpPr/>
            <p:nvPr/>
          </p:nvSpPr>
          <p:spPr>
            <a:xfrm>
              <a:off x="0" y="3102749"/>
              <a:ext cx="10972801" cy="3489784"/>
            </a:xfrm>
            <a:prstGeom prst="rect">
              <a:avLst/>
            </a:prstGeom>
            <a:solidFill>
              <a:srgbClr val="FDF2F1">
                <a:alpha val="60000"/>
              </a:srgbClr>
            </a:solidFill>
            <a:ln>
              <a:solidFill>
                <a:srgbClr val="FDF2F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78009212-6D3D-13E4-8C7D-B884ED6F3F40}"/>
                </a:ext>
              </a:extLst>
            </p:cNvPr>
            <p:cNvSpPr/>
            <p:nvPr/>
          </p:nvSpPr>
          <p:spPr>
            <a:xfrm>
              <a:off x="-1" y="3738"/>
              <a:ext cx="10972801" cy="3094726"/>
            </a:xfrm>
            <a:prstGeom prst="rect">
              <a:avLst/>
            </a:prstGeom>
            <a:solidFill>
              <a:srgbClr val="FDF2F1">
                <a:alpha val="20000"/>
              </a:srgbClr>
            </a:solidFill>
            <a:ln>
              <a:solidFill>
                <a:srgbClr val="FDF2F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0" name="Rounded Rectangle 42">
            <a:extLst>
              <a:ext uri="{FF2B5EF4-FFF2-40B4-BE49-F238E27FC236}">
                <a16:creationId xmlns:a16="http://schemas.microsoft.com/office/drawing/2014/main" id="{C86A439A-AF7F-0855-7977-73C0CDD46599}"/>
              </a:ext>
            </a:extLst>
          </p:cNvPr>
          <p:cNvSpPr/>
          <p:nvPr/>
        </p:nvSpPr>
        <p:spPr>
          <a:xfrm>
            <a:off x="807386" y="3614571"/>
            <a:ext cx="2750004" cy="1890489"/>
          </a:xfrm>
          <a:prstGeom prst="roundRect">
            <a:avLst/>
          </a:prstGeom>
          <a:solidFill>
            <a:srgbClr val="DCEAF7">
              <a:alpha val="16078"/>
            </a:srgb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1" name="Graphic 160">
            <a:extLst>
              <a:ext uri="{FF2B5EF4-FFF2-40B4-BE49-F238E27FC236}">
                <a16:creationId xmlns:a16="http://schemas.microsoft.com/office/drawing/2014/main" id="{D15A23C4-6FA8-C11C-3717-023D404616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8641" r="25368" b="46454"/>
          <a:stretch/>
        </p:blipFill>
        <p:spPr>
          <a:xfrm>
            <a:off x="1794490" y="1310411"/>
            <a:ext cx="3307359" cy="2235058"/>
          </a:xfrm>
          <a:prstGeom prst="rect">
            <a:avLst/>
          </a:prstGeom>
        </p:spPr>
      </p:pic>
      <p:sp>
        <p:nvSpPr>
          <p:cNvPr id="162" name="Rectangle 161">
            <a:extLst>
              <a:ext uri="{FF2B5EF4-FFF2-40B4-BE49-F238E27FC236}">
                <a16:creationId xmlns:a16="http://schemas.microsoft.com/office/drawing/2014/main" id="{4C81CF83-FDE8-6CC7-C000-50EA08984407}"/>
              </a:ext>
            </a:extLst>
          </p:cNvPr>
          <p:cNvSpPr/>
          <p:nvPr/>
        </p:nvSpPr>
        <p:spPr>
          <a:xfrm>
            <a:off x="3436966" y="2668702"/>
            <a:ext cx="455424" cy="540591"/>
          </a:xfrm>
          <a:prstGeom prst="rect">
            <a:avLst/>
          </a:prstGeom>
          <a:noFill/>
          <a:ln w="12700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Oval 163">
            <a:extLst>
              <a:ext uri="{FF2B5EF4-FFF2-40B4-BE49-F238E27FC236}">
                <a16:creationId xmlns:a16="http://schemas.microsoft.com/office/drawing/2014/main" id="{3A0B4D2B-7060-1E38-6496-868E29CBD8DF}"/>
              </a:ext>
            </a:extLst>
          </p:cNvPr>
          <p:cNvSpPr/>
          <p:nvPr/>
        </p:nvSpPr>
        <p:spPr>
          <a:xfrm>
            <a:off x="6267466" y="4306526"/>
            <a:ext cx="111062" cy="128379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4B03B9BF-FF58-EB50-1FA3-284E5631F26A}"/>
              </a:ext>
            </a:extLst>
          </p:cNvPr>
          <p:cNvSpPr txBox="1"/>
          <p:nvPr/>
        </p:nvSpPr>
        <p:spPr>
          <a:xfrm>
            <a:off x="5471196" y="5992730"/>
            <a:ext cx="1300356" cy="2460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99" b="1" dirty="0">
                <a:latin typeface="Arial" panose="020B0604020202020204" pitchFamily="34" charset="0"/>
                <a:cs typeface="Arial" panose="020B0604020202020204" pitchFamily="34" charset="0"/>
              </a:rPr>
              <a:t>T-Cell Association</a:t>
            </a:r>
          </a:p>
        </p:txBody>
      </p:sp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B34E7034-5C18-2E5E-A3EE-242E026811D1}"/>
              </a:ext>
            </a:extLst>
          </p:cNvPr>
          <p:cNvCxnSpPr>
            <a:cxnSpLocks/>
          </p:cNvCxnSpPr>
          <p:nvPr/>
        </p:nvCxnSpPr>
        <p:spPr>
          <a:xfrm flipH="1">
            <a:off x="2369491" y="3448452"/>
            <a:ext cx="1162" cy="150358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5E94FA95-747F-9C91-B3CC-D9C558E5B8EE}"/>
              </a:ext>
            </a:extLst>
          </p:cNvPr>
          <p:cNvSpPr txBox="1"/>
          <p:nvPr/>
        </p:nvSpPr>
        <p:spPr>
          <a:xfrm>
            <a:off x="805228" y="5977589"/>
            <a:ext cx="2010487" cy="2460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99" b="1" dirty="0">
                <a:latin typeface="Arial" panose="020B0604020202020204" pitchFamily="34" charset="0"/>
                <a:cs typeface="Arial" panose="020B0604020202020204" pitchFamily="34" charset="0"/>
              </a:rPr>
              <a:t>Unique Transcriptomic Profile</a:t>
            </a:r>
          </a:p>
        </p:txBody>
      </p: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7248A97E-C9AA-4DD7-D204-C24FE0D89CD7}"/>
              </a:ext>
            </a:extLst>
          </p:cNvPr>
          <p:cNvGrpSpPr/>
          <p:nvPr/>
        </p:nvGrpSpPr>
        <p:grpSpPr>
          <a:xfrm>
            <a:off x="6519215" y="8033366"/>
            <a:ext cx="860297" cy="246093"/>
            <a:chOff x="4322385" y="9684313"/>
            <a:chExt cx="1376475" cy="393750"/>
          </a:xfrm>
        </p:grpSpPr>
        <p:sp>
          <p:nvSpPr>
            <p:cNvPr id="172" name="Oval 171">
              <a:extLst>
                <a:ext uri="{FF2B5EF4-FFF2-40B4-BE49-F238E27FC236}">
                  <a16:creationId xmlns:a16="http://schemas.microsoft.com/office/drawing/2014/main" id="{B140A391-E2D0-0485-6552-F784C9679E01}"/>
                </a:ext>
              </a:extLst>
            </p:cNvPr>
            <p:cNvSpPr/>
            <p:nvPr/>
          </p:nvSpPr>
          <p:spPr>
            <a:xfrm>
              <a:off x="4322385" y="9794816"/>
              <a:ext cx="153880" cy="148326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76EF3150-87EC-3F7D-604D-EB562671ACE9}"/>
                </a:ext>
              </a:extLst>
            </p:cNvPr>
            <p:cNvSpPr txBox="1"/>
            <p:nvPr/>
          </p:nvSpPr>
          <p:spPr>
            <a:xfrm>
              <a:off x="4524119" y="9684313"/>
              <a:ext cx="1174741" cy="393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99" b="1" dirty="0">
                  <a:latin typeface="Arial" panose="020B0604020202020204" pitchFamily="34" charset="0"/>
                  <a:cs typeface="Arial" panose="020B0604020202020204" pitchFamily="34" charset="0"/>
                </a:rPr>
                <a:t>T-Cell</a:t>
              </a:r>
            </a:p>
          </p:txBody>
        </p:sp>
      </p:grpSp>
      <p:sp>
        <p:nvSpPr>
          <p:cNvPr id="174" name="Oval 173">
            <a:extLst>
              <a:ext uri="{FF2B5EF4-FFF2-40B4-BE49-F238E27FC236}">
                <a16:creationId xmlns:a16="http://schemas.microsoft.com/office/drawing/2014/main" id="{9EC515D4-CF28-3CD0-5237-54DF7AD17573}"/>
              </a:ext>
            </a:extLst>
          </p:cNvPr>
          <p:cNvSpPr/>
          <p:nvPr/>
        </p:nvSpPr>
        <p:spPr>
          <a:xfrm>
            <a:off x="6840073" y="7112385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Oval 174">
            <a:extLst>
              <a:ext uri="{FF2B5EF4-FFF2-40B4-BE49-F238E27FC236}">
                <a16:creationId xmlns:a16="http://schemas.microsoft.com/office/drawing/2014/main" id="{25A385F6-C97D-9C36-0FDE-C541451A7AE3}"/>
              </a:ext>
            </a:extLst>
          </p:cNvPr>
          <p:cNvSpPr/>
          <p:nvPr/>
        </p:nvSpPr>
        <p:spPr>
          <a:xfrm>
            <a:off x="6372327" y="6294418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Oval 175">
            <a:extLst>
              <a:ext uri="{FF2B5EF4-FFF2-40B4-BE49-F238E27FC236}">
                <a16:creationId xmlns:a16="http://schemas.microsoft.com/office/drawing/2014/main" id="{2A4E3115-CCA3-34AF-99A9-83F89B71D80E}"/>
              </a:ext>
            </a:extLst>
          </p:cNvPr>
          <p:cNvSpPr/>
          <p:nvPr/>
        </p:nvSpPr>
        <p:spPr>
          <a:xfrm>
            <a:off x="5539879" y="7789488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Oval 176">
            <a:extLst>
              <a:ext uri="{FF2B5EF4-FFF2-40B4-BE49-F238E27FC236}">
                <a16:creationId xmlns:a16="http://schemas.microsoft.com/office/drawing/2014/main" id="{07C4E093-F278-FB35-CB4F-3443A526ECE0}"/>
              </a:ext>
            </a:extLst>
          </p:cNvPr>
          <p:cNvSpPr/>
          <p:nvPr/>
        </p:nvSpPr>
        <p:spPr>
          <a:xfrm>
            <a:off x="6567303" y="6717994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Oval 177">
            <a:extLst>
              <a:ext uri="{FF2B5EF4-FFF2-40B4-BE49-F238E27FC236}">
                <a16:creationId xmlns:a16="http://schemas.microsoft.com/office/drawing/2014/main" id="{0F164E06-AA85-F870-787C-F9CB69BAF4B7}"/>
              </a:ext>
            </a:extLst>
          </p:cNvPr>
          <p:cNvSpPr/>
          <p:nvPr/>
        </p:nvSpPr>
        <p:spPr>
          <a:xfrm>
            <a:off x="5230089" y="7340034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Oval 178">
            <a:extLst>
              <a:ext uri="{FF2B5EF4-FFF2-40B4-BE49-F238E27FC236}">
                <a16:creationId xmlns:a16="http://schemas.microsoft.com/office/drawing/2014/main" id="{75EBD7DF-CC8C-8FA9-CCBB-3B7477F92F29}"/>
              </a:ext>
            </a:extLst>
          </p:cNvPr>
          <p:cNvSpPr/>
          <p:nvPr/>
        </p:nvSpPr>
        <p:spPr>
          <a:xfrm>
            <a:off x="5705032" y="6659526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Oval 179">
            <a:extLst>
              <a:ext uri="{FF2B5EF4-FFF2-40B4-BE49-F238E27FC236}">
                <a16:creationId xmlns:a16="http://schemas.microsoft.com/office/drawing/2014/main" id="{0BAFCCEB-A6A4-4DCE-A20F-97D5E1B959A7}"/>
              </a:ext>
            </a:extLst>
          </p:cNvPr>
          <p:cNvSpPr/>
          <p:nvPr/>
        </p:nvSpPr>
        <p:spPr>
          <a:xfrm>
            <a:off x="5811287" y="7158737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Oval 180">
            <a:extLst>
              <a:ext uri="{FF2B5EF4-FFF2-40B4-BE49-F238E27FC236}">
                <a16:creationId xmlns:a16="http://schemas.microsoft.com/office/drawing/2014/main" id="{CC40A7CC-65DF-AB55-2954-E0039E47008E}"/>
              </a:ext>
            </a:extLst>
          </p:cNvPr>
          <p:cNvSpPr/>
          <p:nvPr/>
        </p:nvSpPr>
        <p:spPr>
          <a:xfrm>
            <a:off x="5937299" y="6931028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Oval 181">
            <a:extLst>
              <a:ext uri="{FF2B5EF4-FFF2-40B4-BE49-F238E27FC236}">
                <a16:creationId xmlns:a16="http://schemas.microsoft.com/office/drawing/2014/main" id="{10DAEC99-8E8C-8994-1E05-65612FEE571C}"/>
              </a:ext>
            </a:extLst>
          </p:cNvPr>
          <p:cNvSpPr/>
          <p:nvPr/>
        </p:nvSpPr>
        <p:spPr>
          <a:xfrm>
            <a:off x="6180795" y="7521725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Oval 182">
            <a:extLst>
              <a:ext uri="{FF2B5EF4-FFF2-40B4-BE49-F238E27FC236}">
                <a16:creationId xmlns:a16="http://schemas.microsoft.com/office/drawing/2014/main" id="{8F5397AF-ACE1-7AB5-8470-826FE8322FA0}"/>
              </a:ext>
            </a:extLst>
          </p:cNvPr>
          <p:cNvSpPr/>
          <p:nvPr/>
        </p:nvSpPr>
        <p:spPr>
          <a:xfrm>
            <a:off x="6555096" y="7340034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Oval 183">
            <a:extLst>
              <a:ext uri="{FF2B5EF4-FFF2-40B4-BE49-F238E27FC236}">
                <a16:creationId xmlns:a16="http://schemas.microsoft.com/office/drawing/2014/main" id="{A0A3791E-2095-B717-C870-88E7B6CB3C37}"/>
              </a:ext>
            </a:extLst>
          </p:cNvPr>
          <p:cNvSpPr/>
          <p:nvPr/>
        </p:nvSpPr>
        <p:spPr>
          <a:xfrm>
            <a:off x="5323154" y="6659526"/>
            <a:ext cx="96174" cy="92704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Oval 184">
            <a:extLst>
              <a:ext uri="{FF2B5EF4-FFF2-40B4-BE49-F238E27FC236}">
                <a16:creationId xmlns:a16="http://schemas.microsoft.com/office/drawing/2014/main" id="{EAC1D1FB-B2DA-1371-6CF4-A7C67876B21F}"/>
              </a:ext>
            </a:extLst>
          </p:cNvPr>
          <p:cNvSpPr/>
          <p:nvPr/>
        </p:nvSpPr>
        <p:spPr>
          <a:xfrm>
            <a:off x="6249421" y="4257020"/>
            <a:ext cx="407816" cy="233456"/>
          </a:xfrm>
          <a:prstGeom prst="ellipse">
            <a:avLst/>
          </a:prstGeom>
          <a:solidFill>
            <a:srgbClr val="FFF8F8"/>
          </a:solidFill>
          <a:ln>
            <a:solidFill>
              <a:srgbClr val="FFF8F8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Oval 185">
            <a:extLst>
              <a:ext uri="{FF2B5EF4-FFF2-40B4-BE49-F238E27FC236}">
                <a16:creationId xmlns:a16="http://schemas.microsoft.com/office/drawing/2014/main" id="{1EDB952C-39CF-D8A8-ACB8-4F3BBC7090B5}"/>
              </a:ext>
            </a:extLst>
          </p:cNvPr>
          <p:cNvSpPr/>
          <p:nvPr/>
        </p:nvSpPr>
        <p:spPr>
          <a:xfrm>
            <a:off x="6855267" y="4272429"/>
            <a:ext cx="304789" cy="233456"/>
          </a:xfrm>
          <a:prstGeom prst="ellipse">
            <a:avLst/>
          </a:prstGeom>
          <a:solidFill>
            <a:srgbClr val="FFF8F8"/>
          </a:solidFill>
          <a:ln>
            <a:solidFill>
              <a:srgbClr val="FFF8F8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9630A6B5-80FC-D419-0BF1-D65F2111D6AA}"/>
              </a:ext>
            </a:extLst>
          </p:cNvPr>
          <p:cNvSpPr/>
          <p:nvPr/>
        </p:nvSpPr>
        <p:spPr>
          <a:xfrm>
            <a:off x="4031257" y="3655397"/>
            <a:ext cx="887657" cy="644931"/>
          </a:xfrm>
          <a:prstGeom prst="rect">
            <a:avLst/>
          </a:prstGeom>
          <a:solidFill>
            <a:srgbClr val="FFF8F8"/>
          </a:solidFill>
          <a:ln>
            <a:solidFill>
              <a:srgbClr val="FFF8F8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E0B05C93-673F-9DC1-E9EE-B1BCF0FA7A91}"/>
              </a:ext>
            </a:extLst>
          </p:cNvPr>
          <p:cNvGrpSpPr/>
          <p:nvPr/>
        </p:nvGrpSpPr>
        <p:grpSpPr>
          <a:xfrm>
            <a:off x="3972428" y="3519425"/>
            <a:ext cx="1038641" cy="839681"/>
            <a:chOff x="67824" y="1138754"/>
            <a:chExt cx="428864" cy="369911"/>
          </a:xfrm>
        </p:grpSpPr>
        <p:pic>
          <p:nvPicPr>
            <p:cNvPr id="189" name="Picture 188" descr="A pink object with a black background&#10;&#10;Description automatically generated">
              <a:extLst>
                <a:ext uri="{FF2B5EF4-FFF2-40B4-BE49-F238E27FC236}">
                  <a16:creationId xmlns:a16="http://schemas.microsoft.com/office/drawing/2014/main" id="{12EEC4D1-C3D1-5783-A439-FCD6AFFBB0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7824" y="1138754"/>
              <a:ext cx="428864" cy="343963"/>
            </a:xfrm>
            <a:prstGeom prst="rect">
              <a:avLst/>
            </a:prstGeom>
          </p:spPr>
        </p:pic>
        <p:cxnSp>
          <p:nvCxnSpPr>
            <p:cNvPr id="190" name="Straight Connector 189">
              <a:extLst>
                <a:ext uri="{FF2B5EF4-FFF2-40B4-BE49-F238E27FC236}">
                  <a16:creationId xmlns:a16="http://schemas.microsoft.com/office/drawing/2014/main" id="{9EC45196-B7C7-3DF2-006C-9ECA436A6E53}"/>
                </a:ext>
              </a:extLst>
            </p:cNvPr>
            <p:cNvCxnSpPr/>
            <p:nvPr/>
          </p:nvCxnSpPr>
          <p:spPr>
            <a:xfrm>
              <a:off x="219130" y="1171195"/>
              <a:ext cx="2670" cy="334939"/>
            </a:xfrm>
            <a:prstGeom prst="line">
              <a:avLst/>
            </a:prstGeom>
            <a:ln w="9525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6AA79E2C-A863-2654-D259-5A80938CE332}"/>
                </a:ext>
              </a:extLst>
            </p:cNvPr>
            <p:cNvCxnSpPr/>
            <p:nvPr/>
          </p:nvCxnSpPr>
          <p:spPr>
            <a:xfrm>
              <a:off x="257047" y="1169928"/>
              <a:ext cx="2670" cy="334939"/>
            </a:xfrm>
            <a:prstGeom prst="line">
              <a:avLst/>
            </a:prstGeom>
            <a:ln w="9525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D7AA6151-C2AB-F93C-914A-96DD8EEAA25B}"/>
                </a:ext>
              </a:extLst>
            </p:cNvPr>
            <p:cNvCxnSpPr/>
            <p:nvPr/>
          </p:nvCxnSpPr>
          <p:spPr>
            <a:xfrm>
              <a:off x="302349" y="1171195"/>
              <a:ext cx="2670" cy="334939"/>
            </a:xfrm>
            <a:prstGeom prst="line">
              <a:avLst/>
            </a:prstGeom>
            <a:ln w="9525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75A2F1C7-177D-A74D-72A4-92E713E125B9}"/>
                </a:ext>
              </a:extLst>
            </p:cNvPr>
            <p:cNvCxnSpPr/>
            <p:nvPr/>
          </p:nvCxnSpPr>
          <p:spPr>
            <a:xfrm>
              <a:off x="344939" y="1171195"/>
              <a:ext cx="2670" cy="334939"/>
            </a:xfrm>
            <a:prstGeom prst="line">
              <a:avLst/>
            </a:prstGeom>
            <a:ln w="9525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9B7D1DCA-0F5D-5D97-9315-AC33E5BDF053}"/>
                </a:ext>
              </a:extLst>
            </p:cNvPr>
            <p:cNvCxnSpPr/>
            <p:nvPr/>
          </p:nvCxnSpPr>
          <p:spPr>
            <a:xfrm>
              <a:off x="389866" y="1173726"/>
              <a:ext cx="2670" cy="334939"/>
            </a:xfrm>
            <a:prstGeom prst="line">
              <a:avLst/>
            </a:prstGeom>
            <a:ln w="9525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195" name="Graphic 194">
            <a:extLst>
              <a:ext uri="{FF2B5EF4-FFF2-40B4-BE49-F238E27FC236}">
                <a16:creationId xmlns:a16="http://schemas.microsoft.com/office/drawing/2014/main" id="{08FAD0EB-FC31-2D07-5BBB-C09E3ADD783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8641" r="25368" b="46454"/>
          <a:stretch/>
        </p:blipFill>
        <p:spPr>
          <a:xfrm>
            <a:off x="3873657" y="4464243"/>
            <a:ext cx="1328501" cy="897780"/>
          </a:xfrm>
          <a:prstGeom prst="rect">
            <a:avLst/>
          </a:prstGeom>
        </p:spPr>
      </p:pic>
      <p:sp>
        <p:nvSpPr>
          <p:cNvPr id="196" name="Rounded Rectangle 14">
            <a:extLst>
              <a:ext uri="{FF2B5EF4-FFF2-40B4-BE49-F238E27FC236}">
                <a16:creationId xmlns:a16="http://schemas.microsoft.com/office/drawing/2014/main" id="{E5D0C13B-F58D-15D4-AD3D-2CCFD9AEAAE7}"/>
              </a:ext>
            </a:extLst>
          </p:cNvPr>
          <p:cNvSpPr/>
          <p:nvPr/>
        </p:nvSpPr>
        <p:spPr>
          <a:xfrm>
            <a:off x="4038637" y="4555999"/>
            <a:ext cx="1045843" cy="788091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3FC310B9-4A61-E8B7-8D6A-3C97780C2F2A}"/>
              </a:ext>
            </a:extLst>
          </p:cNvPr>
          <p:cNvCxnSpPr>
            <a:cxnSpLocks/>
          </p:cNvCxnSpPr>
          <p:nvPr/>
        </p:nvCxnSpPr>
        <p:spPr>
          <a:xfrm flipH="1">
            <a:off x="4105388" y="4350486"/>
            <a:ext cx="435023" cy="223067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B4167D90-9D4C-CDF1-1D70-E4BF5702B5FD}"/>
              </a:ext>
            </a:extLst>
          </p:cNvPr>
          <p:cNvCxnSpPr>
            <a:cxnSpLocks/>
          </p:cNvCxnSpPr>
          <p:nvPr/>
        </p:nvCxnSpPr>
        <p:spPr>
          <a:xfrm>
            <a:off x="4540412" y="4345314"/>
            <a:ext cx="479559" cy="230976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99" name="Picture 198" descr="A screen shot of a computer&#10;&#10;Description automatically generated">
            <a:extLst>
              <a:ext uri="{FF2B5EF4-FFF2-40B4-BE49-F238E27FC236}">
                <a16:creationId xmlns:a16="http://schemas.microsoft.com/office/drawing/2014/main" id="{C42A116C-549E-5A9E-5ED1-08B1AEC76F2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768181" y="3295365"/>
            <a:ext cx="1886289" cy="2137419"/>
          </a:xfrm>
          <a:prstGeom prst="rect">
            <a:avLst/>
          </a:prstGeom>
          <a:ln w="9525">
            <a:noFill/>
          </a:ln>
        </p:spPr>
      </p:pic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40DDDF04-8251-B07D-1901-E69F2785656E}"/>
              </a:ext>
            </a:extLst>
          </p:cNvPr>
          <p:cNvCxnSpPr>
            <a:cxnSpLocks/>
            <a:endCxn id="202" idx="2"/>
          </p:cNvCxnSpPr>
          <p:nvPr/>
        </p:nvCxnSpPr>
        <p:spPr>
          <a:xfrm flipV="1">
            <a:off x="5662808" y="3831295"/>
            <a:ext cx="327424" cy="116604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330BFE09-90D2-FA66-C097-D4A5FFBB73D0}"/>
              </a:ext>
            </a:extLst>
          </p:cNvPr>
          <p:cNvCxnSpPr>
            <a:cxnSpLocks/>
            <a:endCxn id="202" idx="5"/>
          </p:cNvCxnSpPr>
          <p:nvPr/>
        </p:nvCxnSpPr>
        <p:spPr>
          <a:xfrm flipV="1">
            <a:off x="5647236" y="4234588"/>
            <a:ext cx="905145" cy="77402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2" name="Oval 201">
            <a:extLst>
              <a:ext uri="{FF2B5EF4-FFF2-40B4-BE49-F238E27FC236}">
                <a16:creationId xmlns:a16="http://schemas.microsoft.com/office/drawing/2014/main" id="{D27E8822-505C-7D07-51AF-F4EA0679D8A4}"/>
              </a:ext>
            </a:extLst>
          </p:cNvPr>
          <p:cNvSpPr/>
          <p:nvPr/>
        </p:nvSpPr>
        <p:spPr>
          <a:xfrm rot="789009">
            <a:off x="5980414" y="3541954"/>
            <a:ext cx="748819" cy="749042"/>
          </a:xfrm>
          <a:prstGeom prst="ellipse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1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3" name="Graphic 202">
            <a:extLst>
              <a:ext uri="{FF2B5EF4-FFF2-40B4-BE49-F238E27FC236}">
                <a16:creationId xmlns:a16="http://schemas.microsoft.com/office/drawing/2014/main" id="{89784C0E-A2C8-88B2-B066-96D798E0C5A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6880" t="67045" r="43006" b="6287"/>
          <a:stretch/>
        </p:blipFill>
        <p:spPr>
          <a:xfrm>
            <a:off x="6008171" y="3596316"/>
            <a:ext cx="685086" cy="641874"/>
          </a:xfrm>
          <a:prstGeom prst="ellipse">
            <a:avLst/>
          </a:prstGeom>
        </p:spPr>
      </p:pic>
      <p:pic>
        <p:nvPicPr>
          <p:cNvPr id="204" name="Picture 203" descr="A test tube with a cap&#10;&#10;Description automatically generated">
            <a:extLst>
              <a:ext uri="{FF2B5EF4-FFF2-40B4-BE49-F238E27FC236}">
                <a16:creationId xmlns:a16="http://schemas.microsoft.com/office/drawing/2014/main" id="{4898F477-0AD2-FCC4-A199-82F26F7CCD7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746503" y="3369584"/>
            <a:ext cx="578228" cy="2147393"/>
          </a:xfrm>
          <a:prstGeom prst="rect">
            <a:avLst/>
          </a:prstGeom>
        </p:spPr>
      </p:pic>
      <p:cxnSp>
        <p:nvCxnSpPr>
          <p:cNvPr id="205" name="Straight Arrow Connector 204">
            <a:extLst>
              <a:ext uri="{FF2B5EF4-FFF2-40B4-BE49-F238E27FC236}">
                <a16:creationId xmlns:a16="http://schemas.microsoft.com/office/drawing/2014/main" id="{BC70D67E-C008-A5EC-D75F-FF4420CF6F6A}"/>
              </a:ext>
            </a:extLst>
          </p:cNvPr>
          <p:cNvCxnSpPr>
            <a:cxnSpLocks/>
          </p:cNvCxnSpPr>
          <p:nvPr/>
        </p:nvCxnSpPr>
        <p:spPr>
          <a:xfrm flipV="1">
            <a:off x="6431826" y="4558562"/>
            <a:ext cx="326205" cy="2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6" name="Straight Arrow Connector 205">
            <a:extLst>
              <a:ext uri="{FF2B5EF4-FFF2-40B4-BE49-F238E27FC236}">
                <a16:creationId xmlns:a16="http://schemas.microsoft.com/office/drawing/2014/main" id="{4CCD59A2-6832-D951-AD0C-63875BE5B9C2}"/>
              </a:ext>
            </a:extLst>
          </p:cNvPr>
          <p:cNvCxnSpPr>
            <a:cxnSpLocks/>
          </p:cNvCxnSpPr>
          <p:nvPr/>
        </p:nvCxnSpPr>
        <p:spPr>
          <a:xfrm>
            <a:off x="7017991" y="4498714"/>
            <a:ext cx="0" cy="247693"/>
          </a:xfrm>
          <a:prstGeom prst="straightConnector1">
            <a:avLst/>
          </a:prstGeom>
          <a:ln w="12700">
            <a:prstDash val="sysDash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07" name="Graphic 206">
            <a:extLst>
              <a:ext uri="{FF2B5EF4-FFF2-40B4-BE49-F238E27FC236}">
                <a16:creationId xmlns:a16="http://schemas.microsoft.com/office/drawing/2014/main" id="{8530AE8E-B4C1-5828-B18B-86C82F096F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8584" t="7658" r="86075" b="85490"/>
          <a:stretch/>
        </p:blipFill>
        <p:spPr>
          <a:xfrm>
            <a:off x="7085626" y="3627959"/>
            <a:ext cx="94127" cy="85331"/>
          </a:xfrm>
          <a:prstGeom prst="rect">
            <a:avLst/>
          </a:prstGeom>
        </p:spPr>
      </p:pic>
      <p:pic>
        <p:nvPicPr>
          <p:cNvPr id="208" name="Graphic 207">
            <a:extLst>
              <a:ext uri="{FF2B5EF4-FFF2-40B4-BE49-F238E27FC236}">
                <a16:creationId xmlns:a16="http://schemas.microsoft.com/office/drawing/2014/main" id="{4ADBF7A4-DEC5-78CD-4DED-DA21D1C766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283" t="7658" r="90966" b="85490"/>
          <a:stretch/>
        </p:blipFill>
        <p:spPr>
          <a:xfrm>
            <a:off x="7036699" y="3585539"/>
            <a:ext cx="82684" cy="106729"/>
          </a:xfrm>
          <a:prstGeom prst="rect">
            <a:avLst/>
          </a:prstGeom>
        </p:spPr>
      </p:pic>
      <p:pic>
        <p:nvPicPr>
          <p:cNvPr id="209" name="Graphic 208">
            <a:extLst>
              <a:ext uri="{FF2B5EF4-FFF2-40B4-BE49-F238E27FC236}">
                <a16:creationId xmlns:a16="http://schemas.microsoft.com/office/drawing/2014/main" id="{463F0D9E-2725-9AF1-15DE-0C7296CE7B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283" t="7658" r="90966" b="85490"/>
          <a:stretch/>
        </p:blipFill>
        <p:spPr>
          <a:xfrm>
            <a:off x="7092986" y="3571126"/>
            <a:ext cx="66107" cy="85331"/>
          </a:xfrm>
          <a:prstGeom prst="rect">
            <a:avLst/>
          </a:prstGeom>
        </p:spPr>
      </p:pic>
      <p:sp>
        <p:nvSpPr>
          <p:cNvPr id="210" name="Rectangle 209">
            <a:extLst>
              <a:ext uri="{FF2B5EF4-FFF2-40B4-BE49-F238E27FC236}">
                <a16:creationId xmlns:a16="http://schemas.microsoft.com/office/drawing/2014/main" id="{4CE47F59-04AB-7CBB-0E2D-8BF2B4A5C00C}"/>
              </a:ext>
            </a:extLst>
          </p:cNvPr>
          <p:cNvSpPr/>
          <p:nvPr/>
        </p:nvSpPr>
        <p:spPr>
          <a:xfrm>
            <a:off x="7008897" y="3534247"/>
            <a:ext cx="220706" cy="227111"/>
          </a:xfrm>
          <a:prstGeom prst="rect">
            <a:avLst/>
          </a:prstGeom>
          <a:noFill/>
          <a:ln w="12700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2" name="Graphic 211">
            <a:extLst>
              <a:ext uri="{FF2B5EF4-FFF2-40B4-BE49-F238E27FC236}">
                <a16:creationId xmlns:a16="http://schemas.microsoft.com/office/drawing/2014/main" id="{43599961-BCEF-BC7F-AF9F-5CB987977F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8584" t="7658" r="86075" b="85490"/>
          <a:stretch/>
        </p:blipFill>
        <p:spPr>
          <a:xfrm>
            <a:off x="6973775" y="5293372"/>
            <a:ext cx="94127" cy="85331"/>
          </a:xfrm>
          <a:prstGeom prst="rect">
            <a:avLst/>
          </a:prstGeom>
        </p:spPr>
      </p:pic>
      <p:pic>
        <p:nvPicPr>
          <p:cNvPr id="213" name="Graphic 212">
            <a:extLst>
              <a:ext uri="{FF2B5EF4-FFF2-40B4-BE49-F238E27FC236}">
                <a16:creationId xmlns:a16="http://schemas.microsoft.com/office/drawing/2014/main" id="{2EDDFE46-F9BD-0E99-4DE8-67A1062A79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283" t="7658" r="90966" b="85490"/>
          <a:stretch/>
        </p:blipFill>
        <p:spPr>
          <a:xfrm>
            <a:off x="6951456" y="5226800"/>
            <a:ext cx="82684" cy="106729"/>
          </a:xfrm>
          <a:prstGeom prst="rect">
            <a:avLst/>
          </a:prstGeom>
        </p:spPr>
      </p:pic>
      <p:pic>
        <p:nvPicPr>
          <p:cNvPr id="214" name="Graphic 213">
            <a:extLst>
              <a:ext uri="{FF2B5EF4-FFF2-40B4-BE49-F238E27FC236}">
                <a16:creationId xmlns:a16="http://schemas.microsoft.com/office/drawing/2014/main" id="{0A2FED41-25C2-12CE-2D0F-0F16EB5B04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283" t="7658" r="90966" b="85490"/>
          <a:stretch/>
        </p:blipFill>
        <p:spPr>
          <a:xfrm>
            <a:off x="7007662" y="5239434"/>
            <a:ext cx="66107" cy="85331"/>
          </a:xfrm>
          <a:prstGeom prst="rect">
            <a:avLst/>
          </a:prstGeom>
        </p:spPr>
      </p:pic>
      <p:sp>
        <p:nvSpPr>
          <p:cNvPr id="215" name="Rectangle 214">
            <a:extLst>
              <a:ext uri="{FF2B5EF4-FFF2-40B4-BE49-F238E27FC236}">
                <a16:creationId xmlns:a16="http://schemas.microsoft.com/office/drawing/2014/main" id="{5C87D153-860B-E479-FC32-7507085157EE}"/>
              </a:ext>
            </a:extLst>
          </p:cNvPr>
          <p:cNvSpPr/>
          <p:nvPr/>
        </p:nvSpPr>
        <p:spPr>
          <a:xfrm>
            <a:off x="6922358" y="5219300"/>
            <a:ext cx="220706" cy="227111"/>
          </a:xfrm>
          <a:prstGeom prst="rect">
            <a:avLst/>
          </a:prstGeom>
          <a:noFill/>
          <a:ln w="12700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7" name="Straight Arrow Connector 216">
            <a:extLst>
              <a:ext uri="{FF2B5EF4-FFF2-40B4-BE49-F238E27FC236}">
                <a16:creationId xmlns:a16="http://schemas.microsoft.com/office/drawing/2014/main" id="{C32673F5-82E4-574F-5D85-C9F56604B762}"/>
              </a:ext>
            </a:extLst>
          </p:cNvPr>
          <p:cNvCxnSpPr>
            <a:cxnSpLocks/>
          </p:cNvCxnSpPr>
          <p:nvPr/>
        </p:nvCxnSpPr>
        <p:spPr>
          <a:xfrm>
            <a:off x="3626002" y="4444069"/>
            <a:ext cx="418093" cy="0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8" name="Straight Arrow Connector 217">
            <a:extLst>
              <a:ext uri="{FF2B5EF4-FFF2-40B4-BE49-F238E27FC236}">
                <a16:creationId xmlns:a16="http://schemas.microsoft.com/office/drawing/2014/main" id="{603B28B6-3793-0573-0F4B-A6C8AD260EE5}"/>
              </a:ext>
            </a:extLst>
          </p:cNvPr>
          <p:cNvCxnSpPr>
            <a:cxnSpLocks/>
          </p:cNvCxnSpPr>
          <p:nvPr/>
        </p:nvCxnSpPr>
        <p:spPr>
          <a:xfrm>
            <a:off x="6078082" y="5791145"/>
            <a:ext cx="0" cy="262039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9" name="Straight Arrow Connector 218">
            <a:extLst>
              <a:ext uri="{FF2B5EF4-FFF2-40B4-BE49-F238E27FC236}">
                <a16:creationId xmlns:a16="http://schemas.microsoft.com/office/drawing/2014/main" id="{23641A8C-A765-5B26-1121-885BE67E96DD}"/>
              </a:ext>
            </a:extLst>
          </p:cNvPr>
          <p:cNvCxnSpPr>
            <a:cxnSpLocks/>
          </p:cNvCxnSpPr>
          <p:nvPr/>
        </p:nvCxnSpPr>
        <p:spPr>
          <a:xfrm>
            <a:off x="1901248" y="5795985"/>
            <a:ext cx="0" cy="262039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0" name="Straight Arrow Connector 219">
            <a:extLst>
              <a:ext uri="{FF2B5EF4-FFF2-40B4-BE49-F238E27FC236}">
                <a16:creationId xmlns:a16="http://schemas.microsoft.com/office/drawing/2014/main" id="{2DD912EC-56A0-245B-9DE8-C318F79D1821}"/>
              </a:ext>
            </a:extLst>
          </p:cNvPr>
          <p:cNvCxnSpPr>
            <a:cxnSpLocks/>
          </p:cNvCxnSpPr>
          <p:nvPr/>
        </p:nvCxnSpPr>
        <p:spPr>
          <a:xfrm flipV="1">
            <a:off x="5163379" y="4555997"/>
            <a:ext cx="326205" cy="2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1" name="Triangle 4">
            <a:extLst>
              <a:ext uri="{FF2B5EF4-FFF2-40B4-BE49-F238E27FC236}">
                <a16:creationId xmlns:a16="http://schemas.microsoft.com/office/drawing/2014/main" id="{9BD020AF-1408-A8FF-59AC-F5978A2DE2F6}"/>
              </a:ext>
            </a:extLst>
          </p:cNvPr>
          <p:cNvSpPr/>
          <p:nvPr/>
        </p:nvSpPr>
        <p:spPr>
          <a:xfrm>
            <a:off x="4887243" y="2562535"/>
            <a:ext cx="2292510" cy="527008"/>
          </a:xfrm>
          <a:prstGeom prst="triangle">
            <a:avLst>
              <a:gd name="adj" fmla="val 100000"/>
            </a:avLst>
          </a:prstGeom>
          <a:solidFill>
            <a:srgbClr val="E59EDD">
              <a:alpha val="74902"/>
            </a:srgb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3" name="Group 222">
            <a:extLst>
              <a:ext uri="{FF2B5EF4-FFF2-40B4-BE49-F238E27FC236}">
                <a16:creationId xmlns:a16="http://schemas.microsoft.com/office/drawing/2014/main" id="{92D1CBDF-D084-7CBE-9EC7-1C94D09BC29B}"/>
              </a:ext>
            </a:extLst>
          </p:cNvPr>
          <p:cNvGrpSpPr/>
          <p:nvPr/>
        </p:nvGrpSpPr>
        <p:grpSpPr>
          <a:xfrm>
            <a:off x="5196807" y="6363227"/>
            <a:ext cx="1650776" cy="1675871"/>
            <a:chOff x="5462585" y="1806328"/>
            <a:chExt cx="3002688" cy="3419491"/>
          </a:xfrm>
        </p:grpSpPr>
        <p:sp>
          <p:nvSpPr>
            <p:cNvPr id="224" name="Oval 262">
              <a:extLst>
                <a:ext uri="{FF2B5EF4-FFF2-40B4-BE49-F238E27FC236}">
                  <a16:creationId xmlns:a16="http://schemas.microsoft.com/office/drawing/2014/main" id="{3D8F675F-07B9-98CD-82C3-F334DF8D6C63}"/>
                </a:ext>
              </a:extLst>
            </p:cNvPr>
            <p:cNvSpPr/>
            <p:nvPr/>
          </p:nvSpPr>
          <p:spPr>
            <a:xfrm>
              <a:off x="5462585" y="2268018"/>
              <a:ext cx="1256007" cy="1348259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256007" h="1348259">
                  <a:moveTo>
                    <a:pt x="58531" y="442213"/>
                  </a:moveTo>
                  <a:cubicBezTo>
                    <a:pt x="138478" y="342279"/>
                    <a:pt x="471320" y="666788"/>
                    <a:pt x="550231" y="593862"/>
                  </a:cubicBezTo>
                  <a:cubicBezTo>
                    <a:pt x="629142" y="520936"/>
                    <a:pt x="464539" y="47128"/>
                    <a:pt x="531995" y="4656"/>
                  </a:cubicBezTo>
                  <a:cubicBezTo>
                    <a:pt x="599451" y="-37816"/>
                    <a:pt x="831084" y="221132"/>
                    <a:pt x="954965" y="339029"/>
                  </a:cubicBezTo>
                  <a:cubicBezTo>
                    <a:pt x="1078846" y="456926"/>
                    <a:pt x="1338281" y="811788"/>
                    <a:pt x="1230310" y="996849"/>
                  </a:cubicBezTo>
                  <a:cubicBezTo>
                    <a:pt x="1122339" y="1181910"/>
                    <a:pt x="780251" y="1154299"/>
                    <a:pt x="621934" y="1209554"/>
                  </a:cubicBezTo>
                  <a:cubicBezTo>
                    <a:pt x="463617" y="1264809"/>
                    <a:pt x="432267" y="1398517"/>
                    <a:pt x="280408" y="1328380"/>
                  </a:cubicBezTo>
                  <a:cubicBezTo>
                    <a:pt x="128549" y="1258243"/>
                    <a:pt x="162489" y="1296192"/>
                    <a:pt x="70546" y="1193468"/>
                  </a:cubicBezTo>
                  <a:cubicBezTo>
                    <a:pt x="-21397" y="1090744"/>
                    <a:pt x="-21416" y="542147"/>
                    <a:pt x="58531" y="442213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Oval 262">
              <a:extLst>
                <a:ext uri="{FF2B5EF4-FFF2-40B4-BE49-F238E27FC236}">
                  <a16:creationId xmlns:a16="http://schemas.microsoft.com/office/drawing/2014/main" id="{4998EEBB-E3C0-9911-659A-6B062A5337BD}"/>
                </a:ext>
              </a:extLst>
            </p:cNvPr>
            <p:cNvSpPr/>
            <p:nvPr/>
          </p:nvSpPr>
          <p:spPr>
            <a:xfrm>
              <a:off x="6703739" y="1981755"/>
              <a:ext cx="1151810" cy="1131927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151810" h="1131927">
                  <a:moveTo>
                    <a:pt x="12404" y="481516"/>
                  </a:moveTo>
                  <a:cubicBezTo>
                    <a:pt x="57374" y="394074"/>
                    <a:pt x="335252" y="331336"/>
                    <a:pt x="414163" y="258410"/>
                  </a:cubicBezTo>
                  <a:cubicBezTo>
                    <a:pt x="493074" y="185484"/>
                    <a:pt x="577610" y="45270"/>
                    <a:pt x="665750" y="13978"/>
                  </a:cubicBezTo>
                  <a:cubicBezTo>
                    <a:pt x="753890" y="-17314"/>
                    <a:pt x="880005" y="4934"/>
                    <a:pt x="943005" y="70656"/>
                  </a:cubicBezTo>
                  <a:cubicBezTo>
                    <a:pt x="1006005" y="136378"/>
                    <a:pt x="996059" y="314852"/>
                    <a:pt x="1043750" y="408312"/>
                  </a:cubicBezTo>
                  <a:cubicBezTo>
                    <a:pt x="1091441" y="501772"/>
                    <a:pt x="1217203" y="551288"/>
                    <a:pt x="1109232" y="736349"/>
                  </a:cubicBezTo>
                  <a:cubicBezTo>
                    <a:pt x="1001261" y="921410"/>
                    <a:pt x="909010" y="916283"/>
                    <a:pt x="800660" y="979033"/>
                  </a:cubicBezTo>
                  <a:cubicBezTo>
                    <a:pt x="692310" y="1041783"/>
                    <a:pt x="610993" y="1182987"/>
                    <a:pt x="459134" y="1112850"/>
                  </a:cubicBezTo>
                  <a:cubicBezTo>
                    <a:pt x="307275" y="1042713"/>
                    <a:pt x="236284" y="885789"/>
                    <a:pt x="144341" y="783065"/>
                  </a:cubicBezTo>
                  <a:cubicBezTo>
                    <a:pt x="52398" y="680341"/>
                    <a:pt x="-32566" y="568958"/>
                    <a:pt x="12404" y="48151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Oval 262">
              <a:extLst>
                <a:ext uri="{FF2B5EF4-FFF2-40B4-BE49-F238E27FC236}">
                  <a16:creationId xmlns:a16="http://schemas.microsoft.com/office/drawing/2014/main" id="{60AAA4F6-754F-C54E-24CD-FB1419BE8F79}"/>
                </a:ext>
              </a:extLst>
            </p:cNvPr>
            <p:cNvSpPr/>
            <p:nvPr/>
          </p:nvSpPr>
          <p:spPr>
            <a:xfrm rot="19645332">
              <a:off x="6760723" y="3188178"/>
              <a:ext cx="992103" cy="1015226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7647 w 992103"/>
                <a:gd name="connsiteY0" fmla="*/ 522134 h 1015226"/>
                <a:gd name="connsiteX1" fmla="*/ 205548 w 992103"/>
                <a:gd name="connsiteY1" fmla="*/ 120409 h 1015226"/>
                <a:gd name="connsiteX2" fmla="*/ 484497 w 992103"/>
                <a:gd name="connsiteY2" fmla="*/ 196 h 1015226"/>
                <a:gd name="connsiteX3" fmla="*/ 858244 w 992103"/>
                <a:gd name="connsiteY3" fmla="*/ 100741 h 1015226"/>
                <a:gd name="connsiteX4" fmla="*/ 958989 w 992103"/>
                <a:gd name="connsiteY4" fmla="*/ 438397 h 1015226"/>
                <a:gd name="connsiteX5" fmla="*/ 905863 w 992103"/>
                <a:gd name="connsiteY5" fmla="*/ 868536 h 1015226"/>
                <a:gd name="connsiteX6" fmla="*/ 715899 w 992103"/>
                <a:gd name="connsiteY6" fmla="*/ 1009118 h 1015226"/>
                <a:gd name="connsiteX7" fmla="*/ 456514 w 992103"/>
                <a:gd name="connsiteY7" fmla="*/ 961643 h 1015226"/>
                <a:gd name="connsiteX8" fmla="*/ 311942 w 992103"/>
                <a:gd name="connsiteY8" fmla="*/ 711683 h 1015226"/>
                <a:gd name="connsiteX9" fmla="*/ 59580 w 992103"/>
                <a:gd name="connsiteY9" fmla="*/ 813150 h 1015226"/>
                <a:gd name="connsiteX10" fmla="*/ 27647 w 992103"/>
                <a:gd name="connsiteY10" fmla="*/ 522134 h 10152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92103" h="1015226">
                  <a:moveTo>
                    <a:pt x="27647" y="522134"/>
                  </a:moveTo>
                  <a:cubicBezTo>
                    <a:pt x="51975" y="406677"/>
                    <a:pt x="126637" y="193335"/>
                    <a:pt x="205548" y="120409"/>
                  </a:cubicBezTo>
                  <a:cubicBezTo>
                    <a:pt x="284459" y="47483"/>
                    <a:pt x="375714" y="3474"/>
                    <a:pt x="484497" y="196"/>
                  </a:cubicBezTo>
                  <a:cubicBezTo>
                    <a:pt x="593280" y="-3082"/>
                    <a:pt x="795244" y="35019"/>
                    <a:pt x="858244" y="100741"/>
                  </a:cubicBezTo>
                  <a:cubicBezTo>
                    <a:pt x="921244" y="166463"/>
                    <a:pt x="911298" y="344937"/>
                    <a:pt x="958989" y="438397"/>
                  </a:cubicBezTo>
                  <a:cubicBezTo>
                    <a:pt x="1006680" y="531857"/>
                    <a:pt x="1013834" y="683475"/>
                    <a:pt x="905863" y="868536"/>
                  </a:cubicBezTo>
                  <a:cubicBezTo>
                    <a:pt x="797892" y="1053597"/>
                    <a:pt x="790791" y="993600"/>
                    <a:pt x="715899" y="1009118"/>
                  </a:cubicBezTo>
                  <a:cubicBezTo>
                    <a:pt x="641008" y="1024636"/>
                    <a:pt x="523840" y="1011215"/>
                    <a:pt x="456514" y="961643"/>
                  </a:cubicBezTo>
                  <a:cubicBezTo>
                    <a:pt x="389188" y="912071"/>
                    <a:pt x="393070" y="722280"/>
                    <a:pt x="311942" y="711683"/>
                  </a:cubicBezTo>
                  <a:cubicBezTo>
                    <a:pt x="230814" y="701086"/>
                    <a:pt x="151523" y="915874"/>
                    <a:pt x="59580" y="813150"/>
                  </a:cubicBezTo>
                  <a:cubicBezTo>
                    <a:pt x="-32363" y="710426"/>
                    <a:pt x="3319" y="637591"/>
                    <a:pt x="27647" y="522134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Oval 262">
              <a:extLst>
                <a:ext uri="{FF2B5EF4-FFF2-40B4-BE49-F238E27FC236}">
                  <a16:creationId xmlns:a16="http://schemas.microsoft.com/office/drawing/2014/main" id="{78FBBAB1-E124-FF48-9F9B-C86A65A1DA03}"/>
                </a:ext>
              </a:extLst>
            </p:cNvPr>
            <p:cNvSpPr/>
            <p:nvPr/>
          </p:nvSpPr>
          <p:spPr>
            <a:xfrm rot="19645332">
              <a:off x="5763553" y="3518467"/>
              <a:ext cx="988441" cy="1058348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308280 w 988441"/>
                <a:gd name="connsiteY8" fmla="*/ 714050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229664 w 988441"/>
                <a:gd name="connsiteY8" fmla="*/ 948443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58348"/>
                <a:gd name="connsiteX1" fmla="*/ 140825 w 988441"/>
                <a:gd name="connsiteY1" fmla="*/ 190495 h 1058348"/>
                <a:gd name="connsiteX2" fmla="*/ 480835 w 988441"/>
                <a:gd name="connsiteY2" fmla="*/ 2563 h 1058348"/>
                <a:gd name="connsiteX3" fmla="*/ 854582 w 988441"/>
                <a:gd name="connsiteY3" fmla="*/ 103108 h 1058348"/>
                <a:gd name="connsiteX4" fmla="*/ 955327 w 988441"/>
                <a:gd name="connsiteY4" fmla="*/ 440764 h 1058348"/>
                <a:gd name="connsiteX5" fmla="*/ 902201 w 988441"/>
                <a:gd name="connsiteY5" fmla="*/ 870903 h 1058348"/>
                <a:gd name="connsiteX6" fmla="*/ 712237 w 988441"/>
                <a:gd name="connsiteY6" fmla="*/ 1011485 h 1058348"/>
                <a:gd name="connsiteX7" fmla="*/ 566538 w 988441"/>
                <a:gd name="connsiteY7" fmla="*/ 1036652 h 1058348"/>
                <a:gd name="connsiteX8" fmla="*/ 229664 w 988441"/>
                <a:gd name="connsiteY8" fmla="*/ 948443 h 1058348"/>
                <a:gd name="connsiteX9" fmla="*/ 55918 w 988441"/>
                <a:gd name="connsiteY9" fmla="*/ 815517 h 1058348"/>
                <a:gd name="connsiteX10" fmla="*/ 23985 w 988441"/>
                <a:gd name="connsiteY10" fmla="*/ 524501 h 10583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88441" h="1058348">
                  <a:moveTo>
                    <a:pt x="23985" y="524501"/>
                  </a:moveTo>
                  <a:cubicBezTo>
                    <a:pt x="38136" y="420331"/>
                    <a:pt x="61914" y="263421"/>
                    <a:pt x="140825" y="190495"/>
                  </a:cubicBezTo>
                  <a:cubicBezTo>
                    <a:pt x="219736" y="117569"/>
                    <a:pt x="361876" y="17127"/>
                    <a:pt x="480835" y="2563"/>
                  </a:cubicBezTo>
                  <a:cubicBezTo>
                    <a:pt x="599794" y="-12001"/>
                    <a:pt x="791582" y="37386"/>
                    <a:pt x="854582" y="103108"/>
                  </a:cubicBezTo>
                  <a:cubicBezTo>
                    <a:pt x="917582" y="168830"/>
                    <a:pt x="907636" y="347304"/>
                    <a:pt x="955327" y="440764"/>
                  </a:cubicBezTo>
                  <a:cubicBezTo>
                    <a:pt x="1003018" y="534224"/>
                    <a:pt x="1010172" y="685842"/>
                    <a:pt x="902201" y="870903"/>
                  </a:cubicBezTo>
                  <a:cubicBezTo>
                    <a:pt x="794230" y="1055964"/>
                    <a:pt x="768181" y="983860"/>
                    <a:pt x="712237" y="1011485"/>
                  </a:cubicBezTo>
                  <a:cubicBezTo>
                    <a:pt x="656293" y="1039110"/>
                    <a:pt x="633864" y="1086224"/>
                    <a:pt x="566538" y="1036652"/>
                  </a:cubicBezTo>
                  <a:cubicBezTo>
                    <a:pt x="499212" y="987080"/>
                    <a:pt x="310792" y="959040"/>
                    <a:pt x="229664" y="948443"/>
                  </a:cubicBezTo>
                  <a:cubicBezTo>
                    <a:pt x="148536" y="937846"/>
                    <a:pt x="147861" y="918241"/>
                    <a:pt x="55918" y="815517"/>
                  </a:cubicBezTo>
                  <a:cubicBezTo>
                    <a:pt x="-36025" y="712793"/>
                    <a:pt x="9834" y="628671"/>
                    <a:pt x="23985" y="524501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Oval 262">
              <a:extLst>
                <a:ext uri="{FF2B5EF4-FFF2-40B4-BE49-F238E27FC236}">
                  <a16:creationId xmlns:a16="http://schemas.microsoft.com/office/drawing/2014/main" id="{2238F3F2-F7C9-9D83-07D7-48835B9080C9}"/>
                </a:ext>
              </a:extLst>
            </p:cNvPr>
            <p:cNvSpPr/>
            <p:nvPr/>
          </p:nvSpPr>
          <p:spPr>
            <a:xfrm rot="19645332">
              <a:off x="6422111" y="4276729"/>
              <a:ext cx="1127041" cy="949090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308280 w 988441"/>
                <a:gd name="connsiteY8" fmla="*/ 714050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229664 w 988441"/>
                <a:gd name="connsiteY8" fmla="*/ 948443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58348"/>
                <a:gd name="connsiteX1" fmla="*/ 140825 w 988441"/>
                <a:gd name="connsiteY1" fmla="*/ 190495 h 1058348"/>
                <a:gd name="connsiteX2" fmla="*/ 480835 w 988441"/>
                <a:gd name="connsiteY2" fmla="*/ 2563 h 1058348"/>
                <a:gd name="connsiteX3" fmla="*/ 854582 w 988441"/>
                <a:gd name="connsiteY3" fmla="*/ 103108 h 1058348"/>
                <a:gd name="connsiteX4" fmla="*/ 955327 w 988441"/>
                <a:gd name="connsiteY4" fmla="*/ 440764 h 1058348"/>
                <a:gd name="connsiteX5" fmla="*/ 902201 w 988441"/>
                <a:gd name="connsiteY5" fmla="*/ 870903 h 1058348"/>
                <a:gd name="connsiteX6" fmla="*/ 712237 w 988441"/>
                <a:gd name="connsiteY6" fmla="*/ 1011485 h 1058348"/>
                <a:gd name="connsiteX7" fmla="*/ 566538 w 988441"/>
                <a:gd name="connsiteY7" fmla="*/ 1036652 h 1058348"/>
                <a:gd name="connsiteX8" fmla="*/ 229664 w 988441"/>
                <a:gd name="connsiteY8" fmla="*/ 948443 h 1058348"/>
                <a:gd name="connsiteX9" fmla="*/ 55918 w 988441"/>
                <a:gd name="connsiteY9" fmla="*/ 815517 h 1058348"/>
                <a:gd name="connsiteX10" fmla="*/ 23985 w 988441"/>
                <a:gd name="connsiteY10" fmla="*/ 524501 h 1058348"/>
                <a:gd name="connsiteX0" fmla="*/ 23985 w 1113709"/>
                <a:gd name="connsiteY0" fmla="*/ 524501 h 1059352"/>
                <a:gd name="connsiteX1" fmla="*/ 140825 w 1113709"/>
                <a:gd name="connsiteY1" fmla="*/ 190495 h 1059352"/>
                <a:gd name="connsiteX2" fmla="*/ 480835 w 1113709"/>
                <a:gd name="connsiteY2" fmla="*/ 2563 h 1059352"/>
                <a:gd name="connsiteX3" fmla="*/ 854582 w 1113709"/>
                <a:gd name="connsiteY3" fmla="*/ 103108 h 1059352"/>
                <a:gd name="connsiteX4" fmla="*/ 955327 w 1113709"/>
                <a:gd name="connsiteY4" fmla="*/ 440764 h 1059352"/>
                <a:gd name="connsiteX5" fmla="*/ 1080457 w 1113709"/>
                <a:gd name="connsiteY5" fmla="*/ 842493 h 1059352"/>
                <a:gd name="connsiteX6" fmla="*/ 712237 w 1113709"/>
                <a:gd name="connsiteY6" fmla="*/ 1011485 h 1059352"/>
                <a:gd name="connsiteX7" fmla="*/ 566538 w 1113709"/>
                <a:gd name="connsiteY7" fmla="*/ 1036652 h 1059352"/>
                <a:gd name="connsiteX8" fmla="*/ 229664 w 1113709"/>
                <a:gd name="connsiteY8" fmla="*/ 948443 h 1059352"/>
                <a:gd name="connsiteX9" fmla="*/ 55918 w 1113709"/>
                <a:gd name="connsiteY9" fmla="*/ 815517 h 1059352"/>
                <a:gd name="connsiteX10" fmla="*/ 23985 w 1113709"/>
                <a:gd name="connsiteY10" fmla="*/ 524501 h 1059352"/>
                <a:gd name="connsiteX0" fmla="*/ 23985 w 1113709"/>
                <a:gd name="connsiteY0" fmla="*/ 456644 h 991495"/>
                <a:gd name="connsiteX1" fmla="*/ 140825 w 1113709"/>
                <a:gd name="connsiteY1" fmla="*/ 122638 h 991495"/>
                <a:gd name="connsiteX2" fmla="*/ 403633 w 1113709"/>
                <a:gd name="connsiteY2" fmla="*/ 27688 h 991495"/>
                <a:gd name="connsiteX3" fmla="*/ 854582 w 1113709"/>
                <a:gd name="connsiteY3" fmla="*/ 35251 h 991495"/>
                <a:gd name="connsiteX4" fmla="*/ 955327 w 1113709"/>
                <a:gd name="connsiteY4" fmla="*/ 372907 h 991495"/>
                <a:gd name="connsiteX5" fmla="*/ 1080457 w 1113709"/>
                <a:gd name="connsiteY5" fmla="*/ 774636 h 991495"/>
                <a:gd name="connsiteX6" fmla="*/ 712237 w 1113709"/>
                <a:gd name="connsiteY6" fmla="*/ 943628 h 991495"/>
                <a:gd name="connsiteX7" fmla="*/ 566538 w 1113709"/>
                <a:gd name="connsiteY7" fmla="*/ 968795 h 991495"/>
                <a:gd name="connsiteX8" fmla="*/ 229664 w 1113709"/>
                <a:gd name="connsiteY8" fmla="*/ 880586 h 991495"/>
                <a:gd name="connsiteX9" fmla="*/ 55918 w 1113709"/>
                <a:gd name="connsiteY9" fmla="*/ 747660 h 991495"/>
                <a:gd name="connsiteX10" fmla="*/ 23985 w 1113709"/>
                <a:gd name="connsiteY10" fmla="*/ 456644 h 991495"/>
                <a:gd name="connsiteX0" fmla="*/ 23985 w 1113709"/>
                <a:gd name="connsiteY0" fmla="*/ 526690 h 1061541"/>
                <a:gd name="connsiteX1" fmla="*/ 140825 w 1113709"/>
                <a:gd name="connsiteY1" fmla="*/ 192684 h 1061541"/>
                <a:gd name="connsiteX2" fmla="*/ 403633 w 1113709"/>
                <a:gd name="connsiteY2" fmla="*/ 97734 h 1061541"/>
                <a:gd name="connsiteX3" fmla="*/ 748969 w 1113709"/>
                <a:gd name="connsiteY3" fmla="*/ 20024 h 1061541"/>
                <a:gd name="connsiteX4" fmla="*/ 955327 w 1113709"/>
                <a:gd name="connsiteY4" fmla="*/ 442953 h 1061541"/>
                <a:gd name="connsiteX5" fmla="*/ 1080457 w 1113709"/>
                <a:gd name="connsiteY5" fmla="*/ 844682 h 1061541"/>
                <a:gd name="connsiteX6" fmla="*/ 712237 w 1113709"/>
                <a:gd name="connsiteY6" fmla="*/ 1013674 h 1061541"/>
                <a:gd name="connsiteX7" fmla="*/ 566538 w 1113709"/>
                <a:gd name="connsiteY7" fmla="*/ 1038841 h 1061541"/>
                <a:gd name="connsiteX8" fmla="*/ 229664 w 1113709"/>
                <a:gd name="connsiteY8" fmla="*/ 950632 h 1061541"/>
                <a:gd name="connsiteX9" fmla="*/ 55918 w 1113709"/>
                <a:gd name="connsiteY9" fmla="*/ 817706 h 1061541"/>
                <a:gd name="connsiteX10" fmla="*/ 23985 w 1113709"/>
                <a:gd name="connsiteY10" fmla="*/ 526690 h 1061541"/>
                <a:gd name="connsiteX0" fmla="*/ 33099 w 1122823"/>
                <a:gd name="connsiteY0" fmla="*/ 526353 h 1061204"/>
                <a:gd name="connsiteX1" fmla="*/ 37303 w 1122823"/>
                <a:gd name="connsiteY1" fmla="*/ 173742 h 1061204"/>
                <a:gd name="connsiteX2" fmla="*/ 412747 w 1122823"/>
                <a:gd name="connsiteY2" fmla="*/ 97397 h 1061204"/>
                <a:gd name="connsiteX3" fmla="*/ 758083 w 1122823"/>
                <a:gd name="connsiteY3" fmla="*/ 19687 h 1061204"/>
                <a:gd name="connsiteX4" fmla="*/ 964441 w 1122823"/>
                <a:gd name="connsiteY4" fmla="*/ 442616 h 1061204"/>
                <a:gd name="connsiteX5" fmla="*/ 1089571 w 1122823"/>
                <a:gd name="connsiteY5" fmla="*/ 844345 h 1061204"/>
                <a:gd name="connsiteX6" fmla="*/ 721351 w 1122823"/>
                <a:gd name="connsiteY6" fmla="*/ 1013337 h 1061204"/>
                <a:gd name="connsiteX7" fmla="*/ 575652 w 1122823"/>
                <a:gd name="connsiteY7" fmla="*/ 1038504 h 1061204"/>
                <a:gd name="connsiteX8" fmla="*/ 238778 w 1122823"/>
                <a:gd name="connsiteY8" fmla="*/ 950295 h 1061204"/>
                <a:gd name="connsiteX9" fmla="*/ 65032 w 1122823"/>
                <a:gd name="connsiteY9" fmla="*/ 817369 h 1061204"/>
                <a:gd name="connsiteX10" fmla="*/ 33099 w 1122823"/>
                <a:gd name="connsiteY10" fmla="*/ 526353 h 1061204"/>
                <a:gd name="connsiteX0" fmla="*/ 33099 w 1122823"/>
                <a:gd name="connsiteY0" fmla="*/ 526353 h 1061204"/>
                <a:gd name="connsiteX1" fmla="*/ 37303 w 1122823"/>
                <a:gd name="connsiteY1" fmla="*/ 173742 h 1061204"/>
                <a:gd name="connsiteX2" fmla="*/ 412747 w 1122823"/>
                <a:gd name="connsiteY2" fmla="*/ 97397 h 1061204"/>
                <a:gd name="connsiteX3" fmla="*/ 758083 w 1122823"/>
                <a:gd name="connsiteY3" fmla="*/ 19687 h 1061204"/>
                <a:gd name="connsiteX4" fmla="*/ 964441 w 1122823"/>
                <a:gd name="connsiteY4" fmla="*/ 442616 h 1061204"/>
                <a:gd name="connsiteX5" fmla="*/ 1089571 w 1122823"/>
                <a:gd name="connsiteY5" fmla="*/ 844345 h 1061204"/>
                <a:gd name="connsiteX6" fmla="*/ 721351 w 1122823"/>
                <a:gd name="connsiteY6" fmla="*/ 1013337 h 1061204"/>
                <a:gd name="connsiteX7" fmla="*/ 575652 w 1122823"/>
                <a:gd name="connsiteY7" fmla="*/ 1038504 h 1061204"/>
                <a:gd name="connsiteX8" fmla="*/ 577413 w 1122823"/>
                <a:gd name="connsiteY8" fmla="*/ 615214 h 1061204"/>
                <a:gd name="connsiteX9" fmla="*/ 65032 w 1122823"/>
                <a:gd name="connsiteY9" fmla="*/ 817369 h 1061204"/>
                <a:gd name="connsiteX10" fmla="*/ 33099 w 1122823"/>
                <a:gd name="connsiteY10" fmla="*/ 526353 h 1061204"/>
                <a:gd name="connsiteX0" fmla="*/ 33099 w 1122823"/>
                <a:gd name="connsiteY0" fmla="*/ 526353 h 1048702"/>
                <a:gd name="connsiteX1" fmla="*/ 37303 w 1122823"/>
                <a:gd name="connsiteY1" fmla="*/ 173742 h 1048702"/>
                <a:gd name="connsiteX2" fmla="*/ 412747 w 1122823"/>
                <a:gd name="connsiteY2" fmla="*/ 97397 h 1048702"/>
                <a:gd name="connsiteX3" fmla="*/ 758083 w 1122823"/>
                <a:gd name="connsiteY3" fmla="*/ 19687 h 1048702"/>
                <a:gd name="connsiteX4" fmla="*/ 964441 w 1122823"/>
                <a:gd name="connsiteY4" fmla="*/ 442616 h 1048702"/>
                <a:gd name="connsiteX5" fmla="*/ 1089571 w 1122823"/>
                <a:gd name="connsiteY5" fmla="*/ 844345 h 1048702"/>
                <a:gd name="connsiteX6" fmla="*/ 893997 w 1122823"/>
                <a:gd name="connsiteY6" fmla="*/ 910185 h 1048702"/>
                <a:gd name="connsiteX7" fmla="*/ 575652 w 1122823"/>
                <a:gd name="connsiteY7" fmla="*/ 1038504 h 1048702"/>
                <a:gd name="connsiteX8" fmla="*/ 577413 w 1122823"/>
                <a:gd name="connsiteY8" fmla="*/ 615214 h 1048702"/>
                <a:gd name="connsiteX9" fmla="*/ 65032 w 1122823"/>
                <a:gd name="connsiteY9" fmla="*/ 817369 h 1048702"/>
                <a:gd name="connsiteX10" fmla="*/ 33099 w 1122823"/>
                <a:gd name="connsiteY10" fmla="*/ 526353 h 1048702"/>
                <a:gd name="connsiteX0" fmla="*/ 33099 w 1122823"/>
                <a:gd name="connsiteY0" fmla="*/ 526353 h 949090"/>
                <a:gd name="connsiteX1" fmla="*/ 37303 w 1122823"/>
                <a:gd name="connsiteY1" fmla="*/ 173742 h 949090"/>
                <a:gd name="connsiteX2" fmla="*/ 412747 w 1122823"/>
                <a:gd name="connsiteY2" fmla="*/ 97397 h 949090"/>
                <a:gd name="connsiteX3" fmla="*/ 758083 w 1122823"/>
                <a:gd name="connsiteY3" fmla="*/ 19687 h 949090"/>
                <a:gd name="connsiteX4" fmla="*/ 964441 w 1122823"/>
                <a:gd name="connsiteY4" fmla="*/ 442616 h 949090"/>
                <a:gd name="connsiteX5" fmla="*/ 1089571 w 1122823"/>
                <a:gd name="connsiteY5" fmla="*/ 844345 h 949090"/>
                <a:gd name="connsiteX6" fmla="*/ 893997 w 1122823"/>
                <a:gd name="connsiteY6" fmla="*/ 910185 h 949090"/>
                <a:gd name="connsiteX7" fmla="*/ 712866 w 1122823"/>
                <a:gd name="connsiteY7" fmla="*/ 823767 h 949090"/>
                <a:gd name="connsiteX8" fmla="*/ 577413 w 1122823"/>
                <a:gd name="connsiteY8" fmla="*/ 615214 h 949090"/>
                <a:gd name="connsiteX9" fmla="*/ 65032 w 1122823"/>
                <a:gd name="connsiteY9" fmla="*/ 817369 h 949090"/>
                <a:gd name="connsiteX10" fmla="*/ 33099 w 1122823"/>
                <a:gd name="connsiteY10" fmla="*/ 526353 h 949090"/>
                <a:gd name="connsiteX0" fmla="*/ 42445 w 1132169"/>
                <a:gd name="connsiteY0" fmla="*/ 526353 h 949090"/>
                <a:gd name="connsiteX1" fmla="*/ 46649 w 1132169"/>
                <a:gd name="connsiteY1" fmla="*/ 173742 h 949090"/>
                <a:gd name="connsiteX2" fmla="*/ 422093 w 1132169"/>
                <a:gd name="connsiteY2" fmla="*/ 97397 h 949090"/>
                <a:gd name="connsiteX3" fmla="*/ 767429 w 1132169"/>
                <a:gd name="connsiteY3" fmla="*/ 19687 h 949090"/>
                <a:gd name="connsiteX4" fmla="*/ 973787 w 1132169"/>
                <a:gd name="connsiteY4" fmla="*/ 442616 h 949090"/>
                <a:gd name="connsiteX5" fmla="*/ 1098917 w 1132169"/>
                <a:gd name="connsiteY5" fmla="*/ 844345 h 949090"/>
                <a:gd name="connsiteX6" fmla="*/ 903343 w 1132169"/>
                <a:gd name="connsiteY6" fmla="*/ 910185 h 949090"/>
                <a:gd name="connsiteX7" fmla="*/ 722212 w 1132169"/>
                <a:gd name="connsiteY7" fmla="*/ 823767 h 949090"/>
                <a:gd name="connsiteX8" fmla="*/ 586759 w 1132169"/>
                <a:gd name="connsiteY8" fmla="*/ 615214 h 949090"/>
                <a:gd name="connsiteX9" fmla="*/ 272651 w 1132169"/>
                <a:gd name="connsiteY9" fmla="*/ 534912 h 949090"/>
                <a:gd name="connsiteX10" fmla="*/ 42445 w 1132169"/>
                <a:gd name="connsiteY10" fmla="*/ 526353 h 949090"/>
                <a:gd name="connsiteX0" fmla="*/ 51362 w 1127041"/>
                <a:gd name="connsiteY0" fmla="*/ 393015 h 949090"/>
                <a:gd name="connsiteX1" fmla="*/ 41521 w 1127041"/>
                <a:gd name="connsiteY1" fmla="*/ 173742 h 949090"/>
                <a:gd name="connsiteX2" fmla="*/ 416965 w 1127041"/>
                <a:gd name="connsiteY2" fmla="*/ 97397 h 949090"/>
                <a:gd name="connsiteX3" fmla="*/ 762301 w 1127041"/>
                <a:gd name="connsiteY3" fmla="*/ 19687 h 949090"/>
                <a:gd name="connsiteX4" fmla="*/ 968659 w 1127041"/>
                <a:gd name="connsiteY4" fmla="*/ 442616 h 949090"/>
                <a:gd name="connsiteX5" fmla="*/ 1093789 w 1127041"/>
                <a:gd name="connsiteY5" fmla="*/ 844345 h 949090"/>
                <a:gd name="connsiteX6" fmla="*/ 898215 w 1127041"/>
                <a:gd name="connsiteY6" fmla="*/ 910185 h 949090"/>
                <a:gd name="connsiteX7" fmla="*/ 717084 w 1127041"/>
                <a:gd name="connsiteY7" fmla="*/ 823767 h 949090"/>
                <a:gd name="connsiteX8" fmla="*/ 581631 w 1127041"/>
                <a:gd name="connsiteY8" fmla="*/ 615214 h 949090"/>
                <a:gd name="connsiteX9" fmla="*/ 267523 w 1127041"/>
                <a:gd name="connsiteY9" fmla="*/ 534912 h 949090"/>
                <a:gd name="connsiteX10" fmla="*/ 51362 w 1127041"/>
                <a:gd name="connsiteY10" fmla="*/ 393015 h 9490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127041" h="949090">
                  <a:moveTo>
                    <a:pt x="51362" y="393015"/>
                  </a:moveTo>
                  <a:cubicBezTo>
                    <a:pt x="13695" y="332820"/>
                    <a:pt x="-37390" y="246668"/>
                    <a:pt x="41521" y="173742"/>
                  </a:cubicBezTo>
                  <a:cubicBezTo>
                    <a:pt x="120432" y="100816"/>
                    <a:pt x="296835" y="123073"/>
                    <a:pt x="416965" y="97397"/>
                  </a:cubicBezTo>
                  <a:cubicBezTo>
                    <a:pt x="537095" y="71721"/>
                    <a:pt x="699301" y="-46035"/>
                    <a:pt x="762301" y="19687"/>
                  </a:cubicBezTo>
                  <a:cubicBezTo>
                    <a:pt x="825301" y="85409"/>
                    <a:pt x="920968" y="349156"/>
                    <a:pt x="968659" y="442616"/>
                  </a:cubicBezTo>
                  <a:cubicBezTo>
                    <a:pt x="1016350" y="536076"/>
                    <a:pt x="1201760" y="659284"/>
                    <a:pt x="1093789" y="844345"/>
                  </a:cubicBezTo>
                  <a:cubicBezTo>
                    <a:pt x="985818" y="1029406"/>
                    <a:pt x="960999" y="913615"/>
                    <a:pt x="898215" y="910185"/>
                  </a:cubicBezTo>
                  <a:cubicBezTo>
                    <a:pt x="835431" y="906755"/>
                    <a:pt x="784410" y="873339"/>
                    <a:pt x="717084" y="823767"/>
                  </a:cubicBezTo>
                  <a:cubicBezTo>
                    <a:pt x="649758" y="774195"/>
                    <a:pt x="662759" y="625811"/>
                    <a:pt x="581631" y="615214"/>
                  </a:cubicBezTo>
                  <a:cubicBezTo>
                    <a:pt x="500503" y="604617"/>
                    <a:pt x="359466" y="637636"/>
                    <a:pt x="267523" y="534912"/>
                  </a:cubicBezTo>
                  <a:cubicBezTo>
                    <a:pt x="175580" y="432188"/>
                    <a:pt x="89029" y="453210"/>
                    <a:pt x="51362" y="393015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Oval 267">
              <a:extLst>
                <a:ext uri="{FF2B5EF4-FFF2-40B4-BE49-F238E27FC236}">
                  <a16:creationId xmlns:a16="http://schemas.microsoft.com/office/drawing/2014/main" id="{D37CB98B-C0AD-515D-922D-DD4E6BB7B403}"/>
                </a:ext>
              </a:extLst>
            </p:cNvPr>
            <p:cNvSpPr/>
            <p:nvPr/>
          </p:nvSpPr>
          <p:spPr>
            <a:xfrm>
              <a:off x="7570627" y="4066611"/>
              <a:ext cx="659568" cy="713353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59568" h="713353">
                  <a:moveTo>
                    <a:pt x="0" y="319240"/>
                  </a:moveTo>
                  <a:cubicBezTo>
                    <a:pt x="0" y="200383"/>
                    <a:pt x="167390" y="5140"/>
                    <a:pt x="277318" y="143"/>
                  </a:cubicBezTo>
                  <a:cubicBezTo>
                    <a:pt x="387246" y="-4854"/>
                    <a:pt x="659568" y="121306"/>
                    <a:pt x="659568" y="289260"/>
                  </a:cubicBezTo>
                  <a:cubicBezTo>
                    <a:pt x="659568" y="457214"/>
                    <a:pt x="387246" y="708291"/>
                    <a:pt x="277318" y="713288"/>
                  </a:cubicBezTo>
                  <a:cubicBezTo>
                    <a:pt x="167390" y="718285"/>
                    <a:pt x="0" y="438097"/>
                    <a:pt x="0" y="319240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Oval 267">
              <a:extLst>
                <a:ext uri="{FF2B5EF4-FFF2-40B4-BE49-F238E27FC236}">
                  <a16:creationId xmlns:a16="http://schemas.microsoft.com/office/drawing/2014/main" id="{7AAB91C3-CA1B-ABB3-33F8-DF890500C616}"/>
                </a:ext>
              </a:extLst>
            </p:cNvPr>
            <p:cNvSpPr/>
            <p:nvPr/>
          </p:nvSpPr>
          <p:spPr>
            <a:xfrm>
              <a:off x="7751530" y="2868031"/>
              <a:ext cx="675262" cy="983625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675262" h="983625">
                  <a:moveTo>
                    <a:pt x="1353" y="319182"/>
                  </a:moveTo>
                  <a:cubicBezTo>
                    <a:pt x="16343" y="187833"/>
                    <a:pt x="168743" y="5082"/>
                    <a:pt x="278671" y="85"/>
                  </a:cubicBezTo>
                  <a:cubicBezTo>
                    <a:pt x="388599" y="-4912"/>
                    <a:pt x="597414" y="212792"/>
                    <a:pt x="660921" y="289202"/>
                  </a:cubicBezTo>
                  <a:cubicBezTo>
                    <a:pt x="724428" y="365612"/>
                    <a:pt x="557482" y="367861"/>
                    <a:pt x="539792" y="443554"/>
                  </a:cubicBezTo>
                  <a:cubicBezTo>
                    <a:pt x="522102" y="519247"/>
                    <a:pt x="674703" y="728367"/>
                    <a:pt x="674703" y="818308"/>
                  </a:cubicBezTo>
                  <a:cubicBezTo>
                    <a:pt x="674703" y="908249"/>
                    <a:pt x="600801" y="975729"/>
                    <a:pt x="539792" y="983200"/>
                  </a:cubicBezTo>
                  <a:cubicBezTo>
                    <a:pt x="478783" y="990671"/>
                    <a:pt x="278470" y="898851"/>
                    <a:pt x="188730" y="788181"/>
                  </a:cubicBezTo>
                  <a:cubicBezTo>
                    <a:pt x="98990" y="677511"/>
                    <a:pt x="-13637" y="450531"/>
                    <a:pt x="1353" y="319182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Oval 267">
              <a:extLst>
                <a:ext uri="{FF2B5EF4-FFF2-40B4-BE49-F238E27FC236}">
                  <a16:creationId xmlns:a16="http://schemas.microsoft.com/office/drawing/2014/main" id="{D78D1588-7F6A-A467-8ABE-24C2AE8E4FE8}"/>
                </a:ext>
              </a:extLst>
            </p:cNvPr>
            <p:cNvSpPr/>
            <p:nvPr/>
          </p:nvSpPr>
          <p:spPr>
            <a:xfrm rot="16622697">
              <a:off x="6314777" y="1535326"/>
              <a:ext cx="564488" cy="1106491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  <a:gd name="connsiteX0" fmla="*/ 1353 w 674703"/>
                <a:gd name="connsiteY0" fmla="*/ 332766 h 997209"/>
                <a:gd name="connsiteX1" fmla="*/ 278671 w 674703"/>
                <a:gd name="connsiteY1" fmla="*/ 13669 h 997209"/>
                <a:gd name="connsiteX2" fmla="*/ 469697 w 674703"/>
                <a:gd name="connsiteY2" fmla="*/ 99855 h 997209"/>
                <a:gd name="connsiteX3" fmla="*/ 539792 w 674703"/>
                <a:gd name="connsiteY3" fmla="*/ 457138 h 997209"/>
                <a:gd name="connsiteX4" fmla="*/ 674703 w 674703"/>
                <a:gd name="connsiteY4" fmla="*/ 831892 h 997209"/>
                <a:gd name="connsiteX5" fmla="*/ 539792 w 674703"/>
                <a:gd name="connsiteY5" fmla="*/ 996784 h 997209"/>
                <a:gd name="connsiteX6" fmla="*/ 188730 w 674703"/>
                <a:gd name="connsiteY6" fmla="*/ 801765 h 997209"/>
                <a:gd name="connsiteX7" fmla="*/ 1353 w 674703"/>
                <a:gd name="connsiteY7" fmla="*/ 332766 h 997209"/>
                <a:gd name="connsiteX0" fmla="*/ 1130 w 674480"/>
                <a:gd name="connsiteY0" fmla="*/ 332766 h 1106491"/>
                <a:gd name="connsiteX1" fmla="*/ 278448 w 674480"/>
                <a:gd name="connsiteY1" fmla="*/ 13669 h 1106491"/>
                <a:gd name="connsiteX2" fmla="*/ 469474 w 674480"/>
                <a:gd name="connsiteY2" fmla="*/ 99855 h 1106491"/>
                <a:gd name="connsiteX3" fmla="*/ 539569 w 674480"/>
                <a:gd name="connsiteY3" fmla="*/ 457138 h 1106491"/>
                <a:gd name="connsiteX4" fmla="*/ 674480 w 674480"/>
                <a:gd name="connsiteY4" fmla="*/ 831892 h 1106491"/>
                <a:gd name="connsiteX5" fmla="*/ 386953 w 674480"/>
                <a:gd name="connsiteY5" fmla="*/ 1106270 h 1106491"/>
                <a:gd name="connsiteX6" fmla="*/ 188507 w 674480"/>
                <a:gd name="connsiteY6" fmla="*/ 801765 h 1106491"/>
                <a:gd name="connsiteX7" fmla="*/ 1130 w 674480"/>
                <a:gd name="connsiteY7" fmla="*/ 332766 h 1106491"/>
                <a:gd name="connsiteX0" fmla="*/ 1130 w 564488"/>
                <a:gd name="connsiteY0" fmla="*/ 332766 h 1106491"/>
                <a:gd name="connsiteX1" fmla="*/ 278448 w 564488"/>
                <a:gd name="connsiteY1" fmla="*/ 13669 h 1106491"/>
                <a:gd name="connsiteX2" fmla="*/ 469474 w 564488"/>
                <a:gd name="connsiteY2" fmla="*/ 99855 h 1106491"/>
                <a:gd name="connsiteX3" fmla="*/ 539569 w 564488"/>
                <a:gd name="connsiteY3" fmla="*/ 457138 h 1106491"/>
                <a:gd name="connsiteX4" fmla="*/ 564488 w 564488"/>
                <a:gd name="connsiteY4" fmla="*/ 1041840 h 1106491"/>
                <a:gd name="connsiteX5" fmla="*/ 386953 w 564488"/>
                <a:gd name="connsiteY5" fmla="*/ 1106270 h 1106491"/>
                <a:gd name="connsiteX6" fmla="*/ 188507 w 564488"/>
                <a:gd name="connsiteY6" fmla="*/ 801765 h 1106491"/>
                <a:gd name="connsiteX7" fmla="*/ 1130 w 564488"/>
                <a:gd name="connsiteY7" fmla="*/ 332766 h 11064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64488" h="1106491">
                  <a:moveTo>
                    <a:pt x="1130" y="332766"/>
                  </a:moveTo>
                  <a:cubicBezTo>
                    <a:pt x="16120" y="201417"/>
                    <a:pt x="200391" y="52488"/>
                    <a:pt x="278448" y="13669"/>
                  </a:cubicBezTo>
                  <a:cubicBezTo>
                    <a:pt x="356505" y="-25150"/>
                    <a:pt x="405967" y="23445"/>
                    <a:pt x="469474" y="99855"/>
                  </a:cubicBezTo>
                  <a:cubicBezTo>
                    <a:pt x="532981" y="176265"/>
                    <a:pt x="557259" y="381445"/>
                    <a:pt x="539569" y="457138"/>
                  </a:cubicBezTo>
                  <a:cubicBezTo>
                    <a:pt x="521879" y="532831"/>
                    <a:pt x="564488" y="951899"/>
                    <a:pt x="564488" y="1041840"/>
                  </a:cubicBezTo>
                  <a:cubicBezTo>
                    <a:pt x="564488" y="1131781"/>
                    <a:pt x="447962" y="1098799"/>
                    <a:pt x="386953" y="1106270"/>
                  </a:cubicBezTo>
                  <a:cubicBezTo>
                    <a:pt x="325944" y="1113741"/>
                    <a:pt x="252811" y="930682"/>
                    <a:pt x="188507" y="801765"/>
                  </a:cubicBezTo>
                  <a:cubicBezTo>
                    <a:pt x="124203" y="672848"/>
                    <a:pt x="-13860" y="464115"/>
                    <a:pt x="1130" y="33276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Oval 267">
              <a:extLst>
                <a:ext uri="{FF2B5EF4-FFF2-40B4-BE49-F238E27FC236}">
                  <a16:creationId xmlns:a16="http://schemas.microsoft.com/office/drawing/2014/main" id="{8D6BCE09-8CFB-878F-F9DA-39327236A447}"/>
                </a:ext>
              </a:extLst>
            </p:cNvPr>
            <p:cNvSpPr/>
            <p:nvPr/>
          </p:nvSpPr>
          <p:spPr>
            <a:xfrm rot="16622697">
              <a:off x="7838500" y="1799921"/>
              <a:ext cx="550858" cy="702688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  <a:gd name="connsiteX0" fmla="*/ 1353 w 674703"/>
                <a:gd name="connsiteY0" fmla="*/ 332766 h 997209"/>
                <a:gd name="connsiteX1" fmla="*/ 278671 w 674703"/>
                <a:gd name="connsiteY1" fmla="*/ 13669 h 997209"/>
                <a:gd name="connsiteX2" fmla="*/ 469697 w 674703"/>
                <a:gd name="connsiteY2" fmla="*/ 99855 h 997209"/>
                <a:gd name="connsiteX3" fmla="*/ 539792 w 674703"/>
                <a:gd name="connsiteY3" fmla="*/ 457138 h 997209"/>
                <a:gd name="connsiteX4" fmla="*/ 674703 w 674703"/>
                <a:gd name="connsiteY4" fmla="*/ 831892 h 997209"/>
                <a:gd name="connsiteX5" fmla="*/ 539792 w 674703"/>
                <a:gd name="connsiteY5" fmla="*/ 996784 h 997209"/>
                <a:gd name="connsiteX6" fmla="*/ 188730 w 674703"/>
                <a:gd name="connsiteY6" fmla="*/ 801765 h 997209"/>
                <a:gd name="connsiteX7" fmla="*/ 1353 w 674703"/>
                <a:gd name="connsiteY7" fmla="*/ 332766 h 997209"/>
                <a:gd name="connsiteX0" fmla="*/ 1130 w 674480"/>
                <a:gd name="connsiteY0" fmla="*/ 332766 h 1106491"/>
                <a:gd name="connsiteX1" fmla="*/ 278448 w 674480"/>
                <a:gd name="connsiteY1" fmla="*/ 13669 h 1106491"/>
                <a:gd name="connsiteX2" fmla="*/ 469474 w 674480"/>
                <a:gd name="connsiteY2" fmla="*/ 99855 h 1106491"/>
                <a:gd name="connsiteX3" fmla="*/ 539569 w 674480"/>
                <a:gd name="connsiteY3" fmla="*/ 457138 h 1106491"/>
                <a:gd name="connsiteX4" fmla="*/ 674480 w 674480"/>
                <a:gd name="connsiteY4" fmla="*/ 831892 h 1106491"/>
                <a:gd name="connsiteX5" fmla="*/ 386953 w 674480"/>
                <a:gd name="connsiteY5" fmla="*/ 1106270 h 1106491"/>
                <a:gd name="connsiteX6" fmla="*/ 188507 w 674480"/>
                <a:gd name="connsiteY6" fmla="*/ 801765 h 1106491"/>
                <a:gd name="connsiteX7" fmla="*/ 1130 w 674480"/>
                <a:gd name="connsiteY7" fmla="*/ 332766 h 1106491"/>
                <a:gd name="connsiteX0" fmla="*/ 1130 w 564488"/>
                <a:gd name="connsiteY0" fmla="*/ 332766 h 1106491"/>
                <a:gd name="connsiteX1" fmla="*/ 278448 w 564488"/>
                <a:gd name="connsiteY1" fmla="*/ 13669 h 1106491"/>
                <a:gd name="connsiteX2" fmla="*/ 469474 w 564488"/>
                <a:gd name="connsiteY2" fmla="*/ 99855 h 1106491"/>
                <a:gd name="connsiteX3" fmla="*/ 539569 w 564488"/>
                <a:gd name="connsiteY3" fmla="*/ 457138 h 1106491"/>
                <a:gd name="connsiteX4" fmla="*/ 564488 w 564488"/>
                <a:gd name="connsiteY4" fmla="*/ 1041840 h 1106491"/>
                <a:gd name="connsiteX5" fmla="*/ 386953 w 564488"/>
                <a:gd name="connsiteY5" fmla="*/ 1106270 h 1106491"/>
                <a:gd name="connsiteX6" fmla="*/ 188507 w 564488"/>
                <a:gd name="connsiteY6" fmla="*/ 801765 h 1106491"/>
                <a:gd name="connsiteX7" fmla="*/ 1130 w 564488"/>
                <a:gd name="connsiteY7" fmla="*/ 332766 h 1106491"/>
                <a:gd name="connsiteX0" fmla="*/ 1130 w 546440"/>
                <a:gd name="connsiteY0" fmla="*/ 332766 h 1106491"/>
                <a:gd name="connsiteX1" fmla="*/ 278448 w 546440"/>
                <a:gd name="connsiteY1" fmla="*/ 13669 h 1106491"/>
                <a:gd name="connsiteX2" fmla="*/ 469474 w 546440"/>
                <a:gd name="connsiteY2" fmla="*/ 99855 h 1106491"/>
                <a:gd name="connsiteX3" fmla="*/ 539569 w 546440"/>
                <a:gd name="connsiteY3" fmla="*/ 457138 h 1106491"/>
                <a:gd name="connsiteX4" fmla="*/ 546440 w 546440"/>
                <a:gd name="connsiteY4" fmla="*/ 651362 h 1106491"/>
                <a:gd name="connsiteX5" fmla="*/ 386953 w 546440"/>
                <a:gd name="connsiteY5" fmla="*/ 1106270 h 1106491"/>
                <a:gd name="connsiteX6" fmla="*/ 188507 w 546440"/>
                <a:gd name="connsiteY6" fmla="*/ 801765 h 1106491"/>
                <a:gd name="connsiteX7" fmla="*/ 1130 w 546440"/>
                <a:gd name="connsiteY7" fmla="*/ 332766 h 1106491"/>
                <a:gd name="connsiteX0" fmla="*/ 1054 w 546364"/>
                <a:gd name="connsiteY0" fmla="*/ 332766 h 814951"/>
                <a:gd name="connsiteX1" fmla="*/ 278372 w 546364"/>
                <a:gd name="connsiteY1" fmla="*/ 13669 h 814951"/>
                <a:gd name="connsiteX2" fmla="*/ 469398 w 546364"/>
                <a:gd name="connsiteY2" fmla="*/ 99855 h 814951"/>
                <a:gd name="connsiteX3" fmla="*/ 539493 w 546364"/>
                <a:gd name="connsiteY3" fmla="*/ 457138 h 814951"/>
                <a:gd name="connsiteX4" fmla="*/ 546364 w 546364"/>
                <a:gd name="connsiteY4" fmla="*/ 651362 h 814951"/>
                <a:gd name="connsiteX5" fmla="*/ 320522 w 546364"/>
                <a:gd name="connsiteY5" fmla="*/ 691553 h 814951"/>
                <a:gd name="connsiteX6" fmla="*/ 188431 w 546364"/>
                <a:gd name="connsiteY6" fmla="*/ 801765 h 814951"/>
                <a:gd name="connsiteX7" fmla="*/ 1054 w 546364"/>
                <a:gd name="connsiteY7" fmla="*/ 332766 h 814951"/>
                <a:gd name="connsiteX0" fmla="*/ 5548 w 550858"/>
                <a:gd name="connsiteY0" fmla="*/ 332766 h 702688"/>
                <a:gd name="connsiteX1" fmla="*/ 282866 w 550858"/>
                <a:gd name="connsiteY1" fmla="*/ 13669 h 702688"/>
                <a:gd name="connsiteX2" fmla="*/ 473892 w 550858"/>
                <a:gd name="connsiteY2" fmla="*/ 99855 h 702688"/>
                <a:gd name="connsiteX3" fmla="*/ 543987 w 550858"/>
                <a:gd name="connsiteY3" fmla="*/ 457138 h 702688"/>
                <a:gd name="connsiteX4" fmla="*/ 550858 w 550858"/>
                <a:gd name="connsiteY4" fmla="*/ 651362 h 702688"/>
                <a:gd name="connsiteX5" fmla="*/ 325016 w 550858"/>
                <a:gd name="connsiteY5" fmla="*/ 691553 h 702688"/>
                <a:gd name="connsiteX6" fmla="*/ 115031 w 550858"/>
                <a:gd name="connsiteY6" fmla="*/ 660349 h 702688"/>
                <a:gd name="connsiteX7" fmla="*/ 5548 w 550858"/>
                <a:gd name="connsiteY7" fmla="*/ 332766 h 7026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50858" h="702688">
                  <a:moveTo>
                    <a:pt x="5548" y="332766"/>
                  </a:moveTo>
                  <a:cubicBezTo>
                    <a:pt x="33521" y="224986"/>
                    <a:pt x="204809" y="52488"/>
                    <a:pt x="282866" y="13669"/>
                  </a:cubicBezTo>
                  <a:cubicBezTo>
                    <a:pt x="360923" y="-25150"/>
                    <a:pt x="410385" y="23445"/>
                    <a:pt x="473892" y="99855"/>
                  </a:cubicBezTo>
                  <a:cubicBezTo>
                    <a:pt x="537399" y="176265"/>
                    <a:pt x="561677" y="381445"/>
                    <a:pt x="543987" y="457138"/>
                  </a:cubicBezTo>
                  <a:cubicBezTo>
                    <a:pt x="526297" y="532831"/>
                    <a:pt x="550858" y="561421"/>
                    <a:pt x="550858" y="651362"/>
                  </a:cubicBezTo>
                  <a:cubicBezTo>
                    <a:pt x="550858" y="741303"/>
                    <a:pt x="386025" y="684082"/>
                    <a:pt x="325016" y="691553"/>
                  </a:cubicBezTo>
                  <a:cubicBezTo>
                    <a:pt x="264007" y="699024"/>
                    <a:pt x="168276" y="720147"/>
                    <a:pt x="115031" y="660349"/>
                  </a:cubicBezTo>
                  <a:cubicBezTo>
                    <a:pt x="61786" y="600551"/>
                    <a:pt x="-22425" y="440546"/>
                    <a:pt x="5548" y="33276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3" name="Group 242">
            <a:extLst>
              <a:ext uri="{FF2B5EF4-FFF2-40B4-BE49-F238E27FC236}">
                <a16:creationId xmlns:a16="http://schemas.microsoft.com/office/drawing/2014/main" id="{B69306C7-5C9E-778D-393C-F21983B0B07F}"/>
              </a:ext>
            </a:extLst>
          </p:cNvPr>
          <p:cNvGrpSpPr/>
          <p:nvPr/>
        </p:nvGrpSpPr>
        <p:grpSpPr>
          <a:xfrm>
            <a:off x="495916" y="6831283"/>
            <a:ext cx="829887" cy="840316"/>
            <a:chOff x="5462585" y="1806328"/>
            <a:chExt cx="3002688" cy="3419491"/>
          </a:xfrm>
        </p:grpSpPr>
        <p:sp>
          <p:nvSpPr>
            <p:cNvPr id="244" name="Oval 262">
              <a:extLst>
                <a:ext uri="{FF2B5EF4-FFF2-40B4-BE49-F238E27FC236}">
                  <a16:creationId xmlns:a16="http://schemas.microsoft.com/office/drawing/2014/main" id="{C55C6769-24E6-AE69-0CD5-CF50B4A84C21}"/>
                </a:ext>
              </a:extLst>
            </p:cNvPr>
            <p:cNvSpPr/>
            <p:nvPr/>
          </p:nvSpPr>
          <p:spPr>
            <a:xfrm>
              <a:off x="5462585" y="2268018"/>
              <a:ext cx="1256007" cy="1348259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256007" h="1348259">
                  <a:moveTo>
                    <a:pt x="58531" y="442213"/>
                  </a:moveTo>
                  <a:cubicBezTo>
                    <a:pt x="138478" y="342279"/>
                    <a:pt x="471320" y="666788"/>
                    <a:pt x="550231" y="593862"/>
                  </a:cubicBezTo>
                  <a:cubicBezTo>
                    <a:pt x="629142" y="520936"/>
                    <a:pt x="464539" y="47128"/>
                    <a:pt x="531995" y="4656"/>
                  </a:cubicBezTo>
                  <a:cubicBezTo>
                    <a:pt x="599451" y="-37816"/>
                    <a:pt x="831084" y="221132"/>
                    <a:pt x="954965" y="339029"/>
                  </a:cubicBezTo>
                  <a:cubicBezTo>
                    <a:pt x="1078846" y="456926"/>
                    <a:pt x="1338281" y="811788"/>
                    <a:pt x="1230310" y="996849"/>
                  </a:cubicBezTo>
                  <a:cubicBezTo>
                    <a:pt x="1122339" y="1181910"/>
                    <a:pt x="780251" y="1154299"/>
                    <a:pt x="621934" y="1209554"/>
                  </a:cubicBezTo>
                  <a:cubicBezTo>
                    <a:pt x="463617" y="1264809"/>
                    <a:pt x="432267" y="1398517"/>
                    <a:pt x="280408" y="1328380"/>
                  </a:cubicBezTo>
                  <a:cubicBezTo>
                    <a:pt x="128549" y="1258243"/>
                    <a:pt x="162489" y="1296192"/>
                    <a:pt x="70546" y="1193468"/>
                  </a:cubicBezTo>
                  <a:cubicBezTo>
                    <a:pt x="-21397" y="1090744"/>
                    <a:pt x="-21416" y="542147"/>
                    <a:pt x="58531" y="442213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Oval 262">
              <a:extLst>
                <a:ext uri="{FF2B5EF4-FFF2-40B4-BE49-F238E27FC236}">
                  <a16:creationId xmlns:a16="http://schemas.microsoft.com/office/drawing/2014/main" id="{D7F30122-216B-1756-C454-623E8E493B13}"/>
                </a:ext>
              </a:extLst>
            </p:cNvPr>
            <p:cNvSpPr/>
            <p:nvPr/>
          </p:nvSpPr>
          <p:spPr>
            <a:xfrm>
              <a:off x="6703739" y="1981755"/>
              <a:ext cx="1151810" cy="1131927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151810" h="1131927">
                  <a:moveTo>
                    <a:pt x="12404" y="481516"/>
                  </a:moveTo>
                  <a:cubicBezTo>
                    <a:pt x="57374" y="394074"/>
                    <a:pt x="335252" y="331336"/>
                    <a:pt x="414163" y="258410"/>
                  </a:cubicBezTo>
                  <a:cubicBezTo>
                    <a:pt x="493074" y="185484"/>
                    <a:pt x="577610" y="45270"/>
                    <a:pt x="665750" y="13978"/>
                  </a:cubicBezTo>
                  <a:cubicBezTo>
                    <a:pt x="753890" y="-17314"/>
                    <a:pt x="880005" y="4934"/>
                    <a:pt x="943005" y="70656"/>
                  </a:cubicBezTo>
                  <a:cubicBezTo>
                    <a:pt x="1006005" y="136378"/>
                    <a:pt x="996059" y="314852"/>
                    <a:pt x="1043750" y="408312"/>
                  </a:cubicBezTo>
                  <a:cubicBezTo>
                    <a:pt x="1091441" y="501772"/>
                    <a:pt x="1217203" y="551288"/>
                    <a:pt x="1109232" y="736349"/>
                  </a:cubicBezTo>
                  <a:cubicBezTo>
                    <a:pt x="1001261" y="921410"/>
                    <a:pt x="909010" y="916283"/>
                    <a:pt x="800660" y="979033"/>
                  </a:cubicBezTo>
                  <a:cubicBezTo>
                    <a:pt x="692310" y="1041783"/>
                    <a:pt x="610993" y="1182987"/>
                    <a:pt x="459134" y="1112850"/>
                  </a:cubicBezTo>
                  <a:cubicBezTo>
                    <a:pt x="307275" y="1042713"/>
                    <a:pt x="236284" y="885789"/>
                    <a:pt x="144341" y="783065"/>
                  </a:cubicBezTo>
                  <a:cubicBezTo>
                    <a:pt x="52398" y="680341"/>
                    <a:pt x="-32566" y="568958"/>
                    <a:pt x="12404" y="48151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Oval 262">
              <a:extLst>
                <a:ext uri="{FF2B5EF4-FFF2-40B4-BE49-F238E27FC236}">
                  <a16:creationId xmlns:a16="http://schemas.microsoft.com/office/drawing/2014/main" id="{1DC0DC2A-57B5-0AD9-8072-E6144E09D26C}"/>
                </a:ext>
              </a:extLst>
            </p:cNvPr>
            <p:cNvSpPr/>
            <p:nvPr/>
          </p:nvSpPr>
          <p:spPr>
            <a:xfrm rot="19645332">
              <a:off x="6760723" y="3188178"/>
              <a:ext cx="992103" cy="1015226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7647 w 992103"/>
                <a:gd name="connsiteY0" fmla="*/ 522134 h 1015226"/>
                <a:gd name="connsiteX1" fmla="*/ 205548 w 992103"/>
                <a:gd name="connsiteY1" fmla="*/ 120409 h 1015226"/>
                <a:gd name="connsiteX2" fmla="*/ 484497 w 992103"/>
                <a:gd name="connsiteY2" fmla="*/ 196 h 1015226"/>
                <a:gd name="connsiteX3" fmla="*/ 858244 w 992103"/>
                <a:gd name="connsiteY3" fmla="*/ 100741 h 1015226"/>
                <a:gd name="connsiteX4" fmla="*/ 958989 w 992103"/>
                <a:gd name="connsiteY4" fmla="*/ 438397 h 1015226"/>
                <a:gd name="connsiteX5" fmla="*/ 905863 w 992103"/>
                <a:gd name="connsiteY5" fmla="*/ 868536 h 1015226"/>
                <a:gd name="connsiteX6" fmla="*/ 715899 w 992103"/>
                <a:gd name="connsiteY6" fmla="*/ 1009118 h 1015226"/>
                <a:gd name="connsiteX7" fmla="*/ 456514 w 992103"/>
                <a:gd name="connsiteY7" fmla="*/ 961643 h 1015226"/>
                <a:gd name="connsiteX8" fmla="*/ 311942 w 992103"/>
                <a:gd name="connsiteY8" fmla="*/ 711683 h 1015226"/>
                <a:gd name="connsiteX9" fmla="*/ 59580 w 992103"/>
                <a:gd name="connsiteY9" fmla="*/ 813150 h 1015226"/>
                <a:gd name="connsiteX10" fmla="*/ 27647 w 992103"/>
                <a:gd name="connsiteY10" fmla="*/ 522134 h 10152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92103" h="1015226">
                  <a:moveTo>
                    <a:pt x="27647" y="522134"/>
                  </a:moveTo>
                  <a:cubicBezTo>
                    <a:pt x="51975" y="406677"/>
                    <a:pt x="126637" y="193335"/>
                    <a:pt x="205548" y="120409"/>
                  </a:cubicBezTo>
                  <a:cubicBezTo>
                    <a:pt x="284459" y="47483"/>
                    <a:pt x="375714" y="3474"/>
                    <a:pt x="484497" y="196"/>
                  </a:cubicBezTo>
                  <a:cubicBezTo>
                    <a:pt x="593280" y="-3082"/>
                    <a:pt x="795244" y="35019"/>
                    <a:pt x="858244" y="100741"/>
                  </a:cubicBezTo>
                  <a:cubicBezTo>
                    <a:pt x="921244" y="166463"/>
                    <a:pt x="911298" y="344937"/>
                    <a:pt x="958989" y="438397"/>
                  </a:cubicBezTo>
                  <a:cubicBezTo>
                    <a:pt x="1006680" y="531857"/>
                    <a:pt x="1013834" y="683475"/>
                    <a:pt x="905863" y="868536"/>
                  </a:cubicBezTo>
                  <a:cubicBezTo>
                    <a:pt x="797892" y="1053597"/>
                    <a:pt x="790791" y="993600"/>
                    <a:pt x="715899" y="1009118"/>
                  </a:cubicBezTo>
                  <a:cubicBezTo>
                    <a:pt x="641008" y="1024636"/>
                    <a:pt x="523840" y="1011215"/>
                    <a:pt x="456514" y="961643"/>
                  </a:cubicBezTo>
                  <a:cubicBezTo>
                    <a:pt x="389188" y="912071"/>
                    <a:pt x="393070" y="722280"/>
                    <a:pt x="311942" y="711683"/>
                  </a:cubicBezTo>
                  <a:cubicBezTo>
                    <a:pt x="230814" y="701086"/>
                    <a:pt x="151523" y="915874"/>
                    <a:pt x="59580" y="813150"/>
                  </a:cubicBezTo>
                  <a:cubicBezTo>
                    <a:pt x="-32363" y="710426"/>
                    <a:pt x="3319" y="637591"/>
                    <a:pt x="27647" y="522134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Oval 262">
              <a:extLst>
                <a:ext uri="{FF2B5EF4-FFF2-40B4-BE49-F238E27FC236}">
                  <a16:creationId xmlns:a16="http://schemas.microsoft.com/office/drawing/2014/main" id="{4D6893C0-FF04-25C6-B27C-5CB0D8CD333E}"/>
                </a:ext>
              </a:extLst>
            </p:cNvPr>
            <p:cNvSpPr/>
            <p:nvPr/>
          </p:nvSpPr>
          <p:spPr>
            <a:xfrm rot="19645332">
              <a:off x="5763553" y="3518467"/>
              <a:ext cx="988441" cy="1058348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308280 w 988441"/>
                <a:gd name="connsiteY8" fmla="*/ 714050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229664 w 988441"/>
                <a:gd name="connsiteY8" fmla="*/ 948443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58348"/>
                <a:gd name="connsiteX1" fmla="*/ 140825 w 988441"/>
                <a:gd name="connsiteY1" fmla="*/ 190495 h 1058348"/>
                <a:gd name="connsiteX2" fmla="*/ 480835 w 988441"/>
                <a:gd name="connsiteY2" fmla="*/ 2563 h 1058348"/>
                <a:gd name="connsiteX3" fmla="*/ 854582 w 988441"/>
                <a:gd name="connsiteY3" fmla="*/ 103108 h 1058348"/>
                <a:gd name="connsiteX4" fmla="*/ 955327 w 988441"/>
                <a:gd name="connsiteY4" fmla="*/ 440764 h 1058348"/>
                <a:gd name="connsiteX5" fmla="*/ 902201 w 988441"/>
                <a:gd name="connsiteY5" fmla="*/ 870903 h 1058348"/>
                <a:gd name="connsiteX6" fmla="*/ 712237 w 988441"/>
                <a:gd name="connsiteY6" fmla="*/ 1011485 h 1058348"/>
                <a:gd name="connsiteX7" fmla="*/ 566538 w 988441"/>
                <a:gd name="connsiteY7" fmla="*/ 1036652 h 1058348"/>
                <a:gd name="connsiteX8" fmla="*/ 229664 w 988441"/>
                <a:gd name="connsiteY8" fmla="*/ 948443 h 1058348"/>
                <a:gd name="connsiteX9" fmla="*/ 55918 w 988441"/>
                <a:gd name="connsiteY9" fmla="*/ 815517 h 1058348"/>
                <a:gd name="connsiteX10" fmla="*/ 23985 w 988441"/>
                <a:gd name="connsiteY10" fmla="*/ 524501 h 10583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88441" h="1058348">
                  <a:moveTo>
                    <a:pt x="23985" y="524501"/>
                  </a:moveTo>
                  <a:cubicBezTo>
                    <a:pt x="38136" y="420331"/>
                    <a:pt x="61914" y="263421"/>
                    <a:pt x="140825" y="190495"/>
                  </a:cubicBezTo>
                  <a:cubicBezTo>
                    <a:pt x="219736" y="117569"/>
                    <a:pt x="361876" y="17127"/>
                    <a:pt x="480835" y="2563"/>
                  </a:cubicBezTo>
                  <a:cubicBezTo>
                    <a:pt x="599794" y="-12001"/>
                    <a:pt x="791582" y="37386"/>
                    <a:pt x="854582" y="103108"/>
                  </a:cubicBezTo>
                  <a:cubicBezTo>
                    <a:pt x="917582" y="168830"/>
                    <a:pt x="907636" y="347304"/>
                    <a:pt x="955327" y="440764"/>
                  </a:cubicBezTo>
                  <a:cubicBezTo>
                    <a:pt x="1003018" y="534224"/>
                    <a:pt x="1010172" y="685842"/>
                    <a:pt x="902201" y="870903"/>
                  </a:cubicBezTo>
                  <a:cubicBezTo>
                    <a:pt x="794230" y="1055964"/>
                    <a:pt x="768181" y="983860"/>
                    <a:pt x="712237" y="1011485"/>
                  </a:cubicBezTo>
                  <a:cubicBezTo>
                    <a:pt x="656293" y="1039110"/>
                    <a:pt x="633864" y="1086224"/>
                    <a:pt x="566538" y="1036652"/>
                  </a:cubicBezTo>
                  <a:cubicBezTo>
                    <a:pt x="499212" y="987080"/>
                    <a:pt x="310792" y="959040"/>
                    <a:pt x="229664" y="948443"/>
                  </a:cubicBezTo>
                  <a:cubicBezTo>
                    <a:pt x="148536" y="937846"/>
                    <a:pt x="147861" y="918241"/>
                    <a:pt x="55918" y="815517"/>
                  </a:cubicBezTo>
                  <a:cubicBezTo>
                    <a:pt x="-36025" y="712793"/>
                    <a:pt x="9834" y="628671"/>
                    <a:pt x="23985" y="524501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Oval 262">
              <a:extLst>
                <a:ext uri="{FF2B5EF4-FFF2-40B4-BE49-F238E27FC236}">
                  <a16:creationId xmlns:a16="http://schemas.microsoft.com/office/drawing/2014/main" id="{EAD86BF6-11E5-2DF1-8CD5-77032D36AB53}"/>
                </a:ext>
              </a:extLst>
            </p:cNvPr>
            <p:cNvSpPr/>
            <p:nvPr/>
          </p:nvSpPr>
          <p:spPr>
            <a:xfrm rot="19645332">
              <a:off x="6422111" y="4276729"/>
              <a:ext cx="1127041" cy="949090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308280 w 988441"/>
                <a:gd name="connsiteY8" fmla="*/ 714050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229664 w 988441"/>
                <a:gd name="connsiteY8" fmla="*/ 948443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58348"/>
                <a:gd name="connsiteX1" fmla="*/ 140825 w 988441"/>
                <a:gd name="connsiteY1" fmla="*/ 190495 h 1058348"/>
                <a:gd name="connsiteX2" fmla="*/ 480835 w 988441"/>
                <a:gd name="connsiteY2" fmla="*/ 2563 h 1058348"/>
                <a:gd name="connsiteX3" fmla="*/ 854582 w 988441"/>
                <a:gd name="connsiteY3" fmla="*/ 103108 h 1058348"/>
                <a:gd name="connsiteX4" fmla="*/ 955327 w 988441"/>
                <a:gd name="connsiteY4" fmla="*/ 440764 h 1058348"/>
                <a:gd name="connsiteX5" fmla="*/ 902201 w 988441"/>
                <a:gd name="connsiteY5" fmla="*/ 870903 h 1058348"/>
                <a:gd name="connsiteX6" fmla="*/ 712237 w 988441"/>
                <a:gd name="connsiteY6" fmla="*/ 1011485 h 1058348"/>
                <a:gd name="connsiteX7" fmla="*/ 566538 w 988441"/>
                <a:gd name="connsiteY7" fmla="*/ 1036652 h 1058348"/>
                <a:gd name="connsiteX8" fmla="*/ 229664 w 988441"/>
                <a:gd name="connsiteY8" fmla="*/ 948443 h 1058348"/>
                <a:gd name="connsiteX9" fmla="*/ 55918 w 988441"/>
                <a:gd name="connsiteY9" fmla="*/ 815517 h 1058348"/>
                <a:gd name="connsiteX10" fmla="*/ 23985 w 988441"/>
                <a:gd name="connsiteY10" fmla="*/ 524501 h 1058348"/>
                <a:gd name="connsiteX0" fmla="*/ 23985 w 1113709"/>
                <a:gd name="connsiteY0" fmla="*/ 524501 h 1059352"/>
                <a:gd name="connsiteX1" fmla="*/ 140825 w 1113709"/>
                <a:gd name="connsiteY1" fmla="*/ 190495 h 1059352"/>
                <a:gd name="connsiteX2" fmla="*/ 480835 w 1113709"/>
                <a:gd name="connsiteY2" fmla="*/ 2563 h 1059352"/>
                <a:gd name="connsiteX3" fmla="*/ 854582 w 1113709"/>
                <a:gd name="connsiteY3" fmla="*/ 103108 h 1059352"/>
                <a:gd name="connsiteX4" fmla="*/ 955327 w 1113709"/>
                <a:gd name="connsiteY4" fmla="*/ 440764 h 1059352"/>
                <a:gd name="connsiteX5" fmla="*/ 1080457 w 1113709"/>
                <a:gd name="connsiteY5" fmla="*/ 842493 h 1059352"/>
                <a:gd name="connsiteX6" fmla="*/ 712237 w 1113709"/>
                <a:gd name="connsiteY6" fmla="*/ 1011485 h 1059352"/>
                <a:gd name="connsiteX7" fmla="*/ 566538 w 1113709"/>
                <a:gd name="connsiteY7" fmla="*/ 1036652 h 1059352"/>
                <a:gd name="connsiteX8" fmla="*/ 229664 w 1113709"/>
                <a:gd name="connsiteY8" fmla="*/ 948443 h 1059352"/>
                <a:gd name="connsiteX9" fmla="*/ 55918 w 1113709"/>
                <a:gd name="connsiteY9" fmla="*/ 815517 h 1059352"/>
                <a:gd name="connsiteX10" fmla="*/ 23985 w 1113709"/>
                <a:gd name="connsiteY10" fmla="*/ 524501 h 1059352"/>
                <a:gd name="connsiteX0" fmla="*/ 23985 w 1113709"/>
                <a:gd name="connsiteY0" fmla="*/ 456644 h 991495"/>
                <a:gd name="connsiteX1" fmla="*/ 140825 w 1113709"/>
                <a:gd name="connsiteY1" fmla="*/ 122638 h 991495"/>
                <a:gd name="connsiteX2" fmla="*/ 403633 w 1113709"/>
                <a:gd name="connsiteY2" fmla="*/ 27688 h 991495"/>
                <a:gd name="connsiteX3" fmla="*/ 854582 w 1113709"/>
                <a:gd name="connsiteY3" fmla="*/ 35251 h 991495"/>
                <a:gd name="connsiteX4" fmla="*/ 955327 w 1113709"/>
                <a:gd name="connsiteY4" fmla="*/ 372907 h 991495"/>
                <a:gd name="connsiteX5" fmla="*/ 1080457 w 1113709"/>
                <a:gd name="connsiteY5" fmla="*/ 774636 h 991495"/>
                <a:gd name="connsiteX6" fmla="*/ 712237 w 1113709"/>
                <a:gd name="connsiteY6" fmla="*/ 943628 h 991495"/>
                <a:gd name="connsiteX7" fmla="*/ 566538 w 1113709"/>
                <a:gd name="connsiteY7" fmla="*/ 968795 h 991495"/>
                <a:gd name="connsiteX8" fmla="*/ 229664 w 1113709"/>
                <a:gd name="connsiteY8" fmla="*/ 880586 h 991495"/>
                <a:gd name="connsiteX9" fmla="*/ 55918 w 1113709"/>
                <a:gd name="connsiteY9" fmla="*/ 747660 h 991495"/>
                <a:gd name="connsiteX10" fmla="*/ 23985 w 1113709"/>
                <a:gd name="connsiteY10" fmla="*/ 456644 h 991495"/>
                <a:gd name="connsiteX0" fmla="*/ 23985 w 1113709"/>
                <a:gd name="connsiteY0" fmla="*/ 526690 h 1061541"/>
                <a:gd name="connsiteX1" fmla="*/ 140825 w 1113709"/>
                <a:gd name="connsiteY1" fmla="*/ 192684 h 1061541"/>
                <a:gd name="connsiteX2" fmla="*/ 403633 w 1113709"/>
                <a:gd name="connsiteY2" fmla="*/ 97734 h 1061541"/>
                <a:gd name="connsiteX3" fmla="*/ 748969 w 1113709"/>
                <a:gd name="connsiteY3" fmla="*/ 20024 h 1061541"/>
                <a:gd name="connsiteX4" fmla="*/ 955327 w 1113709"/>
                <a:gd name="connsiteY4" fmla="*/ 442953 h 1061541"/>
                <a:gd name="connsiteX5" fmla="*/ 1080457 w 1113709"/>
                <a:gd name="connsiteY5" fmla="*/ 844682 h 1061541"/>
                <a:gd name="connsiteX6" fmla="*/ 712237 w 1113709"/>
                <a:gd name="connsiteY6" fmla="*/ 1013674 h 1061541"/>
                <a:gd name="connsiteX7" fmla="*/ 566538 w 1113709"/>
                <a:gd name="connsiteY7" fmla="*/ 1038841 h 1061541"/>
                <a:gd name="connsiteX8" fmla="*/ 229664 w 1113709"/>
                <a:gd name="connsiteY8" fmla="*/ 950632 h 1061541"/>
                <a:gd name="connsiteX9" fmla="*/ 55918 w 1113709"/>
                <a:gd name="connsiteY9" fmla="*/ 817706 h 1061541"/>
                <a:gd name="connsiteX10" fmla="*/ 23985 w 1113709"/>
                <a:gd name="connsiteY10" fmla="*/ 526690 h 1061541"/>
                <a:gd name="connsiteX0" fmla="*/ 33099 w 1122823"/>
                <a:gd name="connsiteY0" fmla="*/ 526353 h 1061204"/>
                <a:gd name="connsiteX1" fmla="*/ 37303 w 1122823"/>
                <a:gd name="connsiteY1" fmla="*/ 173742 h 1061204"/>
                <a:gd name="connsiteX2" fmla="*/ 412747 w 1122823"/>
                <a:gd name="connsiteY2" fmla="*/ 97397 h 1061204"/>
                <a:gd name="connsiteX3" fmla="*/ 758083 w 1122823"/>
                <a:gd name="connsiteY3" fmla="*/ 19687 h 1061204"/>
                <a:gd name="connsiteX4" fmla="*/ 964441 w 1122823"/>
                <a:gd name="connsiteY4" fmla="*/ 442616 h 1061204"/>
                <a:gd name="connsiteX5" fmla="*/ 1089571 w 1122823"/>
                <a:gd name="connsiteY5" fmla="*/ 844345 h 1061204"/>
                <a:gd name="connsiteX6" fmla="*/ 721351 w 1122823"/>
                <a:gd name="connsiteY6" fmla="*/ 1013337 h 1061204"/>
                <a:gd name="connsiteX7" fmla="*/ 575652 w 1122823"/>
                <a:gd name="connsiteY7" fmla="*/ 1038504 h 1061204"/>
                <a:gd name="connsiteX8" fmla="*/ 238778 w 1122823"/>
                <a:gd name="connsiteY8" fmla="*/ 950295 h 1061204"/>
                <a:gd name="connsiteX9" fmla="*/ 65032 w 1122823"/>
                <a:gd name="connsiteY9" fmla="*/ 817369 h 1061204"/>
                <a:gd name="connsiteX10" fmla="*/ 33099 w 1122823"/>
                <a:gd name="connsiteY10" fmla="*/ 526353 h 1061204"/>
                <a:gd name="connsiteX0" fmla="*/ 33099 w 1122823"/>
                <a:gd name="connsiteY0" fmla="*/ 526353 h 1061204"/>
                <a:gd name="connsiteX1" fmla="*/ 37303 w 1122823"/>
                <a:gd name="connsiteY1" fmla="*/ 173742 h 1061204"/>
                <a:gd name="connsiteX2" fmla="*/ 412747 w 1122823"/>
                <a:gd name="connsiteY2" fmla="*/ 97397 h 1061204"/>
                <a:gd name="connsiteX3" fmla="*/ 758083 w 1122823"/>
                <a:gd name="connsiteY3" fmla="*/ 19687 h 1061204"/>
                <a:gd name="connsiteX4" fmla="*/ 964441 w 1122823"/>
                <a:gd name="connsiteY4" fmla="*/ 442616 h 1061204"/>
                <a:gd name="connsiteX5" fmla="*/ 1089571 w 1122823"/>
                <a:gd name="connsiteY5" fmla="*/ 844345 h 1061204"/>
                <a:gd name="connsiteX6" fmla="*/ 721351 w 1122823"/>
                <a:gd name="connsiteY6" fmla="*/ 1013337 h 1061204"/>
                <a:gd name="connsiteX7" fmla="*/ 575652 w 1122823"/>
                <a:gd name="connsiteY7" fmla="*/ 1038504 h 1061204"/>
                <a:gd name="connsiteX8" fmla="*/ 577413 w 1122823"/>
                <a:gd name="connsiteY8" fmla="*/ 615214 h 1061204"/>
                <a:gd name="connsiteX9" fmla="*/ 65032 w 1122823"/>
                <a:gd name="connsiteY9" fmla="*/ 817369 h 1061204"/>
                <a:gd name="connsiteX10" fmla="*/ 33099 w 1122823"/>
                <a:gd name="connsiteY10" fmla="*/ 526353 h 1061204"/>
                <a:gd name="connsiteX0" fmla="*/ 33099 w 1122823"/>
                <a:gd name="connsiteY0" fmla="*/ 526353 h 1048702"/>
                <a:gd name="connsiteX1" fmla="*/ 37303 w 1122823"/>
                <a:gd name="connsiteY1" fmla="*/ 173742 h 1048702"/>
                <a:gd name="connsiteX2" fmla="*/ 412747 w 1122823"/>
                <a:gd name="connsiteY2" fmla="*/ 97397 h 1048702"/>
                <a:gd name="connsiteX3" fmla="*/ 758083 w 1122823"/>
                <a:gd name="connsiteY3" fmla="*/ 19687 h 1048702"/>
                <a:gd name="connsiteX4" fmla="*/ 964441 w 1122823"/>
                <a:gd name="connsiteY4" fmla="*/ 442616 h 1048702"/>
                <a:gd name="connsiteX5" fmla="*/ 1089571 w 1122823"/>
                <a:gd name="connsiteY5" fmla="*/ 844345 h 1048702"/>
                <a:gd name="connsiteX6" fmla="*/ 893997 w 1122823"/>
                <a:gd name="connsiteY6" fmla="*/ 910185 h 1048702"/>
                <a:gd name="connsiteX7" fmla="*/ 575652 w 1122823"/>
                <a:gd name="connsiteY7" fmla="*/ 1038504 h 1048702"/>
                <a:gd name="connsiteX8" fmla="*/ 577413 w 1122823"/>
                <a:gd name="connsiteY8" fmla="*/ 615214 h 1048702"/>
                <a:gd name="connsiteX9" fmla="*/ 65032 w 1122823"/>
                <a:gd name="connsiteY9" fmla="*/ 817369 h 1048702"/>
                <a:gd name="connsiteX10" fmla="*/ 33099 w 1122823"/>
                <a:gd name="connsiteY10" fmla="*/ 526353 h 1048702"/>
                <a:gd name="connsiteX0" fmla="*/ 33099 w 1122823"/>
                <a:gd name="connsiteY0" fmla="*/ 526353 h 949090"/>
                <a:gd name="connsiteX1" fmla="*/ 37303 w 1122823"/>
                <a:gd name="connsiteY1" fmla="*/ 173742 h 949090"/>
                <a:gd name="connsiteX2" fmla="*/ 412747 w 1122823"/>
                <a:gd name="connsiteY2" fmla="*/ 97397 h 949090"/>
                <a:gd name="connsiteX3" fmla="*/ 758083 w 1122823"/>
                <a:gd name="connsiteY3" fmla="*/ 19687 h 949090"/>
                <a:gd name="connsiteX4" fmla="*/ 964441 w 1122823"/>
                <a:gd name="connsiteY4" fmla="*/ 442616 h 949090"/>
                <a:gd name="connsiteX5" fmla="*/ 1089571 w 1122823"/>
                <a:gd name="connsiteY5" fmla="*/ 844345 h 949090"/>
                <a:gd name="connsiteX6" fmla="*/ 893997 w 1122823"/>
                <a:gd name="connsiteY6" fmla="*/ 910185 h 949090"/>
                <a:gd name="connsiteX7" fmla="*/ 712866 w 1122823"/>
                <a:gd name="connsiteY7" fmla="*/ 823767 h 949090"/>
                <a:gd name="connsiteX8" fmla="*/ 577413 w 1122823"/>
                <a:gd name="connsiteY8" fmla="*/ 615214 h 949090"/>
                <a:gd name="connsiteX9" fmla="*/ 65032 w 1122823"/>
                <a:gd name="connsiteY9" fmla="*/ 817369 h 949090"/>
                <a:gd name="connsiteX10" fmla="*/ 33099 w 1122823"/>
                <a:gd name="connsiteY10" fmla="*/ 526353 h 949090"/>
                <a:gd name="connsiteX0" fmla="*/ 42445 w 1132169"/>
                <a:gd name="connsiteY0" fmla="*/ 526353 h 949090"/>
                <a:gd name="connsiteX1" fmla="*/ 46649 w 1132169"/>
                <a:gd name="connsiteY1" fmla="*/ 173742 h 949090"/>
                <a:gd name="connsiteX2" fmla="*/ 422093 w 1132169"/>
                <a:gd name="connsiteY2" fmla="*/ 97397 h 949090"/>
                <a:gd name="connsiteX3" fmla="*/ 767429 w 1132169"/>
                <a:gd name="connsiteY3" fmla="*/ 19687 h 949090"/>
                <a:gd name="connsiteX4" fmla="*/ 973787 w 1132169"/>
                <a:gd name="connsiteY4" fmla="*/ 442616 h 949090"/>
                <a:gd name="connsiteX5" fmla="*/ 1098917 w 1132169"/>
                <a:gd name="connsiteY5" fmla="*/ 844345 h 949090"/>
                <a:gd name="connsiteX6" fmla="*/ 903343 w 1132169"/>
                <a:gd name="connsiteY6" fmla="*/ 910185 h 949090"/>
                <a:gd name="connsiteX7" fmla="*/ 722212 w 1132169"/>
                <a:gd name="connsiteY7" fmla="*/ 823767 h 949090"/>
                <a:gd name="connsiteX8" fmla="*/ 586759 w 1132169"/>
                <a:gd name="connsiteY8" fmla="*/ 615214 h 949090"/>
                <a:gd name="connsiteX9" fmla="*/ 272651 w 1132169"/>
                <a:gd name="connsiteY9" fmla="*/ 534912 h 949090"/>
                <a:gd name="connsiteX10" fmla="*/ 42445 w 1132169"/>
                <a:gd name="connsiteY10" fmla="*/ 526353 h 949090"/>
                <a:gd name="connsiteX0" fmla="*/ 51362 w 1127041"/>
                <a:gd name="connsiteY0" fmla="*/ 393015 h 949090"/>
                <a:gd name="connsiteX1" fmla="*/ 41521 w 1127041"/>
                <a:gd name="connsiteY1" fmla="*/ 173742 h 949090"/>
                <a:gd name="connsiteX2" fmla="*/ 416965 w 1127041"/>
                <a:gd name="connsiteY2" fmla="*/ 97397 h 949090"/>
                <a:gd name="connsiteX3" fmla="*/ 762301 w 1127041"/>
                <a:gd name="connsiteY3" fmla="*/ 19687 h 949090"/>
                <a:gd name="connsiteX4" fmla="*/ 968659 w 1127041"/>
                <a:gd name="connsiteY4" fmla="*/ 442616 h 949090"/>
                <a:gd name="connsiteX5" fmla="*/ 1093789 w 1127041"/>
                <a:gd name="connsiteY5" fmla="*/ 844345 h 949090"/>
                <a:gd name="connsiteX6" fmla="*/ 898215 w 1127041"/>
                <a:gd name="connsiteY6" fmla="*/ 910185 h 949090"/>
                <a:gd name="connsiteX7" fmla="*/ 717084 w 1127041"/>
                <a:gd name="connsiteY7" fmla="*/ 823767 h 949090"/>
                <a:gd name="connsiteX8" fmla="*/ 581631 w 1127041"/>
                <a:gd name="connsiteY8" fmla="*/ 615214 h 949090"/>
                <a:gd name="connsiteX9" fmla="*/ 267523 w 1127041"/>
                <a:gd name="connsiteY9" fmla="*/ 534912 h 949090"/>
                <a:gd name="connsiteX10" fmla="*/ 51362 w 1127041"/>
                <a:gd name="connsiteY10" fmla="*/ 393015 h 9490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127041" h="949090">
                  <a:moveTo>
                    <a:pt x="51362" y="393015"/>
                  </a:moveTo>
                  <a:cubicBezTo>
                    <a:pt x="13695" y="332820"/>
                    <a:pt x="-37390" y="246668"/>
                    <a:pt x="41521" y="173742"/>
                  </a:cubicBezTo>
                  <a:cubicBezTo>
                    <a:pt x="120432" y="100816"/>
                    <a:pt x="296835" y="123073"/>
                    <a:pt x="416965" y="97397"/>
                  </a:cubicBezTo>
                  <a:cubicBezTo>
                    <a:pt x="537095" y="71721"/>
                    <a:pt x="699301" y="-46035"/>
                    <a:pt x="762301" y="19687"/>
                  </a:cubicBezTo>
                  <a:cubicBezTo>
                    <a:pt x="825301" y="85409"/>
                    <a:pt x="920968" y="349156"/>
                    <a:pt x="968659" y="442616"/>
                  </a:cubicBezTo>
                  <a:cubicBezTo>
                    <a:pt x="1016350" y="536076"/>
                    <a:pt x="1201760" y="659284"/>
                    <a:pt x="1093789" y="844345"/>
                  </a:cubicBezTo>
                  <a:cubicBezTo>
                    <a:pt x="985818" y="1029406"/>
                    <a:pt x="960999" y="913615"/>
                    <a:pt x="898215" y="910185"/>
                  </a:cubicBezTo>
                  <a:cubicBezTo>
                    <a:pt x="835431" y="906755"/>
                    <a:pt x="784410" y="873339"/>
                    <a:pt x="717084" y="823767"/>
                  </a:cubicBezTo>
                  <a:cubicBezTo>
                    <a:pt x="649758" y="774195"/>
                    <a:pt x="662759" y="625811"/>
                    <a:pt x="581631" y="615214"/>
                  </a:cubicBezTo>
                  <a:cubicBezTo>
                    <a:pt x="500503" y="604617"/>
                    <a:pt x="359466" y="637636"/>
                    <a:pt x="267523" y="534912"/>
                  </a:cubicBezTo>
                  <a:cubicBezTo>
                    <a:pt x="175580" y="432188"/>
                    <a:pt x="89029" y="453210"/>
                    <a:pt x="51362" y="393015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Oval 267">
              <a:extLst>
                <a:ext uri="{FF2B5EF4-FFF2-40B4-BE49-F238E27FC236}">
                  <a16:creationId xmlns:a16="http://schemas.microsoft.com/office/drawing/2014/main" id="{D628ABAB-C3CA-01A1-475F-34E0E70859C1}"/>
                </a:ext>
              </a:extLst>
            </p:cNvPr>
            <p:cNvSpPr/>
            <p:nvPr/>
          </p:nvSpPr>
          <p:spPr>
            <a:xfrm>
              <a:off x="7570627" y="4066611"/>
              <a:ext cx="659568" cy="713353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59568" h="713353">
                  <a:moveTo>
                    <a:pt x="0" y="319240"/>
                  </a:moveTo>
                  <a:cubicBezTo>
                    <a:pt x="0" y="200383"/>
                    <a:pt x="167390" y="5140"/>
                    <a:pt x="277318" y="143"/>
                  </a:cubicBezTo>
                  <a:cubicBezTo>
                    <a:pt x="387246" y="-4854"/>
                    <a:pt x="659568" y="121306"/>
                    <a:pt x="659568" y="289260"/>
                  </a:cubicBezTo>
                  <a:cubicBezTo>
                    <a:pt x="659568" y="457214"/>
                    <a:pt x="387246" y="708291"/>
                    <a:pt x="277318" y="713288"/>
                  </a:cubicBezTo>
                  <a:cubicBezTo>
                    <a:pt x="167390" y="718285"/>
                    <a:pt x="0" y="438097"/>
                    <a:pt x="0" y="319240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Oval 267">
              <a:extLst>
                <a:ext uri="{FF2B5EF4-FFF2-40B4-BE49-F238E27FC236}">
                  <a16:creationId xmlns:a16="http://schemas.microsoft.com/office/drawing/2014/main" id="{F82D078E-C3F1-6644-B4DD-C57BD0A8AC71}"/>
                </a:ext>
              </a:extLst>
            </p:cNvPr>
            <p:cNvSpPr/>
            <p:nvPr/>
          </p:nvSpPr>
          <p:spPr>
            <a:xfrm>
              <a:off x="7751530" y="2868031"/>
              <a:ext cx="675262" cy="983625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675262" h="983625">
                  <a:moveTo>
                    <a:pt x="1353" y="319182"/>
                  </a:moveTo>
                  <a:cubicBezTo>
                    <a:pt x="16343" y="187833"/>
                    <a:pt x="168743" y="5082"/>
                    <a:pt x="278671" y="85"/>
                  </a:cubicBezTo>
                  <a:cubicBezTo>
                    <a:pt x="388599" y="-4912"/>
                    <a:pt x="597414" y="212792"/>
                    <a:pt x="660921" y="289202"/>
                  </a:cubicBezTo>
                  <a:cubicBezTo>
                    <a:pt x="724428" y="365612"/>
                    <a:pt x="557482" y="367861"/>
                    <a:pt x="539792" y="443554"/>
                  </a:cubicBezTo>
                  <a:cubicBezTo>
                    <a:pt x="522102" y="519247"/>
                    <a:pt x="674703" y="728367"/>
                    <a:pt x="674703" y="818308"/>
                  </a:cubicBezTo>
                  <a:cubicBezTo>
                    <a:pt x="674703" y="908249"/>
                    <a:pt x="600801" y="975729"/>
                    <a:pt x="539792" y="983200"/>
                  </a:cubicBezTo>
                  <a:cubicBezTo>
                    <a:pt x="478783" y="990671"/>
                    <a:pt x="278470" y="898851"/>
                    <a:pt x="188730" y="788181"/>
                  </a:cubicBezTo>
                  <a:cubicBezTo>
                    <a:pt x="98990" y="677511"/>
                    <a:pt x="-13637" y="450531"/>
                    <a:pt x="1353" y="319182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Oval 267">
              <a:extLst>
                <a:ext uri="{FF2B5EF4-FFF2-40B4-BE49-F238E27FC236}">
                  <a16:creationId xmlns:a16="http://schemas.microsoft.com/office/drawing/2014/main" id="{5AFE70B1-59E7-C6F6-D4D5-3E66B61A2443}"/>
                </a:ext>
              </a:extLst>
            </p:cNvPr>
            <p:cNvSpPr/>
            <p:nvPr/>
          </p:nvSpPr>
          <p:spPr>
            <a:xfrm rot="16622697">
              <a:off x="6314777" y="1535326"/>
              <a:ext cx="564488" cy="1106491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  <a:gd name="connsiteX0" fmla="*/ 1353 w 674703"/>
                <a:gd name="connsiteY0" fmla="*/ 332766 h 997209"/>
                <a:gd name="connsiteX1" fmla="*/ 278671 w 674703"/>
                <a:gd name="connsiteY1" fmla="*/ 13669 h 997209"/>
                <a:gd name="connsiteX2" fmla="*/ 469697 w 674703"/>
                <a:gd name="connsiteY2" fmla="*/ 99855 h 997209"/>
                <a:gd name="connsiteX3" fmla="*/ 539792 w 674703"/>
                <a:gd name="connsiteY3" fmla="*/ 457138 h 997209"/>
                <a:gd name="connsiteX4" fmla="*/ 674703 w 674703"/>
                <a:gd name="connsiteY4" fmla="*/ 831892 h 997209"/>
                <a:gd name="connsiteX5" fmla="*/ 539792 w 674703"/>
                <a:gd name="connsiteY5" fmla="*/ 996784 h 997209"/>
                <a:gd name="connsiteX6" fmla="*/ 188730 w 674703"/>
                <a:gd name="connsiteY6" fmla="*/ 801765 h 997209"/>
                <a:gd name="connsiteX7" fmla="*/ 1353 w 674703"/>
                <a:gd name="connsiteY7" fmla="*/ 332766 h 997209"/>
                <a:gd name="connsiteX0" fmla="*/ 1130 w 674480"/>
                <a:gd name="connsiteY0" fmla="*/ 332766 h 1106491"/>
                <a:gd name="connsiteX1" fmla="*/ 278448 w 674480"/>
                <a:gd name="connsiteY1" fmla="*/ 13669 h 1106491"/>
                <a:gd name="connsiteX2" fmla="*/ 469474 w 674480"/>
                <a:gd name="connsiteY2" fmla="*/ 99855 h 1106491"/>
                <a:gd name="connsiteX3" fmla="*/ 539569 w 674480"/>
                <a:gd name="connsiteY3" fmla="*/ 457138 h 1106491"/>
                <a:gd name="connsiteX4" fmla="*/ 674480 w 674480"/>
                <a:gd name="connsiteY4" fmla="*/ 831892 h 1106491"/>
                <a:gd name="connsiteX5" fmla="*/ 386953 w 674480"/>
                <a:gd name="connsiteY5" fmla="*/ 1106270 h 1106491"/>
                <a:gd name="connsiteX6" fmla="*/ 188507 w 674480"/>
                <a:gd name="connsiteY6" fmla="*/ 801765 h 1106491"/>
                <a:gd name="connsiteX7" fmla="*/ 1130 w 674480"/>
                <a:gd name="connsiteY7" fmla="*/ 332766 h 1106491"/>
                <a:gd name="connsiteX0" fmla="*/ 1130 w 564488"/>
                <a:gd name="connsiteY0" fmla="*/ 332766 h 1106491"/>
                <a:gd name="connsiteX1" fmla="*/ 278448 w 564488"/>
                <a:gd name="connsiteY1" fmla="*/ 13669 h 1106491"/>
                <a:gd name="connsiteX2" fmla="*/ 469474 w 564488"/>
                <a:gd name="connsiteY2" fmla="*/ 99855 h 1106491"/>
                <a:gd name="connsiteX3" fmla="*/ 539569 w 564488"/>
                <a:gd name="connsiteY3" fmla="*/ 457138 h 1106491"/>
                <a:gd name="connsiteX4" fmla="*/ 564488 w 564488"/>
                <a:gd name="connsiteY4" fmla="*/ 1041840 h 1106491"/>
                <a:gd name="connsiteX5" fmla="*/ 386953 w 564488"/>
                <a:gd name="connsiteY5" fmla="*/ 1106270 h 1106491"/>
                <a:gd name="connsiteX6" fmla="*/ 188507 w 564488"/>
                <a:gd name="connsiteY6" fmla="*/ 801765 h 1106491"/>
                <a:gd name="connsiteX7" fmla="*/ 1130 w 564488"/>
                <a:gd name="connsiteY7" fmla="*/ 332766 h 11064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64488" h="1106491">
                  <a:moveTo>
                    <a:pt x="1130" y="332766"/>
                  </a:moveTo>
                  <a:cubicBezTo>
                    <a:pt x="16120" y="201417"/>
                    <a:pt x="200391" y="52488"/>
                    <a:pt x="278448" y="13669"/>
                  </a:cubicBezTo>
                  <a:cubicBezTo>
                    <a:pt x="356505" y="-25150"/>
                    <a:pt x="405967" y="23445"/>
                    <a:pt x="469474" y="99855"/>
                  </a:cubicBezTo>
                  <a:cubicBezTo>
                    <a:pt x="532981" y="176265"/>
                    <a:pt x="557259" y="381445"/>
                    <a:pt x="539569" y="457138"/>
                  </a:cubicBezTo>
                  <a:cubicBezTo>
                    <a:pt x="521879" y="532831"/>
                    <a:pt x="564488" y="951899"/>
                    <a:pt x="564488" y="1041840"/>
                  </a:cubicBezTo>
                  <a:cubicBezTo>
                    <a:pt x="564488" y="1131781"/>
                    <a:pt x="447962" y="1098799"/>
                    <a:pt x="386953" y="1106270"/>
                  </a:cubicBezTo>
                  <a:cubicBezTo>
                    <a:pt x="325944" y="1113741"/>
                    <a:pt x="252811" y="930682"/>
                    <a:pt x="188507" y="801765"/>
                  </a:cubicBezTo>
                  <a:cubicBezTo>
                    <a:pt x="124203" y="672848"/>
                    <a:pt x="-13860" y="464115"/>
                    <a:pt x="1130" y="33276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Oval 267">
              <a:extLst>
                <a:ext uri="{FF2B5EF4-FFF2-40B4-BE49-F238E27FC236}">
                  <a16:creationId xmlns:a16="http://schemas.microsoft.com/office/drawing/2014/main" id="{91DDDF8E-D5C9-F585-F689-14A1594F9DB5}"/>
                </a:ext>
              </a:extLst>
            </p:cNvPr>
            <p:cNvSpPr/>
            <p:nvPr/>
          </p:nvSpPr>
          <p:spPr>
            <a:xfrm rot="16622697">
              <a:off x="7838500" y="1799921"/>
              <a:ext cx="550858" cy="702688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  <a:gd name="connsiteX0" fmla="*/ 1353 w 674703"/>
                <a:gd name="connsiteY0" fmla="*/ 332766 h 997209"/>
                <a:gd name="connsiteX1" fmla="*/ 278671 w 674703"/>
                <a:gd name="connsiteY1" fmla="*/ 13669 h 997209"/>
                <a:gd name="connsiteX2" fmla="*/ 469697 w 674703"/>
                <a:gd name="connsiteY2" fmla="*/ 99855 h 997209"/>
                <a:gd name="connsiteX3" fmla="*/ 539792 w 674703"/>
                <a:gd name="connsiteY3" fmla="*/ 457138 h 997209"/>
                <a:gd name="connsiteX4" fmla="*/ 674703 w 674703"/>
                <a:gd name="connsiteY4" fmla="*/ 831892 h 997209"/>
                <a:gd name="connsiteX5" fmla="*/ 539792 w 674703"/>
                <a:gd name="connsiteY5" fmla="*/ 996784 h 997209"/>
                <a:gd name="connsiteX6" fmla="*/ 188730 w 674703"/>
                <a:gd name="connsiteY6" fmla="*/ 801765 h 997209"/>
                <a:gd name="connsiteX7" fmla="*/ 1353 w 674703"/>
                <a:gd name="connsiteY7" fmla="*/ 332766 h 997209"/>
                <a:gd name="connsiteX0" fmla="*/ 1130 w 674480"/>
                <a:gd name="connsiteY0" fmla="*/ 332766 h 1106491"/>
                <a:gd name="connsiteX1" fmla="*/ 278448 w 674480"/>
                <a:gd name="connsiteY1" fmla="*/ 13669 h 1106491"/>
                <a:gd name="connsiteX2" fmla="*/ 469474 w 674480"/>
                <a:gd name="connsiteY2" fmla="*/ 99855 h 1106491"/>
                <a:gd name="connsiteX3" fmla="*/ 539569 w 674480"/>
                <a:gd name="connsiteY3" fmla="*/ 457138 h 1106491"/>
                <a:gd name="connsiteX4" fmla="*/ 674480 w 674480"/>
                <a:gd name="connsiteY4" fmla="*/ 831892 h 1106491"/>
                <a:gd name="connsiteX5" fmla="*/ 386953 w 674480"/>
                <a:gd name="connsiteY5" fmla="*/ 1106270 h 1106491"/>
                <a:gd name="connsiteX6" fmla="*/ 188507 w 674480"/>
                <a:gd name="connsiteY6" fmla="*/ 801765 h 1106491"/>
                <a:gd name="connsiteX7" fmla="*/ 1130 w 674480"/>
                <a:gd name="connsiteY7" fmla="*/ 332766 h 1106491"/>
                <a:gd name="connsiteX0" fmla="*/ 1130 w 564488"/>
                <a:gd name="connsiteY0" fmla="*/ 332766 h 1106491"/>
                <a:gd name="connsiteX1" fmla="*/ 278448 w 564488"/>
                <a:gd name="connsiteY1" fmla="*/ 13669 h 1106491"/>
                <a:gd name="connsiteX2" fmla="*/ 469474 w 564488"/>
                <a:gd name="connsiteY2" fmla="*/ 99855 h 1106491"/>
                <a:gd name="connsiteX3" fmla="*/ 539569 w 564488"/>
                <a:gd name="connsiteY3" fmla="*/ 457138 h 1106491"/>
                <a:gd name="connsiteX4" fmla="*/ 564488 w 564488"/>
                <a:gd name="connsiteY4" fmla="*/ 1041840 h 1106491"/>
                <a:gd name="connsiteX5" fmla="*/ 386953 w 564488"/>
                <a:gd name="connsiteY5" fmla="*/ 1106270 h 1106491"/>
                <a:gd name="connsiteX6" fmla="*/ 188507 w 564488"/>
                <a:gd name="connsiteY6" fmla="*/ 801765 h 1106491"/>
                <a:gd name="connsiteX7" fmla="*/ 1130 w 564488"/>
                <a:gd name="connsiteY7" fmla="*/ 332766 h 1106491"/>
                <a:gd name="connsiteX0" fmla="*/ 1130 w 546440"/>
                <a:gd name="connsiteY0" fmla="*/ 332766 h 1106491"/>
                <a:gd name="connsiteX1" fmla="*/ 278448 w 546440"/>
                <a:gd name="connsiteY1" fmla="*/ 13669 h 1106491"/>
                <a:gd name="connsiteX2" fmla="*/ 469474 w 546440"/>
                <a:gd name="connsiteY2" fmla="*/ 99855 h 1106491"/>
                <a:gd name="connsiteX3" fmla="*/ 539569 w 546440"/>
                <a:gd name="connsiteY3" fmla="*/ 457138 h 1106491"/>
                <a:gd name="connsiteX4" fmla="*/ 546440 w 546440"/>
                <a:gd name="connsiteY4" fmla="*/ 651362 h 1106491"/>
                <a:gd name="connsiteX5" fmla="*/ 386953 w 546440"/>
                <a:gd name="connsiteY5" fmla="*/ 1106270 h 1106491"/>
                <a:gd name="connsiteX6" fmla="*/ 188507 w 546440"/>
                <a:gd name="connsiteY6" fmla="*/ 801765 h 1106491"/>
                <a:gd name="connsiteX7" fmla="*/ 1130 w 546440"/>
                <a:gd name="connsiteY7" fmla="*/ 332766 h 1106491"/>
                <a:gd name="connsiteX0" fmla="*/ 1054 w 546364"/>
                <a:gd name="connsiteY0" fmla="*/ 332766 h 814951"/>
                <a:gd name="connsiteX1" fmla="*/ 278372 w 546364"/>
                <a:gd name="connsiteY1" fmla="*/ 13669 h 814951"/>
                <a:gd name="connsiteX2" fmla="*/ 469398 w 546364"/>
                <a:gd name="connsiteY2" fmla="*/ 99855 h 814951"/>
                <a:gd name="connsiteX3" fmla="*/ 539493 w 546364"/>
                <a:gd name="connsiteY3" fmla="*/ 457138 h 814951"/>
                <a:gd name="connsiteX4" fmla="*/ 546364 w 546364"/>
                <a:gd name="connsiteY4" fmla="*/ 651362 h 814951"/>
                <a:gd name="connsiteX5" fmla="*/ 320522 w 546364"/>
                <a:gd name="connsiteY5" fmla="*/ 691553 h 814951"/>
                <a:gd name="connsiteX6" fmla="*/ 188431 w 546364"/>
                <a:gd name="connsiteY6" fmla="*/ 801765 h 814951"/>
                <a:gd name="connsiteX7" fmla="*/ 1054 w 546364"/>
                <a:gd name="connsiteY7" fmla="*/ 332766 h 814951"/>
                <a:gd name="connsiteX0" fmla="*/ 5548 w 550858"/>
                <a:gd name="connsiteY0" fmla="*/ 332766 h 702688"/>
                <a:gd name="connsiteX1" fmla="*/ 282866 w 550858"/>
                <a:gd name="connsiteY1" fmla="*/ 13669 h 702688"/>
                <a:gd name="connsiteX2" fmla="*/ 473892 w 550858"/>
                <a:gd name="connsiteY2" fmla="*/ 99855 h 702688"/>
                <a:gd name="connsiteX3" fmla="*/ 543987 w 550858"/>
                <a:gd name="connsiteY3" fmla="*/ 457138 h 702688"/>
                <a:gd name="connsiteX4" fmla="*/ 550858 w 550858"/>
                <a:gd name="connsiteY4" fmla="*/ 651362 h 702688"/>
                <a:gd name="connsiteX5" fmla="*/ 325016 w 550858"/>
                <a:gd name="connsiteY5" fmla="*/ 691553 h 702688"/>
                <a:gd name="connsiteX6" fmla="*/ 115031 w 550858"/>
                <a:gd name="connsiteY6" fmla="*/ 660349 h 702688"/>
                <a:gd name="connsiteX7" fmla="*/ 5548 w 550858"/>
                <a:gd name="connsiteY7" fmla="*/ 332766 h 7026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50858" h="702688">
                  <a:moveTo>
                    <a:pt x="5548" y="332766"/>
                  </a:moveTo>
                  <a:cubicBezTo>
                    <a:pt x="33521" y="224986"/>
                    <a:pt x="204809" y="52488"/>
                    <a:pt x="282866" y="13669"/>
                  </a:cubicBezTo>
                  <a:cubicBezTo>
                    <a:pt x="360923" y="-25150"/>
                    <a:pt x="410385" y="23445"/>
                    <a:pt x="473892" y="99855"/>
                  </a:cubicBezTo>
                  <a:cubicBezTo>
                    <a:pt x="537399" y="176265"/>
                    <a:pt x="561677" y="381445"/>
                    <a:pt x="543987" y="457138"/>
                  </a:cubicBezTo>
                  <a:cubicBezTo>
                    <a:pt x="526297" y="532831"/>
                    <a:pt x="550858" y="561421"/>
                    <a:pt x="550858" y="651362"/>
                  </a:cubicBezTo>
                  <a:cubicBezTo>
                    <a:pt x="550858" y="741303"/>
                    <a:pt x="386025" y="684082"/>
                    <a:pt x="325016" y="691553"/>
                  </a:cubicBezTo>
                  <a:cubicBezTo>
                    <a:pt x="264007" y="699024"/>
                    <a:pt x="168276" y="720147"/>
                    <a:pt x="115031" y="660349"/>
                  </a:cubicBezTo>
                  <a:cubicBezTo>
                    <a:pt x="61786" y="600551"/>
                    <a:pt x="-22425" y="440546"/>
                    <a:pt x="5548" y="33276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3" name="Group 262">
            <a:extLst>
              <a:ext uri="{FF2B5EF4-FFF2-40B4-BE49-F238E27FC236}">
                <a16:creationId xmlns:a16="http://schemas.microsoft.com/office/drawing/2014/main" id="{193CACFB-7F90-596A-8292-4264631D3C13}"/>
              </a:ext>
            </a:extLst>
          </p:cNvPr>
          <p:cNvGrpSpPr/>
          <p:nvPr/>
        </p:nvGrpSpPr>
        <p:grpSpPr>
          <a:xfrm>
            <a:off x="6488208" y="1931873"/>
            <a:ext cx="563698" cy="615072"/>
            <a:chOff x="5462585" y="1806328"/>
            <a:chExt cx="3002688" cy="3419491"/>
          </a:xfrm>
        </p:grpSpPr>
        <p:sp>
          <p:nvSpPr>
            <p:cNvPr id="264" name="Oval 262">
              <a:extLst>
                <a:ext uri="{FF2B5EF4-FFF2-40B4-BE49-F238E27FC236}">
                  <a16:creationId xmlns:a16="http://schemas.microsoft.com/office/drawing/2014/main" id="{DADBF9FB-3E62-C66B-A945-6A718677AAE2}"/>
                </a:ext>
              </a:extLst>
            </p:cNvPr>
            <p:cNvSpPr/>
            <p:nvPr/>
          </p:nvSpPr>
          <p:spPr>
            <a:xfrm>
              <a:off x="5462585" y="2268018"/>
              <a:ext cx="1256007" cy="1348259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256007" h="1348259">
                  <a:moveTo>
                    <a:pt x="58531" y="442213"/>
                  </a:moveTo>
                  <a:cubicBezTo>
                    <a:pt x="138478" y="342279"/>
                    <a:pt x="471320" y="666788"/>
                    <a:pt x="550231" y="593862"/>
                  </a:cubicBezTo>
                  <a:cubicBezTo>
                    <a:pt x="629142" y="520936"/>
                    <a:pt x="464539" y="47128"/>
                    <a:pt x="531995" y="4656"/>
                  </a:cubicBezTo>
                  <a:cubicBezTo>
                    <a:pt x="599451" y="-37816"/>
                    <a:pt x="831084" y="221132"/>
                    <a:pt x="954965" y="339029"/>
                  </a:cubicBezTo>
                  <a:cubicBezTo>
                    <a:pt x="1078846" y="456926"/>
                    <a:pt x="1338281" y="811788"/>
                    <a:pt x="1230310" y="996849"/>
                  </a:cubicBezTo>
                  <a:cubicBezTo>
                    <a:pt x="1122339" y="1181910"/>
                    <a:pt x="780251" y="1154299"/>
                    <a:pt x="621934" y="1209554"/>
                  </a:cubicBezTo>
                  <a:cubicBezTo>
                    <a:pt x="463617" y="1264809"/>
                    <a:pt x="432267" y="1398517"/>
                    <a:pt x="280408" y="1328380"/>
                  </a:cubicBezTo>
                  <a:cubicBezTo>
                    <a:pt x="128549" y="1258243"/>
                    <a:pt x="162489" y="1296192"/>
                    <a:pt x="70546" y="1193468"/>
                  </a:cubicBezTo>
                  <a:cubicBezTo>
                    <a:pt x="-21397" y="1090744"/>
                    <a:pt x="-21416" y="542147"/>
                    <a:pt x="58531" y="442213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Oval 262">
              <a:extLst>
                <a:ext uri="{FF2B5EF4-FFF2-40B4-BE49-F238E27FC236}">
                  <a16:creationId xmlns:a16="http://schemas.microsoft.com/office/drawing/2014/main" id="{B2F5CC36-5E39-FBF2-E3F3-45EEC0F738F7}"/>
                </a:ext>
              </a:extLst>
            </p:cNvPr>
            <p:cNvSpPr/>
            <p:nvPr/>
          </p:nvSpPr>
          <p:spPr>
            <a:xfrm>
              <a:off x="6703739" y="1981755"/>
              <a:ext cx="1151810" cy="1131927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151810" h="1131927">
                  <a:moveTo>
                    <a:pt x="12404" y="481516"/>
                  </a:moveTo>
                  <a:cubicBezTo>
                    <a:pt x="57374" y="394074"/>
                    <a:pt x="335252" y="331336"/>
                    <a:pt x="414163" y="258410"/>
                  </a:cubicBezTo>
                  <a:cubicBezTo>
                    <a:pt x="493074" y="185484"/>
                    <a:pt x="577610" y="45270"/>
                    <a:pt x="665750" y="13978"/>
                  </a:cubicBezTo>
                  <a:cubicBezTo>
                    <a:pt x="753890" y="-17314"/>
                    <a:pt x="880005" y="4934"/>
                    <a:pt x="943005" y="70656"/>
                  </a:cubicBezTo>
                  <a:cubicBezTo>
                    <a:pt x="1006005" y="136378"/>
                    <a:pt x="996059" y="314852"/>
                    <a:pt x="1043750" y="408312"/>
                  </a:cubicBezTo>
                  <a:cubicBezTo>
                    <a:pt x="1091441" y="501772"/>
                    <a:pt x="1217203" y="551288"/>
                    <a:pt x="1109232" y="736349"/>
                  </a:cubicBezTo>
                  <a:cubicBezTo>
                    <a:pt x="1001261" y="921410"/>
                    <a:pt x="909010" y="916283"/>
                    <a:pt x="800660" y="979033"/>
                  </a:cubicBezTo>
                  <a:cubicBezTo>
                    <a:pt x="692310" y="1041783"/>
                    <a:pt x="610993" y="1182987"/>
                    <a:pt x="459134" y="1112850"/>
                  </a:cubicBezTo>
                  <a:cubicBezTo>
                    <a:pt x="307275" y="1042713"/>
                    <a:pt x="236284" y="885789"/>
                    <a:pt x="144341" y="783065"/>
                  </a:cubicBezTo>
                  <a:cubicBezTo>
                    <a:pt x="52398" y="680341"/>
                    <a:pt x="-32566" y="568958"/>
                    <a:pt x="12404" y="48151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Oval 262">
              <a:extLst>
                <a:ext uri="{FF2B5EF4-FFF2-40B4-BE49-F238E27FC236}">
                  <a16:creationId xmlns:a16="http://schemas.microsoft.com/office/drawing/2014/main" id="{D7DD0726-877A-2744-43DA-FD8CA1896696}"/>
                </a:ext>
              </a:extLst>
            </p:cNvPr>
            <p:cNvSpPr/>
            <p:nvPr/>
          </p:nvSpPr>
          <p:spPr>
            <a:xfrm rot="19645332">
              <a:off x="6760723" y="3188178"/>
              <a:ext cx="992103" cy="1015226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7647 w 992103"/>
                <a:gd name="connsiteY0" fmla="*/ 522134 h 1015226"/>
                <a:gd name="connsiteX1" fmla="*/ 205548 w 992103"/>
                <a:gd name="connsiteY1" fmla="*/ 120409 h 1015226"/>
                <a:gd name="connsiteX2" fmla="*/ 484497 w 992103"/>
                <a:gd name="connsiteY2" fmla="*/ 196 h 1015226"/>
                <a:gd name="connsiteX3" fmla="*/ 858244 w 992103"/>
                <a:gd name="connsiteY3" fmla="*/ 100741 h 1015226"/>
                <a:gd name="connsiteX4" fmla="*/ 958989 w 992103"/>
                <a:gd name="connsiteY4" fmla="*/ 438397 h 1015226"/>
                <a:gd name="connsiteX5" fmla="*/ 905863 w 992103"/>
                <a:gd name="connsiteY5" fmla="*/ 868536 h 1015226"/>
                <a:gd name="connsiteX6" fmla="*/ 715899 w 992103"/>
                <a:gd name="connsiteY6" fmla="*/ 1009118 h 1015226"/>
                <a:gd name="connsiteX7" fmla="*/ 456514 w 992103"/>
                <a:gd name="connsiteY7" fmla="*/ 961643 h 1015226"/>
                <a:gd name="connsiteX8" fmla="*/ 311942 w 992103"/>
                <a:gd name="connsiteY8" fmla="*/ 711683 h 1015226"/>
                <a:gd name="connsiteX9" fmla="*/ 59580 w 992103"/>
                <a:gd name="connsiteY9" fmla="*/ 813150 h 1015226"/>
                <a:gd name="connsiteX10" fmla="*/ 27647 w 992103"/>
                <a:gd name="connsiteY10" fmla="*/ 522134 h 10152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92103" h="1015226">
                  <a:moveTo>
                    <a:pt x="27647" y="522134"/>
                  </a:moveTo>
                  <a:cubicBezTo>
                    <a:pt x="51975" y="406677"/>
                    <a:pt x="126637" y="193335"/>
                    <a:pt x="205548" y="120409"/>
                  </a:cubicBezTo>
                  <a:cubicBezTo>
                    <a:pt x="284459" y="47483"/>
                    <a:pt x="375714" y="3474"/>
                    <a:pt x="484497" y="196"/>
                  </a:cubicBezTo>
                  <a:cubicBezTo>
                    <a:pt x="593280" y="-3082"/>
                    <a:pt x="795244" y="35019"/>
                    <a:pt x="858244" y="100741"/>
                  </a:cubicBezTo>
                  <a:cubicBezTo>
                    <a:pt x="921244" y="166463"/>
                    <a:pt x="911298" y="344937"/>
                    <a:pt x="958989" y="438397"/>
                  </a:cubicBezTo>
                  <a:cubicBezTo>
                    <a:pt x="1006680" y="531857"/>
                    <a:pt x="1013834" y="683475"/>
                    <a:pt x="905863" y="868536"/>
                  </a:cubicBezTo>
                  <a:cubicBezTo>
                    <a:pt x="797892" y="1053597"/>
                    <a:pt x="790791" y="993600"/>
                    <a:pt x="715899" y="1009118"/>
                  </a:cubicBezTo>
                  <a:cubicBezTo>
                    <a:pt x="641008" y="1024636"/>
                    <a:pt x="523840" y="1011215"/>
                    <a:pt x="456514" y="961643"/>
                  </a:cubicBezTo>
                  <a:cubicBezTo>
                    <a:pt x="389188" y="912071"/>
                    <a:pt x="393070" y="722280"/>
                    <a:pt x="311942" y="711683"/>
                  </a:cubicBezTo>
                  <a:cubicBezTo>
                    <a:pt x="230814" y="701086"/>
                    <a:pt x="151523" y="915874"/>
                    <a:pt x="59580" y="813150"/>
                  </a:cubicBezTo>
                  <a:cubicBezTo>
                    <a:pt x="-32363" y="710426"/>
                    <a:pt x="3319" y="637591"/>
                    <a:pt x="27647" y="522134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Oval 262">
              <a:extLst>
                <a:ext uri="{FF2B5EF4-FFF2-40B4-BE49-F238E27FC236}">
                  <a16:creationId xmlns:a16="http://schemas.microsoft.com/office/drawing/2014/main" id="{CE1E1D0D-0900-30E2-793E-A7368F0CE6BE}"/>
                </a:ext>
              </a:extLst>
            </p:cNvPr>
            <p:cNvSpPr/>
            <p:nvPr/>
          </p:nvSpPr>
          <p:spPr>
            <a:xfrm rot="19645332">
              <a:off x="5763553" y="3518467"/>
              <a:ext cx="988441" cy="1058348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308280 w 988441"/>
                <a:gd name="connsiteY8" fmla="*/ 714050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229664 w 988441"/>
                <a:gd name="connsiteY8" fmla="*/ 948443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58348"/>
                <a:gd name="connsiteX1" fmla="*/ 140825 w 988441"/>
                <a:gd name="connsiteY1" fmla="*/ 190495 h 1058348"/>
                <a:gd name="connsiteX2" fmla="*/ 480835 w 988441"/>
                <a:gd name="connsiteY2" fmla="*/ 2563 h 1058348"/>
                <a:gd name="connsiteX3" fmla="*/ 854582 w 988441"/>
                <a:gd name="connsiteY3" fmla="*/ 103108 h 1058348"/>
                <a:gd name="connsiteX4" fmla="*/ 955327 w 988441"/>
                <a:gd name="connsiteY4" fmla="*/ 440764 h 1058348"/>
                <a:gd name="connsiteX5" fmla="*/ 902201 w 988441"/>
                <a:gd name="connsiteY5" fmla="*/ 870903 h 1058348"/>
                <a:gd name="connsiteX6" fmla="*/ 712237 w 988441"/>
                <a:gd name="connsiteY6" fmla="*/ 1011485 h 1058348"/>
                <a:gd name="connsiteX7" fmla="*/ 566538 w 988441"/>
                <a:gd name="connsiteY7" fmla="*/ 1036652 h 1058348"/>
                <a:gd name="connsiteX8" fmla="*/ 229664 w 988441"/>
                <a:gd name="connsiteY8" fmla="*/ 948443 h 1058348"/>
                <a:gd name="connsiteX9" fmla="*/ 55918 w 988441"/>
                <a:gd name="connsiteY9" fmla="*/ 815517 h 1058348"/>
                <a:gd name="connsiteX10" fmla="*/ 23985 w 988441"/>
                <a:gd name="connsiteY10" fmla="*/ 524501 h 10583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88441" h="1058348">
                  <a:moveTo>
                    <a:pt x="23985" y="524501"/>
                  </a:moveTo>
                  <a:cubicBezTo>
                    <a:pt x="38136" y="420331"/>
                    <a:pt x="61914" y="263421"/>
                    <a:pt x="140825" y="190495"/>
                  </a:cubicBezTo>
                  <a:cubicBezTo>
                    <a:pt x="219736" y="117569"/>
                    <a:pt x="361876" y="17127"/>
                    <a:pt x="480835" y="2563"/>
                  </a:cubicBezTo>
                  <a:cubicBezTo>
                    <a:pt x="599794" y="-12001"/>
                    <a:pt x="791582" y="37386"/>
                    <a:pt x="854582" y="103108"/>
                  </a:cubicBezTo>
                  <a:cubicBezTo>
                    <a:pt x="917582" y="168830"/>
                    <a:pt x="907636" y="347304"/>
                    <a:pt x="955327" y="440764"/>
                  </a:cubicBezTo>
                  <a:cubicBezTo>
                    <a:pt x="1003018" y="534224"/>
                    <a:pt x="1010172" y="685842"/>
                    <a:pt x="902201" y="870903"/>
                  </a:cubicBezTo>
                  <a:cubicBezTo>
                    <a:pt x="794230" y="1055964"/>
                    <a:pt x="768181" y="983860"/>
                    <a:pt x="712237" y="1011485"/>
                  </a:cubicBezTo>
                  <a:cubicBezTo>
                    <a:pt x="656293" y="1039110"/>
                    <a:pt x="633864" y="1086224"/>
                    <a:pt x="566538" y="1036652"/>
                  </a:cubicBezTo>
                  <a:cubicBezTo>
                    <a:pt x="499212" y="987080"/>
                    <a:pt x="310792" y="959040"/>
                    <a:pt x="229664" y="948443"/>
                  </a:cubicBezTo>
                  <a:cubicBezTo>
                    <a:pt x="148536" y="937846"/>
                    <a:pt x="147861" y="918241"/>
                    <a:pt x="55918" y="815517"/>
                  </a:cubicBezTo>
                  <a:cubicBezTo>
                    <a:pt x="-36025" y="712793"/>
                    <a:pt x="9834" y="628671"/>
                    <a:pt x="23985" y="524501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Oval 262">
              <a:extLst>
                <a:ext uri="{FF2B5EF4-FFF2-40B4-BE49-F238E27FC236}">
                  <a16:creationId xmlns:a16="http://schemas.microsoft.com/office/drawing/2014/main" id="{80FB902C-E1AF-322F-21EF-ABDDE2D8F8EA}"/>
                </a:ext>
              </a:extLst>
            </p:cNvPr>
            <p:cNvSpPr/>
            <p:nvPr/>
          </p:nvSpPr>
          <p:spPr>
            <a:xfrm rot="19645332">
              <a:off x="6422111" y="4276729"/>
              <a:ext cx="1127041" cy="949090"/>
            </a:xfrm>
            <a:custGeom>
              <a:avLst/>
              <a:gdLst>
                <a:gd name="connsiteX0" fmla="*/ 0 w 1546533"/>
                <a:gd name="connsiteY0" fmla="*/ 692390 h 1384779"/>
                <a:gd name="connsiteX1" fmla="*/ 773267 w 1546533"/>
                <a:gd name="connsiteY1" fmla="*/ 0 h 1384779"/>
                <a:gd name="connsiteX2" fmla="*/ 1546534 w 1546533"/>
                <a:gd name="connsiteY2" fmla="*/ 692390 h 1384779"/>
                <a:gd name="connsiteX3" fmla="*/ 773267 w 1546533"/>
                <a:gd name="connsiteY3" fmla="*/ 1384780 h 1384779"/>
                <a:gd name="connsiteX4" fmla="*/ 0 w 1546533"/>
                <a:gd name="connsiteY4" fmla="*/ 692390 h 1384779"/>
                <a:gd name="connsiteX0" fmla="*/ 52 w 1546586"/>
                <a:gd name="connsiteY0" fmla="*/ 707380 h 1399770"/>
                <a:gd name="connsiteX1" fmla="*/ 803300 w 1546586"/>
                <a:gd name="connsiteY1" fmla="*/ 0 h 1399770"/>
                <a:gd name="connsiteX2" fmla="*/ 1546586 w 1546586"/>
                <a:gd name="connsiteY2" fmla="*/ 707380 h 1399770"/>
                <a:gd name="connsiteX3" fmla="*/ 773319 w 1546586"/>
                <a:gd name="connsiteY3" fmla="*/ 1399770 h 1399770"/>
                <a:gd name="connsiteX4" fmla="*/ 52 w 1546586"/>
                <a:gd name="connsiteY4" fmla="*/ 707380 h 1399770"/>
                <a:gd name="connsiteX0" fmla="*/ 52 w 1569351"/>
                <a:gd name="connsiteY0" fmla="*/ 716310 h 1408700"/>
                <a:gd name="connsiteX1" fmla="*/ 803300 w 1569351"/>
                <a:gd name="connsiteY1" fmla="*/ 8930 h 1408700"/>
                <a:gd name="connsiteX2" fmla="*/ 1226270 w 1569351"/>
                <a:gd name="connsiteY2" fmla="*/ 343303 h 1408700"/>
                <a:gd name="connsiteX3" fmla="*/ 1546586 w 1569351"/>
                <a:gd name="connsiteY3" fmla="*/ 716310 h 1408700"/>
                <a:gd name="connsiteX4" fmla="*/ 773319 w 1569351"/>
                <a:gd name="connsiteY4" fmla="*/ 1408700 h 1408700"/>
                <a:gd name="connsiteX5" fmla="*/ 52 w 1569351"/>
                <a:gd name="connsiteY5" fmla="*/ 716310 h 1408700"/>
                <a:gd name="connsiteX0" fmla="*/ 36 w 1527296"/>
                <a:gd name="connsiteY0" fmla="*/ 716310 h 1414204"/>
                <a:gd name="connsiteX1" fmla="*/ 803284 w 1527296"/>
                <a:gd name="connsiteY1" fmla="*/ 8930 h 1414204"/>
                <a:gd name="connsiteX2" fmla="*/ 1226254 w 1527296"/>
                <a:gd name="connsiteY2" fmla="*/ 343303 h 1414204"/>
                <a:gd name="connsiteX3" fmla="*/ 1501599 w 1527296"/>
                <a:gd name="connsiteY3" fmla="*/ 1001123 h 1414204"/>
                <a:gd name="connsiteX4" fmla="*/ 773303 w 1527296"/>
                <a:gd name="connsiteY4" fmla="*/ 1408700 h 1414204"/>
                <a:gd name="connsiteX5" fmla="*/ 36 w 1527296"/>
                <a:gd name="connsiteY5" fmla="*/ 716310 h 1414204"/>
                <a:gd name="connsiteX0" fmla="*/ 2734 w 1529994"/>
                <a:gd name="connsiteY0" fmla="*/ 716310 h 1227707"/>
                <a:gd name="connsiteX1" fmla="*/ 805982 w 1529994"/>
                <a:gd name="connsiteY1" fmla="*/ 8930 h 1227707"/>
                <a:gd name="connsiteX2" fmla="*/ 1228952 w 1529994"/>
                <a:gd name="connsiteY2" fmla="*/ 343303 h 1227707"/>
                <a:gd name="connsiteX3" fmla="*/ 1504297 w 1529994"/>
                <a:gd name="connsiteY3" fmla="*/ 1001123 h 1227707"/>
                <a:gd name="connsiteX4" fmla="*/ 1105784 w 1529994"/>
                <a:gd name="connsiteY4" fmla="*/ 1213828 h 1227707"/>
                <a:gd name="connsiteX5" fmla="*/ 2734 w 1529994"/>
                <a:gd name="connsiteY5" fmla="*/ 716310 h 1227707"/>
                <a:gd name="connsiteX0" fmla="*/ 2734 w 1529994"/>
                <a:gd name="connsiteY0" fmla="*/ 716310 h 1245705"/>
                <a:gd name="connsiteX1" fmla="*/ 805982 w 1529994"/>
                <a:gd name="connsiteY1" fmla="*/ 8930 h 1245705"/>
                <a:gd name="connsiteX2" fmla="*/ 1228952 w 1529994"/>
                <a:gd name="connsiteY2" fmla="*/ 343303 h 1245705"/>
                <a:gd name="connsiteX3" fmla="*/ 1504297 w 1529994"/>
                <a:gd name="connsiteY3" fmla="*/ 1001123 h 1245705"/>
                <a:gd name="connsiteX4" fmla="*/ 1105784 w 1529994"/>
                <a:gd name="connsiteY4" fmla="*/ 1213828 h 1245705"/>
                <a:gd name="connsiteX5" fmla="*/ 2734 w 1529994"/>
                <a:gd name="connsiteY5" fmla="*/ 716310 h 1245705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1106041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2991 w 1530251"/>
                <a:gd name="connsiteY0" fmla="*/ 716310 h 1357514"/>
                <a:gd name="connsiteX1" fmla="*/ 806239 w 1530251"/>
                <a:gd name="connsiteY1" fmla="*/ 8930 h 1357514"/>
                <a:gd name="connsiteX2" fmla="*/ 1229209 w 1530251"/>
                <a:gd name="connsiteY2" fmla="*/ 343303 h 1357514"/>
                <a:gd name="connsiteX3" fmla="*/ 1504554 w 1530251"/>
                <a:gd name="connsiteY3" fmla="*/ 1001123 h 1357514"/>
                <a:gd name="connsiteX4" fmla="*/ 896178 w 1530251"/>
                <a:gd name="connsiteY4" fmla="*/ 1213828 h 1357514"/>
                <a:gd name="connsiteX5" fmla="*/ 554652 w 1530251"/>
                <a:gd name="connsiteY5" fmla="*/ 1332654 h 1357514"/>
                <a:gd name="connsiteX6" fmla="*/ 2991 w 1530251"/>
                <a:gd name="connsiteY6" fmla="*/ 716310 h 1357514"/>
                <a:gd name="connsiteX0" fmla="*/ 11615 w 1538875"/>
                <a:gd name="connsiteY0" fmla="*/ 716310 h 1352533"/>
                <a:gd name="connsiteX1" fmla="*/ 814863 w 1538875"/>
                <a:gd name="connsiteY1" fmla="*/ 8930 h 1352533"/>
                <a:gd name="connsiteX2" fmla="*/ 1237833 w 1538875"/>
                <a:gd name="connsiteY2" fmla="*/ 343303 h 1352533"/>
                <a:gd name="connsiteX3" fmla="*/ 1513178 w 1538875"/>
                <a:gd name="connsiteY3" fmla="*/ 1001123 h 1352533"/>
                <a:gd name="connsiteX4" fmla="*/ 904802 w 1538875"/>
                <a:gd name="connsiteY4" fmla="*/ 1213828 h 1352533"/>
                <a:gd name="connsiteX5" fmla="*/ 563276 w 1538875"/>
                <a:gd name="connsiteY5" fmla="*/ 1332654 h 1352533"/>
                <a:gd name="connsiteX6" fmla="*/ 353414 w 1538875"/>
                <a:gd name="connsiteY6" fmla="*/ 1197742 h 1352533"/>
                <a:gd name="connsiteX7" fmla="*/ 11615 w 1538875"/>
                <a:gd name="connsiteY7" fmla="*/ 716310 h 1352533"/>
                <a:gd name="connsiteX0" fmla="*/ 57357 w 1254833"/>
                <a:gd name="connsiteY0" fmla="*/ 438457 h 1344503"/>
                <a:gd name="connsiteX1" fmla="*/ 530821 w 1254833"/>
                <a:gd name="connsiteY1" fmla="*/ 900 h 1344503"/>
                <a:gd name="connsiteX2" fmla="*/ 953791 w 1254833"/>
                <a:gd name="connsiteY2" fmla="*/ 335273 h 1344503"/>
                <a:gd name="connsiteX3" fmla="*/ 1229136 w 1254833"/>
                <a:gd name="connsiteY3" fmla="*/ 993093 h 1344503"/>
                <a:gd name="connsiteX4" fmla="*/ 620760 w 1254833"/>
                <a:gd name="connsiteY4" fmla="*/ 1205798 h 1344503"/>
                <a:gd name="connsiteX5" fmla="*/ 279234 w 1254833"/>
                <a:gd name="connsiteY5" fmla="*/ 1324624 h 1344503"/>
                <a:gd name="connsiteX6" fmla="*/ 69372 w 1254833"/>
                <a:gd name="connsiteY6" fmla="*/ 1189712 h 1344503"/>
                <a:gd name="connsiteX7" fmla="*/ 57357 w 1254833"/>
                <a:gd name="connsiteY7" fmla="*/ 438457 h 1344503"/>
                <a:gd name="connsiteX0" fmla="*/ 113768 w 1311244"/>
                <a:gd name="connsiteY0" fmla="*/ 438457 h 1344503"/>
                <a:gd name="connsiteX1" fmla="*/ 587232 w 1311244"/>
                <a:gd name="connsiteY1" fmla="*/ 900 h 1344503"/>
                <a:gd name="connsiteX2" fmla="*/ 1010202 w 1311244"/>
                <a:gd name="connsiteY2" fmla="*/ 335273 h 1344503"/>
                <a:gd name="connsiteX3" fmla="*/ 1285547 w 1311244"/>
                <a:gd name="connsiteY3" fmla="*/ 993093 h 1344503"/>
                <a:gd name="connsiteX4" fmla="*/ 677171 w 1311244"/>
                <a:gd name="connsiteY4" fmla="*/ 1205798 h 1344503"/>
                <a:gd name="connsiteX5" fmla="*/ 335645 w 1311244"/>
                <a:gd name="connsiteY5" fmla="*/ 1324624 h 1344503"/>
                <a:gd name="connsiteX6" fmla="*/ 125783 w 1311244"/>
                <a:gd name="connsiteY6" fmla="*/ 1189712 h 1344503"/>
                <a:gd name="connsiteX7" fmla="*/ 113768 w 1311244"/>
                <a:gd name="connsiteY7" fmla="*/ 438457 h 1344503"/>
                <a:gd name="connsiteX0" fmla="*/ 58531 w 1256007"/>
                <a:gd name="connsiteY0" fmla="*/ 442213 h 1348259"/>
                <a:gd name="connsiteX1" fmla="*/ 550231 w 1256007"/>
                <a:gd name="connsiteY1" fmla="*/ 593862 h 1348259"/>
                <a:gd name="connsiteX2" fmla="*/ 531995 w 1256007"/>
                <a:gd name="connsiteY2" fmla="*/ 4656 h 1348259"/>
                <a:gd name="connsiteX3" fmla="*/ 954965 w 1256007"/>
                <a:gd name="connsiteY3" fmla="*/ 339029 h 1348259"/>
                <a:gd name="connsiteX4" fmla="*/ 1230310 w 1256007"/>
                <a:gd name="connsiteY4" fmla="*/ 996849 h 1348259"/>
                <a:gd name="connsiteX5" fmla="*/ 621934 w 1256007"/>
                <a:gd name="connsiteY5" fmla="*/ 1209554 h 1348259"/>
                <a:gd name="connsiteX6" fmla="*/ 280408 w 1256007"/>
                <a:gd name="connsiteY6" fmla="*/ 1328380 h 1348259"/>
                <a:gd name="connsiteX7" fmla="*/ 70546 w 1256007"/>
                <a:gd name="connsiteY7" fmla="*/ 1193468 h 1348259"/>
                <a:gd name="connsiteX8" fmla="*/ 58531 w 1256007"/>
                <a:gd name="connsiteY8" fmla="*/ 442213 h 1348259"/>
                <a:gd name="connsiteX0" fmla="*/ 45688 w 1243164"/>
                <a:gd name="connsiteY0" fmla="*/ 442559 h 1348605"/>
                <a:gd name="connsiteX1" fmla="*/ 327526 w 1243164"/>
                <a:gd name="connsiteY1" fmla="*/ 159493 h 1348605"/>
                <a:gd name="connsiteX2" fmla="*/ 519152 w 1243164"/>
                <a:gd name="connsiteY2" fmla="*/ 5002 h 1348605"/>
                <a:gd name="connsiteX3" fmla="*/ 942122 w 1243164"/>
                <a:gd name="connsiteY3" fmla="*/ 339375 h 1348605"/>
                <a:gd name="connsiteX4" fmla="*/ 1217467 w 1243164"/>
                <a:gd name="connsiteY4" fmla="*/ 997195 h 1348605"/>
                <a:gd name="connsiteX5" fmla="*/ 609091 w 1243164"/>
                <a:gd name="connsiteY5" fmla="*/ 1209900 h 1348605"/>
                <a:gd name="connsiteX6" fmla="*/ 267565 w 1243164"/>
                <a:gd name="connsiteY6" fmla="*/ 1328726 h 1348605"/>
                <a:gd name="connsiteX7" fmla="*/ 57703 w 1243164"/>
                <a:gd name="connsiteY7" fmla="*/ 1193814 h 1348605"/>
                <a:gd name="connsiteX8" fmla="*/ 45688 w 1243164"/>
                <a:gd name="connsiteY8" fmla="*/ 442559 h 1348605"/>
                <a:gd name="connsiteX0" fmla="*/ 8444 w 1385802"/>
                <a:gd name="connsiteY0" fmla="*/ 472540 h 1348605"/>
                <a:gd name="connsiteX1" fmla="*/ 470164 w 1385802"/>
                <a:gd name="connsiteY1" fmla="*/ 159493 h 1348605"/>
                <a:gd name="connsiteX2" fmla="*/ 661790 w 1385802"/>
                <a:gd name="connsiteY2" fmla="*/ 5002 h 1348605"/>
                <a:gd name="connsiteX3" fmla="*/ 1084760 w 1385802"/>
                <a:gd name="connsiteY3" fmla="*/ 339375 h 1348605"/>
                <a:gd name="connsiteX4" fmla="*/ 1360105 w 1385802"/>
                <a:gd name="connsiteY4" fmla="*/ 997195 h 1348605"/>
                <a:gd name="connsiteX5" fmla="*/ 751729 w 1385802"/>
                <a:gd name="connsiteY5" fmla="*/ 1209900 h 1348605"/>
                <a:gd name="connsiteX6" fmla="*/ 410203 w 1385802"/>
                <a:gd name="connsiteY6" fmla="*/ 1328726 h 1348605"/>
                <a:gd name="connsiteX7" fmla="*/ 200341 w 1385802"/>
                <a:gd name="connsiteY7" fmla="*/ 1193814 h 1348605"/>
                <a:gd name="connsiteX8" fmla="*/ 8444 w 1385802"/>
                <a:gd name="connsiteY8" fmla="*/ 472540 h 1348605"/>
                <a:gd name="connsiteX0" fmla="*/ 5659 w 1383017"/>
                <a:gd name="connsiteY0" fmla="*/ 468392 h 1344457"/>
                <a:gd name="connsiteX1" fmla="*/ 407418 w 1383017"/>
                <a:gd name="connsiteY1" fmla="*/ 245286 h 1344457"/>
                <a:gd name="connsiteX2" fmla="*/ 659005 w 1383017"/>
                <a:gd name="connsiteY2" fmla="*/ 854 h 1344457"/>
                <a:gd name="connsiteX3" fmla="*/ 1081975 w 1383017"/>
                <a:gd name="connsiteY3" fmla="*/ 335227 h 1344457"/>
                <a:gd name="connsiteX4" fmla="*/ 1357320 w 1383017"/>
                <a:gd name="connsiteY4" fmla="*/ 993047 h 1344457"/>
                <a:gd name="connsiteX5" fmla="*/ 748944 w 1383017"/>
                <a:gd name="connsiteY5" fmla="*/ 1205752 h 1344457"/>
                <a:gd name="connsiteX6" fmla="*/ 407418 w 1383017"/>
                <a:gd name="connsiteY6" fmla="*/ 1324578 h 1344457"/>
                <a:gd name="connsiteX7" fmla="*/ 197556 w 1383017"/>
                <a:gd name="connsiteY7" fmla="*/ 1189666 h 1344457"/>
                <a:gd name="connsiteX8" fmla="*/ 5659 w 1383017"/>
                <a:gd name="connsiteY8" fmla="*/ 468392 h 1344457"/>
                <a:gd name="connsiteX0" fmla="*/ 12404 w 1389762"/>
                <a:gd name="connsiteY0" fmla="*/ 468392 h 1344457"/>
                <a:gd name="connsiteX1" fmla="*/ 414163 w 1389762"/>
                <a:gd name="connsiteY1" fmla="*/ 245286 h 1344457"/>
                <a:gd name="connsiteX2" fmla="*/ 665750 w 1389762"/>
                <a:gd name="connsiteY2" fmla="*/ 854 h 1344457"/>
                <a:gd name="connsiteX3" fmla="*/ 1088720 w 1389762"/>
                <a:gd name="connsiteY3" fmla="*/ 335227 h 1344457"/>
                <a:gd name="connsiteX4" fmla="*/ 1364065 w 1389762"/>
                <a:gd name="connsiteY4" fmla="*/ 993047 h 1344457"/>
                <a:gd name="connsiteX5" fmla="*/ 755689 w 1389762"/>
                <a:gd name="connsiteY5" fmla="*/ 1205752 h 1344457"/>
                <a:gd name="connsiteX6" fmla="*/ 414163 w 1389762"/>
                <a:gd name="connsiteY6" fmla="*/ 1324578 h 1344457"/>
                <a:gd name="connsiteX7" fmla="*/ 144341 w 1389762"/>
                <a:gd name="connsiteY7" fmla="*/ 769941 h 1344457"/>
                <a:gd name="connsiteX8" fmla="*/ 12404 w 1389762"/>
                <a:gd name="connsiteY8" fmla="*/ 468392 h 1344457"/>
                <a:gd name="connsiteX0" fmla="*/ 12404 w 1389762"/>
                <a:gd name="connsiteY0" fmla="*/ 468392 h 1209184"/>
                <a:gd name="connsiteX1" fmla="*/ 414163 w 1389762"/>
                <a:gd name="connsiteY1" fmla="*/ 245286 h 1209184"/>
                <a:gd name="connsiteX2" fmla="*/ 665750 w 1389762"/>
                <a:gd name="connsiteY2" fmla="*/ 854 h 1209184"/>
                <a:gd name="connsiteX3" fmla="*/ 1088720 w 1389762"/>
                <a:gd name="connsiteY3" fmla="*/ 335227 h 1209184"/>
                <a:gd name="connsiteX4" fmla="*/ 1364065 w 1389762"/>
                <a:gd name="connsiteY4" fmla="*/ 993047 h 1209184"/>
                <a:gd name="connsiteX5" fmla="*/ 755689 w 1389762"/>
                <a:gd name="connsiteY5" fmla="*/ 1205752 h 1209184"/>
                <a:gd name="connsiteX6" fmla="*/ 459134 w 1389762"/>
                <a:gd name="connsiteY6" fmla="*/ 1099726 h 1209184"/>
                <a:gd name="connsiteX7" fmla="*/ 144341 w 1389762"/>
                <a:gd name="connsiteY7" fmla="*/ 769941 h 1209184"/>
                <a:gd name="connsiteX8" fmla="*/ 12404 w 1389762"/>
                <a:gd name="connsiteY8" fmla="*/ 468392 h 1209184"/>
                <a:gd name="connsiteX0" fmla="*/ 12404 w 1389762"/>
                <a:gd name="connsiteY0" fmla="*/ 468392 h 1115450"/>
                <a:gd name="connsiteX1" fmla="*/ 414163 w 1389762"/>
                <a:gd name="connsiteY1" fmla="*/ 245286 h 1115450"/>
                <a:gd name="connsiteX2" fmla="*/ 665750 w 1389762"/>
                <a:gd name="connsiteY2" fmla="*/ 854 h 1115450"/>
                <a:gd name="connsiteX3" fmla="*/ 1088720 w 1389762"/>
                <a:gd name="connsiteY3" fmla="*/ 335227 h 1115450"/>
                <a:gd name="connsiteX4" fmla="*/ 1364065 w 1389762"/>
                <a:gd name="connsiteY4" fmla="*/ 993047 h 1115450"/>
                <a:gd name="connsiteX5" fmla="*/ 800660 w 1389762"/>
                <a:gd name="connsiteY5" fmla="*/ 965909 h 1115450"/>
                <a:gd name="connsiteX6" fmla="*/ 459134 w 1389762"/>
                <a:gd name="connsiteY6" fmla="*/ 1099726 h 1115450"/>
                <a:gd name="connsiteX7" fmla="*/ 144341 w 1389762"/>
                <a:gd name="connsiteY7" fmla="*/ 769941 h 1115450"/>
                <a:gd name="connsiteX8" fmla="*/ 12404 w 1389762"/>
                <a:gd name="connsiteY8" fmla="*/ 468392 h 1115450"/>
                <a:gd name="connsiteX0" fmla="*/ 12404 w 1186175"/>
                <a:gd name="connsiteY0" fmla="*/ 468392 h 1118803"/>
                <a:gd name="connsiteX1" fmla="*/ 414163 w 1186175"/>
                <a:gd name="connsiteY1" fmla="*/ 245286 h 1118803"/>
                <a:gd name="connsiteX2" fmla="*/ 665750 w 1186175"/>
                <a:gd name="connsiteY2" fmla="*/ 854 h 1118803"/>
                <a:gd name="connsiteX3" fmla="*/ 1088720 w 1186175"/>
                <a:gd name="connsiteY3" fmla="*/ 335227 h 1118803"/>
                <a:gd name="connsiteX4" fmla="*/ 1109232 w 1186175"/>
                <a:gd name="connsiteY4" fmla="*/ 723225 h 1118803"/>
                <a:gd name="connsiteX5" fmla="*/ 800660 w 1186175"/>
                <a:gd name="connsiteY5" fmla="*/ 965909 h 1118803"/>
                <a:gd name="connsiteX6" fmla="*/ 459134 w 1186175"/>
                <a:gd name="connsiteY6" fmla="*/ 1099726 h 1118803"/>
                <a:gd name="connsiteX7" fmla="*/ 144341 w 1186175"/>
                <a:gd name="connsiteY7" fmla="*/ 769941 h 1118803"/>
                <a:gd name="connsiteX8" fmla="*/ 12404 w 1186175"/>
                <a:gd name="connsiteY8" fmla="*/ 468392 h 1118803"/>
                <a:gd name="connsiteX0" fmla="*/ 12404 w 1168638"/>
                <a:gd name="connsiteY0" fmla="*/ 469718 h 1120129"/>
                <a:gd name="connsiteX1" fmla="*/ 414163 w 1168638"/>
                <a:gd name="connsiteY1" fmla="*/ 246612 h 1120129"/>
                <a:gd name="connsiteX2" fmla="*/ 665750 w 1168638"/>
                <a:gd name="connsiteY2" fmla="*/ 2180 h 1120129"/>
                <a:gd name="connsiteX3" fmla="*/ 1043750 w 1168638"/>
                <a:gd name="connsiteY3" fmla="*/ 396514 h 1120129"/>
                <a:gd name="connsiteX4" fmla="*/ 1109232 w 1168638"/>
                <a:gd name="connsiteY4" fmla="*/ 724551 h 1120129"/>
                <a:gd name="connsiteX5" fmla="*/ 800660 w 1168638"/>
                <a:gd name="connsiteY5" fmla="*/ 967235 h 1120129"/>
                <a:gd name="connsiteX6" fmla="*/ 459134 w 1168638"/>
                <a:gd name="connsiteY6" fmla="*/ 1101052 h 1120129"/>
                <a:gd name="connsiteX7" fmla="*/ 144341 w 1168638"/>
                <a:gd name="connsiteY7" fmla="*/ 771267 h 1120129"/>
                <a:gd name="connsiteX8" fmla="*/ 12404 w 1168638"/>
                <a:gd name="connsiteY8" fmla="*/ 469718 h 1120129"/>
                <a:gd name="connsiteX0" fmla="*/ 12404 w 1151810"/>
                <a:gd name="connsiteY0" fmla="*/ 481516 h 1131927"/>
                <a:gd name="connsiteX1" fmla="*/ 414163 w 1151810"/>
                <a:gd name="connsiteY1" fmla="*/ 258410 h 1131927"/>
                <a:gd name="connsiteX2" fmla="*/ 665750 w 1151810"/>
                <a:gd name="connsiteY2" fmla="*/ 13978 h 1131927"/>
                <a:gd name="connsiteX3" fmla="*/ 943005 w 1151810"/>
                <a:gd name="connsiteY3" fmla="*/ 70656 h 1131927"/>
                <a:gd name="connsiteX4" fmla="*/ 1043750 w 1151810"/>
                <a:gd name="connsiteY4" fmla="*/ 408312 h 1131927"/>
                <a:gd name="connsiteX5" fmla="*/ 1109232 w 1151810"/>
                <a:gd name="connsiteY5" fmla="*/ 736349 h 1131927"/>
                <a:gd name="connsiteX6" fmla="*/ 800660 w 1151810"/>
                <a:gd name="connsiteY6" fmla="*/ 979033 h 1131927"/>
                <a:gd name="connsiteX7" fmla="*/ 459134 w 1151810"/>
                <a:gd name="connsiteY7" fmla="*/ 1112850 h 1131927"/>
                <a:gd name="connsiteX8" fmla="*/ 144341 w 1151810"/>
                <a:gd name="connsiteY8" fmla="*/ 783065 h 1131927"/>
                <a:gd name="connsiteX9" fmla="*/ 12404 w 1151810"/>
                <a:gd name="connsiteY9" fmla="*/ 481516 h 1131927"/>
                <a:gd name="connsiteX0" fmla="*/ 12404 w 1151810"/>
                <a:gd name="connsiteY0" fmla="*/ 519408 h 1169819"/>
                <a:gd name="connsiteX1" fmla="*/ 414163 w 1151810"/>
                <a:gd name="connsiteY1" fmla="*/ 296302 h 1169819"/>
                <a:gd name="connsiteX2" fmla="*/ 569258 w 1151810"/>
                <a:gd name="connsiteY2" fmla="*/ 8003 h 1169819"/>
                <a:gd name="connsiteX3" fmla="*/ 943005 w 1151810"/>
                <a:gd name="connsiteY3" fmla="*/ 108548 h 1169819"/>
                <a:gd name="connsiteX4" fmla="*/ 1043750 w 1151810"/>
                <a:gd name="connsiteY4" fmla="*/ 446204 h 1169819"/>
                <a:gd name="connsiteX5" fmla="*/ 1109232 w 1151810"/>
                <a:gd name="connsiteY5" fmla="*/ 774241 h 1169819"/>
                <a:gd name="connsiteX6" fmla="*/ 800660 w 1151810"/>
                <a:gd name="connsiteY6" fmla="*/ 1016925 h 1169819"/>
                <a:gd name="connsiteX7" fmla="*/ 459134 w 1151810"/>
                <a:gd name="connsiteY7" fmla="*/ 1150742 h 1169819"/>
                <a:gd name="connsiteX8" fmla="*/ 144341 w 1151810"/>
                <a:gd name="connsiteY8" fmla="*/ 820957 h 1169819"/>
                <a:gd name="connsiteX9" fmla="*/ 12404 w 1151810"/>
                <a:gd name="connsiteY9" fmla="*/ 519408 h 1169819"/>
                <a:gd name="connsiteX0" fmla="*/ 6666 w 1146072"/>
                <a:gd name="connsiteY0" fmla="*/ 516873 h 1167284"/>
                <a:gd name="connsiteX1" fmla="*/ 311932 w 1146072"/>
                <a:gd name="connsiteY1" fmla="*/ 249899 h 1167284"/>
                <a:gd name="connsiteX2" fmla="*/ 563520 w 1146072"/>
                <a:gd name="connsiteY2" fmla="*/ 5468 h 1167284"/>
                <a:gd name="connsiteX3" fmla="*/ 937267 w 1146072"/>
                <a:gd name="connsiteY3" fmla="*/ 106013 h 1167284"/>
                <a:gd name="connsiteX4" fmla="*/ 1038012 w 1146072"/>
                <a:gd name="connsiteY4" fmla="*/ 443669 h 1167284"/>
                <a:gd name="connsiteX5" fmla="*/ 1103494 w 1146072"/>
                <a:gd name="connsiteY5" fmla="*/ 771706 h 1167284"/>
                <a:gd name="connsiteX6" fmla="*/ 794922 w 1146072"/>
                <a:gd name="connsiteY6" fmla="*/ 1014390 h 1167284"/>
                <a:gd name="connsiteX7" fmla="*/ 453396 w 1146072"/>
                <a:gd name="connsiteY7" fmla="*/ 1148207 h 1167284"/>
                <a:gd name="connsiteX8" fmla="*/ 138603 w 1146072"/>
                <a:gd name="connsiteY8" fmla="*/ 818422 h 1167284"/>
                <a:gd name="connsiteX9" fmla="*/ 6666 w 1146072"/>
                <a:gd name="connsiteY9" fmla="*/ 516873 h 1167284"/>
                <a:gd name="connsiteX0" fmla="*/ 29346 w 1068748"/>
                <a:gd name="connsiteY0" fmla="*/ 527406 h 1167284"/>
                <a:gd name="connsiteX1" fmla="*/ 234608 w 1068748"/>
                <a:gd name="connsiteY1" fmla="*/ 249899 h 1167284"/>
                <a:gd name="connsiteX2" fmla="*/ 486196 w 1068748"/>
                <a:gd name="connsiteY2" fmla="*/ 5468 h 1167284"/>
                <a:gd name="connsiteX3" fmla="*/ 859943 w 1068748"/>
                <a:gd name="connsiteY3" fmla="*/ 106013 h 1167284"/>
                <a:gd name="connsiteX4" fmla="*/ 960688 w 1068748"/>
                <a:gd name="connsiteY4" fmla="*/ 443669 h 1167284"/>
                <a:gd name="connsiteX5" fmla="*/ 1026170 w 1068748"/>
                <a:gd name="connsiteY5" fmla="*/ 771706 h 1167284"/>
                <a:gd name="connsiteX6" fmla="*/ 717598 w 1068748"/>
                <a:gd name="connsiteY6" fmla="*/ 1014390 h 1167284"/>
                <a:gd name="connsiteX7" fmla="*/ 376072 w 1068748"/>
                <a:gd name="connsiteY7" fmla="*/ 1148207 h 1167284"/>
                <a:gd name="connsiteX8" fmla="*/ 61279 w 1068748"/>
                <a:gd name="connsiteY8" fmla="*/ 818422 h 1167284"/>
                <a:gd name="connsiteX9" fmla="*/ 29346 w 1068748"/>
                <a:gd name="connsiteY9" fmla="*/ 527406 h 1167284"/>
                <a:gd name="connsiteX0" fmla="*/ 29346 w 993802"/>
                <a:gd name="connsiteY0" fmla="*/ 527406 h 1165877"/>
                <a:gd name="connsiteX1" fmla="*/ 234608 w 993802"/>
                <a:gd name="connsiteY1" fmla="*/ 249899 h 1165877"/>
                <a:gd name="connsiteX2" fmla="*/ 486196 w 993802"/>
                <a:gd name="connsiteY2" fmla="*/ 5468 h 1165877"/>
                <a:gd name="connsiteX3" fmla="*/ 859943 w 993802"/>
                <a:gd name="connsiteY3" fmla="*/ 106013 h 1165877"/>
                <a:gd name="connsiteX4" fmla="*/ 960688 w 993802"/>
                <a:gd name="connsiteY4" fmla="*/ 443669 h 1165877"/>
                <a:gd name="connsiteX5" fmla="*/ 907562 w 993802"/>
                <a:gd name="connsiteY5" fmla="*/ 873808 h 1165877"/>
                <a:gd name="connsiteX6" fmla="*/ 717598 w 993802"/>
                <a:gd name="connsiteY6" fmla="*/ 1014390 h 1165877"/>
                <a:gd name="connsiteX7" fmla="*/ 376072 w 993802"/>
                <a:gd name="connsiteY7" fmla="*/ 1148207 h 1165877"/>
                <a:gd name="connsiteX8" fmla="*/ 61279 w 993802"/>
                <a:gd name="connsiteY8" fmla="*/ 818422 h 1165877"/>
                <a:gd name="connsiteX9" fmla="*/ 29346 w 993802"/>
                <a:gd name="connsiteY9" fmla="*/ 527406 h 1165877"/>
                <a:gd name="connsiteX0" fmla="*/ 29346 w 993802"/>
                <a:gd name="connsiteY0" fmla="*/ 527406 h 1030692"/>
                <a:gd name="connsiteX1" fmla="*/ 234608 w 993802"/>
                <a:gd name="connsiteY1" fmla="*/ 249899 h 1030692"/>
                <a:gd name="connsiteX2" fmla="*/ 486196 w 993802"/>
                <a:gd name="connsiteY2" fmla="*/ 5468 h 1030692"/>
                <a:gd name="connsiteX3" fmla="*/ 859943 w 993802"/>
                <a:gd name="connsiteY3" fmla="*/ 106013 h 1030692"/>
                <a:gd name="connsiteX4" fmla="*/ 960688 w 993802"/>
                <a:gd name="connsiteY4" fmla="*/ 443669 h 1030692"/>
                <a:gd name="connsiteX5" fmla="*/ 907562 w 993802"/>
                <a:gd name="connsiteY5" fmla="*/ 873808 h 1030692"/>
                <a:gd name="connsiteX6" fmla="*/ 717598 w 993802"/>
                <a:gd name="connsiteY6" fmla="*/ 1014390 h 1030692"/>
                <a:gd name="connsiteX7" fmla="*/ 313641 w 993802"/>
                <a:gd name="connsiteY7" fmla="*/ 716955 h 1030692"/>
                <a:gd name="connsiteX8" fmla="*/ 61279 w 993802"/>
                <a:gd name="connsiteY8" fmla="*/ 818422 h 1030692"/>
                <a:gd name="connsiteX9" fmla="*/ 29346 w 993802"/>
                <a:gd name="connsiteY9" fmla="*/ 527406 h 1030692"/>
                <a:gd name="connsiteX0" fmla="*/ 29346 w 993802"/>
                <a:gd name="connsiteY0" fmla="*/ 527406 h 1020498"/>
                <a:gd name="connsiteX1" fmla="*/ 234608 w 993802"/>
                <a:gd name="connsiteY1" fmla="*/ 249899 h 1020498"/>
                <a:gd name="connsiteX2" fmla="*/ 486196 w 993802"/>
                <a:gd name="connsiteY2" fmla="*/ 5468 h 1020498"/>
                <a:gd name="connsiteX3" fmla="*/ 859943 w 993802"/>
                <a:gd name="connsiteY3" fmla="*/ 106013 h 1020498"/>
                <a:gd name="connsiteX4" fmla="*/ 960688 w 993802"/>
                <a:gd name="connsiteY4" fmla="*/ 443669 h 1020498"/>
                <a:gd name="connsiteX5" fmla="*/ 907562 w 993802"/>
                <a:gd name="connsiteY5" fmla="*/ 873808 h 1020498"/>
                <a:gd name="connsiteX6" fmla="*/ 717598 w 993802"/>
                <a:gd name="connsiteY6" fmla="*/ 1014390 h 1020498"/>
                <a:gd name="connsiteX7" fmla="*/ 458213 w 993802"/>
                <a:gd name="connsiteY7" fmla="*/ 966915 h 1020498"/>
                <a:gd name="connsiteX8" fmla="*/ 313641 w 993802"/>
                <a:gd name="connsiteY8" fmla="*/ 716955 h 1020498"/>
                <a:gd name="connsiteX9" fmla="*/ 61279 w 993802"/>
                <a:gd name="connsiteY9" fmla="*/ 818422 h 1020498"/>
                <a:gd name="connsiteX10" fmla="*/ 29346 w 993802"/>
                <a:gd name="connsiteY10" fmla="*/ 527406 h 1020498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308280 w 988441"/>
                <a:gd name="connsiteY8" fmla="*/ 714050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17593"/>
                <a:gd name="connsiteX1" fmla="*/ 140825 w 988441"/>
                <a:gd name="connsiteY1" fmla="*/ 190495 h 1017593"/>
                <a:gd name="connsiteX2" fmla="*/ 480835 w 988441"/>
                <a:gd name="connsiteY2" fmla="*/ 2563 h 1017593"/>
                <a:gd name="connsiteX3" fmla="*/ 854582 w 988441"/>
                <a:gd name="connsiteY3" fmla="*/ 103108 h 1017593"/>
                <a:gd name="connsiteX4" fmla="*/ 955327 w 988441"/>
                <a:gd name="connsiteY4" fmla="*/ 440764 h 1017593"/>
                <a:gd name="connsiteX5" fmla="*/ 902201 w 988441"/>
                <a:gd name="connsiteY5" fmla="*/ 870903 h 1017593"/>
                <a:gd name="connsiteX6" fmla="*/ 712237 w 988441"/>
                <a:gd name="connsiteY6" fmla="*/ 1011485 h 1017593"/>
                <a:gd name="connsiteX7" fmla="*/ 452852 w 988441"/>
                <a:gd name="connsiteY7" fmla="*/ 964010 h 1017593"/>
                <a:gd name="connsiteX8" fmla="*/ 229664 w 988441"/>
                <a:gd name="connsiteY8" fmla="*/ 948443 h 1017593"/>
                <a:gd name="connsiteX9" fmla="*/ 55918 w 988441"/>
                <a:gd name="connsiteY9" fmla="*/ 815517 h 1017593"/>
                <a:gd name="connsiteX10" fmla="*/ 23985 w 988441"/>
                <a:gd name="connsiteY10" fmla="*/ 524501 h 1017593"/>
                <a:gd name="connsiteX0" fmla="*/ 23985 w 988441"/>
                <a:gd name="connsiteY0" fmla="*/ 524501 h 1058348"/>
                <a:gd name="connsiteX1" fmla="*/ 140825 w 988441"/>
                <a:gd name="connsiteY1" fmla="*/ 190495 h 1058348"/>
                <a:gd name="connsiteX2" fmla="*/ 480835 w 988441"/>
                <a:gd name="connsiteY2" fmla="*/ 2563 h 1058348"/>
                <a:gd name="connsiteX3" fmla="*/ 854582 w 988441"/>
                <a:gd name="connsiteY3" fmla="*/ 103108 h 1058348"/>
                <a:gd name="connsiteX4" fmla="*/ 955327 w 988441"/>
                <a:gd name="connsiteY4" fmla="*/ 440764 h 1058348"/>
                <a:gd name="connsiteX5" fmla="*/ 902201 w 988441"/>
                <a:gd name="connsiteY5" fmla="*/ 870903 h 1058348"/>
                <a:gd name="connsiteX6" fmla="*/ 712237 w 988441"/>
                <a:gd name="connsiteY6" fmla="*/ 1011485 h 1058348"/>
                <a:gd name="connsiteX7" fmla="*/ 566538 w 988441"/>
                <a:gd name="connsiteY7" fmla="*/ 1036652 h 1058348"/>
                <a:gd name="connsiteX8" fmla="*/ 229664 w 988441"/>
                <a:gd name="connsiteY8" fmla="*/ 948443 h 1058348"/>
                <a:gd name="connsiteX9" fmla="*/ 55918 w 988441"/>
                <a:gd name="connsiteY9" fmla="*/ 815517 h 1058348"/>
                <a:gd name="connsiteX10" fmla="*/ 23985 w 988441"/>
                <a:gd name="connsiteY10" fmla="*/ 524501 h 1058348"/>
                <a:gd name="connsiteX0" fmla="*/ 23985 w 1113709"/>
                <a:gd name="connsiteY0" fmla="*/ 524501 h 1059352"/>
                <a:gd name="connsiteX1" fmla="*/ 140825 w 1113709"/>
                <a:gd name="connsiteY1" fmla="*/ 190495 h 1059352"/>
                <a:gd name="connsiteX2" fmla="*/ 480835 w 1113709"/>
                <a:gd name="connsiteY2" fmla="*/ 2563 h 1059352"/>
                <a:gd name="connsiteX3" fmla="*/ 854582 w 1113709"/>
                <a:gd name="connsiteY3" fmla="*/ 103108 h 1059352"/>
                <a:gd name="connsiteX4" fmla="*/ 955327 w 1113709"/>
                <a:gd name="connsiteY4" fmla="*/ 440764 h 1059352"/>
                <a:gd name="connsiteX5" fmla="*/ 1080457 w 1113709"/>
                <a:gd name="connsiteY5" fmla="*/ 842493 h 1059352"/>
                <a:gd name="connsiteX6" fmla="*/ 712237 w 1113709"/>
                <a:gd name="connsiteY6" fmla="*/ 1011485 h 1059352"/>
                <a:gd name="connsiteX7" fmla="*/ 566538 w 1113709"/>
                <a:gd name="connsiteY7" fmla="*/ 1036652 h 1059352"/>
                <a:gd name="connsiteX8" fmla="*/ 229664 w 1113709"/>
                <a:gd name="connsiteY8" fmla="*/ 948443 h 1059352"/>
                <a:gd name="connsiteX9" fmla="*/ 55918 w 1113709"/>
                <a:gd name="connsiteY9" fmla="*/ 815517 h 1059352"/>
                <a:gd name="connsiteX10" fmla="*/ 23985 w 1113709"/>
                <a:gd name="connsiteY10" fmla="*/ 524501 h 1059352"/>
                <a:gd name="connsiteX0" fmla="*/ 23985 w 1113709"/>
                <a:gd name="connsiteY0" fmla="*/ 456644 h 991495"/>
                <a:gd name="connsiteX1" fmla="*/ 140825 w 1113709"/>
                <a:gd name="connsiteY1" fmla="*/ 122638 h 991495"/>
                <a:gd name="connsiteX2" fmla="*/ 403633 w 1113709"/>
                <a:gd name="connsiteY2" fmla="*/ 27688 h 991495"/>
                <a:gd name="connsiteX3" fmla="*/ 854582 w 1113709"/>
                <a:gd name="connsiteY3" fmla="*/ 35251 h 991495"/>
                <a:gd name="connsiteX4" fmla="*/ 955327 w 1113709"/>
                <a:gd name="connsiteY4" fmla="*/ 372907 h 991495"/>
                <a:gd name="connsiteX5" fmla="*/ 1080457 w 1113709"/>
                <a:gd name="connsiteY5" fmla="*/ 774636 h 991495"/>
                <a:gd name="connsiteX6" fmla="*/ 712237 w 1113709"/>
                <a:gd name="connsiteY6" fmla="*/ 943628 h 991495"/>
                <a:gd name="connsiteX7" fmla="*/ 566538 w 1113709"/>
                <a:gd name="connsiteY7" fmla="*/ 968795 h 991495"/>
                <a:gd name="connsiteX8" fmla="*/ 229664 w 1113709"/>
                <a:gd name="connsiteY8" fmla="*/ 880586 h 991495"/>
                <a:gd name="connsiteX9" fmla="*/ 55918 w 1113709"/>
                <a:gd name="connsiteY9" fmla="*/ 747660 h 991495"/>
                <a:gd name="connsiteX10" fmla="*/ 23985 w 1113709"/>
                <a:gd name="connsiteY10" fmla="*/ 456644 h 991495"/>
                <a:gd name="connsiteX0" fmla="*/ 23985 w 1113709"/>
                <a:gd name="connsiteY0" fmla="*/ 526690 h 1061541"/>
                <a:gd name="connsiteX1" fmla="*/ 140825 w 1113709"/>
                <a:gd name="connsiteY1" fmla="*/ 192684 h 1061541"/>
                <a:gd name="connsiteX2" fmla="*/ 403633 w 1113709"/>
                <a:gd name="connsiteY2" fmla="*/ 97734 h 1061541"/>
                <a:gd name="connsiteX3" fmla="*/ 748969 w 1113709"/>
                <a:gd name="connsiteY3" fmla="*/ 20024 h 1061541"/>
                <a:gd name="connsiteX4" fmla="*/ 955327 w 1113709"/>
                <a:gd name="connsiteY4" fmla="*/ 442953 h 1061541"/>
                <a:gd name="connsiteX5" fmla="*/ 1080457 w 1113709"/>
                <a:gd name="connsiteY5" fmla="*/ 844682 h 1061541"/>
                <a:gd name="connsiteX6" fmla="*/ 712237 w 1113709"/>
                <a:gd name="connsiteY6" fmla="*/ 1013674 h 1061541"/>
                <a:gd name="connsiteX7" fmla="*/ 566538 w 1113709"/>
                <a:gd name="connsiteY7" fmla="*/ 1038841 h 1061541"/>
                <a:gd name="connsiteX8" fmla="*/ 229664 w 1113709"/>
                <a:gd name="connsiteY8" fmla="*/ 950632 h 1061541"/>
                <a:gd name="connsiteX9" fmla="*/ 55918 w 1113709"/>
                <a:gd name="connsiteY9" fmla="*/ 817706 h 1061541"/>
                <a:gd name="connsiteX10" fmla="*/ 23985 w 1113709"/>
                <a:gd name="connsiteY10" fmla="*/ 526690 h 1061541"/>
                <a:gd name="connsiteX0" fmla="*/ 33099 w 1122823"/>
                <a:gd name="connsiteY0" fmla="*/ 526353 h 1061204"/>
                <a:gd name="connsiteX1" fmla="*/ 37303 w 1122823"/>
                <a:gd name="connsiteY1" fmla="*/ 173742 h 1061204"/>
                <a:gd name="connsiteX2" fmla="*/ 412747 w 1122823"/>
                <a:gd name="connsiteY2" fmla="*/ 97397 h 1061204"/>
                <a:gd name="connsiteX3" fmla="*/ 758083 w 1122823"/>
                <a:gd name="connsiteY3" fmla="*/ 19687 h 1061204"/>
                <a:gd name="connsiteX4" fmla="*/ 964441 w 1122823"/>
                <a:gd name="connsiteY4" fmla="*/ 442616 h 1061204"/>
                <a:gd name="connsiteX5" fmla="*/ 1089571 w 1122823"/>
                <a:gd name="connsiteY5" fmla="*/ 844345 h 1061204"/>
                <a:gd name="connsiteX6" fmla="*/ 721351 w 1122823"/>
                <a:gd name="connsiteY6" fmla="*/ 1013337 h 1061204"/>
                <a:gd name="connsiteX7" fmla="*/ 575652 w 1122823"/>
                <a:gd name="connsiteY7" fmla="*/ 1038504 h 1061204"/>
                <a:gd name="connsiteX8" fmla="*/ 238778 w 1122823"/>
                <a:gd name="connsiteY8" fmla="*/ 950295 h 1061204"/>
                <a:gd name="connsiteX9" fmla="*/ 65032 w 1122823"/>
                <a:gd name="connsiteY9" fmla="*/ 817369 h 1061204"/>
                <a:gd name="connsiteX10" fmla="*/ 33099 w 1122823"/>
                <a:gd name="connsiteY10" fmla="*/ 526353 h 1061204"/>
                <a:gd name="connsiteX0" fmla="*/ 33099 w 1122823"/>
                <a:gd name="connsiteY0" fmla="*/ 526353 h 1061204"/>
                <a:gd name="connsiteX1" fmla="*/ 37303 w 1122823"/>
                <a:gd name="connsiteY1" fmla="*/ 173742 h 1061204"/>
                <a:gd name="connsiteX2" fmla="*/ 412747 w 1122823"/>
                <a:gd name="connsiteY2" fmla="*/ 97397 h 1061204"/>
                <a:gd name="connsiteX3" fmla="*/ 758083 w 1122823"/>
                <a:gd name="connsiteY3" fmla="*/ 19687 h 1061204"/>
                <a:gd name="connsiteX4" fmla="*/ 964441 w 1122823"/>
                <a:gd name="connsiteY4" fmla="*/ 442616 h 1061204"/>
                <a:gd name="connsiteX5" fmla="*/ 1089571 w 1122823"/>
                <a:gd name="connsiteY5" fmla="*/ 844345 h 1061204"/>
                <a:gd name="connsiteX6" fmla="*/ 721351 w 1122823"/>
                <a:gd name="connsiteY6" fmla="*/ 1013337 h 1061204"/>
                <a:gd name="connsiteX7" fmla="*/ 575652 w 1122823"/>
                <a:gd name="connsiteY7" fmla="*/ 1038504 h 1061204"/>
                <a:gd name="connsiteX8" fmla="*/ 577413 w 1122823"/>
                <a:gd name="connsiteY8" fmla="*/ 615214 h 1061204"/>
                <a:gd name="connsiteX9" fmla="*/ 65032 w 1122823"/>
                <a:gd name="connsiteY9" fmla="*/ 817369 h 1061204"/>
                <a:gd name="connsiteX10" fmla="*/ 33099 w 1122823"/>
                <a:gd name="connsiteY10" fmla="*/ 526353 h 1061204"/>
                <a:gd name="connsiteX0" fmla="*/ 33099 w 1122823"/>
                <a:gd name="connsiteY0" fmla="*/ 526353 h 1048702"/>
                <a:gd name="connsiteX1" fmla="*/ 37303 w 1122823"/>
                <a:gd name="connsiteY1" fmla="*/ 173742 h 1048702"/>
                <a:gd name="connsiteX2" fmla="*/ 412747 w 1122823"/>
                <a:gd name="connsiteY2" fmla="*/ 97397 h 1048702"/>
                <a:gd name="connsiteX3" fmla="*/ 758083 w 1122823"/>
                <a:gd name="connsiteY3" fmla="*/ 19687 h 1048702"/>
                <a:gd name="connsiteX4" fmla="*/ 964441 w 1122823"/>
                <a:gd name="connsiteY4" fmla="*/ 442616 h 1048702"/>
                <a:gd name="connsiteX5" fmla="*/ 1089571 w 1122823"/>
                <a:gd name="connsiteY5" fmla="*/ 844345 h 1048702"/>
                <a:gd name="connsiteX6" fmla="*/ 893997 w 1122823"/>
                <a:gd name="connsiteY6" fmla="*/ 910185 h 1048702"/>
                <a:gd name="connsiteX7" fmla="*/ 575652 w 1122823"/>
                <a:gd name="connsiteY7" fmla="*/ 1038504 h 1048702"/>
                <a:gd name="connsiteX8" fmla="*/ 577413 w 1122823"/>
                <a:gd name="connsiteY8" fmla="*/ 615214 h 1048702"/>
                <a:gd name="connsiteX9" fmla="*/ 65032 w 1122823"/>
                <a:gd name="connsiteY9" fmla="*/ 817369 h 1048702"/>
                <a:gd name="connsiteX10" fmla="*/ 33099 w 1122823"/>
                <a:gd name="connsiteY10" fmla="*/ 526353 h 1048702"/>
                <a:gd name="connsiteX0" fmla="*/ 33099 w 1122823"/>
                <a:gd name="connsiteY0" fmla="*/ 526353 h 949090"/>
                <a:gd name="connsiteX1" fmla="*/ 37303 w 1122823"/>
                <a:gd name="connsiteY1" fmla="*/ 173742 h 949090"/>
                <a:gd name="connsiteX2" fmla="*/ 412747 w 1122823"/>
                <a:gd name="connsiteY2" fmla="*/ 97397 h 949090"/>
                <a:gd name="connsiteX3" fmla="*/ 758083 w 1122823"/>
                <a:gd name="connsiteY3" fmla="*/ 19687 h 949090"/>
                <a:gd name="connsiteX4" fmla="*/ 964441 w 1122823"/>
                <a:gd name="connsiteY4" fmla="*/ 442616 h 949090"/>
                <a:gd name="connsiteX5" fmla="*/ 1089571 w 1122823"/>
                <a:gd name="connsiteY5" fmla="*/ 844345 h 949090"/>
                <a:gd name="connsiteX6" fmla="*/ 893997 w 1122823"/>
                <a:gd name="connsiteY6" fmla="*/ 910185 h 949090"/>
                <a:gd name="connsiteX7" fmla="*/ 712866 w 1122823"/>
                <a:gd name="connsiteY7" fmla="*/ 823767 h 949090"/>
                <a:gd name="connsiteX8" fmla="*/ 577413 w 1122823"/>
                <a:gd name="connsiteY8" fmla="*/ 615214 h 949090"/>
                <a:gd name="connsiteX9" fmla="*/ 65032 w 1122823"/>
                <a:gd name="connsiteY9" fmla="*/ 817369 h 949090"/>
                <a:gd name="connsiteX10" fmla="*/ 33099 w 1122823"/>
                <a:gd name="connsiteY10" fmla="*/ 526353 h 949090"/>
                <a:gd name="connsiteX0" fmla="*/ 42445 w 1132169"/>
                <a:gd name="connsiteY0" fmla="*/ 526353 h 949090"/>
                <a:gd name="connsiteX1" fmla="*/ 46649 w 1132169"/>
                <a:gd name="connsiteY1" fmla="*/ 173742 h 949090"/>
                <a:gd name="connsiteX2" fmla="*/ 422093 w 1132169"/>
                <a:gd name="connsiteY2" fmla="*/ 97397 h 949090"/>
                <a:gd name="connsiteX3" fmla="*/ 767429 w 1132169"/>
                <a:gd name="connsiteY3" fmla="*/ 19687 h 949090"/>
                <a:gd name="connsiteX4" fmla="*/ 973787 w 1132169"/>
                <a:gd name="connsiteY4" fmla="*/ 442616 h 949090"/>
                <a:gd name="connsiteX5" fmla="*/ 1098917 w 1132169"/>
                <a:gd name="connsiteY5" fmla="*/ 844345 h 949090"/>
                <a:gd name="connsiteX6" fmla="*/ 903343 w 1132169"/>
                <a:gd name="connsiteY6" fmla="*/ 910185 h 949090"/>
                <a:gd name="connsiteX7" fmla="*/ 722212 w 1132169"/>
                <a:gd name="connsiteY7" fmla="*/ 823767 h 949090"/>
                <a:gd name="connsiteX8" fmla="*/ 586759 w 1132169"/>
                <a:gd name="connsiteY8" fmla="*/ 615214 h 949090"/>
                <a:gd name="connsiteX9" fmla="*/ 272651 w 1132169"/>
                <a:gd name="connsiteY9" fmla="*/ 534912 h 949090"/>
                <a:gd name="connsiteX10" fmla="*/ 42445 w 1132169"/>
                <a:gd name="connsiteY10" fmla="*/ 526353 h 949090"/>
                <a:gd name="connsiteX0" fmla="*/ 51362 w 1127041"/>
                <a:gd name="connsiteY0" fmla="*/ 393015 h 949090"/>
                <a:gd name="connsiteX1" fmla="*/ 41521 w 1127041"/>
                <a:gd name="connsiteY1" fmla="*/ 173742 h 949090"/>
                <a:gd name="connsiteX2" fmla="*/ 416965 w 1127041"/>
                <a:gd name="connsiteY2" fmla="*/ 97397 h 949090"/>
                <a:gd name="connsiteX3" fmla="*/ 762301 w 1127041"/>
                <a:gd name="connsiteY3" fmla="*/ 19687 h 949090"/>
                <a:gd name="connsiteX4" fmla="*/ 968659 w 1127041"/>
                <a:gd name="connsiteY4" fmla="*/ 442616 h 949090"/>
                <a:gd name="connsiteX5" fmla="*/ 1093789 w 1127041"/>
                <a:gd name="connsiteY5" fmla="*/ 844345 h 949090"/>
                <a:gd name="connsiteX6" fmla="*/ 898215 w 1127041"/>
                <a:gd name="connsiteY6" fmla="*/ 910185 h 949090"/>
                <a:gd name="connsiteX7" fmla="*/ 717084 w 1127041"/>
                <a:gd name="connsiteY7" fmla="*/ 823767 h 949090"/>
                <a:gd name="connsiteX8" fmla="*/ 581631 w 1127041"/>
                <a:gd name="connsiteY8" fmla="*/ 615214 h 949090"/>
                <a:gd name="connsiteX9" fmla="*/ 267523 w 1127041"/>
                <a:gd name="connsiteY9" fmla="*/ 534912 h 949090"/>
                <a:gd name="connsiteX10" fmla="*/ 51362 w 1127041"/>
                <a:gd name="connsiteY10" fmla="*/ 393015 h 9490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127041" h="949090">
                  <a:moveTo>
                    <a:pt x="51362" y="393015"/>
                  </a:moveTo>
                  <a:cubicBezTo>
                    <a:pt x="13695" y="332820"/>
                    <a:pt x="-37390" y="246668"/>
                    <a:pt x="41521" y="173742"/>
                  </a:cubicBezTo>
                  <a:cubicBezTo>
                    <a:pt x="120432" y="100816"/>
                    <a:pt x="296835" y="123073"/>
                    <a:pt x="416965" y="97397"/>
                  </a:cubicBezTo>
                  <a:cubicBezTo>
                    <a:pt x="537095" y="71721"/>
                    <a:pt x="699301" y="-46035"/>
                    <a:pt x="762301" y="19687"/>
                  </a:cubicBezTo>
                  <a:cubicBezTo>
                    <a:pt x="825301" y="85409"/>
                    <a:pt x="920968" y="349156"/>
                    <a:pt x="968659" y="442616"/>
                  </a:cubicBezTo>
                  <a:cubicBezTo>
                    <a:pt x="1016350" y="536076"/>
                    <a:pt x="1201760" y="659284"/>
                    <a:pt x="1093789" y="844345"/>
                  </a:cubicBezTo>
                  <a:cubicBezTo>
                    <a:pt x="985818" y="1029406"/>
                    <a:pt x="960999" y="913615"/>
                    <a:pt x="898215" y="910185"/>
                  </a:cubicBezTo>
                  <a:cubicBezTo>
                    <a:pt x="835431" y="906755"/>
                    <a:pt x="784410" y="873339"/>
                    <a:pt x="717084" y="823767"/>
                  </a:cubicBezTo>
                  <a:cubicBezTo>
                    <a:pt x="649758" y="774195"/>
                    <a:pt x="662759" y="625811"/>
                    <a:pt x="581631" y="615214"/>
                  </a:cubicBezTo>
                  <a:cubicBezTo>
                    <a:pt x="500503" y="604617"/>
                    <a:pt x="359466" y="637636"/>
                    <a:pt x="267523" y="534912"/>
                  </a:cubicBezTo>
                  <a:cubicBezTo>
                    <a:pt x="175580" y="432188"/>
                    <a:pt x="89029" y="453210"/>
                    <a:pt x="51362" y="393015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Oval 267">
              <a:extLst>
                <a:ext uri="{FF2B5EF4-FFF2-40B4-BE49-F238E27FC236}">
                  <a16:creationId xmlns:a16="http://schemas.microsoft.com/office/drawing/2014/main" id="{098CC9BB-8E4F-587B-6E11-C78F63426F61}"/>
                </a:ext>
              </a:extLst>
            </p:cNvPr>
            <p:cNvSpPr/>
            <p:nvPr/>
          </p:nvSpPr>
          <p:spPr>
            <a:xfrm>
              <a:off x="7570627" y="4066611"/>
              <a:ext cx="659568" cy="713353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59568" h="713353">
                  <a:moveTo>
                    <a:pt x="0" y="319240"/>
                  </a:moveTo>
                  <a:cubicBezTo>
                    <a:pt x="0" y="200383"/>
                    <a:pt x="167390" y="5140"/>
                    <a:pt x="277318" y="143"/>
                  </a:cubicBezTo>
                  <a:cubicBezTo>
                    <a:pt x="387246" y="-4854"/>
                    <a:pt x="659568" y="121306"/>
                    <a:pt x="659568" y="289260"/>
                  </a:cubicBezTo>
                  <a:cubicBezTo>
                    <a:pt x="659568" y="457214"/>
                    <a:pt x="387246" y="708291"/>
                    <a:pt x="277318" y="713288"/>
                  </a:cubicBezTo>
                  <a:cubicBezTo>
                    <a:pt x="167390" y="718285"/>
                    <a:pt x="0" y="438097"/>
                    <a:pt x="0" y="319240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Oval 267">
              <a:extLst>
                <a:ext uri="{FF2B5EF4-FFF2-40B4-BE49-F238E27FC236}">
                  <a16:creationId xmlns:a16="http://schemas.microsoft.com/office/drawing/2014/main" id="{6D7BC014-0D88-C8AE-158A-ED01F6C64C22}"/>
                </a:ext>
              </a:extLst>
            </p:cNvPr>
            <p:cNvSpPr/>
            <p:nvPr/>
          </p:nvSpPr>
          <p:spPr>
            <a:xfrm>
              <a:off x="7751530" y="2868031"/>
              <a:ext cx="675262" cy="983625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675262" h="983625">
                  <a:moveTo>
                    <a:pt x="1353" y="319182"/>
                  </a:moveTo>
                  <a:cubicBezTo>
                    <a:pt x="16343" y="187833"/>
                    <a:pt x="168743" y="5082"/>
                    <a:pt x="278671" y="85"/>
                  </a:cubicBezTo>
                  <a:cubicBezTo>
                    <a:pt x="388599" y="-4912"/>
                    <a:pt x="597414" y="212792"/>
                    <a:pt x="660921" y="289202"/>
                  </a:cubicBezTo>
                  <a:cubicBezTo>
                    <a:pt x="724428" y="365612"/>
                    <a:pt x="557482" y="367861"/>
                    <a:pt x="539792" y="443554"/>
                  </a:cubicBezTo>
                  <a:cubicBezTo>
                    <a:pt x="522102" y="519247"/>
                    <a:pt x="674703" y="728367"/>
                    <a:pt x="674703" y="818308"/>
                  </a:cubicBezTo>
                  <a:cubicBezTo>
                    <a:pt x="674703" y="908249"/>
                    <a:pt x="600801" y="975729"/>
                    <a:pt x="539792" y="983200"/>
                  </a:cubicBezTo>
                  <a:cubicBezTo>
                    <a:pt x="478783" y="990671"/>
                    <a:pt x="278470" y="898851"/>
                    <a:pt x="188730" y="788181"/>
                  </a:cubicBezTo>
                  <a:cubicBezTo>
                    <a:pt x="98990" y="677511"/>
                    <a:pt x="-13637" y="450531"/>
                    <a:pt x="1353" y="319182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Oval 267">
              <a:extLst>
                <a:ext uri="{FF2B5EF4-FFF2-40B4-BE49-F238E27FC236}">
                  <a16:creationId xmlns:a16="http://schemas.microsoft.com/office/drawing/2014/main" id="{1D2F4CC4-CA69-6DCD-E3C2-0B1C21BB2066}"/>
                </a:ext>
              </a:extLst>
            </p:cNvPr>
            <p:cNvSpPr/>
            <p:nvPr/>
          </p:nvSpPr>
          <p:spPr>
            <a:xfrm rot="16622697">
              <a:off x="6314777" y="1535326"/>
              <a:ext cx="564488" cy="1106491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  <a:gd name="connsiteX0" fmla="*/ 1353 w 674703"/>
                <a:gd name="connsiteY0" fmla="*/ 332766 h 997209"/>
                <a:gd name="connsiteX1" fmla="*/ 278671 w 674703"/>
                <a:gd name="connsiteY1" fmla="*/ 13669 h 997209"/>
                <a:gd name="connsiteX2" fmla="*/ 469697 w 674703"/>
                <a:gd name="connsiteY2" fmla="*/ 99855 h 997209"/>
                <a:gd name="connsiteX3" fmla="*/ 539792 w 674703"/>
                <a:gd name="connsiteY3" fmla="*/ 457138 h 997209"/>
                <a:gd name="connsiteX4" fmla="*/ 674703 w 674703"/>
                <a:gd name="connsiteY4" fmla="*/ 831892 h 997209"/>
                <a:gd name="connsiteX5" fmla="*/ 539792 w 674703"/>
                <a:gd name="connsiteY5" fmla="*/ 996784 h 997209"/>
                <a:gd name="connsiteX6" fmla="*/ 188730 w 674703"/>
                <a:gd name="connsiteY6" fmla="*/ 801765 h 997209"/>
                <a:gd name="connsiteX7" fmla="*/ 1353 w 674703"/>
                <a:gd name="connsiteY7" fmla="*/ 332766 h 997209"/>
                <a:gd name="connsiteX0" fmla="*/ 1130 w 674480"/>
                <a:gd name="connsiteY0" fmla="*/ 332766 h 1106491"/>
                <a:gd name="connsiteX1" fmla="*/ 278448 w 674480"/>
                <a:gd name="connsiteY1" fmla="*/ 13669 h 1106491"/>
                <a:gd name="connsiteX2" fmla="*/ 469474 w 674480"/>
                <a:gd name="connsiteY2" fmla="*/ 99855 h 1106491"/>
                <a:gd name="connsiteX3" fmla="*/ 539569 w 674480"/>
                <a:gd name="connsiteY3" fmla="*/ 457138 h 1106491"/>
                <a:gd name="connsiteX4" fmla="*/ 674480 w 674480"/>
                <a:gd name="connsiteY4" fmla="*/ 831892 h 1106491"/>
                <a:gd name="connsiteX5" fmla="*/ 386953 w 674480"/>
                <a:gd name="connsiteY5" fmla="*/ 1106270 h 1106491"/>
                <a:gd name="connsiteX6" fmla="*/ 188507 w 674480"/>
                <a:gd name="connsiteY6" fmla="*/ 801765 h 1106491"/>
                <a:gd name="connsiteX7" fmla="*/ 1130 w 674480"/>
                <a:gd name="connsiteY7" fmla="*/ 332766 h 1106491"/>
                <a:gd name="connsiteX0" fmla="*/ 1130 w 564488"/>
                <a:gd name="connsiteY0" fmla="*/ 332766 h 1106491"/>
                <a:gd name="connsiteX1" fmla="*/ 278448 w 564488"/>
                <a:gd name="connsiteY1" fmla="*/ 13669 h 1106491"/>
                <a:gd name="connsiteX2" fmla="*/ 469474 w 564488"/>
                <a:gd name="connsiteY2" fmla="*/ 99855 h 1106491"/>
                <a:gd name="connsiteX3" fmla="*/ 539569 w 564488"/>
                <a:gd name="connsiteY3" fmla="*/ 457138 h 1106491"/>
                <a:gd name="connsiteX4" fmla="*/ 564488 w 564488"/>
                <a:gd name="connsiteY4" fmla="*/ 1041840 h 1106491"/>
                <a:gd name="connsiteX5" fmla="*/ 386953 w 564488"/>
                <a:gd name="connsiteY5" fmla="*/ 1106270 h 1106491"/>
                <a:gd name="connsiteX6" fmla="*/ 188507 w 564488"/>
                <a:gd name="connsiteY6" fmla="*/ 801765 h 1106491"/>
                <a:gd name="connsiteX7" fmla="*/ 1130 w 564488"/>
                <a:gd name="connsiteY7" fmla="*/ 332766 h 11064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64488" h="1106491">
                  <a:moveTo>
                    <a:pt x="1130" y="332766"/>
                  </a:moveTo>
                  <a:cubicBezTo>
                    <a:pt x="16120" y="201417"/>
                    <a:pt x="200391" y="52488"/>
                    <a:pt x="278448" y="13669"/>
                  </a:cubicBezTo>
                  <a:cubicBezTo>
                    <a:pt x="356505" y="-25150"/>
                    <a:pt x="405967" y="23445"/>
                    <a:pt x="469474" y="99855"/>
                  </a:cubicBezTo>
                  <a:cubicBezTo>
                    <a:pt x="532981" y="176265"/>
                    <a:pt x="557259" y="381445"/>
                    <a:pt x="539569" y="457138"/>
                  </a:cubicBezTo>
                  <a:cubicBezTo>
                    <a:pt x="521879" y="532831"/>
                    <a:pt x="564488" y="951899"/>
                    <a:pt x="564488" y="1041840"/>
                  </a:cubicBezTo>
                  <a:cubicBezTo>
                    <a:pt x="564488" y="1131781"/>
                    <a:pt x="447962" y="1098799"/>
                    <a:pt x="386953" y="1106270"/>
                  </a:cubicBezTo>
                  <a:cubicBezTo>
                    <a:pt x="325944" y="1113741"/>
                    <a:pt x="252811" y="930682"/>
                    <a:pt x="188507" y="801765"/>
                  </a:cubicBezTo>
                  <a:cubicBezTo>
                    <a:pt x="124203" y="672848"/>
                    <a:pt x="-13860" y="464115"/>
                    <a:pt x="1130" y="33276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Oval 267">
              <a:extLst>
                <a:ext uri="{FF2B5EF4-FFF2-40B4-BE49-F238E27FC236}">
                  <a16:creationId xmlns:a16="http://schemas.microsoft.com/office/drawing/2014/main" id="{E2C6E18E-149B-D4A6-C8A0-9AAC2935D8DD}"/>
                </a:ext>
              </a:extLst>
            </p:cNvPr>
            <p:cNvSpPr/>
            <p:nvPr/>
          </p:nvSpPr>
          <p:spPr>
            <a:xfrm rot="16622697">
              <a:off x="7838500" y="1799921"/>
              <a:ext cx="550858" cy="702688"/>
            </a:xfrm>
            <a:custGeom>
              <a:avLst/>
              <a:gdLst>
                <a:gd name="connsiteX0" fmla="*/ 0 w 674557"/>
                <a:gd name="connsiteY0" fmla="*/ 304107 h 608213"/>
                <a:gd name="connsiteX1" fmla="*/ 337279 w 674557"/>
                <a:gd name="connsiteY1" fmla="*/ 0 h 608213"/>
                <a:gd name="connsiteX2" fmla="*/ 674558 w 674557"/>
                <a:gd name="connsiteY2" fmla="*/ 304107 h 608213"/>
                <a:gd name="connsiteX3" fmla="*/ 337279 w 674557"/>
                <a:gd name="connsiteY3" fmla="*/ 608214 h 608213"/>
                <a:gd name="connsiteX4" fmla="*/ 0 w 674557"/>
                <a:gd name="connsiteY4" fmla="*/ 304107 h 608213"/>
                <a:gd name="connsiteX0" fmla="*/ 0 w 674558"/>
                <a:gd name="connsiteY0" fmla="*/ 304107 h 713145"/>
                <a:gd name="connsiteX1" fmla="*/ 337279 w 674558"/>
                <a:gd name="connsiteY1" fmla="*/ 0 h 713145"/>
                <a:gd name="connsiteX2" fmla="*/ 674558 w 674558"/>
                <a:gd name="connsiteY2" fmla="*/ 304107 h 713145"/>
                <a:gd name="connsiteX3" fmla="*/ 337279 w 674558"/>
                <a:gd name="connsiteY3" fmla="*/ 713145 h 713145"/>
                <a:gd name="connsiteX4" fmla="*/ 0 w 674558"/>
                <a:gd name="connsiteY4" fmla="*/ 304107 h 713145"/>
                <a:gd name="connsiteX0" fmla="*/ 0 w 614597"/>
                <a:gd name="connsiteY0" fmla="*/ 319130 h 713194"/>
                <a:gd name="connsiteX1" fmla="*/ 277318 w 614597"/>
                <a:gd name="connsiteY1" fmla="*/ 33 h 713194"/>
                <a:gd name="connsiteX2" fmla="*/ 614597 w 614597"/>
                <a:gd name="connsiteY2" fmla="*/ 304140 h 713194"/>
                <a:gd name="connsiteX3" fmla="*/ 277318 w 614597"/>
                <a:gd name="connsiteY3" fmla="*/ 713178 h 713194"/>
                <a:gd name="connsiteX4" fmla="*/ 0 w 614597"/>
                <a:gd name="connsiteY4" fmla="*/ 319130 h 713194"/>
                <a:gd name="connsiteX0" fmla="*/ 0 w 659568"/>
                <a:gd name="connsiteY0" fmla="*/ 319240 h 713353"/>
                <a:gd name="connsiteX1" fmla="*/ 277318 w 659568"/>
                <a:gd name="connsiteY1" fmla="*/ 143 h 713353"/>
                <a:gd name="connsiteX2" fmla="*/ 659568 w 659568"/>
                <a:gd name="connsiteY2" fmla="*/ 289260 h 713353"/>
                <a:gd name="connsiteX3" fmla="*/ 277318 w 659568"/>
                <a:gd name="connsiteY3" fmla="*/ 713288 h 713353"/>
                <a:gd name="connsiteX4" fmla="*/ 0 w 659568"/>
                <a:gd name="connsiteY4" fmla="*/ 319240 h 713353"/>
                <a:gd name="connsiteX0" fmla="*/ 1600 w 661168"/>
                <a:gd name="connsiteY0" fmla="*/ 319240 h 788293"/>
                <a:gd name="connsiteX1" fmla="*/ 278918 w 661168"/>
                <a:gd name="connsiteY1" fmla="*/ 143 h 788293"/>
                <a:gd name="connsiteX2" fmla="*/ 661168 w 661168"/>
                <a:gd name="connsiteY2" fmla="*/ 289260 h 788293"/>
                <a:gd name="connsiteX3" fmla="*/ 188977 w 661168"/>
                <a:gd name="connsiteY3" fmla="*/ 788239 h 788293"/>
                <a:gd name="connsiteX4" fmla="*/ 1600 w 661168"/>
                <a:gd name="connsiteY4" fmla="*/ 319240 h 788293"/>
                <a:gd name="connsiteX0" fmla="*/ 1353 w 666543"/>
                <a:gd name="connsiteY0" fmla="*/ 319192 h 1005577"/>
                <a:gd name="connsiteX1" fmla="*/ 278671 w 666543"/>
                <a:gd name="connsiteY1" fmla="*/ 95 h 1005577"/>
                <a:gd name="connsiteX2" fmla="*/ 660921 w 666543"/>
                <a:gd name="connsiteY2" fmla="*/ 289212 h 1005577"/>
                <a:gd name="connsiteX3" fmla="*/ 539792 w 666543"/>
                <a:gd name="connsiteY3" fmla="*/ 983210 h 1005577"/>
                <a:gd name="connsiteX4" fmla="*/ 188730 w 666543"/>
                <a:gd name="connsiteY4" fmla="*/ 788191 h 1005577"/>
                <a:gd name="connsiteX5" fmla="*/ 1353 w 666543"/>
                <a:gd name="connsiteY5" fmla="*/ 319192 h 1005577"/>
                <a:gd name="connsiteX0" fmla="*/ 1353 w 675422"/>
                <a:gd name="connsiteY0" fmla="*/ 319182 h 995577"/>
                <a:gd name="connsiteX1" fmla="*/ 278671 w 675422"/>
                <a:gd name="connsiteY1" fmla="*/ 85 h 995577"/>
                <a:gd name="connsiteX2" fmla="*/ 660921 w 675422"/>
                <a:gd name="connsiteY2" fmla="*/ 289202 h 995577"/>
                <a:gd name="connsiteX3" fmla="*/ 539792 w 675422"/>
                <a:gd name="connsiteY3" fmla="*/ 443554 h 995577"/>
                <a:gd name="connsiteX4" fmla="*/ 539792 w 675422"/>
                <a:gd name="connsiteY4" fmla="*/ 983200 h 995577"/>
                <a:gd name="connsiteX5" fmla="*/ 188730 w 675422"/>
                <a:gd name="connsiteY5" fmla="*/ 788181 h 995577"/>
                <a:gd name="connsiteX6" fmla="*/ 1353 w 675422"/>
                <a:gd name="connsiteY6" fmla="*/ 319182 h 995577"/>
                <a:gd name="connsiteX0" fmla="*/ 1353 w 675262"/>
                <a:gd name="connsiteY0" fmla="*/ 319182 h 983625"/>
                <a:gd name="connsiteX1" fmla="*/ 278671 w 675262"/>
                <a:gd name="connsiteY1" fmla="*/ 85 h 983625"/>
                <a:gd name="connsiteX2" fmla="*/ 660921 w 675262"/>
                <a:gd name="connsiteY2" fmla="*/ 289202 h 983625"/>
                <a:gd name="connsiteX3" fmla="*/ 539792 w 675262"/>
                <a:gd name="connsiteY3" fmla="*/ 443554 h 983625"/>
                <a:gd name="connsiteX4" fmla="*/ 674703 w 675262"/>
                <a:gd name="connsiteY4" fmla="*/ 818308 h 983625"/>
                <a:gd name="connsiteX5" fmla="*/ 539792 w 675262"/>
                <a:gd name="connsiteY5" fmla="*/ 983200 h 983625"/>
                <a:gd name="connsiteX6" fmla="*/ 188730 w 675262"/>
                <a:gd name="connsiteY6" fmla="*/ 788181 h 983625"/>
                <a:gd name="connsiteX7" fmla="*/ 1353 w 675262"/>
                <a:gd name="connsiteY7" fmla="*/ 319182 h 983625"/>
                <a:gd name="connsiteX0" fmla="*/ 1353 w 674703"/>
                <a:gd name="connsiteY0" fmla="*/ 332766 h 997209"/>
                <a:gd name="connsiteX1" fmla="*/ 278671 w 674703"/>
                <a:gd name="connsiteY1" fmla="*/ 13669 h 997209"/>
                <a:gd name="connsiteX2" fmla="*/ 469697 w 674703"/>
                <a:gd name="connsiteY2" fmla="*/ 99855 h 997209"/>
                <a:gd name="connsiteX3" fmla="*/ 539792 w 674703"/>
                <a:gd name="connsiteY3" fmla="*/ 457138 h 997209"/>
                <a:gd name="connsiteX4" fmla="*/ 674703 w 674703"/>
                <a:gd name="connsiteY4" fmla="*/ 831892 h 997209"/>
                <a:gd name="connsiteX5" fmla="*/ 539792 w 674703"/>
                <a:gd name="connsiteY5" fmla="*/ 996784 h 997209"/>
                <a:gd name="connsiteX6" fmla="*/ 188730 w 674703"/>
                <a:gd name="connsiteY6" fmla="*/ 801765 h 997209"/>
                <a:gd name="connsiteX7" fmla="*/ 1353 w 674703"/>
                <a:gd name="connsiteY7" fmla="*/ 332766 h 997209"/>
                <a:gd name="connsiteX0" fmla="*/ 1130 w 674480"/>
                <a:gd name="connsiteY0" fmla="*/ 332766 h 1106491"/>
                <a:gd name="connsiteX1" fmla="*/ 278448 w 674480"/>
                <a:gd name="connsiteY1" fmla="*/ 13669 h 1106491"/>
                <a:gd name="connsiteX2" fmla="*/ 469474 w 674480"/>
                <a:gd name="connsiteY2" fmla="*/ 99855 h 1106491"/>
                <a:gd name="connsiteX3" fmla="*/ 539569 w 674480"/>
                <a:gd name="connsiteY3" fmla="*/ 457138 h 1106491"/>
                <a:gd name="connsiteX4" fmla="*/ 674480 w 674480"/>
                <a:gd name="connsiteY4" fmla="*/ 831892 h 1106491"/>
                <a:gd name="connsiteX5" fmla="*/ 386953 w 674480"/>
                <a:gd name="connsiteY5" fmla="*/ 1106270 h 1106491"/>
                <a:gd name="connsiteX6" fmla="*/ 188507 w 674480"/>
                <a:gd name="connsiteY6" fmla="*/ 801765 h 1106491"/>
                <a:gd name="connsiteX7" fmla="*/ 1130 w 674480"/>
                <a:gd name="connsiteY7" fmla="*/ 332766 h 1106491"/>
                <a:gd name="connsiteX0" fmla="*/ 1130 w 564488"/>
                <a:gd name="connsiteY0" fmla="*/ 332766 h 1106491"/>
                <a:gd name="connsiteX1" fmla="*/ 278448 w 564488"/>
                <a:gd name="connsiteY1" fmla="*/ 13669 h 1106491"/>
                <a:gd name="connsiteX2" fmla="*/ 469474 w 564488"/>
                <a:gd name="connsiteY2" fmla="*/ 99855 h 1106491"/>
                <a:gd name="connsiteX3" fmla="*/ 539569 w 564488"/>
                <a:gd name="connsiteY3" fmla="*/ 457138 h 1106491"/>
                <a:gd name="connsiteX4" fmla="*/ 564488 w 564488"/>
                <a:gd name="connsiteY4" fmla="*/ 1041840 h 1106491"/>
                <a:gd name="connsiteX5" fmla="*/ 386953 w 564488"/>
                <a:gd name="connsiteY5" fmla="*/ 1106270 h 1106491"/>
                <a:gd name="connsiteX6" fmla="*/ 188507 w 564488"/>
                <a:gd name="connsiteY6" fmla="*/ 801765 h 1106491"/>
                <a:gd name="connsiteX7" fmla="*/ 1130 w 564488"/>
                <a:gd name="connsiteY7" fmla="*/ 332766 h 1106491"/>
                <a:gd name="connsiteX0" fmla="*/ 1130 w 546440"/>
                <a:gd name="connsiteY0" fmla="*/ 332766 h 1106491"/>
                <a:gd name="connsiteX1" fmla="*/ 278448 w 546440"/>
                <a:gd name="connsiteY1" fmla="*/ 13669 h 1106491"/>
                <a:gd name="connsiteX2" fmla="*/ 469474 w 546440"/>
                <a:gd name="connsiteY2" fmla="*/ 99855 h 1106491"/>
                <a:gd name="connsiteX3" fmla="*/ 539569 w 546440"/>
                <a:gd name="connsiteY3" fmla="*/ 457138 h 1106491"/>
                <a:gd name="connsiteX4" fmla="*/ 546440 w 546440"/>
                <a:gd name="connsiteY4" fmla="*/ 651362 h 1106491"/>
                <a:gd name="connsiteX5" fmla="*/ 386953 w 546440"/>
                <a:gd name="connsiteY5" fmla="*/ 1106270 h 1106491"/>
                <a:gd name="connsiteX6" fmla="*/ 188507 w 546440"/>
                <a:gd name="connsiteY6" fmla="*/ 801765 h 1106491"/>
                <a:gd name="connsiteX7" fmla="*/ 1130 w 546440"/>
                <a:gd name="connsiteY7" fmla="*/ 332766 h 1106491"/>
                <a:gd name="connsiteX0" fmla="*/ 1054 w 546364"/>
                <a:gd name="connsiteY0" fmla="*/ 332766 h 814951"/>
                <a:gd name="connsiteX1" fmla="*/ 278372 w 546364"/>
                <a:gd name="connsiteY1" fmla="*/ 13669 h 814951"/>
                <a:gd name="connsiteX2" fmla="*/ 469398 w 546364"/>
                <a:gd name="connsiteY2" fmla="*/ 99855 h 814951"/>
                <a:gd name="connsiteX3" fmla="*/ 539493 w 546364"/>
                <a:gd name="connsiteY3" fmla="*/ 457138 h 814951"/>
                <a:gd name="connsiteX4" fmla="*/ 546364 w 546364"/>
                <a:gd name="connsiteY4" fmla="*/ 651362 h 814951"/>
                <a:gd name="connsiteX5" fmla="*/ 320522 w 546364"/>
                <a:gd name="connsiteY5" fmla="*/ 691553 h 814951"/>
                <a:gd name="connsiteX6" fmla="*/ 188431 w 546364"/>
                <a:gd name="connsiteY6" fmla="*/ 801765 h 814951"/>
                <a:gd name="connsiteX7" fmla="*/ 1054 w 546364"/>
                <a:gd name="connsiteY7" fmla="*/ 332766 h 814951"/>
                <a:gd name="connsiteX0" fmla="*/ 5548 w 550858"/>
                <a:gd name="connsiteY0" fmla="*/ 332766 h 702688"/>
                <a:gd name="connsiteX1" fmla="*/ 282866 w 550858"/>
                <a:gd name="connsiteY1" fmla="*/ 13669 h 702688"/>
                <a:gd name="connsiteX2" fmla="*/ 473892 w 550858"/>
                <a:gd name="connsiteY2" fmla="*/ 99855 h 702688"/>
                <a:gd name="connsiteX3" fmla="*/ 543987 w 550858"/>
                <a:gd name="connsiteY3" fmla="*/ 457138 h 702688"/>
                <a:gd name="connsiteX4" fmla="*/ 550858 w 550858"/>
                <a:gd name="connsiteY4" fmla="*/ 651362 h 702688"/>
                <a:gd name="connsiteX5" fmla="*/ 325016 w 550858"/>
                <a:gd name="connsiteY5" fmla="*/ 691553 h 702688"/>
                <a:gd name="connsiteX6" fmla="*/ 115031 w 550858"/>
                <a:gd name="connsiteY6" fmla="*/ 660349 h 702688"/>
                <a:gd name="connsiteX7" fmla="*/ 5548 w 550858"/>
                <a:gd name="connsiteY7" fmla="*/ 332766 h 7026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50858" h="702688">
                  <a:moveTo>
                    <a:pt x="5548" y="332766"/>
                  </a:moveTo>
                  <a:cubicBezTo>
                    <a:pt x="33521" y="224986"/>
                    <a:pt x="204809" y="52488"/>
                    <a:pt x="282866" y="13669"/>
                  </a:cubicBezTo>
                  <a:cubicBezTo>
                    <a:pt x="360923" y="-25150"/>
                    <a:pt x="410385" y="23445"/>
                    <a:pt x="473892" y="99855"/>
                  </a:cubicBezTo>
                  <a:cubicBezTo>
                    <a:pt x="537399" y="176265"/>
                    <a:pt x="561677" y="381445"/>
                    <a:pt x="543987" y="457138"/>
                  </a:cubicBezTo>
                  <a:cubicBezTo>
                    <a:pt x="526297" y="532831"/>
                    <a:pt x="550858" y="561421"/>
                    <a:pt x="550858" y="651362"/>
                  </a:cubicBezTo>
                  <a:cubicBezTo>
                    <a:pt x="550858" y="741303"/>
                    <a:pt x="386025" y="684082"/>
                    <a:pt x="325016" y="691553"/>
                  </a:cubicBezTo>
                  <a:cubicBezTo>
                    <a:pt x="264007" y="699024"/>
                    <a:pt x="168276" y="720147"/>
                    <a:pt x="115031" y="660349"/>
                  </a:cubicBezTo>
                  <a:cubicBezTo>
                    <a:pt x="61786" y="600551"/>
                    <a:pt x="-22425" y="440546"/>
                    <a:pt x="5548" y="332766"/>
                  </a:cubicBezTo>
                  <a:close/>
                </a:path>
              </a:pathLst>
            </a:custGeom>
            <a:solidFill>
              <a:srgbClr val="9F7362">
                <a:alpha val="40000"/>
              </a:srgbClr>
            </a:solidFill>
            <a:ln w="28575">
              <a:solidFill>
                <a:srgbClr val="6A4D4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3" name="Oval 262">
            <a:extLst>
              <a:ext uri="{FF2B5EF4-FFF2-40B4-BE49-F238E27FC236}">
                <a16:creationId xmlns:a16="http://schemas.microsoft.com/office/drawing/2014/main" id="{21D5ADA6-63C2-54AC-6A0D-FD679617CE22}"/>
              </a:ext>
            </a:extLst>
          </p:cNvPr>
          <p:cNvSpPr/>
          <p:nvPr/>
        </p:nvSpPr>
        <p:spPr>
          <a:xfrm>
            <a:off x="5391747" y="2598672"/>
            <a:ext cx="252866" cy="275479"/>
          </a:xfrm>
          <a:custGeom>
            <a:avLst/>
            <a:gdLst>
              <a:gd name="connsiteX0" fmla="*/ 0 w 1546533"/>
              <a:gd name="connsiteY0" fmla="*/ 692390 h 1384779"/>
              <a:gd name="connsiteX1" fmla="*/ 773267 w 1546533"/>
              <a:gd name="connsiteY1" fmla="*/ 0 h 1384779"/>
              <a:gd name="connsiteX2" fmla="*/ 1546534 w 1546533"/>
              <a:gd name="connsiteY2" fmla="*/ 692390 h 1384779"/>
              <a:gd name="connsiteX3" fmla="*/ 773267 w 1546533"/>
              <a:gd name="connsiteY3" fmla="*/ 1384780 h 1384779"/>
              <a:gd name="connsiteX4" fmla="*/ 0 w 1546533"/>
              <a:gd name="connsiteY4" fmla="*/ 692390 h 1384779"/>
              <a:gd name="connsiteX0" fmla="*/ 52 w 1546586"/>
              <a:gd name="connsiteY0" fmla="*/ 707380 h 1399770"/>
              <a:gd name="connsiteX1" fmla="*/ 803300 w 1546586"/>
              <a:gd name="connsiteY1" fmla="*/ 0 h 1399770"/>
              <a:gd name="connsiteX2" fmla="*/ 1546586 w 1546586"/>
              <a:gd name="connsiteY2" fmla="*/ 707380 h 1399770"/>
              <a:gd name="connsiteX3" fmla="*/ 773319 w 1546586"/>
              <a:gd name="connsiteY3" fmla="*/ 1399770 h 1399770"/>
              <a:gd name="connsiteX4" fmla="*/ 52 w 1546586"/>
              <a:gd name="connsiteY4" fmla="*/ 707380 h 1399770"/>
              <a:gd name="connsiteX0" fmla="*/ 52 w 1569351"/>
              <a:gd name="connsiteY0" fmla="*/ 716310 h 1408700"/>
              <a:gd name="connsiteX1" fmla="*/ 803300 w 1569351"/>
              <a:gd name="connsiteY1" fmla="*/ 8930 h 1408700"/>
              <a:gd name="connsiteX2" fmla="*/ 1226270 w 1569351"/>
              <a:gd name="connsiteY2" fmla="*/ 343303 h 1408700"/>
              <a:gd name="connsiteX3" fmla="*/ 1546586 w 1569351"/>
              <a:gd name="connsiteY3" fmla="*/ 716310 h 1408700"/>
              <a:gd name="connsiteX4" fmla="*/ 773319 w 1569351"/>
              <a:gd name="connsiteY4" fmla="*/ 1408700 h 1408700"/>
              <a:gd name="connsiteX5" fmla="*/ 52 w 1569351"/>
              <a:gd name="connsiteY5" fmla="*/ 716310 h 1408700"/>
              <a:gd name="connsiteX0" fmla="*/ 36 w 1527296"/>
              <a:gd name="connsiteY0" fmla="*/ 716310 h 1414204"/>
              <a:gd name="connsiteX1" fmla="*/ 803284 w 1527296"/>
              <a:gd name="connsiteY1" fmla="*/ 8930 h 1414204"/>
              <a:gd name="connsiteX2" fmla="*/ 1226254 w 1527296"/>
              <a:gd name="connsiteY2" fmla="*/ 343303 h 1414204"/>
              <a:gd name="connsiteX3" fmla="*/ 1501599 w 1527296"/>
              <a:gd name="connsiteY3" fmla="*/ 1001123 h 1414204"/>
              <a:gd name="connsiteX4" fmla="*/ 773303 w 1527296"/>
              <a:gd name="connsiteY4" fmla="*/ 1408700 h 1414204"/>
              <a:gd name="connsiteX5" fmla="*/ 36 w 1527296"/>
              <a:gd name="connsiteY5" fmla="*/ 716310 h 1414204"/>
              <a:gd name="connsiteX0" fmla="*/ 2734 w 1529994"/>
              <a:gd name="connsiteY0" fmla="*/ 716310 h 1227707"/>
              <a:gd name="connsiteX1" fmla="*/ 805982 w 1529994"/>
              <a:gd name="connsiteY1" fmla="*/ 8930 h 1227707"/>
              <a:gd name="connsiteX2" fmla="*/ 1228952 w 1529994"/>
              <a:gd name="connsiteY2" fmla="*/ 343303 h 1227707"/>
              <a:gd name="connsiteX3" fmla="*/ 1504297 w 1529994"/>
              <a:gd name="connsiteY3" fmla="*/ 1001123 h 1227707"/>
              <a:gd name="connsiteX4" fmla="*/ 1105784 w 1529994"/>
              <a:gd name="connsiteY4" fmla="*/ 1213828 h 1227707"/>
              <a:gd name="connsiteX5" fmla="*/ 2734 w 1529994"/>
              <a:gd name="connsiteY5" fmla="*/ 716310 h 1227707"/>
              <a:gd name="connsiteX0" fmla="*/ 2734 w 1529994"/>
              <a:gd name="connsiteY0" fmla="*/ 716310 h 1245705"/>
              <a:gd name="connsiteX1" fmla="*/ 805982 w 1529994"/>
              <a:gd name="connsiteY1" fmla="*/ 8930 h 1245705"/>
              <a:gd name="connsiteX2" fmla="*/ 1228952 w 1529994"/>
              <a:gd name="connsiteY2" fmla="*/ 343303 h 1245705"/>
              <a:gd name="connsiteX3" fmla="*/ 1504297 w 1529994"/>
              <a:gd name="connsiteY3" fmla="*/ 1001123 h 1245705"/>
              <a:gd name="connsiteX4" fmla="*/ 1105784 w 1529994"/>
              <a:gd name="connsiteY4" fmla="*/ 1213828 h 1245705"/>
              <a:gd name="connsiteX5" fmla="*/ 2734 w 1529994"/>
              <a:gd name="connsiteY5" fmla="*/ 716310 h 1245705"/>
              <a:gd name="connsiteX0" fmla="*/ 2991 w 1530251"/>
              <a:gd name="connsiteY0" fmla="*/ 716310 h 1357514"/>
              <a:gd name="connsiteX1" fmla="*/ 806239 w 1530251"/>
              <a:gd name="connsiteY1" fmla="*/ 8930 h 1357514"/>
              <a:gd name="connsiteX2" fmla="*/ 1229209 w 1530251"/>
              <a:gd name="connsiteY2" fmla="*/ 343303 h 1357514"/>
              <a:gd name="connsiteX3" fmla="*/ 1504554 w 1530251"/>
              <a:gd name="connsiteY3" fmla="*/ 1001123 h 1357514"/>
              <a:gd name="connsiteX4" fmla="*/ 1106041 w 1530251"/>
              <a:gd name="connsiteY4" fmla="*/ 1213828 h 1357514"/>
              <a:gd name="connsiteX5" fmla="*/ 554652 w 1530251"/>
              <a:gd name="connsiteY5" fmla="*/ 1332654 h 1357514"/>
              <a:gd name="connsiteX6" fmla="*/ 2991 w 1530251"/>
              <a:gd name="connsiteY6" fmla="*/ 716310 h 1357514"/>
              <a:gd name="connsiteX0" fmla="*/ 2991 w 1530251"/>
              <a:gd name="connsiteY0" fmla="*/ 716310 h 1357514"/>
              <a:gd name="connsiteX1" fmla="*/ 806239 w 1530251"/>
              <a:gd name="connsiteY1" fmla="*/ 8930 h 1357514"/>
              <a:gd name="connsiteX2" fmla="*/ 1229209 w 1530251"/>
              <a:gd name="connsiteY2" fmla="*/ 343303 h 1357514"/>
              <a:gd name="connsiteX3" fmla="*/ 1504554 w 1530251"/>
              <a:gd name="connsiteY3" fmla="*/ 1001123 h 1357514"/>
              <a:gd name="connsiteX4" fmla="*/ 896178 w 1530251"/>
              <a:gd name="connsiteY4" fmla="*/ 1213828 h 1357514"/>
              <a:gd name="connsiteX5" fmla="*/ 554652 w 1530251"/>
              <a:gd name="connsiteY5" fmla="*/ 1332654 h 1357514"/>
              <a:gd name="connsiteX6" fmla="*/ 2991 w 1530251"/>
              <a:gd name="connsiteY6" fmla="*/ 716310 h 1357514"/>
              <a:gd name="connsiteX0" fmla="*/ 11615 w 1538875"/>
              <a:gd name="connsiteY0" fmla="*/ 716310 h 1352533"/>
              <a:gd name="connsiteX1" fmla="*/ 814863 w 1538875"/>
              <a:gd name="connsiteY1" fmla="*/ 8930 h 1352533"/>
              <a:gd name="connsiteX2" fmla="*/ 1237833 w 1538875"/>
              <a:gd name="connsiteY2" fmla="*/ 343303 h 1352533"/>
              <a:gd name="connsiteX3" fmla="*/ 1513178 w 1538875"/>
              <a:gd name="connsiteY3" fmla="*/ 1001123 h 1352533"/>
              <a:gd name="connsiteX4" fmla="*/ 904802 w 1538875"/>
              <a:gd name="connsiteY4" fmla="*/ 1213828 h 1352533"/>
              <a:gd name="connsiteX5" fmla="*/ 563276 w 1538875"/>
              <a:gd name="connsiteY5" fmla="*/ 1332654 h 1352533"/>
              <a:gd name="connsiteX6" fmla="*/ 353414 w 1538875"/>
              <a:gd name="connsiteY6" fmla="*/ 1197742 h 1352533"/>
              <a:gd name="connsiteX7" fmla="*/ 11615 w 1538875"/>
              <a:gd name="connsiteY7" fmla="*/ 716310 h 1352533"/>
              <a:gd name="connsiteX0" fmla="*/ 57357 w 1254833"/>
              <a:gd name="connsiteY0" fmla="*/ 438457 h 1344503"/>
              <a:gd name="connsiteX1" fmla="*/ 530821 w 1254833"/>
              <a:gd name="connsiteY1" fmla="*/ 900 h 1344503"/>
              <a:gd name="connsiteX2" fmla="*/ 953791 w 1254833"/>
              <a:gd name="connsiteY2" fmla="*/ 335273 h 1344503"/>
              <a:gd name="connsiteX3" fmla="*/ 1229136 w 1254833"/>
              <a:gd name="connsiteY3" fmla="*/ 993093 h 1344503"/>
              <a:gd name="connsiteX4" fmla="*/ 620760 w 1254833"/>
              <a:gd name="connsiteY4" fmla="*/ 1205798 h 1344503"/>
              <a:gd name="connsiteX5" fmla="*/ 279234 w 1254833"/>
              <a:gd name="connsiteY5" fmla="*/ 1324624 h 1344503"/>
              <a:gd name="connsiteX6" fmla="*/ 69372 w 1254833"/>
              <a:gd name="connsiteY6" fmla="*/ 1189712 h 1344503"/>
              <a:gd name="connsiteX7" fmla="*/ 57357 w 1254833"/>
              <a:gd name="connsiteY7" fmla="*/ 438457 h 1344503"/>
              <a:gd name="connsiteX0" fmla="*/ 113768 w 1311244"/>
              <a:gd name="connsiteY0" fmla="*/ 438457 h 1344503"/>
              <a:gd name="connsiteX1" fmla="*/ 587232 w 1311244"/>
              <a:gd name="connsiteY1" fmla="*/ 900 h 1344503"/>
              <a:gd name="connsiteX2" fmla="*/ 1010202 w 1311244"/>
              <a:gd name="connsiteY2" fmla="*/ 335273 h 1344503"/>
              <a:gd name="connsiteX3" fmla="*/ 1285547 w 1311244"/>
              <a:gd name="connsiteY3" fmla="*/ 993093 h 1344503"/>
              <a:gd name="connsiteX4" fmla="*/ 677171 w 1311244"/>
              <a:gd name="connsiteY4" fmla="*/ 1205798 h 1344503"/>
              <a:gd name="connsiteX5" fmla="*/ 335645 w 1311244"/>
              <a:gd name="connsiteY5" fmla="*/ 1324624 h 1344503"/>
              <a:gd name="connsiteX6" fmla="*/ 125783 w 1311244"/>
              <a:gd name="connsiteY6" fmla="*/ 1189712 h 1344503"/>
              <a:gd name="connsiteX7" fmla="*/ 113768 w 1311244"/>
              <a:gd name="connsiteY7" fmla="*/ 438457 h 1344503"/>
              <a:gd name="connsiteX0" fmla="*/ 58531 w 1256007"/>
              <a:gd name="connsiteY0" fmla="*/ 442213 h 1348259"/>
              <a:gd name="connsiteX1" fmla="*/ 550231 w 1256007"/>
              <a:gd name="connsiteY1" fmla="*/ 593862 h 1348259"/>
              <a:gd name="connsiteX2" fmla="*/ 531995 w 1256007"/>
              <a:gd name="connsiteY2" fmla="*/ 4656 h 1348259"/>
              <a:gd name="connsiteX3" fmla="*/ 954965 w 1256007"/>
              <a:gd name="connsiteY3" fmla="*/ 339029 h 1348259"/>
              <a:gd name="connsiteX4" fmla="*/ 1230310 w 1256007"/>
              <a:gd name="connsiteY4" fmla="*/ 996849 h 1348259"/>
              <a:gd name="connsiteX5" fmla="*/ 621934 w 1256007"/>
              <a:gd name="connsiteY5" fmla="*/ 1209554 h 1348259"/>
              <a:gd name="connsiteX6" fmla="*/ 280408 w 1256007"/>
              <a:gd name="connsiteY6" fmla="*/ 1328380 h 1348259"/>
              <a:gd name="connsiteX7" fmla="*/ 70546 w 1256007"/>
              <a:gd name="connsiteY7" fmla="*/ 1193468 h 1348259"/>
              <a:gd name="connsiteX8" fmla="*/ 58531 w 1256007"/>
              <a:gd name="connsiteY8" fmla="*/ 442213 h 134825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256007" h="1348259">
                <a:moveTo>
                  <a:pt x="58531" y="442213"/>
                </a:moveTo>
                <a:cubicBezTo>
                  <a:pt x="138478" y="342279"/>
                  <a:pt x="471320" y="666788"/>
                  <a:pt x="550231" y="593862"/>
                </a:cubicBezTo>
                <a:cubicBezTo>
                  <a:pt x="629142" y="520936"/>
                  <a:pt x="464539" y="47128"/>
                  <a:pt x="531995" y="4656"/>
                </a:cubicBezTo>
                <a:cubicBezTo>
                  <a:pt x="599451" y="-37816"/>
                  <a:pt x="831084" y="221132"/>
                  <a:pt x="954965" y="339029"/>
                </a:cubicBezTo>
                <a:cubicBezTo>
                  <a:pt x="1078846" y="456926"/>
                  <a:pt x="1338281" y="811788"/>
                  <a:pt x="1230310" y="996849"/>
                </a:cubicBezTo>
                <a:cubicBezTo>
                  <a:pt x="1122339" y="1181910"/>
                  <a:pt x="780251" y="1154299"/>
                  <a:pt x="621934" y="1209554"/>
                </a:cubicBezTo>
                <a:cubicBezTo>
                  <a:pt x="463617" y="1264809"/>
                  <a:pt x="432267" y="1398517"/>
                  <a:pt x="280408" y="1328380"/>
                </a:cubicBezTo>
                <a:cubicBezTo>
                  <a:pt x="128549" y="1258243"/>
                  <a:pt x="162489" y="1296192"/>
                  <a:pt x="70546" y="1193468"/>
                </a:cubicBezTo>
                <a:cubicBezTo>
                  <a:pt x="-21397" y="1090744"/>
                  <a:pt x="-21416" y="542147"/>
                  <a:pt x="58531" y="442213"/>
                </a:cubicBezTo>
                <a:close/>
              </a:path>
            </a:pathLst>
          </a:custGeom>
          <a:solidFill>
            <a:srgbClr val="9F7362">
              <a:alpha val="40000"/>
            </a:srgbClr>
          </a:solidFill>
          <a:ln w="28575">
            <a:solidFill>
              <a:srgbClr val="6A4D4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Oval 262">
            <a:extLst>
              <a:ext uri="{FF2B5EF4-FFF2-40B4-BE49-F238E27FC236}">
                <a16:creationId xmlns:a16="http://schemas.microsoft.com/office/drawing/2014/main" id="{ED88CC9E-746B-A293-3C60-B42C19D53A4B}"/>
              </a:ext>
            </a:extLst>
          </p:cNvPr>
          <p:cNvSpPr/>
          <p:nvPr/>
        </p:nvSpPr>
        <p:spPr>
          <a:xfrm>
            <a:off x="6056632" y="2422526"/>
            <a:ext cx="248325" cy="341370"/>
          </a:xfrm>
          <a:custGeom>
            <a:avLst/>
            <a:gdLst>
              <a:gd name="connsiteX0" fmla="*/ 0 w 1546533"/>
              <a:gd name="connsiteY0" fmla="*/ 692390 h 1384779"/>
              <a:gd name="connsiteX1" fmla="*/ 773267 w 1546533"/>
              <a:gd name="connsiteY1" fmla="*/ 0 h 1384779"/>
              <a:gd name="connsiteX2" fmla="*/ 1546534 w 1546533"/>
              <a:gd name="connsiteY2" fmla="*/ 692390 h 1384779"/>
              <a:gd name="connsiteX3" fmla="*/ 773267 w 1546533"/>
              <a:gd name="connsiteY3" fmla="*/ 1384780 h 1384779"/>
              <a:gd name="connsiteX4" fmla="*/ 0 w 1546533"/>
              <a:gd name="connsiteY4" fmla="*/ 692390 h 1384779"/>
              <a:gd name="connsiteX0" fmla="*/ 52 w 1546586"/>
              <a:gd name="connsiteY0" fmla="*/ 707380 h 1399770"/>
              <a:gd name="connsiteX1" fmla="*/ 803300 w 1546586"/>
              <a:gd name="connsiteY1" fmla="*/ 0 h 1399770"/>
              <a:gd name="connsiteX2" fmla="*/ 1546586 w 1546586"/>
              <a:gd name="connsiteY2" fmla="*/ 707380 h 1399770"/>
              <a:gd name="connsiteX3" fmla="*/ 773319 w 1546586"/>
              <a:gd name="connsiteY3" fmla="*/ 1399770 h 1399770"/>
              <a:gd name="connsiteX4" fmla="*/ 52 w 1546586"/>
              <a:gd name="connsiteY4" fmla="*/ 707380 h 1399770"/>
              <a:gd name="connsiteX0" fmla="*/ 52 w 1569351"/>
              <a:gd name="connsiteY0" fmla="*/ 716310 h 1408700"/>
              <a:gd name="connsiteX1" fmla="*/ 803300 w 1569351"/>
              <a:gd name="connsiteY1" fmla="*/ 8930 h 1408700"/>
              <a:gd name="connsiteX2" fmla="*/ 1226270 w 1569351"/>
              <a:gd name="connsiteY2" fmla="*/ 343303 h 1408700"/>
              <a:gd name="connsiteX3" fmla="*/ 1546586 w 1569351"/>
              <a:gd name="connsiteY3" fmla="*/ 716310 h 1408700"/>
              <a:gd name="connsiteX4" fmla="*/ 773319 w 1569351"/>
              <a:gd name="connsiteY4" fmla="*/ 1408700 h 1408700"/>
              <a:gd name="connsiteX5" fmla="*/ 52 w 1569351"/>
              <a:gd name="connsiteY5" fmla="*/ 716310 h 1408700"/>
              <a:gd name="connsiteX0" fmla="*/ 36 w 1527296"/>
              <a:gd name="connsiteY0" fmla="*/ 716310 h 1414204"/>
              <a:gd name="connsiteX1" fmla="*/ 803284 w 1527296"/>
              <a:gd name="connsiteY1" fmla="*/ 8930 h 1414204"/>
              <a:gd name="connsiteX2" fmla="*/ 1226254 w 1527296"/>
              <a:gd name="connsiteY2" fmla="*/ 343303 h 1414204"/>
              <a:gd name="connsiteX3" fmla="*/ 1501599 w 1527296"/>
              <a:gd name="connsiteY3" fmla="*/ 1001123 h 1414204"/>
              <a:gd name="connsiteX4" fmla="*/ 773303 w 1527296"/>
              <a:gd name="connsiteY4" fmla="*/ 1408700 h 1414204"/>
              <a:gd name="connsiteX5" fmla="*/ 36 w 1527296"/>
              <a:gd name="connsiteY5" fmla="*/ 716310 h 1414204"/>
              <a:gd name="connsiteX0" fmla="*/ 2734 w 1529994"/>
              <a:gd name="connsiteY0" fmla="*/ 716310 h 1227707"/>
              <a:gd name="connsiteX1" fmla="*/ 805982 w 1529994"/>
              <a:gd name="connsiteY1" fmla="*/ 8930 h 1227707"/>
              <a:gd name="connsiteX2" fmla="*/ 1228952 w 1529994"/>
              <a:gd name="connsiteY2" fmla="*/ 343303 h 1227707"/>
              <a:gd name="connsiteX3" fmla="*/ 1504297 w 1529994"/>
              <a:gd name="connsiteY3" fmla="*/ 1001123 h 1227707"/>
              <a:gd name="connsiteX4" fmla="*/ 1105784 w 1529994"/>
              <a:gd name="connsiteY4" fmla="*/ 1213828 h 1227707"/>
              <a:gd name="connsiteX5" fmla="*/ 2734 w 1529994"/>
              <a:gd name="connsiteY5" fmla="*/ 716310 h 1227707"/>
              <a:gd name="connsiteX0" fmla="*/ 2734 w 1529994"/>
              <a:gd name="connsiteY0" fmla="*/ 716310 h 1245705"/>
              <a:gd name="connsiteX1" fmla="*/ 805982 w 1529994"/>
              <a:gd name="connsiteY1" fmla="*/ 8930 h 1245705"/>
              <a:gd name="connsiteX2" fmla="*/ 1228952 w 1529994"/>
              <a:gd name="connsiteY2" fmla="*/ 343303 h 1245705"/>
              <a:gd name="connsiteX3" fmla="*/ 1504297 w 1529994"/>
              <a:gd name="connsiteY3" fmla="*/ 1001123 h 1245705"/>
              <a:gd name="connsiteX4" fmla="*/ 1105784 w 1529994"/>
              <a:gd name="connsiteY4" fmla="*/ 1213828 h 1245705"/>
              <a:gd name="connsiteX5" fmla="*/ 2734 w 1529994"/>
              <a:gd name="connsiteY5" fmla="*/ 716310 h 1245705"/>
              <a:gd name="connsiteX0" fmla="*/ 2991 w 1530251"/>
              <a:gd name="connsiteY0" fmla="*/ 716310 h 1357514"/>
              <a:gd name="connsiteX1" fmla="*/ 806239 w 1530251"/>
              <a:gd name="connsiteY1" fmla="*/ 8930 h 1357514"/>
              <a:gd name="connsiteX2" fmla="*/ 1229209 w 1530251"/>
              <a:gd name="connsiteY2" fmla="*/ 343303 h 1357514"/>
              <a:gd name="connsiteX3" fmla="*/ 1504554 w 1530251"/>
              <a:gd name="connsiteY3" fmla="*/ 1001123 h 1357514"/>
              <a:gd name="connsiteX4" fmla="*/ 1106041 w 1530251"/>
              <a:gd name="connsiteY4" fmla="*/ 1213828 h 1357514"/>
              <a:gd name="connsiteX5" fmla="*/ 554652 w 1530251"/>
              <a:gd name="connsiteY5" fmla="*/ 1332654 h 1357514"/>
              <a:gd name="connsiteX6" fmla="*/ 2991 w 1530251"/>
              <a:gd name="connsiteY6" fmla="*/ 716310 h 1357514"/>
              <a:gd name="connsiteX0" fmla="*/ 2991 w 1530251"/>
              <a:gd name="connsiteY0" fmla="*/ 716310 h 1357514"/>
              <a:gd name="connsiteX1" fmla="*/ 806239 w 1530251"/>
              <a:gd name="connsiteY1" fmla="*/ 8930 h 1357514"/>
              <a:gd name="connsiteX2" fmla="*/ 1229209 w 1530251"/>
              <a:gd name="connsiteY2" fmla="*/ 343303 h 1357514"/>
              <a:gd name="connsiteX3" fmla="*/ 1504554 w 1530251"/>
              <a:gd name="connsiteY3" fmla="*/ 1001123 h 1357514"/>
              <a:gd name="connsiteX4" fmla="*/ 896178 w 1530251"/>
              <a:gd name="connsiteY4" fmla="*/ 1213828 h 1357514"/>
              <a:gd name="connsiteX5" fmla="*/ 554652 w 1530251"/>
              <a:gd name="connsiteY5" fmla="*/ 1332654 h 1357514"/>
              <a:gd name="connsiteX6" fmla="*/ 2991 w 1530251"/>
              <a:gd name="connsiteY6" fmla="*/ 716310 h 1357514"/>
              <a:gd name="connsiteX0" fmla="*/ 11615 w 1538875"/>
              <a:gd name="connsiteY0" fmla="*/ 716310 h 1352533"/>
              <a:gd name="connsiteX1" fmla="*/ 814863 w 1538875"/>
              <a:gd name="connsiteY1" fmla="*/ 8930 h 1352533"/>
              <a:gd name="connsiteX2" fmla="*/ 1237833 w 1538875"/>
              <a:gd name="connsiteY2" fmla="*/ 343303 h 1352533"/>
              <a:gd name="connsiteX3" fmla="*/ 1513178 w 1538875"/>
              <a:gd name="connsiteY3" fmla="*/ 1001123 h 1352533"/>
              <a:gd name="connsiteX4" fmla="*/ 904802 w 1538875"/>
              <a:gd name="connsiteY4" fmla="*/ 1213828 h 1352533"/>
              <a:gd name="connsiteX5" fmla="*/ 563276 w 1538875"/>
              <a:gd name="connsiteY5" fmla="*/ 1332654 h 1352533"/>
              <a:gd name="connsiteX6" fmla="*/ 353414 w 1538875"/>
              <a:gd name="connsiteY6" fmla="*/ 1197742 h 1352533"/>
              <a:gd name="connsiteX7" fmla="*/ 11615 w 1538875"/>
              <a:gd name="connsiteY7" fmla="*/ 716310 h 1352533"/>
              <a:gd name="connsiteX0" fmla="*/ 57357 w 1254833"/>
              <a:gd name="connsiteY0" fmla="*/ 438457 h 1344503"/>
              <a:gd name="connsiteX1" fmla="*/ 530821 w 1254833"/>
              <a:gd name="connsiteY1" fmla="*/ 900 h 1344503"/>
              <a:gd name="connsiteX2" fmla="*/ 953791 w 1254833"/>
              <a:gd name="connsiteY2" fmla="*/ 335273 h 1344503"/>
              <a:gd name="connsiteX3" fmla="*/ 1229136 w 1254833"/>
              <a:gd name="connsiteY3" fmla="*/ 993093 h 1344503"/>
              <a:gd name="connsiteX4" fmla="*/ 620760 w 1254833"/>
              <a:gd name="connsiteY4" fmla="*/ 1205798 h 1344503"/>
              <a:gd name="connsiteX5" fmla="*/ 279234 w 1254833"/>
              <a:gd name="connsiteY5" fmla="*/ 1324624 h 1344503"/>
              <a:gd name="connsiteX6" fmla="*/ 69372 w 1254833"/>
              <a:gd name="connsiteY6" fmla="*/ 1189712 h 1344503"/>
              <a:gd name="connsiteX7" fmla="*/ 57357 w 1254833"/>
              <a:gd name="connsiteY7" fmla="*/ 438457 h 1344503"/>
              <a:gd name="connsiteX0" fmla="*/ 113768 w 1311244"/>
              <a:gd name="connsiteY0" fmla="*/ 438457 h 1344503"/>
              <a:gd name="connsiteX1" fmla="*/ 587232 w 1311244"/>
              <a:gd name="connsiteY1" fmla="*/ 900 h 1344503"/>
              <a:gd name="connsiteX2" fmla="*/ 1010202 w 1311244"/>
              <a:gd name="connsiteY2" fmla="*/ 335273 h 1344503"/>
              <a:gd name="connsiteX3" fmla="*/ 1285547 w 1311244"/>
              <a:gd name="connsiteY3" fmla="*/ 993093 h 1344503"/>
              <a:gd name="connsiteX4" fmla="*/ 677171 w 1311244"/>
              <a:gd name="connsiteY4" fmla="*/ 1205798 h 1344503"/>
              <a:gd name="connsiteX5" fmla="*/ 335645 w 1311244"/>
              <a:gd name="connsiteY5" fmla="*/ 1324624 h 1344503"/>
              <a:gd name="connsiteX6" fmla="*/ 125783 w 1311244"/>
              <a:gd name="connsiteY6" fmla="*/ 1189712 h 1344503"/>
              <a:gd name="connsiteX7" fmla="*/ 113768 w 1311244"/>
              <a:gd name="connsiteY7" fmla="*/ 438457 h 1344503"/>
              <a:gd name="connsiteX0" fmla="*/ 58531 w 1256007"/>
              <a:gd name="connsiteY0" fmla="*/ 442213 h 1348259"/>
              <a:gd name="connsiteX1" fmla="*/ 550231 w 1256007"/>
              <a:gd name="connsiteY1" fmla="*/ 593862 h 1348259"/>
              <a:gd name="connsiteX2" fmla="*/ 531995 w 1256007"/>
              <a:gd name="connsiteY2" fmla="*/ 4656 h 1348259"/>
              <a:gd name="connsiteX3" fmla="*/ 954965 w 1256007"/>
              <a:gd name="connsiteY3" fmla="*/ 339029 h 1348259"/>
              <a:gd name="connsiteX4" fmla="*/ 1230310 w 1256007"/>
              <a:gd name="connsiteY4" fmla="*/ 996849 h 1348259"/>
              <a:gd name="connsiteX5" fmla="*/ 621934 w 1256007"/>
              <a:gd name="connsiteY5" fmla="*/ 1209554 h 1348259"/>
              <a:gd name="connsiteX6" fmla="*/ 280408 w 1256007"/>
              <a:gd name="connsiteY6" fmla="*/ 1328380 h 1348259"/>
              <a:gd name="connsiteX7" fmla="*/ 70546 w 1256007"/>
              <a:gd name="connsiteY7" fmla="*/ 1193468 h 1348259"/>
              <a:gd name="connsiteX8" fmla="*/ 58531 w 1256007"/>
              <a:gd name="connsiteY8" fmla="*/ 442213 h 1348259"/>
              <a:gd name="connsiteX0" fmla="*/ 45688 w 1243164"/>
              <a:gd name="connsiteY0" fmla="*/ 442559 h 1348605"/>
              <a:gd name="connsiteX1" fmla="*/ 327526 w 1243164"/>
              <a:gd name="connsiteY1" fmla="*/ 159493 h 1348605"/>
              <a:gd name="connsiteX2" fmla="*/ 519152 w 1243164"/>
              <a:gd name="connsiteY2" fmla="*/ 5002 h 1348605"/>
              <a:gd name="connsiteX3" fmla="*/ 942122 w 1243164"/>
              <a:gd name="connsiteY3" fmla="*/ 339375 h 1348605"/>
              <a:gd name="connsiteX4" fmla="*/ 1217467 w 1243164"/>
              <a:gd name="connsiteY4" fmla="*/ 997195 h 1348605"/>
              <a:gd name="connsiteX5" fmla="*/ 609091 w 1243164"/>
              <a:gd name="connsiteY5" fmla="*/ 1209900 h 1348605"/>
              <a:gd name="connsiteX6" fmla="*/ 267565 w 1243164"/>
              <a:gd name="connsiteY6" fmla="*/ 1328726 h 1348605"/>
              <a:gd name="connsiteX7" fmla="*/ 57703 w 1243164"/>
              <a:gd name="connsiteY7" fmla="*/ 1193814 h 1348605"/>
              <a:gd name="connsiteX8" fmla="*/ 45688 w 1243164"/>
              <a:gd name="connsiteY8" fmla="*/ 442559 h 1348605"/>
              <a:gd name="connsiteX0" fmla="*/ 8444 w 1385802"/>
              <a:gd name="connsiteY0" fmla="*/ 472540 h 1348605"/>
              <a:gd name="connsiteX1" fmla="*/ 470164 w 1385802"/>
              <a:gd name="connsiteY1" fmla="*/ 159493 h 1348605"/>
              <a:gd name="connsiteX2" fmla="*/ 661790 w 1385802"/>
              <a:gd name="connsiteY2" fmla="*/ 5002 h 1348605"/>
              <a:gd name="connsiteX3" fmla="*/ 1084760 w 1385802"/>
              <a:gd name="connsiteY3" fmla="*/ 339375 h 1348605"/>
              <a:gd name="connsiteX4" fmla="*/ 1360105 w 1385802"/>
              <a:gd name="connsiteY4" fmla="*/ 997195 h 1348605"/>
              <a:gd name="connsiteX5" fmla="*/ 751729 w 1385802"/>
              <a:gd name="connsiteY5" fmla="*/ 1209900 h 1348605"/>
              <a:gd name="connsiteX6" fmla="*/ 410203 w 1385802"/>
              <a:gd name="connsiteY6" fmla="*/ 1328726 h 1348605"/>
              <a:gd name="connsiteX7" fmla="*/ 200341 w 1385802"/>
              <a:gd name="connsiteY7" fmla="*/ 1193814 h 1348605"/>
              <a:gd name="connsiteX8" fmla="*/ 8444 w 1385802"/>
              <a:gd name="connsiteY8" fmla="*/ 472540 h 1348605"/>
              <a:gd name="connsiteX0" fmla="*/ 5659 w 1383017"/>
              <a:gd name="connsiteY0" fmla="*/ 468392 h 1344457"/>
              <a:gd name="connsiteX1" fmla="*/ 407418 w 1383017"/>
              <a:gd name="connsiteY1" fmla="*/ 245286 h 1344457"/>
              <a:gd name="connsiteX2" fmla="*/ 659005 w 1383017"/>
              <a:gd name="connsiteY2" fmla="*/ 854 h 1344457"/>
              <a:gd name="connsiteX3" fmla="*/ 1081975 w 1383017"/>
              <a:gd name="connsiteY3" fmla="*/ 335227 h 1344457"/>
              <a:gd name="connsiteX4" fmla="*/ 1357320 w 1383017"/>
              <a:gd name="connsiteY4" fmla="*/ 993047 h 1344457"/>
              <a:gd name="connsiteX5" fmla="*/ 748944 w 1383017"/>
              <a:gd name="connsiteY5" fmla="*/ 1205752 h 1344457"/>
              <a:gd name="connsiteX6" fmla="*/ 407418 w 1383017"/>
              <a:gd name="connsiteY6" fmla="*/ 1324578 h 1344457"/>
              <a:gd name="connsiteX7" fmla="*/ 197556 w 1383017"/>
              <a:gd name="connsiteY7" fmla="*/ 1189666 h 1344457"/>
              <a:gd name="connsiteX8" fmla="*/ 5659 w 1383017"/>
              <a:gd name="connsiteY8" fmla="*/ 468392 h 1344457"/>
              <a:gd name="connsiteX0" fmla="*/ 12404 w 1389762"/>
              <a:gd name="connsiteY0" fmla="*/ 468392 h 1344457"/>
              <a:gd name="connsiteX1" fmla="*/ 414163 w 1389762"/>
              <a:gd name="connsiteY1" fmla="*/ 245286 h 1344457"/>
              <a:gd name="connsiteX2" fmla="*/ 665750 w 1389762"/>
              <a:gd name="connsiteY2" fmla="*/ 854 h 1344457"/>
              <a:gd name="connsiteX3" fmla="*/ 1088720 w 1389762"/>
              <a:gd name="connsiteY3" fmla="*/ 335227 h 1344457"/>
              <a:gd name="connsiteX4" fmla="*/ 1364065 w 1389762"/>
              <a:gd name="connsiteY4" fmla="*/ 993047 h 1344457"/>
              <a:gd name="connsiteX5" fmla="*/ 755689 w 1389762"/>
              <a:gd name="connsiteY5" fmla="*/ 1205752 h 1344457"/>
              <a:gd name="connsiteX6" fmla="*/ 414163 w 1389762"/>
              <a:gd name="connsiteY6" fmla="*/ 1324578 h 1344457"/>
              <a:gd name="connsiteX7" fmla="*/ 144341 w 1389762"/>
              <a:gd name="connsiteY7" fmla="*/ 769941 h 1344457"/>
              <a:gd name="connsiteX8" fmla="*/ 12404 w 1389762"/>
              <a:gd name="connsiteY8" fmla="*/ 468392 h 1344457"/>
              <a:gd name="connsiteX0" fmla="*/ 12404 w 1389762"/>
              <a:gd name="connsiteY0" fmla="*/ 468392 h 1209184"/>
              <a:gd name="connsiteX1" fmla="*/ 414163 w 1389762"/>
              <a:gd name="connsiteY1" fmla="*/ 245286 h 1209184"/>
              <a:gd name="connsiteX2" fmla="*/ 665750 w 1389762"/>
              <a:gd name="connsiteY2" fmla="*/ 854 h 1209184"/>
              <a:gd name="connsiteX3" fmla="*/ 1088720 w 1389762"/>
              <a:gd name="connsiteY3" fmla="*/ 335227 h 1209184"/>
              <a:gd name="connsiteX4" fmla="*/ 1364065 w 1389762"/>
              <a:gd name="connsiteY4" fmla="*/ 993047 h 1209184"/>
              <a:gd name="connsiteX5" fmla="*/ 755689 w 1389762"/>
              <a:gd name="connsiteY5" fmla="*/ 1205752 h 1209184"/>
              <a:gd name="connsiteX6" fmla="*/ 459134 w 1389762"/>
              <a:gd name="connsiteY6" fmla="*/ 1099726 h 1209184"/>
              <a:gd name="connsiteX7" fmla="*/ 144341 w 1389762"/>
              <a:gd name="connsiteY7" fmla="*/ 769941 h 1209184"/>
              <a:gd name="connsiteX8" fmla="*/ 12404 w 1389762"/>
              <a:gd name="connsiteY8" fmla="*/ 468392 h 1209184"/>
              <a:gd name="connsiteX0" fmla="*/ 12404 w 1389762"/>
              <a:gd name="connsiteY0" fmla="*/ 468392 h 1115450"/>
              <a:gd name="connsiteX1" fmla="*/ 414163 w 1389762"/>
              <a:gd name="connsiteY1" fmla="*/ 245286 h 1115450"/>
              <a:gd name="connsiteX2" fmla="*/ 665750 w 1389762"/>
              <a:gd name="connsiteY2" fmla="*/ 854 h 1115450"/>
              <a:gd name="connsiteX3" fmla="*/ 1088720 w 1389762"/>
              <a:gd name="connsiteY3" fmla="*/ 335227 h 1115450"/>
              <a:gd name="connsiteX4" fmla="*/ 1364065 w 1389762"/>
              <a:gd name="connsiteY4" fmla="*/ 993047 h 1115450"/>
              <a:gd name="connsiteX5" fmla="*/ 800660 w 1389762"/>
              <a:gd name="connsiteY5" fmla="*/ 965909 h 1115450"/>
              <a:gd name="connsiteX6" fmla="*/ 459134 w 1389762"/>
              <a:gd name="connsiteY6" fmla="*/ 1099726 h 1115450"/>
              <a:gd name="connsiteX7" fmla="*/ 144341 w 1389762"/>
              <a:gd name="connsiteY7" fmla="*/ 769941 h 1115450"/>
              <a:gd name="connsiteX8" fmla="*/ 12404 w 1389762"/>
              <a:gd name="connsiteY8" fmla="*/ 468392 h 1115450"/>
              <a:gd name="connsiteX0" fmla="*/ 12404 w 1186175"/>
              <a:gd name="connsiteY0" fmla="*/ 468392 h 1118803"/>
              <a:gd name="connsiteX1" fmla="*/ 414163 w 1186175"/>
              <a:gd name="connsiteY1" fmla="*/ 245286 h 1118803"/>
              <a:gd name="connsiteX2" fmla="*/ 665750 w 1186175"/>
              <a:gd name="connsiteY2" fmla="*/ 854 h 1118803"/>
              <a:gd name="connsiteX3" fmla="*/ 1088720 w 1186175"/>
              <a:gd name="connsiteY3" fmla="*/ 335227 h 1118803"/>
              <a:gd name="connsiteX4" fmla="*/ 1109232 w 1186175"/>
              <a:gd name="connsiteY4" fmla="*/ 723225 h 1118803"/>
              <a:gd name="connsiteX5" fmla="*/ 800660 w 1186175"/>
              <a:gd name="connsiteY5" fmla="*/ 965909 h 1118803"/>
              <a:gd name="connsiteX6" fmla="*/ 459134 w 1186175"/>
              <a:gd name="connsiteY6" fmla="*/ 1099726 h 1118803"/>
              <a:gd name="connsiteX7" fmla="*/ 144341 w 1186175"/>
              <a:gd name="connsiteY7" fmla="*/ 769941 h 1118803"/>
              <a:gd name="connsiteX8" fmla="*/ 12404 w 1186175"/>
              <a:gd name="connsiteY8" fmla="*/ 468392 h 1118803"/>
              <a:gd name="connsiteX0" fmla="*/ 12404 w 1168638"/>
              <a:gd name="connsiteY0" fmla="*/ 469718 h 1120129"/>
              <a:gd name="connsiteX1" fmla="*/ 414163 w 1168638"/>
              <a:gd name="connsiteY1" fmla="*/ 246612 h 1120129"/>
              <a:gd name="connsiteX2" fmla="*/ 665750 w 1168638"/>
              <a:gd name="connsiteY2" fmla="*/ 2180 h 1120129"/>
              <a:gd name="connsiteX3" fmla="*/ 1043750 w 1168638"/>
              <a:gd name="connsiteY3" fmla="*/ 396514 h 1120129"/>
              <a:gd name="connsiteX4" fmla="*/ 1109232 w 1168638"/>
              <a:gd name="connsiteY4" fmla="*/ 724551 h 1120129"/>
              <a:gd name="connsiteX5" fmla="*/ 800660 w 1168638"/>
              <a:gd name="connsiteY5" fmla="*/ 967235 h 1120129"/>
              <a:gd name="connsiteX6" fmla="*/ 459134 w 1168638"/>
              <a:gd name="connsiteY6" fmla="*/ 1101052 h 1120129"/>
              <a:gd name="connsiteX7" fmla="*/ 144341 w 1168638"/>
              <a:gd name="connsiteY7" fmla="*/ 771267 h 1120129"/>
              <a:gd name="connsiteX8" fmla="*/ 12404 w 1168638"/>
              <a:gd name="connsiteY8" fmla="*/ 469718 h 1120129"/>
              <a:gd name="connsiteX0" fmla="*/ 12404 w 1151810"/>
              <a:gd name="connsiteY0" fmla="*/ 481516 h 1131927"/>
              <a:gd name="connsiteX1" fmla="*/ 414163 w 1151810"/>
              <a:gd name="connsiteY1" fmla="*/ 258410 h 1131927"/>
              <a:gd name="connsiteX2" fmla="*/ 665750 w 1151810"/>
              <a:gd name="connsiteY2" fmla="*/ 13978 h 1131927"/>
              <a:gd name="connsiteX3" fmla="*/ 943005 w 1151810"/>
              <a:gd name="connsiteY3" fmla="*/ 70656 h 1131927"/>
              <a:gd name="connsiteX4" fmla="*/ 1043750 w 1151810"/>
              <a:gd name="connsiteY4" fmla="*/ 408312 h 1131927"/>
              <a:gd name="connsiteX5" fmla="*/ 1109232 w 1151810"/>
              <a:gd name="connsiteY5" fmla="*/ 736349 h 1131927"/>
              <a:gd name="connsiteX6" fmla="*/ 800660 w 1151810"/>
              <a:gd name="connsiteY6" fmla="*/ 979033 h 1131927"/>
              <a:gd name="connsiteX7" fmla="*/ 459134 w 1151810"/>
              <a:gd name="connsiteY7" fmla="*/ 1112850 h 1131927"/>
              <a:gd name="connsiteX8" fmla="*/ 144341 w 1151810"/>
              <a:gd name="connsiteY8" fmla="*/ 783065 h 1131927"/>
              <a:gd name="connsiteX9" fmla="*/ 12404 w 1151810"/>
              <a:gd name="connsiteY9" fmla="*/ 481516 h 11319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1151810" h="1131927">
                <a:moveTo>
                  <a:pt x="12404" y="481516"/>
                </a:moveTo>
                <a:cubicBezTo>
                  <a:pt x="57374" y="394074"/>
                  <a:pt x="335252" y="331336"/>
                  <a:pt x="414163" y="258410"/>
                </a:cubicBezTo>
                <a:cubicBezTo>
                  <a:pt x="493074" y="185484"/>
                  <a:pt x="577610" y="45270"/>
                  <a:pt x="665750" y="13978"/>
                </a:cubicBezTo>
                <a:cubicBezTo>
                  <a:pt x="753890" y="-17314"/>
                  <a:pt x="880005" y="4934"/>
                  <a:pt x="943005" y="70656"/>
                </a:cubicBezTo>
                <a:cubicBezTo>
                  <a:pt x="1006005" y="136378"/>
                  <a:pt x="996059" y="314852"/>
                  <a:pt x="1043750" y="408312"/>
                </a:cubicBezTo>
                <a:cubicBezTo>
                  <a:pt x="1091441" y="501772"/>
                  <a:pt x="1217203" y="551288"/>
                  <a:pt x="1109232" y="736349"/>
                </a:cubicBezTo>
                <a:cubicBezTo>
                  <a:pt x="1001261" y="921410"/>
                  <a:pt x="909010" y="916283"/>
                  <a:pt x="800660" y="979033"/>
                </a:cubicBezTo>
                <a:cubicBezTo>
                  <a:pt x="692310" y="1041783"/>
                  <a:pt x="610993" y="1182987"/>
                  <a:pt x="459134" y="1112850"/>
                </a:cubicBezTo>
                <a:cubicBezTo>
                  <a:pt x="307275" y="1042713"/>
                  <a:pt x="236284" y="885789"/>
                  <a:pt x="144341" y="783065"/>
                </a:cubicBezTo>
                <a:cubicBezTo>
                  <a:pt x="52398" y="680341"/>
                  <a:pt x="-32566" y="568958"/>
                  <a:pt x="12404" y="481516"/>
                </a:cubicBezTo>
                <a:close/>
              </a:path>
            </a:pathLst>
          </a:custGeom>
          <a:solidFill>
            <a:srgbClr val="9F7362">
              <a:alpha val="40000"/>
            </a:srgbClr>
          </a:solidFill>
          <a:ln w="28575">
            <a:solidFill>
              <a:srgbClr val="6A4D4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Oval 267">
            <a:extLst>
              <a:ext uri="{FF2B5EF4-FFF2-40B4-BE49-F238E27FC236}">
                <a16:creationId xmlns:a16="http://schemas.microsoft.com/office/drawing/2014/main" id="{4EFBE3F8-9C75-D320-DC92-BEF334619ABA}"/>
              </a:ext>
            </a:extLst>
          </p:cNvPr>
          <p:cNvSpPr/>
          <p:nvPr/>
        </p:nvSpPr>
        <p:spPr>
          <a:xfrm rot="12809198">
            <a:off x="5954997" y="2370612"/>
            <a:ext cx="137054" cy="147527"/>
          </a:xfrm>
          <a:custGeom>
            <a:avLst/>
            <a:gdLst>
              <a:gd name="connsiteX0" fmla="*/ 0 w 674557"/>
              <a:gd name="connsiteY0" fmla="*/ 304107 h 608213"/>
              <a:gd name="connsiteX1" fmla="*/ 337279 w 674557"/>
              <a:gd name="connsiteY1" fmla="*/ 0 h 608213"/>
              <a:gd name="connsiteX2" fmla="*/ 674558 w 674557"/>
              <a:gd name="connsiteY2" fmla="*/ 304107 h 608213"/>
              <a:gd name="connsiteX3" fmla="*/ 337279 w 674557"/>
              <a:gd name="connsiteY3" fmla="*/ 608214 h 608213"/>
              <a:gd name="connsiteX4" fmla="*/ 0 w 674557"/>
              <a:gd name="connsiteY4" fmla="*/ 304107 h 608213"/>
              <a:gd name="connsiteX0" fmla="*/ 0 w 674558"/>
              <a:gd name="connsiteY0" fmla="*/ 304107 h 713145"/>
              <a:gd name="connsiteX1" fmla="*/ 337279 w 674558"/>
              <a:gd name="connsiteY1" fmla="*/ 0 h 713145"/>
              <a:gd name="connsiteX2" fmla="*/ 674558 w 674558"/>
              <a:gd name="connsiteY2" fmla="*/ 304107 h 713145"/>
              <a:gd name="connsiteX3" fmla="*/ 337279 w 674558"/>
              <a:gd name="connsiteY3" fmla="*/ 713145 h 713145"/>
              <a:gd name="connsiteX4" fmla="*/ 0 w 674558"/>
              <a:gd name="connsiteY4" fmla="*/ 304107 h 713145"/>
              <a:gd name="connsiteX0" fmla="*/ 0 w 614597"/>
              <a:gd name="connsiteY0" fmla="*/ 319130 h 713194"/>
              <a:gd name="connsiteX1" fmla="*/ 277318 w 614597"/>
              <a:gd name="connsiteY1" fmla="*/ 33 h 713194"/>
              <a:gd name="connsiteX2" fmla="*/ 614597 w 614597"/>
              <a:gd name="connsiteY2" fmla="*/ 304140 h 713194"/>
              <a:gd name="connsiteX3" fmla="*/ 277318 w 614597"/>
              <a:gd name="connsiteY3" fmla="*/ 713178 h 713194"/>
              <a:gd name="connsiteX4" fmla="*/ 0 w 614597"/>
              <a:gd name="connsiteY4" fmla="*/ 319130 h 713194"/>
              <a:gd name="connsiteX0" fmla="*/ 0 w 659568"/>
              <a:gd name="connsiteY0" fmla="*/ 319240 h 713353"/>
              <a:gd name="connsiteX1" fmla="*/ 277318 w 659568"/>
              <a:gd name="connsiteY1" fmla="*/ 143 h 713353"/>
              <a:gd name="connsiteX2" fmla="*/ 659568 w 659568"/>
              <a:gd name="connsiteY2" fmla="*/ 289260 h 713353"/>
              <a:gd name="connsiteX3" fmla="*/ 277318 w 659568"/>
              <a:gd name="connsiteY3" fmla="*/ 713288 h 713353"/>
              <a:gd name="connsiteX4" fmla="*/ 0 w 659568"/>
              <a:gd name="connsiteY4" fmla="*/ 319240 h 713353"/>
              <a:gd name="connsiteX0" fmla="*/ 1600 w 661168"/>
              <a:gd name="connsiteY0" fmla="*/ 319240 h 788293"/>
              <a:gd name="connsiteX1" fmla="*/ 278918 w 661168"/>
              <a:gd name="connsiteY1" fmla="*/ 143 h 788293"/>
              <a:gd name="connsiteX2" fmla="*/ 661168 w 661168"/>
              <a:gd name="connsiteY2" fmla="*/ 289260 h 788293"/>
              <a:gd name="connsiteX3" fmla="*/ 188977 w 661168"/>
              <a:gd name="connsiteY3" fmla="*/ 788239 h 788293"/>
              <a:gd name="connsiteX4" fmla="*/ 1600 w 661168"/>
              <a:gd name="connsiteY4" fmla="*/ 319240 h 788293"/>
              <a:gd name="connsiteX0" fmla="*/ 1353 w 666543"/>
              <a:gd name="connsiteY0" fmla="*/ 319192 h 1005577"/>
              <a:gd name="connsiteX1" fmla="*/ 278671 w 666543"/>
              <a:gd name="connsiteY1" fmla="*/ 95 h 1005577"/>
              <a:gd name="connsiteX2" fmla="*/ 660921 w 666543"/>
              <a:gd name="connsiteY2" fmla="*/ 289212 h 1005577"/>
              <a:gd name="connsiteX3" fmla="*/ 539792 w 666543"/>
              <a:gd name="connsiteY3" fmla="*/ 983210 h 1005577"/>
              <a:gd name="connsiteX4" fmla="*/ 188730 w 666543"/>
              <a:gd name="connsiteY4" fmla="*/ 788191 h 1005577"/>
              <a:gd name="connsiteX5" fmla="*/ 1353 w 666543"/>
              <a:gd name="connsiteY5" fmla="*/ 319192 h 1005577"/>
              <a:gd name="connsiteX0" fmla="*/ 1353 w 675422"/>
              <a:gd name="connsiteY0" fmla="*/ 319182 h 995577"/>
              <a:gd name="connsiteX1" fmla="*/ 278671 w 675422"/>
              <a:gd name="connsiteY1" fmla="*/ 85 h 995577"/>
              <a:gd name="connsiteX2" fmla="*/ 660921 w 675422"/>
              <a:gd name="connsiteY2" fmla="*/ 289202 h 995577"/>
              <a:gd name="connsiteX3" fmla="*/ 539792 w 675422"/>
              <a:gd name="connsiteY3" fmla="*/ 443554 h 995577"/>
              <a:gd name="connsiteX4" fmla="*/ 539792 w 675422"/>
              <a:gd name="connsiteY4" fmla="*/ 983200 h 995577"/>
              <a:gd name="connsiteX5" fmla="*/ 188730 w 675422"/>
              <a:gd name="connsiteY5" fmla="*/ 788181 h 995577"/>
              <a:gd name="connsiteX6" fmla="*/ 1353 w 675422"/>
              <a:gd name="connsiteY6" fmla="*/ 319182 h 995577"/>
              <a:gd name="connsiteX0" fmla="*/ 1353 w 675262"/>
              <a:gd name="connsiteY0" fmla="*/ 319182 h 983625"/>
              <a:gd name="connsiteX1" fmla="*/ 278671 w 675262"/>
              <a:gd name="connsiteY1" fmla="*/ 85 h 983625"/>
              <a:gd name="connsiteX2" fmla="*/ 660921 w 675262"/>
              <a:gd name="connsiteY2" fmla="*/ 289202 h 983625"/>
              <a:gd name="connsiteX3" fmla="*/ 539792 w 675262"/>
              <a:gd name="connsiteY3" fmla="*/ 443554 h 983625"/>
              <a:gd name="connsiteX4" fmla="*/ 674703 w 675262"/>
              <a:gd name="connsiteY4" fmla="*/ 818308 h 983625"/>
              <a:gd name="connsiteX5" fmla="*/ 539792 w 675262"/>
              <a:gd name="connsiteY5" fmla="*/ 983200 h 983625"/>
              <a:gd name="connsiteX6" fmla="*/ 188730 w 675262"/>
              <a:gd name="connsiteY6" fmla="*/ 788181 h 983625"/>
              <a:gd name="connsiteX7" fmla="*/ 1353 w 675262"/>
              <a:gd name="connsiteY7" fmla="*/ 319182 h 983625"/>
              <a:gd name="connsiteX0" fmla="*/ 1353 w 674703"/>
              <a:gd name="connsiteY0" fmla="*/ 332766 h 997209"/>
              <a:gd name="connsiteX1" fmla="*/ 278671 w 674703"/>
              <a:gd name="connsiteY1" fmla="*/ 13669 h 997209"/>
              <a:gd name="connsiteX2" fmla="*/ 469697 w 674703"/>
              <a:gd name="connsiteY2" fmla="*/ 99855 h 997209"/>
              <a:gd name="connsiteX3" fmla="*/ 539792 w 674703"/>
              <a:gd name="connsiteY3" fmla="*/ 457138 h 997209"/>
              <a:gd name="connsiteX4" fmla="*/ 674703 w 674703"/>
              <a:gd name="connsiteY4" fmla="*/ 831892 h 997209"/>
              <a:gd name="connsiteX5" fmla="*/ 539792 w 674703"/>
              <a:gd name="connsiteY5" fmla="*/ 996784 h 997209"/>
              <a:gd name="connsiteX6" fmla="*/ 188730 w 674703"/>
              <a:gd name="connsiteY6" fmla="*/ 801765 h 997209"/>
              <a:gd name="connsiteX7" fmla="*/ 1353 w 674703"/>
              <a:gd name="connsiteY7" fmla="*/ 332766 h 997209"/>
              <a:gd name="connsiteX0" fmla="*/ 1130 w 674480"/>
              <a:gd name="connsiteY0" fmla="*/ 332766 h 1106491"/>
              <a:gd name="connsiteX1" fmla="*/ 278448 w 674480"/>
              <a:gd name="connsiteY1" fmla="*/ 13669 h 1106491"/>
              <a:gd name="connsiteX2" fmla="*/ 469474 w 674480"/>
              <a:gd name="connsiteY2" fmla="*/ 99855 h 1106491"/>
              <a:gd name="connsiteX3" fmla="*/ 539569 w 674480"/>
              <a:gd name="connsiteY3" fmla="*/ 457138 h 1106491"/>
              <a:gd name="connsiteX4" fmla="*/ 674480 w 674480"/>
              <a:gd name="connsiteY4" fmla="*/ 831892 h 1106491"/>
              <a:gd name="connsiteX5" fmla="*/ 386953 w 674480"/>
              <a:gd name="connsiteY5" fmla="*/ 1106270 h 1106491"/>
              <a:gd name="connsiteX6" fmla="*/ 188507 w 674480"/>
              <a:gd name="connsiteY6" fmla="*/ 801765 h 1106491"/>
              <a:gd name="connsiteX7" fmla="*/ 1130 w 674480"/>
              <a:gd name="connsiteY7" fmla="*/ 332766 h 1106491"/>
              <a:gd name="connsiteX0" fmla="*/ 1130 w 564488"/>
              <a:gd name="connsiteY0" fmla="*/ 332766 h 1106491"/>
              <a:gd name="connsiteX1" fmla="*/ 278448 w 564488"/>
              <a:gd name="connsiteY1" fmla="*/ 13669 h 1106491"/>
              <a:gd name="connsiteX2" fmla="*/ 469474 w 564488"/>
              <a:gd name="connsiteY2" fmla="*/ 99855 h 1106491"/>
              <a:gd name="connsiteX3" fmla="*/ 539569 w 564488"/>
              <a:gd name="connsiteY3" fmla="*/ 457138 h 1106491"/>
              <a:gd name="connsiteX4" fmla="*/ 564488 w 564488"/>
              <a:gd name="connsiteY4" fmla="*/ 1041840 h 1106491"/>
              <a:gd name="connsiteX5" fmla="*/ 386953 w 564488"/>
              <a:gd name="connsiteY5" fmla="*/ 1106270 h 1106491"/>
              <a:gd name="connsiteX6" fmla="*/ 188507 w 564488"/>
              <a:gd name="connsiteY6" fmla="*/ 801765 h 1106491"/>
              <a:gd name="connsiteX7" fmla="*/ 1130 w 564488"/>
              <a:gd name="connsiteY7" fmla="*/ 332766 h 1106491"/>
              <a:gd name="connsiteX0" fmla="*/ 1130 w 546440"/>
              <a:gd name="connsiteY0" fmla="*/ 332766 h 1106491"/>
              <a:gd name="connsiteX1" fmla="*/ 278448 w 546440"/>
              <a:gd name="connsiteY1" fmla="*/ 13669 h 1106491"/>
              <a:gd name="connsiteX2" fmla="*/ 469474 w 546440"/>
              <a:gd name="connsiteY2" fmla="*/ 99855 h 1106491"/>
              <a:gd name="connsiteX3" fmla="*/ 539569 w 546440"/>
              <a:gd name="connsiteY3" fmla="*/ 457138 h 1106491"/>
              <a:gd name="connsiteX4" fmla="*/ 546440 w 546440"/>
              <a:gd name="connsiteY4" fmla="*/ 651362 h 1106491"/>
              <a:gd name="connsiteX5" fmla="*/ 386953 w 546440"/>
              <a:gd name="connsiteY5" fmla="*/ 1106270 h 1106491"/>
              <a:gd name="connsiteX6" fmla="*/ 188507 w 546440"/>
              <a:gd name="connsiteY6" fmla="*/ 801765 h 1106491"/>
              <a:gd name="connsiteX7" fmla="*/ 1130 w 546440"/>
              <a:gd name="connsiteY7" fmla="*/ 332766 h 1106491"/>
              <a:gd name="connsiteX0" fmla="*/ 1054 w 546364"/>
              <a:gd name="connsiteY0" fmla="*/ 332766 h 814951"/>
              <a:gd name="connsiteX1" fmla="*/ 278372 w 546364"/>
              <a:gd name="connsiteY1" fmla="*/ 13669 h 814951"/>
              <a:gd name="connsiteX2" fmla="*/ 469398 w 546364"/>
              <a:gd name="connsiteY2" fmla="*/ 99855 h 814951"/>
              <a:gd name="connsiteX3" fmla="*/ 539493 w 546364"/>
              <a:gd name="connsiteY3" fmla="*/ 457138 h 814951"/>
              <a:gd name="connsiteX4" fmla="*/ 546364 w 546364"/>
              <a:gd name="connsiteY4" fmla="*/ 651362 h 814951"/>
              <a:gd name="connsiteX5" fmla="*/ 320522 w 546364"/>
              <a:gd name="connsiteY5" fmla="*/ 691553 h 814951"/>
              <a:gd name="connsiteX6" fmla="*/ 188431 w 546364"/>
              <a:gd name="connsiteY6" fmla="*/ 801765 h 814951"/>
              <a:gd name="connsiteX7" fmla="*/ 1054 w 546364"/>
              <a:gd name="connsiteY7" fmla="*/ 332766 h 814951"/>
              <a:gd name="connsiteX0" fmla="*/ 5548 w 550858"/>
              <a:gd name="connsiteY0" fmla="*/ 332766 h 702688"/>
              <a:gd name="connsiteX1" fmla="*/ 282866 w 550858"/>
              <a:gd name="connsiteY1" fmla="*/ 13669 h 702688"/>
              <a:gd name="connsiteX2" fmla="*/ 473892 w 550858"/>
              <a:gd name="connsiteY2" fmla="*/ 99855 h 702688"/>
              <a:gd name="connsiteX3" fmla="*/ 543987 w 550858"/>
              <a:gd name="connsiteY3" fmla="*/ 457138 h 702688"/>
              <a:gd name="connsiteX4" fmla="*/ 550858 w 550858"/>
              <a:gd name="connsiteY4" fmla="*/ 651362 h 702688"/>
              <a:gd name="connsiteX5" fmla="*/ 325016 w 550858"/>
              <a:gd name="connsiteY5" fmla="*/ 691553 h 702688"/>
              <a:gd name="connsiteX6" fmla="*/ 115031 w 550858"/>
              <a:gd name="connsiteY6" fmla="*/ 660349 h 702688"/>
              <a:gd name="connsiteX7" fmla="*/ 5548 w 550858"/>
              <a:gd name="connsiteY7" fmla="*/ 332766 h 7026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50858" h="702688">
                <a:moveTo>
                  <a:pt x="5548" y="332766"/>
                </a:moveTo>
                <a:cubicBezTo>
                  <a:pt x="33521" y="224986"/>
                  <a:pt x="204809" y="52488"/>
                  <a:pt x="282866" y="13669"/>
                </a:cubicBezTo>
                <a:cubicBezTo>
                  <a:pt x="360923" y="-25150"/>
                  <a:pt x="410385" y="23445"/>
                  <a:pt x="473892" y="99855"/>
                </a:cubicBezTo>
                <a:cubicBezTo>
                  <a:pt x="537399" y="176265"/>
                  <a:pt x="561677" y="381445"/>
                  <a:pt x="543987" y="457138"/>
                </a:cubicBezTo>
                <a:cubicBezTo>
                  <a:pt x="526297" y="532831"/>
                  <a:pt x="550858" y="561421"/>
                  <a:pt x="550858" y="651362"/>
                </a:cubicBezTo>
                <a:cubicBezTo>
                  <a:pt x="550858" y="741303"/>
                  <a:pt x="386025" y="684082"/>
                  <a:pt x="325016" y="691553"/>
                </a:cubicBezTo>
                <a:cubicBezTo>
                  <a:pt x="264007" y="699024"/>
                  <a:pt x="168276" y="720147"/>
                  <a:pt x="115031" y="660349"/>
                </a:cubicBezTo>
                <a:cubicBezTo>
                  <a:pt x="61786" y="600551"/>
                  <a:pt x="-22425" y="440546"/>
                  <a:pt x="5548" y="332766"/>
                </a:cubicBezTo>
                <a:close/>
              </a:path>
            </a:pathLst>
          </a:custGeom>
          <a:solidFill>
            <a:srgbClr val="9F7362">
              <a:alpha val="40000"/>
            </a:srgbClr>
          </a:solidFill>
          <a:ln w="28575">
            <a:solidFill>
              <a:srgbClr val="6A4D4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CBF2DB58-F365-0034-DCF3-AF7A333576AD}"/>
              </a:ext>
            </a:extLst>
          </p:cNvPr>
          <p:cNvSpPr txBox="1"/>
          <p:nvPr/>
        </p:nvSpPr>
        <p:spPr>
          <a:xfrm>
            <a:off x="4784432" y="5333863"/>
            <a:ext cx="2052165" cy="2460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99" b="1" dirty="0">
                <a:latin typeface="Arial" panose="020B0604020202020204" pitchFamily="34" charset="0"/>
                <a:cs typeface="Arial" panose="020B0604020202020204" pitchFamily="34" charset="0"/>
              </a:rPr>
              <a:t>Laser Capture Microdissection</a:t>
            </a:r>
          </a:p>
        </p:txBody>
      </p:sp>
      <p:sp>
        <p:nvSpPr>
          <p:cNvPr id="277" name="Rounded Rectangle 240">
            <a:extLst>
              <a:ext uri="{FF2B5EF4-FFF2-40B4-BE49-F238E27FC236}">
                <a16:creationId xmlns:a16="http://schemas.microsoft.com/office/drawing/2014/main" id="{12251699-C79A-4098-1740-729CCEAF714B}"/>
              </a:ext>
            </a:extLst>
          </p:cNvPr>
          <p:cNvSpPr/>
          <p:nvPr/>
        </p:nvSpPr>
        <p:spPr>
          <a:xfrm>
            <a:off x="1761898" y="6273132"/>
            <a:ext cx="2940752" cy="579053"/>
          </a:xfrm>
          <a:prstGeom prst="roundRect">
            <a:avLst/>
          </a:prstGeom>
          <a:solidFill>
            <a:srgbClr val="DCEAF7">
              <a:alpha val="74902"/>
            </a:srgb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Rounded Rectangle 241">
            <a:extLst>
              <a:ext uri="{FF2B5EF4-FFF2-40B4-BE49-F238E27FC236}">
                <a16:creationId xmlns:a16="http://schemas.microsoft.com/office/drawing/2014/main" id="{0208023E-8BB9-EB8A-A3C4-9067E66B560B}"/>
              </a:ext>
            </a:extLst>
          </p:cNvPr>
          <p:cNvSpPr/>
          <p:nvPr/>
        </p:nvSpPr>
        <p:spPr>
          <a:xfrm>
            <a:off x="1755616" y="6932228"/>
            <a:ext cx="2940752" cy="579053"/>
          </a:xfrm>
          <a:prstGeom prst="roundRect">
            <a:avLst/>
          </a:prstGeom>
          <a:solidFill>
            <a:srgbClr val="DCEAF7">
              <a:alpha val="74902"/>
            </a:srgb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Rounded Rectangle 242">
            <a:extLst>
              <a:ext uri="{FF2B5EF4-FFF2-40B4-BE49-F238E27FC236}">
                <a16:creationId xmlns:a16="http://schemas.microsoft.com/office/drawing/2014/main" id="{7A506B3C-013B-D766-76AF-C568B5026A67}"/>
              </a:ext>
            </a:extLst>
          </p:cNvPr>
          <p:cNvSpPr/>
          <p:nvPr/>
        </p:nvSpPr>
        <p:spPr>
          <a:xfrm>
            <a:off x="1765737" y="7621862"/>
            <a:ext cx="2940752" cy="579053"/>
          </a:xfrm>
          <a:prstGeom prst="roundRect">
            <a:avLst/>
          </a:prstGeom>
          <a:solidFill>
            <a:srgbClr val="DCEAF7">
              <a:alpha val="74902"/>
            </a:srgb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0" name="Straight Arrow Connector 279">
            <a:extLst>
              <a:ext uri="{FF2B5EF4-FFF2-40B4-BE49-F238E27FC236}">
                <a16:creationId xmlns:a16="http://schemas.microsoft.com/office/drawing/2014/main" id="{48013F2E-34A0-9508-E258-2717AD0DE763}"/>
              </a:ext>
            </a:extLst>
          </p:cNvPr>
          <p:cNvCxnSpPr>
            <a:cxnSpLocks/>
          </p:cNvCxnSpPr>
          <p:nvPr/>
        </p:nvCxnSpPr>
        <p:spPr>
          <a:xfrm>
            <a:off x="1390645" y="7227307"/>
            <a:ext cx="254533" cy="0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1" name="Straight Arrow Connector 280">
            <a:extLst>
              <a:ext uri="{FF2B5EF4-FFF2-40B4-BE49-F238E27FC236}">
                <a16:creationId xmlns:a16="http://schemas.microsoft.com/office/drawing/2014/main" id="{DCB71B03-5157-FF9B-7291-7137838E7714}"/>
              </a:ext>
            </a:extLst>
          </p:cNvPr>
          <p:cNvCxnSpPr>
            <a:cxnSpLocks/>
          </p:cNvCxnSpPr>
          <p:nvPr/>
        </p:nvCxnSpPr>
        <p:spPr>
          <a:xfrm flipV="1">
            <a:off x="1362486" y="6659526"/>
            <a:ext cx="233511" cy="114636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2" name="Straight Arrow Connector 281">
            <a:extLst>
              <a:ext uri="{FF2B5EF4-FFF2-40B4-BE49-F238E27FC236}">
                <a16:creationId xmlns:a16="http://schemas.microsoft.com/office/drawing/2014/main" id="{C7B60706-E15A-3C92-88A0-22B7654F619B}"/>
              </a:ext>
            </a:extLst>
          </p:cNvPr>
          <p:cNvCxnSpPr>
            <a:cxnSpLocks/>
          </p:cNvCxnSpPr>
          <p:nvPr/>
        </p:nvCxnSpPr>
        <p:spPr>
          <a:xfrm>
            <a:off x="1309163" y="7621862"/>
            <a:ext cx="233511" cy="114636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3" name="TextBox 282">
            <a:extLst>
              <a:ext uri="{FF2B5EF4-FFF2-40B4-BE49-F238E27FC236}">
                <a16:creationId xmlns:a16="http://schemas.microsoft.com/office/drawing/2014/main" id="{0630051D-09BE-4D68-FFEE-281DBF9876B6}"/>
              </a:ext>
            </a:extLst>
          </p:cNvPr>
          <p:cNvSpPr txBox="1"/>
          <p:nvPr/>
        </p:nvSpPr>
        <p:spPr>
          <a:xfrm>
            <a:off x="1829479" y="6433045"/>
            <a:ext cx="10823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egradation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86F2B431-EC47-602E-3FEB-6199C169EF78}"/>
              </a:ext>
            </a:extLst>
          </p:cNvPr>
          <p:cNvSpPr txBox="1"/>
          <p:nvPr/>
        </p:nvSpPr>
        <p:spPr>
          <a:xfrm>
            <a:off x="1829479" y="7074362"/>
            <a:ext cx="1563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nergy Production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88E2815E-0423-7363-780C-A56EC9AE6252}"/>
              </a:ext>
            </a:extLst>
          </p:cNvPr>
          <p:cNvSpPr txBox="1"/>
          <p:nvPr/>
        </p:nvSpPr>
        <p:spPr>
          <a:xfrm>
            <a:off x="1864082" y="7771603"/>
            <a:ext cx="1584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mmune Processes</a:t>
            </a:r>
          </a:p>
        </p:txBody>
      </p:sp>
      <p:sp>
        <p:nvSpPr>
          <p:cNvPr id="286" name="Oval 254">
            <a:extLst>
              <a:ext uri="{FF2B5EF4-FFF2-40B4-BE49-F238E27FC236}">
                <a16:creationId xmlns:a16="http://schemas.microsoft.com/office/drawing/2014/main" id="{EBDEF555-9D72-F0F8-BEB1-6B946A8266EB}"/>
              </a:ext>
            </a:extLst>
          </p:cNvPr>
          <p:cNvSpPr/>
          <p:nvPr/>
        </p:nvSpPr>
        <p:spPr>
          <a:xfrm>
            <a:off x="2976923" y="6355374"/>
            <a:ext cx="459739" cy="412898"/>
          </a:xfrm>
          <a:custGeom>
            <a:avLst/>
            <a:gdLst>
              <a:gd name="connsiteX0" fmla="*/ 0 w 1021977"/>
              <a:gd name="connsiteY0" fmla="*/ 433038 h 866076"/>
              <a:gd name="connsiteX1" fmla="*/ 510989 w 1021977"/>
              <a:gd name="connsiteY1" fmla="*/ 0 h 866076"/>
              <a:gd name="connsiteX2" fmla="*/ 1021978 w 1021977"/>
              <a:gd name="connsiteY2" fmla="*/ 433038 h 866076"/>
              <a:gd name="connsiteX3" fmla="*/ 510989 w 1021977"/>
              <a:gd name="connsiteY3" fmla="*/ 866076 h 866076"/>
              <a:gd name="connsiteX4" fmla="*/ 0 w 1021977"/>
              <a:gd name="connsiteY4" fmla="*/ 433038 h 866076"/>
              <a:gd name="connsiteX0" fmla="*/ 4 w 1021982"/>
              <a:gd name="connsiteY0" fmla="*/ 359079 h 792117"/>
              <a:gd name="connsiteX1" fmla="*/ 517717 w 1021982"/>
              <a:gd name="connsiteY1" fmla="*/ 0 h 792117"/>
              <a:gd name="connsiteX2" fmla="*/ 1021982 w 1021982"/>
              <a:gd name="connsiteY2" fmla="*/ 359079 h 792117"/>
              <a:gd name="connsiteX3" fmla="*/ 510993 w 1021982"/>
              <a:gd name="connsiteY3" fmla="*/ 792117 h 792117"/>
              <a:gd name="connsiteX4" fmla="*/ 4 w 1021982"/>
              <a:gd name="connsiteY4" fmla="*/ 359079 h 792117"/>
              <a:gd name="connsiteX0" fmla="*/ 9682 w 1031660"/>
              <a:gd name="connsiteY0" fmla="*/ 400301 h 833339"/>
              <a:gd name="connsiteX1" fmla="*/ 211387 w 1031660"/>
              <a:gd name="connsiteY1" fmla="*/ 47945 h 833339"/>
              <a:gd name="connsiteX2" fmla="*/ 527395 w 1031660"/>
              <a:gd name="connsiteY2" fmla="*/ 41222 h 833339"/>
              <a:gd name="connsiteX3" fmla="*/ 1031660 w 1031660"/>
              <a:gd name="connsiteY3" fmla="*/ 400301 h 833339"/>
              <a:gd name="connsiteX4" fmla="*/ 520671 w 1031660"/>
              <a:gd name="connsiteY4" fmla="*/ 833339 h 833339"/>
              <a:gd name="connsiteX5" fmla="*/ 9682 w 1031660"/>
              <a:gd name="connsiteY5" fmla="*/ 400301 h 833339"/>
              <a:gd name="connsiteX0" fmla="*/ 6466 w 1028444"/>
              <a:gd name="connsiteY0" fmla="*/ 400301 h 846828"/>
              <a:gd name="connsiteX1" fmla="*/ 208171 w 1028444"/>
              <a:gd name="connsiteY1" fmla="*/ 47945 h 846828"/>
              <a:gd name="connsiteX2" fmla="*/ 524179 w 1028444"/>
              <a:gd name="connsiteY2" fmla="*/ 41222 h 846828"/>
              <a:gd name="connsiteX3" fmla="*/ 1028444 w 1028444"/>
              <a:gd name="connsiteY3" fmla="*/ 400301 h 846828"/>
              <a:gd name="connsiteX4" fmla="*/ 517455 w 1028444"/>
              <a:gd name="connsiteY4" fmla="*/ 833339 h 846828"/>
              <a:gd name="connsiteX5" fmla="*/ 93871 w 1028444"/>
              <a:gd name="connsiteY5" fmla="*/ 706851 h 846828"/>
              <a:gd name="connsiteX6" fmla="*/ 6466 w 1028444"/>
              <a:gd name="connsiteY6" fmla="*/ 400301 h 846828"/>
              <a:gd name="connsiteX0" fmla="*/ 6466 w 1030468"/>
              <a:gd name="connsiteY0" fmla="*/ 400301 h 833403"/>
              <a:gd name="connsiteX1" fmla="*/ 208171 w 1030468"/>
              <a:gd name="connsiteY1" fmla="*/ 47945 h 833403"/>
              <a:gd name="connsiteX2" fmla="*/ 524179 w 1030468"/>
              <a:gd name="connsiteY2" fmla="*/ 41222 h 833403"/>
              <a:gd name="connsiteX3" fmla="*/ 1028444 w 1030468"/>
              <a:gd name="connsiteY3" fmla="*/ 400301 h 833403"/>
              <a:gd name="connsiteX4" fmla="*/ 678818 w 1030468"/>
              <a:gd name="connsiteY4" fmla="*/ 693403 h 833403"/>
              <a:gd name="connsiteX5" fmla="*/ 517455 w 1030468"/>
              <a:gd name="connsiteY5" fmla="*/ 833339 h 833403"/>
              <a:gd name="connsiteX6" fmla="*/ 93871 w 1030468"/>
              <a:gd name="connsiteY6" fmla="*/ 706851 h 833403"/>
              <a:gd name="connsiteX7" fmla="*/ 6466 w 1030468"/>
              <a:gd name="connsiteY7" fmla="*/ 400301 h 833403"/>
              <a:gd name="connsiteX0" fmla="*/ 6466 w 1040938"/>
              <a:gd name="connsiteY0" fmla="*/ 386831 h 819933"/>
              <a:gd name="connsiteX1" fmla="*/ 208171 w 1040938"/>
              <a:gd name="connsiteY1" fmla="*/ 34475 h 819933"/>
              <a:gd name="connsiteX2" fmla="*/ 524179 w 1040938"/>
              <a:gd name="connsiteY2" fmla="*/ 27752 h 819933"/>
              <a:gd name="connsiteX3" fmla="*/ 947759 w 1040938"/>
              <a:gd name="connsiteY3" fmla="*/ 162222 h 819933"/>
              <a:gd name="connsiteX4" fmla="*/ 1028444 w 1040938"/>
              <a:gd name="connsiteY4" fmla="*/ 386831 h 819933"/>
              <a:gd name="connsiteX5" fmla="*/ 678818 w 1040938"/>
              <a:gd name="connsiteY5" fmla="*/ 679933 h 819933"/>
              <a:gd name="connsiteX6" fmla="*/ 517455 w 1040938"/>
              <a:gd name="connsiteY6" fmla="*/ 819869 h 819933"/>
              <a:gd name="connsiteX7" fmla="*/ 93871 w 1040938"/>
              <a:gd name="connsiteY7" fmla="*/ 693381 h 819933"/>
              <a:gd name="connsiteX8" fmla="*/ 6466 w 1040938"/>
              <a:gd name="connsiteY8" fmla="*/ 386831 h 819933"/>
              <a:gd name="connsiteX0" fmla="*/ 6466 w 1037480"/>
              <a:gd name="connsiteY0" fmla="*/ 417473 h 850575"/>
              <a:gd name="connsiteX1" fmla="*/ 208171 w 1037480"/>
              <a:gd name="connsiteY1" fmla="*/ 65117 h 850575"/>
              <a:gd name="connsiteX2" fmla="*/ 524179 w 1037480"/>
              <a:gd name="connsiteY2" fmla="*/ 58394 h 850575"/>
              <a:gd name="connsiteX3" fmla="*/ 698989 w 1037480"/>
              <a:gd name="connsiteY3" fmla="*/ 4606 h 850575"/>
              <a:gd name="connsiteX4" fmla="*/ 947759 w 1037480"/>
              <a:gd name="connsiteY4" fmla="*/ 192864 h 850575"/>
              <a:gd name="connsiteX5" fmla="*/ 1028444 w 1037480"/>
              <a:gd name="connsiteY5" fmla="*/ 417473 h 850575"/>
              <a:gd name="connsiteX6" fmla="*/ 678818 w 1037480"/>
              <a:gd name="connsiteY6" fmla="*/ 710575 h 850575"/>
              <a:gd name="connsiteX7" fmla="*/ 517455 w 1037480"/>
              <a:gd name="connsiteY7" fmla="*/ 850511 h 850575"/>
              <a:gd name="connsiteX8" fmla="*/ 93871 w 1037480"/>
              <a:gd name="connsiteY8" fmla="*/ 724023 h 850575"/>
              <a:gd name="connsiteX9" fmla="*/ 6466 w 1037480"/>
              <a:gd name="connsiteY9" fmla="*/ 417473 h 850575"/>
              <a:gd name="connsiteX0" fmla="*/ 6466 w 1033753"/>
              <a:gd name="connsiteY0" fmla="*/ 417473 h 850575"/>
              <a:gd name="connsiteX1" fmla="*/ 208171 w 1033753"/>
              <a:gd name="connsiteY1" fmla="*/ 65117 h 850575"/>
              <a:gd name="connsiteX2" fmla="*/ 524179 w 1033753"/>
              <a:gd name="connsiteY2" fmla="*/ 58394 h 850575"/>
              <a:gd name="connsiteX3" fmla="*/ 698989 w 1033753"/>
              <a:gd name="connsiteY3" fmla="*/ 4606 h 850575"/>
              <a:gd name="connsiteX4" fmla="*/ 947759 w 1033753"/>
              <a:gd name="connsiteY4" fmla="*/ 192864 h 850575"/>
              <a:gd name="connsiteX5" fmla="*/ 1028444 w 1033753"/>
              <a:gd name="connsiteY5" fmla="*/ 417473 h 850575"/>
              <a:gd name="connsiteX6" fmla="*/ 887247 w 1033753"/>
              <a:gd name="connsiteY6" fmla="*/ 650064 h 850575"/>
              <a:gd name="connsiteX7" fmla="*/ 678818 w 1033753"/>
              <a:gd name="connsiteY7" fmla="*/ 710575 h 850575"/>
              <a:gd name="connsiteX8" fmla="*/ 517455 w 1033753"/>
              <a:gd name="connsiteY8" fmla="*/ 850511 h 850575"/>
              <a:gd name="connsiteX9" fmla="*/ 93871 w 1033753"/>
              <a:gd name="connsiteY9" fmla="*/ 724023 h 850575"/>
              <a:gd name="connsiteX10" fmla="*/ 6466 w 1033753"/>
              <a:gd name="connsiteY10" fmla="*/ 417473 h 850575"/>
              <a:gd name="connsiteX0" fmla="*/ 6466 w 1033753"/>
              <a:gd name="connsiteY0" fmla="*/ 417473 h 851052"/>
              <a:gd name="connsiteX1" fmla="*/ 208171 w 1033753"/>
              <a:gd name="connsiteY1" fmla="*/ 65117 h 851052"/>
              <a:gd name="connsiteX2" fmla="*/ 524179 w 1033753"/>
              <a:gd name="connsiteY2" fmla="*/ 58394 h 851052"/>
              <a:gd name="connsiteX3" fmla="*/ 698989 w 1033753"/>
              <a:gd name="connsiteY3" fmla="*/ 4606 h 851052"/>
              <a:gd name="connsiteX4" fmla="*/ 947759 w 1033753"/>
              <a:gd name="connsiteY4" fmla="*/ 192864 h 851052"/>
              <a:gd name="connsiteX5" fmla="*/ 1028444 w 1033753"/>
              <a:gd name="connsiteY5" fmla="*/ 417473 h 851052"/>
              <a:gd name="connsiteX6" fmla="*/ 887247 w 1033753"/>
              <a:gd name="connsiteY6" fmla="*/ 650064 h 851052"/>
              <a:gd name="connsiteX7" fmla="*/ 678818 w 1033753"/>
              <a:gd name="connsiteY7" fmla="*/ 710575 h 851052"/>
              <a:gd name="connsiteX8" fmla="*/ 517455 w 1033753"/>
              <a:gd name="connsiteY8" fmla="*/ 850511 h 851052"/>
              <a:gd name="connsiteX9" fmla="*/ 329195 w 1033753"/>
              <a:gd name="connsiteY9" fmla="*/ 757641 h 851052"/>
              <a:gd name="connsiteX10" fmla="*/ 93871 w 1033753"/>
              <a:gd name="connsiteY10" fmla="*/ 724023 h 851052"/>
              <a:gd name="connsiteX11" fmla="*/ 6466 w 1033753"/>
              <a:gd name="connsiteY11" fmla="*/ 417473 h 851052"/>
              <a:gd name="connsiteX0" fmla="*/ 5600 w 1032887"/>
              <a:gd name="connsiteY0" fmla="*/ 417473 h 851052"/>
              <a:gd name="connsiteX1" fmla="*/ 207305 w 1032887"/>
              <a:gd name="connsiteY1" fmla="*/ 65117 h 851052"/>
              <a:gd name="connsiteX2" fmla="*/ 523313 w 1032887"/>
              <a:gd name="connsiteY2" fmla="*/ 58394 h 851052"/>
              <a:gd name="connsiteX3" fmla="*/ 698123 w 1032887"/>
              <a:gd name="connsiteY3" fmla="*/ 4606 h 851052"/>
              <a:gd name="connsiteX4" fmla="*/ 946893 w 1032887"/>
              <a:gd name="connsiteY4" fmla="*/ 192864 h 851052"/>
              <a:gd name="connsiteX5" fmla="*/ 1027578 w 1032887"/>
              <a:gd name="connsiteY5" fmla="*/ 417473 h 851052"/>
              <a:gd name="connsiteX6" fmla="*/ 886381 w 1032887"/>
              <a:gd name="connsiteY6" fmla="*/ 650064 h 851052"/>
              <a:gd name="connsiteX7" fmla="*/ 677952 w 1032887"/>
              <a:gd name="connsiteY7" fmla="*/ 710575 h 851052"/>
              <a:gd name="connsiteX8" fmla="*/ 516589 w 1032887"/>
              <a:gd name="connsiteY8" fmla="*/ 850511 h 851052"/>
              <a:gd name="connsiteX9" fmla="*/ 328329 w 1032887"/>
              <a:gd name="connsiteY9" fmla="*/ 757641 h 851052"/>
              <a:gd name="connsiteX10" fmla="*/ 93005 w 1032887"/>
              <a:gd name="connsiteY10" fmla="*/ 724023 h 851052"/>
              <a:gd name="connsiteX11" fmla="*/ 59388 w 1032887"/>
              <a:gd name="connsiteY11" fmla="*/ 508869 h 851052"/>
              <a:gd name="connsiteX12" fmla="*/ 5600 w 1032887"/>
              <a:gd name="connsiteY12" fmla="*/ 417473 h 851052"/>
              <a:gd name="connsiteX0" fmla="*/ 4137 w 1031424"/>
              <a:gd name="connsiteY0" fmla="*/ 417473 h 851052"/>
              <a:gd name="connsiteX1" fmla="*/ 178949 w 1031424"/>
              <a:gd name="connsiteY1" fmla="*/ 219758 h 851052"/>
              <a:gd name="connsiteX2" fmla="*/ 205842 w 1031424"/>
              <a:gd name="connsiteY2" fmla="*/ 65117 h 851052"/>
              <a:gd name="connsiteX3" fmla="*/ 521850 w 1031424"/>
              <a:gd name="connsiteY3" fmla="*/ 58394 h 851052"/>
              <a:gd name="connsiteX4" fmla="*/ 696660 w 1031424"/>
              <a:gd name="connsiteY4" fmla="*/ 4606 h 851052"/>
              <a:gd name="connsiteX5" fmla="*/ 945430 w 1031424"/>
              <a:gd name="connsiteY5" fmla="*/ 192864 h 851052"/>
              <a:gd name="connsiteX6" fmla="*/ 1026115 w 1031424"/>
              <a:gd name="connsiteY6" fmla="*/ 417473 h 851052"/>
              <a:gd name="connsiteX7" fmla="*/ 884918 w 1031424"/>
              <a:gd name="connsiteY7" fmla="*/ 650064 h 851052"/>
              <a:gd name="connsiteX8" fmla="*/ 676489 w 1031424"/>
              <a:gd name="connsiteY8" fmla="*/ 710575 h 851052"/>
              <a:gd name="connsiteX9" fmla="*/ 515126 w 1031424"/>
              <a:gd name="connsiteY9" fmla="*/ 850511 h 851052"/>
              <a:gd name="connsiteX10" fmla="*/ 326866 w 1031424"/>
              <a:gd name="connsiteY10" fmla="*/ 757641 h 851052"/>
              <a:gd name="connsiteX11" fmla="*/ 91542 w 1031424"/>
              <a:gd name="connsiteY11" fmla="*/ 724023 h 851052"/>
              <a:gd name="connsiteX12" fmla="*/ 57925 w 1031424"/>
              <a:gd name="connsiteY12" fmla="*/ 508869 h 851052"/>
              <a:gd name="connsiteX13" fmla="*/ 4137 w 1031424"/>
              <a:gd name="connsiteY13" fmla="*/ 417473 h 851052"/>
              <a:gd name="connsiteX0" fmla="*/ 4137 w 1031424"/>
              <a:gd name="connsiteY0" fmla="*/ 416993 h 850572"/>
              <a:gd name="connsiteX1" fmla="*/ 178949 w 1031424"/>
              <a:gd name="connsiteY1" fmla="*/ 219278 h 850572"/>
              <a:gd name="connsiteX2" fmla="*/ 246183 w 1031424"/>
              <a:gd name="connsiteY2" fmla="*/ 4125 h 850572"/>
              <a:gd name="connsiteX3" fmla="*/ 521850 w 1031424"/>
              <a:gd name="connsiteY3" fmla="*/ 57914 h 850572"/>
              <a:gd name="connsiteX4" fmla="*/ 696660 w 1031424"/>
              <a:gd name="connsiteY4" fmla="*/ 4126 h 850572"/>
              <a:gd name="connsiteX5" fmla="*/ 945430 w 1031424"/>
              <a:gd name="connsiteY5" fmla="*/ 192384 h 850572"/>
              <a:gd name="connsiteX6" fmla="*/ 1026115 w 1031424"/>
              <a:gd name="connsiteY6" fmla="*/ 416993 h 850572"/>
              <a:gd name="connsiteX7" fmla="*/ 884918 w 1031424"/>
              <a:gd name="connsiteY7" fmla="*/ 649584 h 850572"/>
              <a:gd name="connsiteX8" fmla="*/ 676489 w 1031424"/>
              <a:gd name="connsiteY8" fmla="*/ 710095 h 850572"/>
              <a:gd name="connsiteX9" fmla="*/ 515126 w 1031424"/>
              <a:gd name="connsiteY9" fmla="*/ 850031 h 850572"/>
              <a:gd name="connsiteX10" fmla="*/ 326866 w 1031424"/>
              <a:gd name="connsiteY10" fmla="*/ 757161 h 850572"/>
              <a:gd name="connsiteX11" fmla="*/ 91542 w 1031424"/>
              <a:gd name="connsiteY11" fmla="*/ 723543 h 850572"/>
              <a:gd name="connsiteX12" fmla="*/ 57925 w 1031424"/>
              <a:gd name="connsiteY12" fmla="*/ 508389 h 850572"/>
              <a:gd name="connsiteX13" fmla="*/ 4137 w 1031424"/>
              <a:gd name="connsiteY13" fmla="*/ 416993 h 850572"/>
              <a:gd name="connsiteX0" fmla="*/ 4137 w 1030097"/>
              <a:gd name="connsiteY0" fmla="*/ 416670 h 850249"/>
              <a:gd name="connsiteX1" fmla="*/ 178949 w 1030097"/>
              <a:gd name="connsiteY1" fmla="*/ 218955 h 850249"/>
              <a:gd name="connsiteX2" fmla="*/ 246183 w 1030097"/>
              <a:gd name="connsiteY2" fmla="*/ 3802 h 850249"/>
              <a:gd name="connsiteX3" fmla="*/ 521850 w 1030097"/>
              <a:gd name="connsiteY3" fmla="*/ 57591 h 850249"/>
              <a:gd name="connsiteX4" fmla="*/ 696660 w 1030097"/>
              <a:gd name="connsiteY4" fmla="*/ 3803 h 850249"/>
              <a:gd name="connsiteX5" fmla="*/ 797513 w 1030097"/>
              <a:gd name="connsiteY5" fmla="*/ 144996 h 850249"/>
              <a:gd name="connsiteX6" fmla="*/ 945430 w 1030097"/>
              <a:gd name="connsiteY6" fmla="*/ 192061 h 850249"/>
              <a:gd name="connsiteX7" fmla="*/ 1026115 w 1030097"/>
              <a:gd name="connsiteY7" fmla="*/ 416670 h 850249"/>
              <a:gd name="connsiteX8" fmla="*/ 884918 w 1030097"/>
              <a:gd name="connsiteY8" fmla="*/ 649261 h 850249"/>
              <a:gd name="connsiteX9" fmla="*/ 676489 w 1030097"/>
              <a:gd name="connsiteY9" fmla="*/ 709772 h 850249"/>
              <a:gd name="connsiteX10" fmla="*/ 515126 w 1030097"/>
              <a:gd name="connsiteY10" fmla="*/ 849708 h 850249"/>
              <a:gd name="connsiteX11" fmla="*/ 326866 w 1030097"/>
              <a:gd name="connsiteY11" fmla="*/ 756838 h 850249"/>
              <a:gd name="connsiteX12" fmla="*/ 91542 w 1030097"/>
              <a:gd name="connsiteY12" fmla="*/ 723220 h 850249"/>
              <a:gd name="connsiteX13" fmla="*/ 57925 w 1030097"/>
              <a:gd name="connsiteY13" fmla="*/ 508066 h 850249"/>
              <a:gd name="connsiteX14" fmla="*/ 4137 w 1030097"/>
              <a:gd name="connsiteY14" fmla="*/ 416670 h 850249"/>
              <a:gd name="connsiteX0" fmla="*/ 4137 w 977150"/>
              <a:gd name="connsiteY0" fmla="*/ 416670 h 850249"/>
              <a:gd name="connsiteX1" fmla="*/ 178949 w 977150"/>
              <a:gd name="connsiteY1" fmla="*/ 218955 h 850249"/>
              <a:gd name="connsiteX2" fmla="*/ 246183 w 977150"/>
              <a:gd name="connsiteY2" fmla="*/ 3802 h 850249"/>
              <a:gd name="connsiteX3" fmla="*/ 521850 w 977150"/>
              <a:gd name="connsiteY3" fmla="*/ 57591 h 850249"/>
              <a:gd name="connsiteX4" fmla="*/ 696660 w 977150"/>
              <a:gd name="connsiteY4" fmla="*/ 3803 h 850249"/>
              <a:gd name="connsiteX5" fmla="*/ 797513 w 977150"/>
              <a:gd name="connsiteY5" fmla="*/ 144996 h 850249"/>
              <a:gd name="connsiteX6" fmla="*/ 945430 w 977150"/>
              <a:gd name="connsiteY6" fmla="*/ 192061 h 850249"/>
              <a:gd name="connsiteX7" fmla="*/ 965603 w 977150"/>
              <a:gd name="connsiteY7" fmla="*/ 396500 h 850249"/>
              <a:gd name="connsiteX8" fmla="*/ 884918 w 977150"/>
              <a:gd name="connsiteY8" fmla="*/ 649261 h 850249"/>
              <a:gd name="connsiteX9" fmla="*/ 676489 w 977150"/>
              <a:gd name="connsiteY9" fmla="*/ 709772 h 850249"/>
              <a:gd name="connsiteX10" fmla="*/ 515126 w 977150"/>
              <a:gd name="connsiteY10" fmla="*/ 849708 h 850249"/>
              <a:gd name="connsiteX11" fmla="*/ 326866 w 977150"/>
              <a:gd name="connsiteY11" fmla="*/ 756838 h 850249"/>
              <a:gd name="connsiteX12" fmla="*/ 91542 w 977150"/>
              <a:gd name="connsiteY12" fmla="*/ 723220 h 850249"/>
              <a:gd name="connsiteX13" fmla="*/ 57925 w 977150"/>
              <a:gd name="connsiteY13" fmla="*/ 508066 h 850249"/>
              <a:gd name="connsiteX14" fmla="*/ 4137 w 977150"/>
              <a:gd name="connsiteY14" fmla="*/ 416670 h 850249"/>
              <a:gd name="connsiteX0" fmla="*/ 4137 w 1019578"/>
              <a:gd name="connsiteY0" fmla="*/ 416670 h 850249"/>
              <a:gd name="connsiteX1" fmla="*/ 178949 w 1019578"/>
              <a:gd name="connsiteY1" fmla="*/ 218955 h 850249"/>
              <a:gd name="connsiteX2" fmla="*/ 246183 w 1019578"/>
              <a:gd name="connsiteY2" fmla="*/ 3802 h 850249"/>
              <a:gd name="connsiteX3" fmla="*/ 521850 w 1019578"/>
              <a:gd name="connsiteY3" fmla="*/ 57591 h 850249"/>
              <a:gd name="connsiteX4" fmla="*/ 696660 w 1019578"/>
              <a:gd name="connsiteY4" fmla="*/ 3803 h 850249"/>
              <a:gd name="connsiteX5" fmla="*/ 797513 w 1019578"/>
              <a:gd name="connsiteY5" fmla="*/ 144996 h 850249"/>
              <a:gd name="connsiteX6" fmla="*/ 945430 w 1019578"/>
              <a:gd name="connsiteY6" fmla="*/ 192061 h 850249"/>
              <a:gd name="connsiteX7" fmla="*/ 1019390 w 1019578"/>
              <a:gd name="connsiteY7" fmla="*/ 319807 h 850249"/>
              <a:gd name="connsiteX8" fmla="*/ 965603 w 1019578"/>
              <a:gd name="connsiteY8" fmla="*/ 396500 h 850249"/>
              <a:gd name="connsiteX9" fmla="*/ 884918 w 1019578"/>
              <a:gd name="connsiteY9" fmla="*/ 649261 h 850249"/>
              <a:gd name="connsiteX10" fmla="*/ 676489 w 1019578"/>
              <a:gd name="connsiteY10" fmla="*/ 709772 h 850249"/>
              <a:gd name="connsiteX11" fmla="*/ 515126 w 1019578"/>
              <a:gd name="connsiteY11" fmla="*/ 849708 h 850249"/>
              <a:gd name="connsiteX12" fmla="*/ 326866 w 1019578"/>
              <a:gd name="connsiteY12" fmla="*/ 756838 h 850249"/>
              <a:gd name="connsiteX13" fmla="*/ 91542 w 1019578"/>
              <a:gd name="connsiteY13" fmla="*/ 723220 h 850249"/>
              <a:gd name="connsiteX14" fmla="*/ 57925 w 1019578"/>
              <a:gd name="connsiteY14" fmla="*/ 508066 h 850249"/>
              <a:gd name="connsiteX15" fmla="*/ 4137 w 1019578"/>
              <a:gd name="connsiteY15" fmla="*/ 416670 h 8502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019578" h="850249">
                <a:moveTo>
                  <a:pt x="4137" y="416670"/>
                </a:moveTo>
                <a:cubicBezTo>
                  <a:pt x="24308" y="368485"/>
                  <a:pt x="145332" y="277681"/>
                  <a:pt x="178949" y="218955"/>
                </a:cubicBezTo>
                <a:cubicBezTo>
                  <a:pt x="212566" y="160229"/>
                  <a:pt x="176706" y="25093"/>
                  <a:pt x="246183" y="3802"/>
                </a:cubicBezTo>
                <a:cubicBezTo>
                  <a:pt x="315660" y="-17489"/>
                  <a:pt x="446771" y="57591"/>
                  <a:pt x="521850" y="57591"/>
                </a:cubicBezTo>
                <a:cubicBezTo>
                  <a:pt x="596929" y="57591"/>
                  <a:pt x="645113" y="-679"/>
                  <a:pt x="696660" y="3803"/>
                </a:cubicBezTo>
                <a:cubicBezTo>
                  <a:pt x="748207" y="8285"/>
                  <a:pt x="756051" y="113620"/>
                  <a:pt x="797513" y="144996"/>
                </a:cubicBezTo>
                <a:cubicBezTo>
                  <a:pt x="838975" y="176372"/>
                  <a:pt x="916295" y="170770"/>
                  <a:pt x="945430" y="192061"/>
                </a:cubicBezTo>
                <a:cubicBezTo>
                  <a:pt x="974565" y="213352"/>
                  <a:pt x="1016028" y="285734"/>
                  <a:pt x="1019390" y="319807"/>
                </a:cubicBezTo>
                <a:cubicBezTo>
                  <a:pt x="1022752" y="353880"/>
                  <a:pt x="980171" y="333747"/>
                  <a:pt x="965603" y="396500"/>
                </a:cubicBezTo>
                <a:cubicBezTo>
                  <a:pt x="951035" y="459253"/>
                  <a:pt x="943189" y="600411"/>
                  <a:pt x="884918" y="649261"/>
                </a:cubicBezTo>
                <a:cubicBezTo>
                  <a:pt x="826647" y="698111"/>
                  <a:pt x="726915" y="668520"/>
                  <a:pt x="676489" y="709772"/>
                </a:cubicBezTo>
                <a:cubicBezTo>
                  <a:pt x="626063" y="751024"/>
                  <a:pt x="573396" y="841864"/>
                  <a:pt x="515126" y="849708"/>
                </a:cubicBezTo>
                <a:cubicBezTo>
                  <a:pt x="456856" y="857552"/>
                  <a:pt x="397463" y="777919"/>
                  <a:pt x="326866" y="756838"/>
                </a:cubicBezTo>
                <a:cubicBezTo>
                  <a:pt x="256269" y="735757"/>
                  <a:pt x="146451" y="755717"/>
                  <a:pt x="91542" y="723220"/>
                </a:cubicBezTo>
                <a:cubicBezTo>
                  <a:pt x="36633" y="690723"/>
                  <a:pt x="72493" y="559158"/>
                  <a:pt x="57925" y="508066"/>
                </a:cubicBezTo>
                <a:cubicBezTo>
                  <a:pt x="43357" y="456974"/>
                  <a:pt x="-16034" y="464855"/>
                  <a:pt x="4137" y="416670"/>
                </a:cubicBezTo>
                <a:close/>
              </a:path>
            </a:pathLst>
          </a:cu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Oval 254">
            <a:extLst>
              <a:ext uri="{FF2B5EF4-FFF2-40B4-BE49-F238E27FC236}">
                <a16:creationId xmlns:a16="http://schemas.microsoft.com/office/drawing/2014/main" id="{BE28F77E-B14B-75CB-0821-8F4B66B8828B}"/>
              </a:ext>
            </a:extLst>
          </p:cNvPr>
          <p:cNvSpPr/>
          <p:nvPr/>
        </p:nvSpPr>
        <p:spPr>
          <a:xfrm>
            <a:off x="3533473" y="6414653"/>
            <a:ext cx="346972" cy="318233"/>
          </a:xfrm>
          <a:custGeom>
            <a:avLst/>
            <a:gdLst>
              <a:gd name="connsiteX0" fmla="*/ 0 w 1021977"/>
              <a:gd name="connsiteY0" fmla="*/ 433038 h 866076"/>
              <a:gd name="connsiteX1" fmla="*/ 510989 w 1021977"/>
              <a:gd name="connsiteY1" fmla="*/ 0 h 866076"/>
              <a:gd name="connsiteX2" fmla="*/ 1021978 w 1021977"/>
              <a:gd name="connsiteY2" fmla="*/ 433038 h 866076"/>
              <a:gd name="connsiteX3" fmla="*/ 510989 w 1021977"/>
              <a:gd name="connsiteY3" fmla="*/ 866076 h 866076"/>
              <a:gd name="connsiteX4" fmla="*/ 0 w 1021977"/>
              <a:gd name="connsiteY4" fmla="*/ 433038 h 866076"/>
              <a:gd name="connsiteX0" fmla="*/ 4 w 1021982"/>
              <a:gd name="connsiteY0" fmla="*/ 359079 h 792117"/>
              <a:gd name="connsiteX1" fmla="*/ 517717 w 1021982"/>
              <a:gd name="connsiteY1" fmla="*/ 0 h 792117"/>
              <a:gd name="connsiteX2" fmla="*/ 1021982 w 1021982"/>
              <a:gd name="connsiteY2" fmla="*/ 359079 h 792117"/>
              <a:gd name="connsiteX3" fmla="*/ 510993 w 1021982"/>
              <a:gd name="connsiteY3" fmla="*/ 792117 h 792117"/>
              <a:gd name="connsiteX4" fmla="*/ 4 w 1021982"/>
              <a:gd name="connsiteY4" fmla="*/ 359079 h 792117"/>
              <a:gd name="connsiteX0" fmla="*/ 9682 w 1031660"/>
              <a:gd name="connsiteY0" fmla="*/ 400301 h 833339"/>
              <a:gd name="connsiteX1" fmla="*/ 211387 w 1031660"/>
              <a:gd name="connsiteY1" fmla="*/ 47945 h 833339"/>
              <a:gd name="connsiteX2" fmla="*/ 527395 w 1031660"/>
              <a:gd name="connsiteY2" fmla="*/ 41222 h 833339"/>
              <a:gd name="connsiteX3" fmla="*/ 1031660 w 1031660"/>
              <a:gd name="connsiteY3" fmla="*/ 400301 h 833339"/>
              <a:gd name="connsiteX4" fmla="*/ 520671 w 1031660"/>
              <a:gd name="connsiteY4" fmla="*/ 833339 h 833339"/>
              <a:gd name="connsiteX5" fmla="*/ 9682 w 1031660"/>
              <a:gd name="connsiteY5" fmla="*/ 400301 h 833339"/>
              <a:gd name="connsiteX0" fmla="*/ 6466 w 1028444"/>
              <a:gd name="connsiteY0" fmla="*/ 400301 h 846828"/>
              <a:gd name="connsiteX1" fmla="*/ 208171 w 1028444"/>
              <a:gd name="connsiteY1" fmla="*/ 47945 h 846828"/>
              <a:gd name="connsiteX2" fmla="*/ 524179 w 1028444"/>
              <a:gd name="connsiteY2" fmla="*/ 41222 h 846828"/>
              <a:gd name="connsiteX3" fmla="*/ 1028444 w 1028444"/>
              <a:gd name="connsiteY3" fmla="*/ 400301 h 846828"/>
              <a:gd name="connsiteX4" fmla="*/ 517455 w 1028444"/>
              <a:gd name="connsiteY4" fmla="*/ 833339 h 846828"/>
              <a:gd name="connsiteX5" fmla="*/ 93871 w 1028444"/>
              <a:gd name="connsiteY5" fmla="*/ 706851 h 846828"/>
              <a:gd name="connsiteX6" fmla="*/ 6466 w 1028444"/>
              <a:gd name="connsiteY6" fmla="*/ 400301 h 846828"/>
              <a:gd name="connsiteX0" fmla="*/ 6466 w 1030468"/>
              <a:gd name="connsiteY0" fmla="*/ 400301 h 833403"/>
              <a:gd name="connsiteX1" fmla="*/ 208171 w 1030468"/>
              <a:gd name="connsiteY1" fmla="*/ 47945 h 833403"/>
              <a:gd name="connsiteX2" fmla="*/ 524179 w 1030468"/>
              <a:gd name="connsiteY2" fmla="*/ 41222 h 833403"/>
              <a:gd name="connsiteX3" fmla="*/ 1028444 w 1030468"/>
              <a:gd name="connsiteY3" fmla="*/ 400301 h 833403"/>
              <a:gd name="connsiteX4" fmla="*/ 678818 w 1030468"/>
              <a:gd name="connsiteY4" fmla="*/ 693403 h 833403"/>
              <a:gd name="connsiteX5" fmla="*/ 517455 w 1030468"/>
              <a:gd name="connsiteY5" fmla="*/ 833339 h 833403"/>
              <a:gd name="connsiteX6" fmla="*/ 93871 w 1030468"/>
              <a:gd name="connsiteY6" fmla="*/ 706851 h 833403"/>
              <a:gd name="connsiteX7" fmla="*/ 6466 w 1030468"/>
              <a:gd name="connsiteY7" fmla="*/ 400301 h 833403"/>
              <a:gd name="connsiteX0" fmla="*/ 6466 w 1040938"/>
              <a:gd name="connsiteY0" fmla="*/ 386831 h 819933"/>
              <a:gd name="connsiteX1" fmla="*/ 208171 w 1040938"/>
              <a:gd name="connsiteY1" fmla="*/ 34475 h 819933"/>
              <a:gd name="connsiteX2" fmla="*/ 524179 w 1040938"/>
              <a:gd name="connsiteY2" fmla="*/ 27752 h 819933"/>
              <a:gd name="connsiteX3" fmla="*/ 947759 w 1040938"/>
              <a:gd name="connsiteY3" fmla="*/ 162222 h 819933"/>
              <a:gd name="connsiteX4" fmla="*/ 1028444 w 1040938"/>
              <a:gd name="connsiteY4" fmla="*/ 386831 h 819933"/>
              <a:gd name="connsiteX5" fmla="*/ 678818 w 1040938"/>
              <a:gd name="connsiteY5" fmla="*/ 679933 h 819933"/>
              <a:gd name="connsiteX6" fmla="*/ 517455 w 1040938"/>
              <a:gd name="connsiteY6" fmla="*/ 819869 h 819933"/>
              <a:gd name="connsiteX7" fmla="*/ 93871 w 1040938"/>
              <a:gd name="connsiteY7" fmla="*/ 693381 h 819933"/>
              <a:gd name="connsiteX8" fmla="*/ 6466 w 1040938"/>
              <a:gd name="connsiteY8" fmla="*/ 386831 h 819933"/>
              <a:gd name="connsiteX0" fmla="*/ 6466 w 1037480"/>
              <a:gd name="connsiteY0" fmla="*/ 417473 h 850575"/>
              <a:gd name="connsiteX1" fmla="*/ 208171 w 1037480"/>
              <a:gd name="connsiteY1" fmla="*/ 65117 h 850575"/>
              <a:gd name="connsiteX2" fmla="*/ 524179 w 1037480"/>
              <a:gd name="connsiteY2" fmla="*/ 58394 h 850575"/>
              <a:gd name="connsiteX3" fmla="*/ 698989 w 1037480"/>
              <a:gd name="connsiteY3" fmla="*/ 4606 h 850575"/>
              <a:gd name="connsiteX4" fmla="*/ 947759 w 1037480"/>
              <a:gd name="connsiteY4" fmla="*/ 192864 h 850575"/>
              <a:gd name="connsiteX5" fmla="*/ 1028444 w 1037480"/>
              <a:gd name="connsiteY5" fmla="*/ 417473 h 850575"/>
              <a:gd name="connsiteX6" fmla="*/ 678818 w 1037480"/>
              <a:gd name="connsiteY6" fmla="*/ 710575 h 850575"/>
              <a:gd name="connsiteX7" fmla="*/ 517455 w 1037480"/>
              <a:gd name="connsiteY7" fmla="*/ 850511 h 850575"/>
              <a:gd name="connsiteX8" fmla="*/ 93871 w 1037480"/>
              <a:gd name="connsiteY8" fmla="*/ 724023 h 850575"/>
              <a:gd name="connsiteX9" fmla="*/ 6466 w 1037480"/>
              <a:gd name="connsiteY9" fmla="*/ 417473 h 850575"/>
              <a:gd name="connsiteX0" fmla="*/ 6466 w 1033753"/>
              <a:gd name="connsiteY0" fmla="*/ 417473 h 850575"/>
              <a:gd name="connsiteX1" fmla="*/ 208171 w 1033753"/>
              <a:gd name="connsiteY1" fmla="*/ 65117 h 850575"/>
              <a:gd name="connsiteX2" fmla="*/ 524179 w 1033753"/>
              <a:gd name="connsiteY2" fmla="*/ 58394 h 850575"/>
              <a:gd name="connsiteX3" fmla="*/ 698989 w 1033753"/>
              <a:gd name="connsiteY3" fmla="*/ 4606 h 850575"/>
              <a:gd name="connsiteX4" fmla="*/ 947759 w 1033753"/>
              <a:gd name="connsiteY4" fmla="*/ 192864 h 850575"/>
              <a:gd name="connsiteX5" fmla="*/ 1028444 w 1033753"/>
              <a:gd name="connsiteY5" fmla="*/ 417473 h 850575"/>
              <a:gd name="connsiteX6" fmla="*/ 887247 w 1033753"/>
              <a:gd name="connsiteY6" fmla="*/ 650064 h 850575"/>
              <a:gd name="connsiteX7" fmla="*/ 678818 w 1033753"/>
              <a:gd name="connsiteY7" fmla="*/ 710575 h 850575"/>
              <a:gd name="connsiteX8" fmla="*/ 517455 w 1033753"/>
              <a:gd name="connsiteY8" fmla="*/ 850511 h 850575"/>
              <a:gd name="connsiteX9" fmla="*/ 93871 w 1033753"/>
              <a:gd name="connsiteY9" fmla="*/ 724023 h 850575"/>
              <a:gd name="connsiteX10" fmla="*/ 6466 w 1033753"/>
              <a:gd name="connsiteY10" fmla="*/ 417473 h 850575"/>
              <a:gd name="connsiteX0" fmla="*/ 6466 w 1033753"/>
              <a:gd name="connsiteY0" fmla="*/ 417473 h 851052"/>
              <a:gd name="connsiteX1" fmla="*/ 208171 w 1033753"/>
              <a:gd name="connsiteY1" fmla="*/ 65117 h 851052"/>
              <a:gd name="connsiteX2" fmla="*/ 524179 w 1033753"/>
              <a:gd name="connsiteY2" fmla="*/ 58394 h 851052"/>
              <a:gd name="connsiteX3" fmla="*/ 698989 w 1033753"/>
              <a:gd name="connsiteY3" fmla="*/ 4606 h 851052"/>
              <a:gd name="connsiteX4" fmla="*/ 947759 w 1033753"/>
              <a:gd name="connsiteY4" fmla="*/ 192864 h 851052"/>
              <a:gd name="connsiteX5" fmla="*/ 1028444 w 1033753"/>
              <a:gd name="connsiteY5" fmla="*/ 417473 h 851052"/>
              <a:gd name="connsiteX6" fmla="*/ 887247 w 1033753"/>
              <a:gd name="connsiteY6" fmla="*/ 650064 h 851052"/>
              <a:gd name="connsiteX7" fmla="*/ 678818 w 1033753"/>
              <a:gd name="connsiteY7" fmla="*/ 710575 h 851052"/>
              <a:gd name="connsiteX8" fmla="*/ 517455 w 1033753"/>
              <a:gd name="connsiteY8" fmla="*/ 850511 h 851052"/>
              <a:gd name="connsiteX9" fmla="*/ 329195 w 1033753"/>
              <a:gd name="connsiteY9" fmla="*/ 757641 h 851052"/>
              <a:gd name="connsiteX10" fmla="*/ 93871 w 1033753"/>
              <a:gd name="connsiteY10" fmla="*/ 724023 h 851052"/>
              <a:gd name="connsiteX11" fmla="*/ 6466 w 1033753"/>
              <a:gd name="connsiteY11" fmla="*/ 417473 h 851052"/>
              <a:gd name="connsiteX0" fmla="*/ 5600 w 1032887"/>
              <a:gd name="connsiteY0" fmla="*/ 417473 h 851052"/>
              <a:gd name="connsiteX1" fmla="*/ 207305 w 1032887"/>
              <a:gd name="connsiteY1" fmla="*/ 65117 h 851052"/>
              <a:gd name="connsiteX2" fmla="*/ 523313 w 1032887"/>
              <a:gd name="connsiteY2" fmla="*/ 58394 h 851052"/>
              <a:gd name="connsiteX3" fmla="*/ 698123 w 1032887"/>
              <a:gd name="connsiteY3" fmla="*/ 4606 h 851052"/>
              <a:gd name="connsiteX4" fmla="*/ 946893 w 1032887"/>
              <a:gd name="connsiteY4" fmla="*/ 192864 h 851052"/>
              <a:gd name="connsiteX5" fmla="*/ 1027578 w 1032887"/>
              <a:gd name="connsiteY5" fmla="*/ 417473 h 851052"/>
              <a:gd name="connsiteX6" fmla="*/ 886381 w 1032887"/>
              <a:gd name="connsiteY6" fmla="*/ 650064 h 851052"/>
              <a:gd name="connsiteX7" fmla="*/ 677952 w 1032887"/>
              <a:gd name="connsiteY7" fmla="*/ 710575 h 851052"/>
              <a:gd name="connsiteX8" fmla="*/ 516589 w 1032887"/>
              <a:gd name="connsiteY8" fmla="*/ 850511 h 851052"/>
              <a:gd name="connsiteX9" fmla="*/ 328329 w 1032887"/>
              <a:gd name="connsiteY9" fmla="*/ 757641 h 851052"/>
              <a:gd name="connsiteX10" fmla="*/ 93005 w 1032887"/>
              <a:gd name="connsiteY10" fmla="*/ 724023 h 851052"/>
              <a:gd name="connsiteX11" fmla="*/ 59388 w 1032887"/>
              <a:gd name="connsiteY11" fmla="*/ 508869 h 851052"/>
              <a:gd name="connsiteX12" fmla="*/ 5600 w 1032887"/>
              <a:gd name="connsiteY12" fmla="*/ 417473 h 851052"/>
              <a:gd name="connsiteX0" fmla="*/ 4137 w 1031424"/>
              <a:gd name="connsiteY0" fmla="*/ 417473 h 851052"/>
              <a:gd name="connsiteX1" fmla="*/ 178949 w 1031424"/>
              <a:gd name="connsiteY1" fmla="*/ 219758 h 851052"/>
              <a:gd name="connsiteX2" fmla="*/ 205842 w 1031424"/>
              <a:gd name="connsiteY2" fmla="*/ 65117 h 851052"/>
              <a:gd name="connsiteX3" fmla="*/ 521850 w 1031424"/>
              <a:gd name="connsiteY3" fmla="*/ 58394 h 851052"/>
              <a:gd name="connsiteX4" fmla="*/ 696660 w 1031424"/>
              <a:gd name="connsiteY4" fmla="*/ 4606 h 851052"/>
              <a:gd name="connsiteX5" fmla="*/ 945430 w 1031424"/>
              <a:gd name="connsiteY5" fmla="*/ 192864 h 851052"/>
              <a:gd name="connsiteX6" fmla="*/ 1026115 w 1031424"/>
              <a:gd name="connsiteY6" fmla="*/ 417473 h 851052"/>
              <a:gd name="connsiteX7" fmla="*/ 884918 w 1031424"/>
              <a:gd name="connsiteY7" fmla="*/ 650064 h 851052"/>
              <a:gd name="connsiteX8" fmla="*/ 676489 w 1031424"/>
              <a:gd name="connsiteY8" fmla="*/ 710575 h 851052"/>
              <a:gd name="connsiteX9" fmla="*/ 515126 w 1031424"/>
              <a:gd name="connsiteY9" fmla="*/ 850511 h 851052"/>
              <a:gd name="connsiteX10" fmla="*/ 326866 w 1031424"/>
              <a:gd name="connsiteY10" fmla="*/ 757641 h 851052"/>
              <a:gd name="connsiteX11" fmla="*/ 91542 w 1031424"/>
              <a:gd name="connsiteY11" fmla="*/ 724023 h 851052"/>
              <a:gd name="connsiteX12" fmla="*/ 57925 w 1031424"/>
              <a:gd name="connsiteY12" fmla="*/ 508869 h 851052"/>
              <a:gd name="connsiteX13" fmla="*/ 4137 w 1031424"/>
              <a:gd name="connsiteY13" fmla="*/ 417473 h 851052"/>
              <a:gd name="connsiteX0" fmla="*/ 4137 w 1031424"/>
              <a:gd name="connsiteY0" fmla="*/ 416993 h 850572"/>
              <a:gd name="connsiteX1" fmla="*/ 178949 w 1031424"/>
              <a:gd name="connsiteY1" fmla="*/ 219278 h 850572"/>
              <a:gd name="connsiteX2" fmla="*/ 246183 w 1031424"/>
              <a:gd name="connsiteY2" fmla="*/ 4125 h 850572"/>
              <a:gd name="connsiteX3" fmla="*/ 521850 w 1031424"/>
              <a:gd name="connsiteY3" fmla="*/ 57914 h 850572"/>
              <a:gd name="connsiteX4" fmla="*/ 696660 w 1031424"/>
              <a:gd name="connsiteY4" fmla="*/ 4126 h 850572"/>
              <a:gd name="connsiteX5" fmla="*/ 945430 w 1031424"/>
              <a:gd name="connsiteY5" fmla="*/ 192384 h 850572"/>
              <a:gd name="connsiteX6" fmla="*/ 1026115 w 1031424"/>
              <a:gd name="connsiteY6" fmla="*/ 416993 h 850572"/>
              <a:gd name="connsiteX7" fmla="*/ 884918 w 1031424"/>
              <a:gd name="connsiteY7" fmla="*/ 649584 h 850572"/>
              <a:gd name="connsiteX8" fmla="*/ 676489 w 1031424"/>
              <a:gd name="connsiteY8" fmla="*/ 710095 h 850572"/>
              <a:gd name="connsiteX9" fmla="*/ 515126 w 1031424"/>
              <a:gd name="connsiteY9" fmla="*/ 850031 h 850572"/>
              <a:gd name="connsiteX10" fmla="*/ 326866 w 1031424"/>
              <a:gd name="connsiteY10" fmla="*/ 757161 h 850572"/>
              <a:gd name="connsiteX11" fmla="*/ 91542 w 1031424"/>
              <a:gd name="connsiteY11" fmla="*/ 723543 h 850572"/>
              <a:gd name="connsiteX12" fmla="*/ 57925 w 1031424"/>
              <a:gd name="connsiteY12" fmla="*/ 508389 h 850572"/>
              <a:gd name="connsiteX13" fmla="*/ 4137 w 1031424"/>
              <a:gd name="connsiteY13" fmla="*/ 416993 h 850572"/>
              <a:gd name="connsiteX0" fmla="*/ 4137 w 1030097"/>
              <a:gd name="connsiteY0" fmla="*/ 416670 h 850249"/>
              <a:gd name="connsiteX1" fmla="*/ 178949 w 1030097"/>
              <a:gd name="connsiteY1" fmla="*/ 218955 h 850249"/>
              <a:gd name="connsiteX2" fmla="*/ 246183 w 1030097"/>
              <a:gd name="connsiteY2" fmla="*/ 3802 h 850249"/>
              <a:gd name="connsiteX3" fmla="*/ 521850 w 1030097"/>
              <a:gd name="connsiteY3" fmla="*/ 57591 h 850249"/>
              <a:gd name="connsiteX4" fmla="*/ 696660 w 1030097"/>
              <a:gd name="connsiteY4" fmla="*/ 3803 h 850249"/>
              <a:gd name="connsiteX5" fmla="*/ 797513 w 1030097"/>
              <a:gd name="connsiteY5" fmla="*/ 144996 h 850249"/>
              <a:gd name="connsiteX6" fmla="*/ 945430 w 1030097"/>
              <a:gd name="connsiteY6" fmla="*/ 192061 h 850249"/>
              <a:gd name="connsiteX7" fmla="*/ 1026115 w 1030097"/>
              <a:gd name="connsiteY7" fmla="*/ 416670 h 850249"/>
              <a:gd name="connsiteX8" fmla="*/ 884918 w 1030097"/>
              <a:gd name="connsiteY8" fmla="*/ 649261 h 850249"/>
              <a:gd name="connsiteX9" fmla="*/ 676489 w 1030097"/>
              <a:gd name="connsiteY9" fmla="*/ 709772 h 850249"/>
              <a:gd name="connsiteX10" fmla="*/ 515126 w 1030097"/>
              <a:gd name="connsiteY10" fmla="*/ 849708 h 850249"/>
              <a:gd name="connsiteX11" fmla="*/ 326866 w 1030097"/>
              <a:gd name="connsiteY11" fmla="*/ 756838 h 850249"/>
              <a:gd name="connsiteX12" fmla="*/ 91542 w 1030097"/>
              <a:gd name="connsiteY12" fmla="*/ 723220 h 850249"/>
              <a:gd name="connsiteX13" fmla="*/ 57925 w 1030097"/>
              <a:gd name="connsiteY13" fmla="*/ 508066 h 850249"/>
              <a:gd name="connsiteX14" fmla="*/ 4137 w 1030097"/>
              <a:gd name="connsiteY14" fmla="*/ 416670 h 850249"/>
              <a:gd name="connsiteX0" fmla="*/ 4137 w 977150"/>
              <a:gd name="connsiteY0" fmla="*/ 416670 h 850249"/>
              <a:gd name="connsiteX1" fmla="*/ 178949 w 977150"/>
              <a:gd name="connsiteY1" fmla="*/ 218955 h 850249"/>
              <a:gd name="connsiteX2" fmla="*/ 246183 w 977150"/>
              <a:gd name="connsiteY2" fmla="*/ 3802 h 850249"/>
              <a:gd name="connsiteX3" fmla="*/ 521850 w 977150"/>
              <a:gd name="connsiteY3" fmla="*/ 57591 h 850249"/>
              <a:gd name="connsiteX4" fmla="*/ 696660 w 977150"/>
              <a:gd name="connsiteY4" fmla="*/ 3803 h 850249"/>
              <a:gd name="connsiteX5" fmla="*/ 797513 w 977150"/>
              <a:gd name="connsiteY5" fmla="*/ 144996 h 850249"/>
              <a:gd name="connsiteX6" fmla="*/ 945430 w 977150"/>
              <a:gd name="connsiteY6" fmla="*/ 192061 h 850249"/>
              <a:gd name="connsiteX7" fmla="*/ 965603 w 977150"/>
              <a:gd name="connsiteY7" fmla="*/ 396500 h 850249"/>
              <a:gd name="connsiteX8" fmla="*/ 884918 w 977150"/>
              <a:gd name="connsiteY8" fmla="*/ 649261 h 850249"/>
              <a:gd name="connsiteX9" fmla="*/ 676489 w 977150"/>
              <a:gd name="connsiteY9" fmla="*/ 709772 h 850249"/>
              <a:gd name="connsiteX10" fmla="*/ 515126 w 977150"/>
              <a:gd name="connsiteY10" fmla="*/ 849708 h 850249"/>
              <a:gd name="connsiteX11" fmla="*/ 326866 w 977150"/>
              <a:gd name="connsiteY11" fmla="*/ 756838 h 850249"/>
              <a:gd name="connsiteX12" fmla="*/ 91542 w 977150"/>
              <a:gd name="connsiteY12" fmla="*/ 723220 h 850249"/>
              <a:gd name="connsiteX13" fmla="*/ 57925 w 977150"/>
              <a:gd name="connsiteY13" fmla="*/ 508066 h 850249"/>
              <a:gd name="connsiteX14" fmla="*/ 4137 w 977150"/>
              <a:gd name="connsiteY14" fmla="*/ 416670 h 850249"/>
              <a:gd name="connsiteX0" fmla="*/ 4137 w 1019578"/>
              <a:gd name="connsiteY0" fmla="*/ 416670 h 850249"/>
              <a:gd name="connsiteX1" fmla="*/ 178949 w 1019578"/>
              <a:gd name="connsiteY1" fmla="*/ 218955 h 850249"/>
              <a:gd name="connsiteX2" fmla="*/ 246183 w 1019578"/>
              <a:gd name="connsiteY2" fmla="*/ 3802 h 850249"/>
              <a:gd name="connsiteX3" fmla="*/ 521850 w 1019578"/>
              <a:gd name="connsiteY3" fmla="*/ 57591 h 850249"/>
              <a:gd name="connsiteX4" fmla="*/ 696660 w 1019578"/>
              <a:gd name="connsiteY4" fmla="*/ 3803 h 850249"/>
              <a:gd name="connsiteX5" fmla="*/ 797513 w 1019578"/>
              <a:gd name="connsiteY5" fmla="*/ 144996 h 850249"/>
              <a:gd name="connsiteX6" fmla="*/ 945430 w 1019578"/>
              <a:gd name="connsiteY6" fmla="*/ 192061 h 850249"/>
              <a:gd name="connsiteX7" fmla="*/ 1019390 w 1019578"/>
              <a:gd name="connsiteY7" fmla="*/ 319807 h 850249"/>
              <a:gd name="connsiteX8" fmla="*/ 965603 w 1019578"/>
              <a:gd name="connsiteY8" fmla="*/ 396500 h 850249"/>
              <a:gd name="connsiteX9" fmla="*/ 884918 w 1019578"/>
              <a:gd name="connsiteY9" fmla="*/ 649261 h 850249"/>
              <a:gd name="connsiteX10" fmla="*/ 676489 w 1019578"/>
              <a:gd name="connsiteY10" fmla="*/ 709772 h 850249"/>
              <a:gd name="connsiteX11" fmla="*/ 515126 w 1019578"/>
              <a:gd name="connsiteY11" fmla="*/ 849708 h 850249"/>
              <a:gd name="connsiteX12" fmla="*/ 326866 w 1019578"/>
              <a:gd name="connsiteY12" fmla="*/ 756838 h 850249"/>
              <a:gd name="connsiteX13" fmla="*/ 91542 w 1019578"/>
              <a:gd name="connsiteY13" fmla="*/ 723220 h 850249"/>
              <a:gd name="connsiteX14" fmla="*/ 57925 w 1019578"/>
              <a:gd name="connsiteY14" fmla="*/ 508066 h 850249"/>
              <a:gd name="connsiteX15" fmla="*/ 4137 w 1019578"/>
              <a:gd name="connsiteY15" fmla="*/ 416670 h 850249"/>
              <a:gd name="connsiteX0" fmla="*/ 4137 w 1019420"/>
              <a:gd name="connsiteY0" fmla="*/ 416670 h 850249"/>
              <a:gd name="connsiteX1" fmla="*/ 178949 w 1019420"/>
              <a:gd name="connsiteY1" fmla="*/ 218955 h 850249"/>
              <a:gd name="connsiteX2" fmla="*/ 246183 w 1019420"/>
              <a:gd name="connsiteY2" fmla="*/ 3802 h 850249"/>
              <a:gd name="connsiteX3" fmla="*/ 521850 w 1019420"/>
              <a:gd name="connsiteY3" fmla="*/ 57591 h 850249"/>
              <a:gd name="connsiteX4" fmla="*/ 696660 w 1019420"/>
              <a:gd name="connsiteY4" fmla="*/ 3803 h 850249"/>
              <a:gd name="connsiteX5" fmla="*/ 797513 w 1019420"/>
              <a:gd name="connsiteY5" fmla="*/ 144996 h 850249"/>
              <a:gd name="connsiteX6" fmla="*/ 945430 w 1019420"/>
              <a:gd name="connsiteY6" fmla="*/ 192061 h 850249"/>
              <a:gd name="connsiteX7" fmla="*/ 1019390 w 1019420"/>
              <a:gd name="connsiteY7" fmla="*/ 319807 h 850249"/>
              <a:gd name="connsiteX8" fmla="*/ 738585 w 1019420"/>
              <a:gd name="connsiteY8" fmla="*/ 356395 h 850249"/>
              <a:gd name="connsiteX9" fmla="*/ 884918 w 1019420"/>
              <a:gd name="connsiteY9" fmla="*/ 649261 h 850249"/>
              <a:gd name="connsiteX10" fmla="*/ 676489 w 1019420"/>
              <a:gd name="connsiteY10" fmla="*/ 709772 h 850249"/>
              <a:gd name="connsiteX11" fmla="*/ 515126 w 1019420"/>
              <a:gd name="connsiteY11" fmla="*/ 849708 h 850249"/>
              <a:gd name="connsiteX12" fmla="*/ 326866 w 1019420"/>
              <a:gd name="connsiteY12" fmla="*/ 756838 h 850249"/>
              <a:gd name="connsiteX13" fmla="*/ 91542 w 1019420"/>
              <a:gd name="connsiteY13" fmla="*/ 723220 h 850249"/>
              <a:gd name="connsiteX14" fmla="*/ 57925 w 1019420"/>
              <a:gd name="connsiteY14" fmla="*/ 508066 h 850249"/>
              <a:gd name="connsiteX15" fmla="*/ 4137 w 1019420"/>
              <a:gd name="connsiteY15" fmla="*/ 416670 h 850249"/>
              <a:gd name="connsiteX0" fmla="*/ 4137 w 1019421"/>
              <a:gd name="connsiteY0" fmla="*/ 416670 h 850249"/>
              <a:gd name="connsiteX1" fmla="*/ 178949 w 1019421"/>
              <a:gd name="connsiteY1" fmla="*/ 218955 h 850249"/>
              <a:gd name="connsiteX2" fmla="*/ 246183 w 1019421"/>
              <a:gd name="connsiteY2" fmla="*/ 3802 h 850249"/>
              <a:gd name="connsiteX3" fmla="*/ 521850 w 1019421"/>
              <a:gd name="connsiteY3" fmla="*/ 57591 h 850249"/>
              <a:gd name="connsiteX4" fmla="*/ 696660 w 1019421"/>
              <a:gd name="connsiteY4" fmla="*/ 3803 h 850249"/>
              <a:gd name="connsiteX5" fmla="*/ 797513 w 1019421"/>
              <a:gd name="connsiteY5" fmla="*/ 144996 h 850249"/>
              <a:gd name="connsiteX6" fmla="*/ 945430 w 1019421"/>
              <a:gd name="connsiteY6" fmla="*/ 192061 h 850249"/>
              <a:gd name="connsiteX7" fmla="*/ 1019390 w 1019421"/>
              <a:gd name="connsiteY7" fmla="*/ 319807 h 850249"/>
              <a:gd name="connsiteX8" fmla="*/ 738585 w 1019421"/>
              <a:gd name="connsiteY8" fmla="*/ 356395 h 850249"/>
              <a:gd name="connsiteX9" fmla="*/ 489737 w 1019421"/>
              <a:gd name="connsiteY9" fmla="*/ 424671 h 850249"/>
              <a:gd name="connsiteX10" fmla="*/ 676489 w 1019421"/>
              <a:gd name="connsiteY10" fmla="*/ 709772 h 850249"/>
              <a:gd name="connsiteX11" fmla="*/ 515126 w 1019421"/>
              <a:gd name="connsiteY11" fmla="*/ 849708 h 850249"/>
              <a:gd name="connsiteX12" fmla="*/ 326866 w 1019421"/>
              <a:gd name="connsiteY12" fmla="*/ 756838 h 850249"/>
              <a:gd name="connsiteX13" fmla="*/ 91542 w 1019421"/>
              <a:gd name="connsiteY13" fmla="*/ 723220 h 850249"/>
              <a:gd name="connsiteX14" fmla="*/ 57925 w 1019421"/>
              <a:gd name="connsiteY14" fmla="*/ 508066 h 850249"/>
              <a:gd name="connsiteX15" fmla="*/ 4137 w 1019421"/>
              <a:gd name="connsiteY15" fmla="*/ 416670 h 850249"/>
              <a:gd name="connsiteX0" fmla="*/ 4137 w 947632"/>
              <a:gd name="connsiteY0" fmla="*/ 416670 h 850249"/>
              <a:gd name="connsiteX1" fmla="*/ 178949 w 947632"/>
              <a:gd name="connsiteY1" fmla="*/ 218955 h 850249"/>
              <a:gd name="connsiteX2" fmla="*/ 246183 w 947632"/>
              <a:gd name="connsiteY2" fmla="*/ 3802 h 850249"/>
              <a:gd name="connsiteX3" fmla="*/ 521850 w 947632"/>
              <a:gd name="connsiteY3" fmla="*/ 57591 h 850249"/>
              <a:gd name="connsiteX4" fmla="*/ 696660 w 947632"/>
              <a:gd name="connsiteY4" fmla="*/ 3803 h 850249"/>
              <a:gd name="connsiteX5" fmla="*/ 797513 w 947632"/>
              <a:gd name="connsiteY5" fmla="*/ 144996 h 850249"/>
              <a:gd name="connsiteX6" fmla="*/ 945430 w 947632"/>
              <a:gd name="connsiteY6" fmla="*/ 192061 h 850249"/>
              <a:gd name="connsiteX7" fmla="*/ 708289 w 947632"/>
              <a:gd name="connsiteY7" fmla="*/ 271680 h 850249"/>
              <a:gd name="connsiteX8" fmla="*/ 738585 w 947632"/>
              <a:gd name="connsiteY8" fmla="*/ 356395 h 850249"/>
              <a:gd name="connsiteX9" fmla="*/ 489737 w 947632"/>
              <a:gd name="connsiteY9" fmla="*/ 424671 h 850249"/>
              <a:gd name="connsiteX10" fmla="*/ 676489 w 947632"/>
              <a:gd name="connsiteY10" fmla="*/ 709772 h 850249"/>
              <a:gd name="connsiteX11" fmla="*/ 515126 w 947632"/>
              <a:gd name="connsiteY11" fmla="*/ 849708 h 850249"/>
              <a:gd name="connsiteX12" fmla="*/ 326866 w 947632"/>
              <a:gd name="connsiteY12" fmla="*/ 756838 h 850249"/>
              <a:gd name="connsiteX13" fmla="*/ 91542 w 947632"/>
              <a:gd name="connsiteY13" fmla="*/ 723220 h 850249"/>
              <a:gd name="connsiteX14" fmla="*/ 57925 w 947632"/>
              <a:gd name="connsiteY14" fmla="*/ 508066 h 850249"/>
              <a:gd name="connsiteX15" fmla="*/ 4137 w 947632"/>
              <a:gd name="connsiteY15" fmla="*/ 416670 h 850249"/>
              <a:gd name="connsiteX0" fmla="*/ 4137 w 947632"/>
              <a:gd name="connsiteY0" fmla="*/ 416670 h 759165"/>
              <a:gd name="connsiteX1" fmla="*/ 178949 w 947632"/>
              <a:gd name="connsiteY1" fmla="*/ 218955 h 759165"/>
              <a:gd name="connsiteX2" fmla="*/ 246183 w 947632"/>
              <a:gd name="connsiteY2" fmla="*/ 3802 h 759165"/>
              <a:gd name="connsiteX3" fmla="*/ 521850 w 947632"/>
              <a:gd name="connsiteY3" fmla="*/ 57591 h 759165"/>
              <a:gd name="connsiteX4" fmla="*/ 696660 w 947632"/>
              <a:gd name="connsiteY4" fmla="*/ 3803 h 759165"/>
              <a:gd name="connsiteX5" fmla="*/ 797513 w 947632"/>
              <a:gd name="connsiteY5" fmla="*/ 144996 h 759165"/>
              <a:gd name="connsiteX6" fmla="*/ 945430 w 947632"/>
              <a:gd name="connsiteY6" fmla="*/ 192061 h 759165"/>
              <a:gd name="connsiteX7" fmla="*/ 708289 w 947632"/>
              <a:gd name="connsiteY7" fmla="*/ 271680 h 759165"/>
              <a:gd name="connsiteX8" fmla="*/ 738585 w 947632"/>
              <a:gd name="connsiteY8" fmla="*/ 356395 h 759165"/>
              <a:gd name="connsiteX9" fmla="*/ 489737 w 947632"/>
              <a:gd name="connsiteY9" fmla="*/ 424671 h 759165"/>
              <a:gd name="connsiteX10" fmla="*/ 676489 w 947632"/>
              <a:gd name="connsiteY10" fmla="*/ 709772 h 759165"/>
              <a:gd name="connsiteX11" fmla="*/ 439454 w 947632"/>
              <a:gd name="connsiteY11" fmla="*/ 641160 h 759165"/>
              <a:gd name="connsiteX12" fmla="*/ 326866 w 947632"/>
              <a:gd name="connsiteY12" fmla="*/ 756838 h 759165"/>
              <a:gd name="connsiteX13" fmla="*/ 91542 w 947632"/>
              <a:gd name="connsiteY13" fmla="*/ 723220 h 759165"/>
              <a:gd name="connsiteX14" fmla="*/ 57925 w 947632"/>
              <a:gd name="connsiteY14" fmla="*/ 508066 h 759165"/>
              <a:gd name="connsiteX15" fmla="*/ 4137 w 947632"/>
              <a:gd name="connsiteY15" fmla="*/ 416670 h 7591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947632" h="759165">
                <a:moveTo>
                  <a:pt x="4137" y="416670"/>
                </a:moveTo>
                <a:cubicBezTo>
                  <a:pt x="24308" y="368485"/>
                  <a:pt x="145332" y="277681"/>
                  <a:pt x="178949" y="218955"/>
                </a:cubicBezTo>
                <a:cubicBezTo>
                  <a:pt x="212566" y="160229"/>
                  <a:pt x="176706" y="25093"/>
                  <a:pt x="246183" y="3802"/>
                </a:cubicBezTo>
                <a:cubicBezTo>
                  <a:pt x="315660" y="-17489"/>
                  <a:pt x="446771" y="57591"/>
                  <a:pt x="521850" y="57591"/>
                </a:cubicBezTo>
                <a:cubicBezTo>
                  <a:pt x="596929" y="57591"/>
                  <a:pt x="645113" y="-679"/>
                  <a:pt x="696660" y="3803"/>
                </a:cubicBezTo>
                <a:cubicBezTo>
                  <a:pt x="748207" y="8285"/>
                  <a:pt x="756051" y="113620"/>
                  <a:pt x="797513" y="144996"/>
                </a:cubicBezTo>
                <a:cubicBezTo>
                  <a:pt x="838975" y="176372"/>
                  <a:pt x="916295" y="170770"/>
                  <a:pt x="945430" y="192061"/>
                </a:cubicBezTo>
                <a:cubicBezTo>
                  <a:pt x="974565" y="213352"/>
                  <a:pt x="704927" y="237607"/>
                  <a:pt x="708289" y="271680"/>
                </a:cubicBezTo>
                <a:cubicBezTo>
                  <a:pt x="711651" y="305753"/>
                  <a:pt x="753153" y="293642"/>
                  <a:pt x="738585" y="356395"/>
                </a:cubicBezTo>
                <a:cubicBezTo>
                  <a:pt x="724017" y="419148"/>
                  <a:pt x="548008" y="375821"/>
                  <a:pt x="489737" y="424671"/>
                </a:cubicBezTo>
                <a:cubicBezTo>
                  <a:pt x="431466" y="473521"/>
                  <a:pt x="726915" y="668520"/>
                  <a:pt x="676489" y="709772"/>
                </a:cubicBezTo>
                <a:cubicBezTo>
                  <a:pt x="626063" y="751024"/>
                  <a:pt x="497724" y="633316"/>
                  <a:pt x="439454" y="641160"/>
                </a:cubicBezTo>
                <a:cubicBezTo>
                  <a:pt x="381184" y="649004"/>
                  <a:pt x="397463" y="777919"/>
                  <a:pt x="326866" y="756838"/>
                </a:cubicBezTo>
                <a:cubicBezTo>
                  <a:pt x="256269" y="735757"/>
                  <a:pt x="146451" y="755717"/>
                  <a:pt x="91542" y="723220"/>
                </a:cubicBezTo>
                <a:cubicBezTo>
                  <a:pt x="36633" y="690723"/>
                  <a:pt x="72493" y="559158"/>
                  <a:pt x="57925" y="508066"/>
                </a:cubicBezTo>
                <a:cubicBezTo>
                  <a:pt x="43357" y="456974"/>
                  <a:pt x="-16034" y="464855"/>
                  <a:pt x="4137" y="416670"/>
                </a:cubicBezTo>
                <a:close/>
              </a:path>
            </a:pathLst>
          </a:cu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Oval 254">
            <a:extLst>
              <a:ext uri="{FF2B5EF4-FFF2-40B4-BE49-F238E27FC236}">
                <a16:creationId xmlns:a16="http://schemas.microsoft.com/office/drawing/2014/main" id="{BB29A6A9-A36B-420C-09BA-C91902E9B0DF}"/>
              </a:ext>
            </a:extLst>
          </p:cNvPr>
          <p:cNvSpPr/>
          <p:nvPr/>
        </p:nvSpPr>
        <p:spPr>
          <a:xfrm>
            <a:off x="3942234" y="6439334"/>
            <a:ext cx="303758" cy="294500"/>
          </a:xfrm>
          <a:custGeom>
            <a:avLst/>
            <a:gdLst>
              <a:gd name="connsiteX0" fmla="*/ 0 w 1021977"/>
              <a:gd name="connsiteY0" fmla="*/ 433038 h 866076"/>
              <a:gd name="connsiteX1" fmla="*/ 510989 w 1021977"/>
              <a:gd name="connsiteY1" fmla="*/ 0 h 866076"/>
              <a:gd name="connsiteX2" fmla="*/ 1021978 w 1021977"/>
              <a:gd name="connsiteY2" fmla="*/ 433038 h 866076"/>
              <a:gd name="connsiteX3" fmla="*/ 510989 w 1021977"/>
              <a:gd name="connsiteY3" fmla="*/ 866076 h 866076"/>
              <a:gd name="connsiteX4" fmla="*/ 0 w 1021977"/>
              <a:gd name="connsiteY4" fmla="*/ 433038 h 866076"/>
              <a:gd name="connsiteX0" fmla="*/ 4 w 1021982"/>
              <a:gd name="connsiteY0" fmla="*/ 359079 h 792117"/>
              <a:gd name="connsiteX1" fmla="*/ 517717 w 1021982"/>
              <a:gd name="connsiteY1" fmla="*/ 0 h 792117"/>
              <a:gd name="connsiteX2" fmla="*/ 1021982 w 1021982"/>
              <a:gd name="connsiteY2" fmla="*/ 359079 h 792117"/>
              <a:gd name="connsiteX3" fmla="*/ 510993 w 1021982"/>
              <a:gd name="connsiteY3" fmla="*/ 792117 h 792117"/>
              <a:gd name="connsiteX4" fmla="*/ 4 w 1021982"/>
              <a:gd name="connsiteY4" fmla="*/ 359079 h 792117"/>
              <a:gd name="connsiteX0" fmla="*/ 9682 w 1031660"/>
              <a:gd name="connsiteY0" fmla="*/ 400301 h 833339"/>
              <a:gd name="connsiteX1" fmla="*/ 211387 w 1031660"/>
              <a:gd name="connsiteY1" fmla="*/ 47945 h 833339"/>
              <a:gd name="connsiteX2" fmla="*/ 527395 w 1031660"/>
              <a:gd name="connsiteY2" fmla="*/ 41222 h 833339"/>
              <a:gd name="connsiteX3" fmla="*/ 1031660 w 1031660"/>
              <a:gd name="connsiteY3" fmla="*/ 400301 h 833339"/>
              <a:gd name="connsiteX4" fmla="*/ 520671 w 1031660"/>
              <a:gd name="connsiteY4" fmla="*/ 833339 h 833339"/>
              <a:gd name="connsiteX5" fmla="*/ 9682 w 1031660"/>
              <a:gd name="connsiteY5" fmla="*/ 400301 h 833339"/>
              <a:gd name="connsiteX0" fmla="*/ 6466 w 1028444"/>
              <a:gd name="connsiteY0" fmla="*/ 400301 h 846828"/>
              <a:gd name="connsiteX1" fmla="*/ 208171 w 1028444"/>
              <a:gd name="connsiteY1" fmla="*/ 47945 h 846828"/>
              <a:gd name="connsiteX2" fmla="*/ 524179 w 1028444"/>
              <a:gd name="connsiteY2" fmla="*/ 41222 h 846828"/>
              <a:gd name="connsiteX3" fmla="*/ 1028444 w 1028444"/>
              <a:gd name="connsiteY3" fmla="*/ 400301 h 846828"/>
              <a:gd name="connsiteX4" fmla="*/ 517455 w 1028444"/>
              <a:gd name="connsiteY4" fmla="*/ 833339 h 846828"/>
              <a:gd name="connsiteX5" fmla="*/ 93871 w 1028444"/>
              <a:gd name="connsiteY5" fmla="*/ 706851 h 846828"/>
              <a:gd name="connsiteX6" fmla="*/ 6466 w 1028444"/>
              <a:gd name="connsiteY6" fmla="*/ 400301 h 846828"/>
              <a:gd name="connsiteX0" fmla="*/ 6466 w 1030468"/>
              <a:gd name="connsiteY0" fmla="*/ 400301 h 833403"/>
              <a:gd name="connsiteX1" fmla="*/ 208171 w 1030468"/>
              <a:gd name="connsiteY1" fmla="*/ 47945 h 833403"/>
              <a:gd name="connsiteX2" fmla="*/ 524179 w 1030468"/>
              <a:gd name="connsiteY2" fmla="*/ 41222 h 833403"/>
              <a:gd name="connsiteX3" fmla="*/ 1028444 w 1030468"/>
              <a:gd name="connsiteY3" fmla="*/ 400301 h 833403"/>
              <a:gd name="connsiteX4" fmla="*/ 678818 w 1030468"/>
              <a:gd name="connsiteY4" fmla="*/ 693403 h 833403"/>
              <a:gd name="connsiteX5" fmla="*/ 517455 w 1030468"/>
              <a:gd name="connsiteY5" fmla="*/ 833339 h 833403"/>
              <a:gd name="connsiteX6" fmla="*/ 93871 w 1030468"/>
              <a:gd name="connsiteY6" fmla="*/ 706851 h 833403"/>
              <a:gd name="connsiteX7" fmla="*/ 6466 w 1030468"/>
              <a:gd name="connsiteY7" fmla="*/ 400301 h 833403"/>
              <a:gd name="connsiteX0" fmla="*/ 6466 w 1040938"/>
              <a:gd name="connsiteY0" fmla="*/ 386831 h 819933"/>
              <a:gd name="connsiteX1" fmla="*/ 208171 w 1040938"/>
              <a:gd name="connsiteY1" fmla="*/ 34475 h 819933"/>
              <a:gd name="connsiteX2" fmla="*/ 524179 w 1040938"/>
              <a:gd name="connsiteY2" fmla="*/ 27752 h 819933"/>
              <a:gd name="connsiteX3" fmla="*/ 947759 w 1040938"/>
              <a:gd name="connsiteY3" fmla="*/ 162222 h 819933"/>
              <a:gd name="connsiteX4" fmla="*/ 1028444 w 1040938"/>
              <a:gd name="connsiteY4" fmla="*/ 386831 h 819933"/>
              <a:gd name="connsiteX5" fmla="*/ 678818 w 1040938"/>
              <a:gd name="connsiteY5" fmla="*/ 679933 h 819933"/>
              <a:gd name="connsiteX6" fmla="*/ 517455 w 1040938"/>
              <a:gd name="connsiteY6" fmla="*/ 819869 h 819933"/>
              <a:gd name="connsiteX7" fmla="*/ 93871 w 1040938"/>
              <a:gd name="connsiteY7" fmla="*/ 693381 h 819933"/>
              <a:gd name="connsiteX8" fmla="*/ 6466 w 1040938"/>
              <a:gd name="connsiteY8" fmla="*/ 386831 h 819933"/>
              <a:gd name="connsiteX0" fmla="*/ 6466 w 1037480"/>
              <a:gd name="connsiteY0" fmla="*/ 417473 h 850575"/>
              <a:gd name="connsiteX1" fmla="*/ 208171 w 1037480"/>
              <a:gd name="connsiteY1" fmla="*/ 65117 h 850575"/>
              <a:gd name="connsiteX2" fmla="*/ 524179 w 1037480"/>
              <a:gd name="connsiteY2" fmla="*/ 58394 h 850575"/>
              <a:gd name="connsiteX3" fmla="*/ 698989 w 1037480"/>
              <a:gd name="connsiteY3" fmla="*/ 4606 h 850575"/>
              <a:gd name="connsiteX4" fmla="*/ 947759 w 1037480"/>
              <a:gd name="connsiteY4" fmla="*/ 192864 h 850575"/>
              <a:gd name="connsiteX5" fmla="*/ 1028444 w 1037480"/>
              <a:gd name="connsiteY5" fmla="*/ 417473 h 850575"/>
              <a:gd name="connsiteX6" fmla="*/ 678818 w 1037480"/>
              <a:gd name="connsiteY6" fmla="*/ 710575 h 850575"/>
              <a:gd name="connsiteX7" fmla="*/ 517455 w 1037480"/>
              <a:gd name="connsiteY7" fmla="*/ 850511 h 850575"/>
              <a:gd name="connsiteX8" fmla="*/ 93871 w 1037480"/>
              <a:gd name="connsiteY8" fmla="*/ 724023 h 850575"/>
              <a:gd name="connsiteX9" fmla="*/ 6466 w 1037480"/>
              <a:gd name="connsiteY9" fmla="*/ 417473 h 850575"/>
              <a:gd name="connsiteX0" fmla="*/ 6466 w 1033753"/>
              <a:gd name="connsiteY0" fmla="*/ 417473 h 850575"/>
              <a:gd name="connsiteX1" fmla="*/ 208171 w 1033753"/>
              <a:gd name="connsiteY1" fmla="*/ 65117 h 850575"/>
              <a:gd name="connsiteX2" fmla="*/ 524179 w 1033753"/>
              <a:gd name="connsiteY2" fmla="*/ 58394 h 850575"/>
              <a:gd name="connsiteX3" fmla="*/ 698989 w 1033753"/>
              <a:gd name="connsiteY3" fmla="*/ 4606 h 850575"/>
              <a:gd name="connsiteX4" fmla="*/ 947759 w 1033753"/>
              <a:gd name="connsiteY4" fmla="*/ 192864 h 850575"/>
              <a:gd name="connsiteX5" fmla="*/ 1028444 w 1033753"/>
              <a:gd name="connsiteY5" fmla="*/ 417473 h 850575"/>
              <a:gd name="connsiteX6" fmla="*/ 887247 w 1033753"/>
              <a:gd name="connsiteY6" fmla="*/ 650064 h 850575"/>
              <a:gd name="connsiteX7" fmla="*/ 678818 w 1033753"/>
              <a:gd name="connsiteY7" fmla="*/ 710575 h 850575"/>
              <a:gd name="connsiteX8" fmla="*/ 517455 w 1033753"/>
              <a:gd name="connsiteY8" fmla="*/ 850511 h 850575"/>
              <a:gd name="connsiteX9" fmla="*/ 93871 w 1033753"/>
              <a:gd name="connsiteY9" fmla="*/ 724023 h 850575"/>
              <a:gd name="connsiteX10" fmla="*/ 6466 w 1033753"/>
              <a:gd name="connsiteY10" fmla="*/ 417473 h 850575"/>
              <a:gd name="connsiteX0" fmla="*/ 6466 w 1033753"/>
              <a:gd name="connsiteY0" fmla="*/ 417473 h 851052"/>
              <a:gd name="connsiteX1" fmla="*/ 208171 w 1033753"/>
              <a:gd name="connsiteY1" fmla="*/ 65117 h 851052"/>
              <a:gd name="connsiteX2" fmla="*/ 524179 w 1033753"/>
              <a:gd name="connsiteY2" fmla="*/ 58394 h 851052"/>
              <a:gd name="connsiteX3" fmla="*/ 698989 w 1033753"/>
              <a:gd name="connsiteY3" fmla="*/ 4606 h 851052"/>
              <a:gd name="connsiteX4" fmla="*/ 947759 w 1033753"/>
              <a:gd name="connsiteY4" fmla="*/ 192864 h 851052"/>
              <a:gd name="connsiteX5" fmla="*/ 1028444 w 1033753"/>
              <a:gd name="connsiteY5" fmla="*/ 417473 h 851052"/>
              <a:gd name="connsiteX6" fmla="*/ 887247 w 1033753"/>
              <a:gd name="connsiteY6" fmla="*/ 650064 h 851052"/>
              <a:gd name="connsiteX7" fmla="*/ 678818 w 1033753"/>
              <a:gd name="connsiteY7" fmla="*/ 710575 h 851052"/>
              <a:gd name="connsiteX8" fmla="*/ 517455 w 1033753"/>
              <a:gd name="connsiteY8" fmla="*/ 850511 h 851052"/>
              <a:gd name="connsiteX9" fmla="*/ 329195 w 1033753"/>
              <a:gd name="connsiteY9" fmla="*/ 757641 h 851052"/>
              <a:gd name="connsiteX10" fmla="*/ 93871 w 1033753"/>
              <a:gd name="connsiteY10" fmla="*/ 724023 h 851052"/>
              <a:gd name="connsiteX11" fmla="*/ 6466 w 1033753"/>
              <a:gd name="connsiteY11" fmla="*/ 417473 h 851052"/>
              <a:gd name="connsiteX0" fmla="*/ 5600 w 1032887"/>
              <a:gd name="connsiteY0" fmla="*/ 417473 h 851052"/>
              <a:gd name="connsiteX1" fmla="*/ 207305 w 1032887"/>
              <a:gd name="connsiteY1" fmla="*/ 65117 h 851052"/>
              <a:gd name="connsiteX2" fmla="*/ 523313 w 1032887"/>
              <a:gd name="connsiteY2" fmla="*/ 58394 h 851052"/>
              <a:gd name="connsiteX3" fmla="*/ 698123 w 1032887"/>
              <a:gd name="connsiteY3" fmla="*/ 4606 h 851052"/>
              <a:gd name="connsiteX4" fmla="*/ 946893 w 1032887"/>
              <a:gd name="connsiteY4" fmla="*/ 192864 h 851052"/>
              <a:gd name="connsiteX5" fmla="*/ 1027578 w 1032887"/>
              <a:gd name="connsiteY5" fmla="*/ 417473 h 851052"/>
              <a:gd name="connsiteX6" fmla="*/ 886381 w 1032887"/>
              <a:gd name="connsiteY6" fmla="*/ 650064 h 851052"/>
              <a:gd name="connsiteX7" fmla="*/ 677952 w 1032887"/>
              <a:gd name="connsiteY7" fmla="*/ 710575 h 851052"/>
              <a:gd name="connsiteX8" fmla="*/ 516589 w 1032887"/>
              <a:gd name="connsiteY8" fmla="*/ 850511 h 851052"/>
              <a:gd name="connsiteX9" fmla="*/ 328329 w 1032887"/>
              <a:gd name="connsiteY9" fmla="*/ 757641 h 851052"/>
              <a:gd name="connsiteX10" fmla="*/ 93005 w 1032887"/>
              <a:gd name="connsiteY10" fmla="*/ 724023 h 851052"/>
              <a:gd name="connsiteX11" fmla="*/ 59388 w 1032887"/>
              <a:gd name="connsiteY11" fmla="*/ 508869 h 851052"/>
              <a:gd name="connsiteX12" fmla="*/ 5600 w 1032887"/>
              <a:gd name="connsiteY12" fmla="*/ 417473 h 851052"/>
              <a:gd name="connsiteX0" fmla="*/ 4137 w 1031424"/>
              <a:gd name="connsiteY0" fmla="*/ 417473 h 851052"/>
              <a:gd name="connsiteX1" fmla="*/ 178949 w 1031424"/>
              <a:gd name="connsiteY1" fmla="*/ 219758 h 851052"/>
              <a:gd name="connsiteX2" fmla="*/ 205842 w 1031424"/>
              <a:gd name="connsiteY2" fmla="*/ 65117 h 851052"/>
              <a:gd name="connsiteX3" fmla="*/ 521850 w 1031424"/>
              <a:gd name="connsiteY3" fmla="*/ 58394 h 851052"/>
              <a:gd name="connsiteX4" fmla="*/ 696660 w 1031424"/>
              <a:gd name="connsiteY4" fmla="*/ 4606 h 851052"/>
              <a:gd name="connsiteX5" fmla="*/ 945430 w 1031424"/>
              <a:gd name="connsiteY5" fmla="*/ 192864 h 851052"/>
              <a:gd name="connsiteX6" fmla="*/ 1026115 w 1031424"/>
              <a:gd name="connsiteY6" fmla="*/ 417473 h 851052"/>
              <a:gd name="connsiteX7" fmla="*/ 884918 w 1031424"/>
              <a:gd name="connsiteY7" fmla="*/ 650064 h 851052"/>
              <a:gd name="connsiteX8" fmla="*/ 676489 w 1031424"/>
              <a:gd name="connsiteY8" fmla="*/ 710575 h 851052"/>
              <a:gd name="connsiteX9" fmla="*/ 515126 w 1031424"/>
              <a:gd name="connsiteY9" fmla="*/ 850511 h 851052"/>
              <a:gd name="connsiteX10" fmla="*/ 326866 w 1031424"/>
              <a:gd name="connsiteY10" fmla="*/ 757641 h 851052"/>
              <a:gd name="connsiteX11" fmla="*/ 91542 w 1031424"/>
              <a:gd name="connsiteY11" fmla="*/ 724023 h 851052"/>
              <a:gd name="connsiteX12" fmla="*/ 57925 w 1031424"/>
              <a:gd name="connsiteY12" fmla="*/ 508869 h 851052"/>
              <a:gd name="connsiteX13" fmla="*/ 4137 w 1031424"/>
              <a:gd name="connsiteY13" fmla="*/ 417473 h 851052"/>
              <a:gd name="connsiteX0" fmla="*/ 4137 w 1031424"/>
              <a:gd name="connsiteY0" fmla="*/ 416993 h 850572"/>
              <a:gd name="connsiteX1" fmla="*/ 178949 w 1031424"/>
              <a:gd name="connsiteY1" fmla="*/ 219278 h 850572"/>
              <a:gd name="connsiteX2" fmla="*/ 246183 w 1031424"/>
              <a:gd name="connsiteY2" fmla="*/ 4125 h 850572"/>
              <a:gd name="connsiteX3" fmla="*/ 521850 w 1031424"/>
              <a:gd name="connsiteY3" fmla="*/ 57914 h 850572"/>
              <a:gd name="connsiteX4" fmla="*/ 696660 w 1031424"/>
              <a:gd name="connsiteY4" fmla="*/ 4126 h 850572"/>
              <a:gd name="connsiteX5" fmla="*/ 945430 w 1031424"/>
              <a:gd name="connsiteY5" fmla="*/ 192384 h 850572"/>
              <a:gd name="connsiteX6" fmla="*/ 1026115 w 1031424"/>
              <a:gd name="connsiteY6" fmla="*/ 416993 h 850572"/>
              <a:gd name="connsiteX7" fmla="*/ 884918 w 1031424"/>
              <a:gd name="connsiteY7" fmla="*/ 649584 h 850572"/>
              <a:gd name="connsiteX8" fmla="*/ 676489 w 1031424"/>
              <a:gd name="connsiteY8" fmla="*/ 710095 h 850572"/>
              <a:gd name="connsiteX9" fmla="*/ 515126 w 1031424"/>
              <a:gd name="connsiteY9" fmla="*/ 850031 h 850572"/>
              <a:gd name="connsiteX10" fmla="*/ 326866 w 1031424"/>
              <a:gd name="connsiteY10" fmla="*/ 757161 h 850572"/>
              <a:gd name="connsiteX11" fmla="*/ 91542 w 1031424"/>
              <a:gd name="connsiteY11" fmla="*/ 723543 h 850572"/>
              <a:gd name="connsiteX12" fmla="*/ 57925 w 1031424"/>
              <a:gd name="connsiteY12" fmla="*/ 508389 h 850572"/>
              <a:gd name="connsiteX13" fmla="*/ 4137 w 1031424"/>
              <a:gd name="connsiteY13" fmla="*/ 416993 h 850572"/>
              <a:gd name="connsiteX0" fmla="*/ 4137 w 1030097"/>
              <a:gd name="connsiteY0" fmla="*/ 416670 h 850249"/>
              <a:gd name="connsiteX1" fmla="*/ 178949 w 1030097"/>
              <a:gd name="connsiteY1" fmla="*/ 218955 h 850249"/>
              <a:gd name="connsiteX2" fmla="*/ 246183 w 1030097"/>
              <a:gd name="connsiteY2" fmla="*/ 3802 h 850249"/>
              <a:gd name="connsiteX3" fmla="*/ 521850 w 1030097"/>
              <a:gd name="connsiteY3" fmla="*/ 57591 h 850249"/>
              <a:gd name="connsiteX4" fmla="*/ 696660 w 1030097"/>
              <a:gd name="connsiteY4" fmla="*/ 3803 h 850249"/>
              <a:gd name="connsiteX5" fmla="*/ 797513 w 1030097"/>
              <a:gd name="connsiteY5" fmla="*/ 144996 h 850249"/>
              <a:gd name="connsiteX6" fmla="*/ 945430 w 1030097"/>
              <a:gd name="connsiteY6" fmla="*/ 192061 h 850249"/>
              <a:gd name="connsiteX7" fmla="*/ 1026115 w 1030097"/>
              <a:gd name="connsiteY7" fmla="*/ 416670 h 850249"/>
              <a:gd name="connsiteX8" fmla="*/ 884918 w 1030097"/>
              <a:gd name="connsiteY8" fmla="*/ 649261 h 850249"/>
              <a:gd name="connsiteX9" fmla="*/ 676489 w 1030097"/>
              <a:gd name="connsiteY9" fmla="*/ 709772 h 850249"/>
              <a:gd name="connsiteX10" fmla="*/ 515126 w 1030097"/>
              <a:gd name="connsiteY10" fmla="*/ 849708 h 850249"/>
              <a:gd name="connsiteX11" fmla="*/ 326866 w 1030097"/>
              <a:gd name="connsiteY11" fmla="*/ 756838 h 850249"/>
              <a:gd name="connsiteX12" fmla="*/ 91542 w 1030097"/>
              <a:gd name="connsiteY12" fmla="*/ 723220 h 850249"/>
              <a:gd name="connsiteX13" fmla="*/ 57925 w 1030097"/>
              <a:gd name="connsiteY13" fmla="*/ 508066 h 850249"/>
              <a:gd name="connsiteX14" fmla="*/ 4137 w 1030097"/>
              <a:gd name="connsiteY14" fmla="*/ 416670 h 850249"/>
              <a:gd name="connsiteX0" fmla="*/ 4137 w 977150"/>
              <a:gd name="connsiteY0" fmla="*/ 416670 h 850249"/>
              <a:gd name="connsiteX1" fmla="*/ 178949 w 977150"/>
              <a:gd name="connsiteY1" fmla="*/ 218955 h 850249"/>
              <a:gd name="connsiteX2" fmla="*/ 246183 w 977150"/>
              <a:gd name="connsiteY2" fmla="*/ 3802 h 850249"/>
              <a:gd name="connsiteX3" fmla="*/ 521850 w 977150"/>
              <a:gd name="connsiteY3" fmla="*/ 57591 h 850249"/>
              <a:gd name="connsiteX4" fmla="*/ 696660 w 977150"/>
              <a:gd name="connsiteY4" fmla="*/ 3803 h 850249"/>
              <a:gd name="connsiteX5" fmla="*/ 797513 w 977150"/>
              <a:gd name="connsiteY5" fmla="*/ 144996 h 850249"/>
              <a:gd name="connsiteX6" fmla="*/ 945430 w 977150"/>
              <a:gd name="connsiteY6" fmla="*/ 192061 h 850249"/>
              <a:gd name="connsiteX7" fmla="*/ 965603 w 977150"/>
              <a:gd name="connsiteY7" fmla="*/ 396500 h 850249"/>
              <a:gd name="connsiteX8" fmla="*/ 884918 w 977150"/>
              <a:gd name="connsiteY8" fmla="*/ 649261 h 850249"/>
              <a:gd name="connsiteX9" fmla="*/ 676489 w 977150"/>
              <a:gd name="connsiteY9" fmla="*/ 709772 h 850249"/>
              <a:gd name="connsiteX10" fmla="*/ 515126 w 977150"/>
              <a:gd name="connsiteY10" fmla="*/ 849708 h 850249"/>
              <a:gd name="connsiteX11" fmla="*/ 326866 w 977150"/>
              <a:gd name="connsiteY11" fmla="*/ 756838 h 850249"/>
              <a:gd name="connsiteX12" fmla="*/ 91542 w 977150"/>
              <a:gd name="connsiteY12" fmla="*/ 723220 h 850249"/>
              <a:gd name="connsiteX13" fmla="*/ 57925 w 977150"/>
              <a:gd name="connsiteY13" fmla="*/ 508066 h 850249"/>
              <a:gd name="connsiteX14" fmla="*/ 4137 w 977150"/>
              <a:gd name="connsiteY14" fmla="*/ 416670 h 850249"/>
              <a:gd name="connsiteX0" fmla="*/ 4137 w 1019578"/>
              <a:gd name="connsiteY0" fmla="*/ 416670 h 850249"/>
              <a:gd name="connsiteX1" fmla="*/ 178949 w 1019578"/>
              <a:gd name="connsiteY1" fmla="*/ 218955 h 850249"/>
              <a:gd name="connsiteX2" fmla="*/ 246183 w 1019578"/>
              <a:gd name="connsiteY2" fmla="*/ 3802 h 850249"/>
              <a:gd name="connsiteX3" fmla="*/ 521850 w 1019578"/>
              <a:gd name="connsiteY3" fmla="*/ 57591 h 850249"/>
              <a:gd name="connsiteX4" fmla="*/ 696660 w 1019578"/>
              <a:gd name="connsiteY4" fmla="*/ 3803 h 850249"/>
              <a:gd name="connsiteX5" fmla="*/ 797513 w 1019578"/>
              <a:gd name="connsiteY5" fmla="*/ 144996 h 850249"/>
              <a:gd name="connsiteX6" fmla="*/ 945430 w 1019578"/>
              <a:gd name="connsiteY6" fmla="*/ 192061 h 850249"/>
              <a:gd name="connsiteX7" fmla="*/ 1019390 w 1019578"/>
              <a:gd name="connsiteY7" fmla="*/ 319807 h 850249"/>
              <a:gd name="connsiteX8" fmla="*/ 965603 w 1019578"/>
              <a:gd name="connsiteY8" fmla="*/ 396500 h 850249"/>
              <a:gd name="connsiteX9" fmla="*/ 884918 w 1019578"/>
              <a:gd name="connsiteY9" fmla="*/ 649261 h 850249"/>
              <a:gd name="connsiteX10" fmla="*/ 676489 w 1019578"/>
              <a:gd name="connsiteY10" fmla="*/ 709772 h 850249"/>
              <a:gd name="connsiteX11" fmla="*/ 515126 w 1019578"/>
              <a:gd name="connsiteY11" fmla="*/ 849708 h 850249"/>
              <a:gd name="connsiteX12" fmla="*/ 326866 w 1019578"/>
              <a:gd name="connsiteY12" fmla="*/ 756838 h 850249"/>
              <a:gd name="connsiteX13" fmla="*/ 91542 w 1019578"/>
              <a:gd name="connsiteY13" fmla="*/ 723220 h 850249"/>
              <a:gd name="connsiteX14" fmla="*/ 57925 w 1019578"/>
              <a:gd name="connsiteY14" fmla="*/ 508066 h 850249"/>
              <a:gd name="connsiteX15" fmla="*/ 4137 w 1019578"/>
              <a:gd name="connsiteY15" fmla="*/ 416670 h 850249"/>
              <a:gd name="connsiteX0" fmla="*/ 4137 w 1019420"/>
              <a:gd name="connsiteY0" fmla="*/ 416670 h 850249"/>
              <a:gd name="connsiteX1" fmla="*/ 178949 w 1019420"/>
              <a:gd name="connsiteY1" fmla="*/ 218955 h 850249"/>
              <a:gd name="connsiteX2" fmla="*/ 246183 w 1019420"/>
              <a:gd name="connsiteY2" fmla="*/ 3802 h 850249"/>
              <a:gd name="connsiteX3" fmla="*/ 521850 w 1019420"/>
              <a:gd name="connsiteY3" fmla="*/ 57591 h 850249"/>
              <a:gd name="connsiteX4" fmla="*/ 696660 w 1019420"/>
              <a:gd name="connsiteY4" fmla="*/ 3803 h 850249"/>
              <a:gd name="connsiteX5" fmla="*/ 797513 w 1019420"/>
              <a:gd name="connsiteY5" fmla="*/ 144996 h 850249"/>
              <a:gd name="connsiteX6" fmla="*/ 945430 w 1019420"/>
              <a:gd name="connsiteY6" fmla="*/ 192061 h 850249"/>
              <a:gd name="connsiteX7" fmla="*/ 1019390 w 1019420"/>
              <a:gd name="connsiteY7" fmla="*/ 319807 h 850249"/>
              <a:gd name="connsiteX8" fmla="*/ 738585 w 1019420"/>
              <a:gd name="connsiteY8" fmla="*/ 356395 h 850249"/>
              <a:gd name="connsiteX9" fmla="*/ 884918 w 1019420"/>
              <a:gd name="connsiteY9" fmla="*/ 649261 h 850249"/>
              <a:gd name="connsiteX10" fmla="*/ 676489 w 1019420"/>
              <a:gd name="connsiteY10" fmla="*/ 709772 h 850249"/>
              <a:gd name="connsiteX11" fmla="*/ 515126 w 1019420"/>
              <a:gd name="connsiteY11" fmla="*/ 849708 h 850249"/>
              <a:gd name="connsiteX12" fmla="*/ 326866 w 1019420"/>
              <a:gd name="connsiteY12" fmla="*/ 756838 h 850249"/>
              <a:gd name="connsiteX13" fmla="*/ 91542 w 1019420"/>
              <a:gd name="connsiteY13" fmla="*/ 723220 h 850249"/>
              <a:gd name="connsiteX14" fmla="*/ 57925 w 1019420"/>
              <a:gd name="connsiteY14" fmla="*/ 508066 h 850249"/>
              <a:gd name="connsiteX15" fmla="*/ 4137 w 1019420"/>
              <a:gd name="connsiteY15" fmla="*/ 416670 h 850249"/>
              <a:gd name="connsiteX0" fmla="*/ 4137 w 1019421"/>
              <a:gd name="connsiteY0" fmla="*/ 416670 h 850249"/>
              <a:gd name="connsiteX1" fmla="*/ 178949 w 1019421"/>
              <a:gd name="connsiteY1" fmla="*/ 218955 h 850249"/>
              <a:gd name="connsiteX2" fmla="*/ 246183 w 1019421"/>
              <a:gd name="connsiteY2" fmla="*/ 3802 h 850249"/>
              <a:gd name="connsiteX3" fmla="*/ 521850 w 1019421"/>
              <a:gd name="connsiteY3" fmla="*/ 57591 h 850249"/>
              <a:gd name="connsiteX4" fmla="*/ 696660 w 1019421"/>
              <a:gd name="connsiteY4" fmla="*/ 3803 h 850249"/>
              <a:gd name="connsiteX5" fmla="*/ 797513 w 1019421"/>
              <a:gd name="connsiteY5" fmla="*/ 144996 h 850249"/>
              <a:gd name="connsiteX6" fmla="*/ 945430 w 1019421"/>
              <a:gd name="connsiteY6" fmla="*/ 192061 h 850249"/>
              <a:gd name="connsiteX7" fmla="*/ 1019390 w 1019421"/>
              <a:gd name="connsiteY7" fmla="*/ 319807 h 850249"/>
              <a:gd name="connsiteX8" fmla="*/ 738585 w 1019421"/>
              <a:gd name="connsiteY8" fmla="*/ 356395 h 850249"/>
              <a:gd name="connsiteX9" fmla="*/ 489737 w 1019421"/>
              <a:gd name="connsiteY9" fmla="*/ 424671 h 850249"/>
              <a:gd name="connsiteX10" fmla="*/ 676489 w 1019421"/>
              <a:gd name="connsiteY10" fmla="*/ 709772 h 850249"/>
              <a:gd name="connsiteX11" fmla="*/ 515126 w 1019421"/>
              <a:gd name="connsiteY11" fmla="*/ 849708 h 850249"/>
              <a:gd name="connsiteX12" fmla="*/ 326866 w 1019421"/>
              <a:gd name="connsiteY12" fmla="*/ 756838 h 850249"/>
              <a:gd name="connsiteX13" fmla="*/ 91542 w 1019421"/>
              <a:gd name="connsiteY13" fmla="*/ 723220 h 850249"/>
              <a:gd name="connsiteX14" fmla="*/ 57925 w 1019421"/>
              <a:gd name="connsiteY14" fmla="*/ 508066 h 850249"/>
              <a:gd name="connsiteX15" fmla="*/ 4137 w 1019421"/>
              <a:gd name="connsiteY15" fmla="*/ 416670 h 850249"/>
              <a:gd name="connsiteX0" fmla="*/ 4137 w 947632"/>
              <a:gd name="connsiteY0" fmla="*/ 416670 h 850249"/>
              <a:gd name="connsiteX1" fmla="*/ 178949 w 947632"/>
              <a:gd name="connsiteY1" fmla="*/ 218955 h 850249"/>
              <a:gd name="connsiteX2" fmla="*/ 246183 w 947632"/>
              <a:gd name="connsiteY2" fmla="*/ 3802 h 850249"/>
              <a:gd name="connsiteX3" fmla="*/ 521850 w 947632"/>
              <a:gd name="connsiteY3" fmla="*/ 57591 h 850249"/>
              <a:gd name="connsiteX4" fmla="*/ 696660 w 947632"/>
              <a:gd name="connsiteY4" fmla="*/ 3803 h 850249"/>
              <a:gd name="connsiteX5" fmla="*/ 797513 w 947632"/>
              <a:gd name="connsiteY5" fmla="*/ 144996 h 850249"/>
              <a:gd name="connsiteX6" fmla="*/ 945430 w 947632"/>
              <a:gd name="connsiteY6" fmla="*/ 192061 h 850249"/>
              <a:gd name="connsiteX7" fmla="*/ 708289 w 947632"/>
              <a:gd name="connsiteY7" fmla="*/ 271680 h 850249"/>
              <a:gd name="connsiteX8" fmla="*/ 738585 w 947632"/>
              <a:gd name="connsiteY8" fmla="*/ 356395 h 850249"/>
              <a:gd name="connsiteX9" fmla="*/ 489737 w 947632"/>
              <a:gd name="connsiteY9" fmla="*/ 424671 h 850249"/>
              <a:gd name="connsiteX10" fmla="*/ 676489 w 947632"/>
              <a:gd name="connsiteY10" fmla="*/ 709772 h 850249"/>
              <a:gd name="connsiteX11" fmla="*/ 515126 w 947632"/>
              <a:gd name="connsiteY11" fmla="*/ 849708 h 850249"/>
              <a:gd name="connsiteX12" fmla="*/ 326866 w 947632"/>
              <a:gd name="connsiteY12" fmla="*/ 756838 h 850249"/>
              <a:gd name="connsiteX13" fmla="*/ 91542 w 947632"/>
              <a:gd name="connsiteY13" fmla="*/ 723220 h 850249"/>
              <a:gd name="connsiteX14" fmla="*/ 57925 w 947632"/>
              <a:gd name="connsiteY14" fmla="*/ 508066 h 850249"/>
              <a:gd name="connsiteX15" fmla="*/ 4137 w 947632"/>
              <a:gd name="connsiteY15" fmla="*/ 416670 h 850249"/>
              <a:gd name="connsiteX0" fmla="*/ 4137 w 947632"/>
              <a:gd name="connsiteY0" fmla="*/ 416670 h 759165"/>
              <a:gd name="connsiteX1" fmla="*/ 178949 w 947632"/>
              <a:gd name="connsiteY1" fmla="*/ 218955 h 759165"/>
              <a:gd name="connsiteX2" fmla="*/ 246183 w 947632"/>
              <a:gd name="connsiteY2" fmla="*/ 3802 h 759165"/>
              <a:gd name="connsiteX3" fmla="*/ 521850 w 947632"/>
              <a:gd name="connsiteY3" fmla="*/ 57591 h 759165"/>
              <a:gd name="connsiteX4" fmla="*/ 696660 w 947632"/>
              <a:gd name="connsiteY4" fmla="*/ 3803 h 759165"/>
              <a:gd name="connsiteX5" fmla="*/ 797513 w 947632"/>
              <a:gd name="connsiteY5" fmla="*/ 144996 h 759165"/>
              <a:gd name="connsiteX6" fmla="*/ 945430 w 947632"/>
              <a:gd name="connsiteY6" fmla="*/ 192061 h 759165"/>
              <a:gd name="connsiteX7" fmla="*/ 708289 w 947632"/>
              <a:gd name="connsiteY7" fmla="*/ 271680 h 759165"/>
              <a:gd name="connsiteX8" fmla="*/ 738585 w 947632"/>
              <a:gd name="connsiteY8" fmla="*/ 356395 h 759165"/>
              <a:gd name="connsiteX9" fmla="*/ 489737 w 947632"/>
              <a:gd name="connsiteY9" fmla="*/ 424671 h 759165"/>
              <a:gd name="connsiteX10" fmla="*/ 676489 w 947632"/>
              <a:gd name="connsiteY10" fmla="*/ 709772 h 759165"/>
              <a:gd name="connsiteX11" fmla="*/ 439454 w 947632"/>
              <a:gd name="connsiteY11" fmla="*/ 641160 h 759165"/>
              <a:gd name="connsiteX12" fmla="*/ 326866 w 947632"/>
              <a:gd name="connsiteY12" fmla="*/ 756838 h 759165"/>
              <a:gd name="connsiteX13" fmla="*/ 91542 w 947632"/>
              <a:gd name="connsiteY13" fmla="*/ 723220 h 759165"/>
              <a:gd name="connsiteX14" fmla="*/ 57925 w 947632"/>
              <a:gd name="connsiteY14" fmla="*/ 508066 h 759165"/>
              <a:gd name="connsiteX15" fmla="*/ 4137 w 947632"/>
              <a:gd name="connsiteY15" fmla="*/ 416670 h 759165"/>
              <a:gd name="connsiteX0" fmla="*/ 4137 w 947632"/>
              <a:gd name="connsiteY0" fmla="*/ 413469 h 755964"/>
              <a:gd name="connsiteX1" fmla="*/ 178949 w 947632"/>
              <a:gd name="connsiteY1" fmla="*/ 215754 h 755964"/>
              <a:gd name="connsiteX2" fmla="*/ 448176 w 947632"/>
              <a:gd name="connsiteY2" fmla="*/ 225155 h 755964"/>
              <a:gd name="connsiteX3" fmla="*/ 521850 w 947632"/>
              <a:gd name="connsiteY3" fmla="*/ 54390 h 755964"/>
              <a:gd name="connsiteX4" fmla="*/ 696660 w 947632"/>
              <a:gd name="connsiteY4" fmla="*/ 602 h 755964"/>
              <a:gd name="connsiteX5" fmla="*/ 797513 w 947632"/>
              <a:gd name="connsiteY5" fmla="*/ 141795 h 755964"/>
              <a:gd name="connsiteX6" fmla="*/ 945430 w 947632"/>
              <a:gd name="connsiteY6" fmla="*/ 188860 h 755964"/>
              <a:gd name="connsiteX7" fmla="*/ 708289 w 947632"/>
              <a:gd name="connsiteY7" fmla="*/ 268479 h 755964"/>
              <a:gd name="connsiteX8" fmla="*/ 738585 w 947632"/>
              <a:gd name="connsiteY8" fmla="*/ 353194 h 755964"/>
              <a:gd name="connsiteX9" fmla="*/ 489737 w 947632"/>
              <a:gd name="connsiteY9" fmla="*/ 421470 h 755964"/>
              <a:gd name="connsiteX10" fmla="*/ 676489 w 947632"/>
              <a:gd name="connsiteY10" fmla="*/ 706571 h 755964"/>
              <a:gd name="connsiteX11" fmla="*/ 439454 w 947632"/>
              <a:gd name="connsiteY11" fmla="*/ 637959 h 755964"/>
              <a:gd name="connsiteX12" fmla="*/ 326866 w 947632"/>
              <a:gd name="connsiteY12" fmla="*/ 753637 h 755964"/>
              <a:gd name="connsiteX13" fmla="*/ 91542 w 947632"/>
              <a:gd name="connsiteY13" fmla="*/ 720019 h 755964"/>
              <a:gd name="connsiteX14" fmla="*/ 57925 w 947632"/>
              <a:gd name="connsiteY14" fmla="*/ 504865 h 755964"/>
              <a:gd name="connsiteX15" fmla="*/ 4137 w 947632"/>
              <a:gd name="connsiteY15" fmla="*/ 413469 h 755964"/>
              <a:gd name="connsiteX0" fmla="*/ 182 w 943677"/>
              <a:gd name="connsiteY0" fmla="*/ 413469 h 755964"/>
              <a:gd name="connsiteX1" fmla="*/ 174994 w 943677"/>
              <a:gd name="connsiteY1" fmla="*/ 215754 h 755964"/>
              <a:gd name="connsiteX2" fmla="*/ 444221 w 943677"/>
              <a:gd name="connsiteY2" fmla="*/ 225155 h 755964"/>
              <a:gd name="connsiteX3" fmla="*/ 517895 w 943677"/>
              <a:gd name="connsiteY3" fmla="*/ 54390 h 755964"/>
              <a:gd name="connsiteX4" fmla="*/ 692705 w 943677"/>
              <a:gd name="connsiteY4" fmla="*/ 602 h 755964"/>
              <a:gd name="connsiteX5" fmla="*/ 793558 w 943677"/>
              <a:gd name="connsiteY5" fmla="*/ 141795 h 755964"/>
              <a:gd name="connsiteX6" fmla="*/ 941475 w 943677"/>
              <a:gd name="connsiteY6" fmla="*/ 188860 h 755964"/>
              <a:gd name="connsiteX7" fmla="*/ 704334 w 943677"/>
              <a:gd name="connsiteY7" fmla="*/ 268479 h 755964"/>
              <a:gd name="connsiteX8" fmla="*/ 734630 w 943677"/>
              <a:gd name="connsiteY8" fmla="*/ 353194 h 755964"/>
              <a:gd name="connsiteX9" fmla="*/ 485782 w 943677"/>
              <a:gd name="connsiteY9" fmla="*/ 421470 h 755964"/>
              <a:gd name="connsiteX10" fmla="*/ 672534 w 943677"/>
              <a:gd name="connsiteY10" fmla="*/ 706571 h 755964"/>
              <a:gd name="connsiteX11" fmla="*/ 435499 w 943677"/>
              <a:gd name="connsiteY11" fmla="*/ 637959 h 755964"/>
              <a:gd name="connsiteX12" fmla="*/ 322911 w 943677"/>
              <a:gd name="connsiteY12" fmla="*/ 753637 h 755964"/>
              <a:gd name="connsiteX13" fmla="*/ 87587 w 943677"/>
              <a:gd name="connsiteY13" fmla="*/ 720019 h 755964"/>
              <a:gd name="connsiteX14" fmla="*/ 211366 w 943677"/>
              <a:gd name="connsiteY14" fmla="*/ 468203 h 755964"/>
              <a:gd name="connsiteX15" fmla="*/ 182 w 943677"/>
              <a:gd name="connsiteY15" fmla="*/ 413469 h 755964"/>
              <a:gd name="connsiteX0" fmla="*/ 73 w 943568"/>
              <a:gd name="connsiteY0" fmla="*/ 413469 h 755964"/>
              <a:gd name="connsiteX1" fmla="*/ 237842 w 943568"/>
              <a:gd name="connsiteY1" fmla="*/ 298241 h 755964"/>
              <a:gd name="connsiteX2" fmla="*/ 444112 w 943568"/>
              <a:gd name="connsiteY2" fmla="*/ 225155 h 755964"/>
              <a:gd name="connsiteX3" fmla="*/ 517786 w 943568"/>
              <a:gd name="connsiteY3" fmla="*/ 54390 h 755964"/>
              <a:gd name="connsiteX4" fmla="*/ 692596 w 943568"/>
              <a:gd name="connsiteY4" fmla="*/ 602 h 755964"/>
              <a:gd name="connsiteX5" fmla="*/ 793449 w 943568"/>
              <a:gd name="connsiteY5" fmla="*/ 141795 h 755964"/>
              <a:gd name="connsiteX6" fmla="*/ 941366 w 943568"/>
              <a:gd name="connsiteY6" fmla="*/ 188860 h 755964"/>
              <a:gd name="connsiteX7" fmla="*/ 704225 w 943568"/>
              <a:gd name="connsiteY7" fmla="*/ 268479 h 755964"/>
              <a:gd name="connsiteX8" fmla="*/ 734521 w 943568"/>
              <a:gd name="connsiteY8" fmla="*/ 353194 h 755964"/>
              <a:gd name="connsiteX9" fmla="*/ 485673 w 943568"/>
              <a:gd name="connsiteY9" fmla="*/ 421470 h 755964"/>
              <a:gd name="connsiteX10" fmla="*/ 672425 w 943568"/>
              <a:gd name="connsiteY10" fmla="*/ 706571 h 755964"/>
              <a:gd name="connsiteX11" fmla="*/ 435390 w 943568"/>
              <a:gd name="connsiteY11" fmla="*/ 637959 h 755964"/>
              <a:gd name="connsiteX12" fmla="*/ 322802 w 943568"/>
              <a:gd name="connsiteY12" fmla="*/ 753637 h 755964"/>
              <a:gd name="connsiteX13" fmla="*/ 87478 w 943568"/>
              <a:gd name="connsiteY13" fmla="*/ 720019 h 755964"/>
              <a:gd name="connsiteX14" fmla="*/ 211257 w 943568"/>
              <a:gd name="connsiteY14" fmla="*/ 468203 h 755964"/>
              <a:gd name="connsiteX15" fmla="*/ 73 w 943568"/>
              <a:gd name="connsiteY15" fmla="*/ 413469 h 755964"/>
              <a:gd name="connsiteX0" fmla="*/ 73 w 943568"/>
              <a:gd name="connsiteY0" fmla="*/ 413469 h 755964"/>
              <a:gd name="connsiteX1" fmla="*/ 237842 w 943568"/>
              <a:gd name="connsiteY1" fmla="*/ 298241 h 755964"/>
              <a:gd name="connsiteX2" fmla="*/ 444112 w 943568"/>
              <a:gd name="connsiteY2" fmla="*/ 225155 h 755964"/>
              <a:gd name="connsiteX3" fmla="*/ 517786 w 943568"/>
              <a:gd name="connsiteY3" fmla="*/ 54390 h 755964"/>
              <a:gd name="connsiteX4" fmla="*/ 692596 w 943568"/>
              <a:gd name="connsiteY4" fmla="*/ 602 h 755964"/>
              <a:gd name="connsiteX5" fmla="*/ 793449 w 943568"/>
              <a:gd name="connsiteY5" fmla="*/ 141795 h 755964"/>
              <a:gd name="connsiteX6" fmla="*/ 941366 w 943568"/>
              <a:gd name="connsiteY6" fmla="*/ 188860 h 755964"/>
              <a:gd name="connsiteX7" fmla="*/ 704225 w 943568"/>
              <a:gd name="connsiteY7" fmla="*/ 268479 h 755964"/>
              <a:gd name="connsiteX8" fmla="*/ 734521 w 943568"/>
              <a:gd name="connsiteY8" fmla="*/ 353194 h 755964"/>
              <a:gd name="connsiteX9" fmla="*/ 485673 w 943568"/>
              <a:gd name="connsiteY9" fmla="*/ 421470 h 755964"/>
              <a:gd name="connsiteX10" fmla="*/ 672425 w 943568"/>
              <a:gd name="connsiteY10" fmla="*/ 706571 h 755964"/>
              <a:gd name="connsiteX11" fmla="*/ 435390 w 943568"/>
              <a:gd name="connsiteY11" fmla="*/ 637959 h 755964"/>
              <a:gd name="connsiteX12" fmla="*/ 322802 w 943568"/>
              <a:gd name="connsiteY12" fmla="*/ 753637 h 755964"/>
              <a:gd name="connsiteX13" fmla="*/ 213396 w 943568"/>
              <a:gd name="connsiteY13" fmla="*/ 610032 h 755964"/>
              <a:gd name="connsiteX14" fmla="*/ 211257 w 943568"/>
              <a:gd name="connsiteY14" fmla="*/ 468203 h 755964"/>
              <a:gd name="connsiteX15" fmla="*/ 73 w 943568"/>
              <a:gd name="connsiteY15" fmla="*/ 413469 h 755964"/>
              <a:gd name="connsiteX0" fmla="*/ 73 w 943568"/>
              <a:gd name="connsiteY0" fmla="*/ 413469 h 756355"/>
              <a:gd name="connsiteX1" fmla="*/ 237842 w 943568"/>
              <a:gd name="connsiteY1" fmla="*/ 298241 h 756355"/>
              <a:gd name="connsiteX2" fmla="*/ 444112 w 943568"/>
              <a:gd name="connsiteY2" fmla="*/ 225155 h 756355"/>
              <a:gd name="connsiteX3" fmla="*/ 517786 w 943568"/>
              <a:gd name="connsiteY3" fmla="*/ 54390 h 756355"/>
              <a:gd name="connsiteX4" fmla="*/ 692596 w 943568"/>
              <a:gd name="connsiteY4" fmla="*/ 602 h 756355"/>
              <a:gd name="connsiteX5" fmla="*/ 793449 w 943568"/>
              <a:gd name="connsiteY5" fmla="*/ 141795 h 756355"/>
              <a:gd name="connsiteX6" fmla="*/ 941366 w 943568"/>
              <a:gd name="connsiteY6" fmla="*/ 188860 h 756355"/>
              <a:gd name="connsiteX7" fmla="*/ 704225 w 943568"/>
              <a:gd name="connsiteY7" fmla="*/ 268479 h 756355"/>
              <a:gd name="connsiteX8" fmla="*/ 734521 w 943568"/>
              <a:gd name="connsiteY8" fmla="*/ 353194 h 756355"/>
              <a:gd name="connsiteX9" fmla="*/ 485673 w 943568"/>
              <a:gd name="connsiteY9" fmla="*/ 421470 h 756355"/>
              <a:gd name="connsiteX10" fmla="*/ 483547 w 943568"/>
              <a:gd name="connsiteY10" fmla="*/ 578254 h 756355"/>
              <a:gd name="connsiteX11" fmla="*/ 435390 w 943568"/>
              <a:gd name="connsiteY11" fmla="*/ 637959 h 756355"/>
              <a:gd name="connsiteX12" fmla="*/ 322802 w 943568"/>
              <a:gd name="connsiteY12" fmla="*/ 753637 h 756355"/>
              <a:gd name="connsiteX13" fmla="*/ 213396 w 943568"/>
              <a:gd name="connsiteY13" fmla="*/ 610032 h 756355"/>
              <a:gd name="connsiteX14" fmla="*/ 211257 w 943568"/>
              <a:gd name="connsiteY14" fmla="*/ 468203 h 756355"/>
              <a:gd name="connsiteX15" fmla="*/ 73 w 943568"/>
              <a:gd name="connsiteY15" fmla="*/ 413469 h 756355"/>
              <a:gd name="connsiteX0" fmla="*/ 73 w 943568"/>
              <a:gd name="connsiteY0" fmla="*/ 359663 h 702549"/>
              <a:gd name="connsiteX1" fmla="*/ 237842 w 943568"/>
              <a:gd name="connsiteY1" fmla="*/ 244435 h 702549"/>
              <a:gd name="connsiteX2" fmla="*/ 444112 w 943568"/>
              <a:gd name="connsiteY2" fmla="*/ 171349 h 702549"/>
              <a:gd name="connsiteX3" fmla="*/ 517786 w 943568"/>
              <a:gd name="connsiteY3" fmla="*/ 584 h 702549"/>
              <a:gd name="connsiteX4" fmla="*/ 566678 w 943568"/>
              <a:gd name="connsiteY4" fmla="*/ 240088 h 702549"/>
              <a:gd name="connsiteX5" fmla="*/ 793449 w 943568"/>
              <a:gd name="connsiteY5" fmla="*/ 87989 h 702549"/>
              <a:gd name="connsiteX6" fmla="*/ 941366 w 943568"/>
              <a:gd name="connsiteY6" fmla="*/ 135054 h 702549"/>
              <a:gd name="connsiteX7" fmla="*/ 704225 w 943568"/>
              <a:gd name="connsiteY7" fmla="*/ 214673 h 702549"/>
              <a:gd name="connsiteX8" fmla="*/ 734521 w 943568"/>
              <a:gd name="connsiteY8" fmla="*/ 299388 h 702549"/>
              <a:gd name="connsiteX9" fmla="*/ 485673 w 943568"/>
              <a:gd name="connsiteY9" fmla="*/ 367664 h 702549"/>
              <a:gd name="connsiteX10" fmla="*/ 483547 w 943568"/>
              <a:gd name="connsiteY10" fmla="*/ 524448 h 702549"/>
              <a:gd name="connsiteX11" fmla="*/ 435390 w 943568"/>
              <a:gd name="connsiteY11" fmla="*/ 584153 h 702549"/>
              <a:gd name="connsiteX12" fmla="*/ 322802 w 943568"/>
              <a:gd name="connsiteY12" fmla="*/ 699831 h 702549"/>
              <a:gd name="connsiteX13" fmla="*/ 213396 w 943568"/>
              <a:gd name="connsiteY13" fmla="*/ 556226 h 702549"/>
              <a:gd name="connsiteX14" fmla="*/ 211257 w 943568"/>
              <a:gd name="connsiteY14" fmla="*/ 414397 h 702549"/>
              <a:gd name="connsiteX15" fmla="*/ 73 w 943568"/>
              <a:gd name="connsiteY15" fmla="*/ 359663 h 702549"/>
              <a:gd name="connsiteX0" fmla="*/ 73 w 829608"/>
              <a:gd name="connsiteY0" fmla="*/ 359663 h 702549"/>
              <a:gd name="connsiteX1" fmla="*/ 237842 w 829608"/>
              <a:gd name="connsiteY1" fmla="*/ 244435 h 702549"/>
              <a:gd name="connsiteX2" fmla="*/ 444112 w 829608"/>
              <a:gd name="connsiteY2" fmla="*/ 171349 h 702549"/>
              <a:gd name="connsiteX3" fmla="*/ 517786 w 829608"/>
              <a:gd name="connsiteY3" fmla="*/ 584 h 702549"/>
              <a:gd name="connsiteX4" fmla="*/ 566678 w 829608"/>
              <a:gd name="connsiteY4" fmla="*/ 240088 h 702549"/>
              <a:gd name="connsiteX5" fmla="*/ 793449 w 829608"/>
              <a:gd name="connsiteY5" fmla="*/ 87989 h 702549"/>
              <a:gd name="connsiteX6" fmla="*/ 825943 w 829608"/>
              <a:gd name="connsiteY6" fmla="*/ 144219 h 702549"/>
              <a:gd name="connsiteX7" fmla="*/ 704225 w 829608"/>
              <a:gd name="connsiteY7" fmla="*/ 214673 h 702549"/>
              <a:gd name="connsiteX8" fmla="*/ 734521 w 829608"/>
              <a:gd name="connsiteY8" fmla="*/ 299388 h 702549"/>
              <a:gd name="connsiteX9" fmla="*/ 485673 w 829608"/>
              <a:gd name="connsiteY9" fmla="*/ 367664 h 702549"/>
              <a:gd name="connsiteX10" fmla="*/ 483547 w 829608"/>
              <a:gd name="connsiteY10" fmla="*/ 524448 h 702549"/>
              <a:gd name="connsiteX11" fmla="*/ 435390 w 829608"/>
              <a:gd name="connsiteY11" fmla="*/ 584153 h 702549"/>
              <a:gd name="connsiteX12" fmla="*/ 322802 w 829608"/>
              <a:gd name="connsiteY12" fmla="*/ 699831 h 702549"/>
              <a:gd name="connsiteX13" fmla="*/ 213396 w 829608"/>
              <a:gd name="connsiteY13" fmla="*/ 556226 h 702549"/>
              <a:gd name="connsiteX14" fmla="*/ 211257 w 829608"/>
              <a:gd name="connsiteY14" fmla="*/ 414397 h 702549"/>
              <a:gd name="connsiteX15" fmla="*/ 73 w 829608"/>
              <a:gd name="connsiteY15" fmla="*/ 359663 h 7025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829608" h="702549">
                <a:moveTo>
                  <a:pt x="73" y="359663"/>
                </a:moveTo>
                <a:cubicBezTo>
                  <a:pt x="4504" y="331336"/>
                  <a:pt x="204225" y="303161"/>
                  <a:pt x="237842" y="244435"/>
                </a:cubicBezTo>
                <a:cubicBezTo>
                  <a:pt x="271459" y="185709"/>
                  <a:pt x="374635" y="192640"/>
                  <a:pt x="444112" y="171349"/>
                </a:cubicBezTo>
                <a:cubicBezTo>
                  <a:pt x="513589" y="150058"/>
                  <a:pt x="497358" y="-10872"/>
                  <a:pt x="517786" y="584"/>
                </a:cubicBezTo>
                <a:cubicBezTo>
                  <a:pt x="538214" y="12040"/>
                  <a:pt x="515131" y="235606"/>
                  <a:pt x="566678" y="240088"/>
                </a:cubicBezTo>
                <a:cubicBezTo>
                  <a:pt x="618225" y="244570"/>
                  <a:pt x="751987" y="56613"/>
                  <a:pt x="793449" y="87989"/>
                </a:cubicBezTo>
                <a:cubicBezTo>
                  <a:pt x="834911" y="119365"/>
                  <a:pt x="796808" y="122928"/>
                  <a:pt x="825943" y="144219"/>
                </a:cubicBezTo>
                <a:cubicBezTo>
                  <a:pt x="855078" y="165510"/>
                  <a:pt x="700863" y="180600"/>
                  <a:pt x="704225" y="214673"/>
                </a:cubicBezTo>
                <a:cubicBezTo>
                  <a:pt x="707587" y="248746"/>
                  <a:pt x="749089" y="236635"/>
                  <a:pt x="734521" y="299388"/>
                </a:cubicBezTo>
                <a:cubicBezTo>
                  <a:pt x="719953" y="362141"/>
                  <a:pt x="543944" y="318814"/>
                  <a:pt x="485673" y="367664"/>
                </a:cubicBezTo>
                <a:cubicBezTo>
                  <a:pt x="427402" y="416514"/>
                  <a:pt x="533973" y="483196"/>
                  <a:pt x="483547" y="524448"/>
                </a:cubicBezTo>
                <a:cubicBezTo>
                  <a:pt x="433121" y="565700"/>
                  <a:pt x="462181" y="554922"/>
                  <a:pt x="435390" y="584153"/>
                </a:cubicBezTo>
                <a:cubicBezTo>
                  <a:pt x="408599" y="613384"/>
                  <a:pt x="393399" y="720912"/>
                  <a:pt x="322802" y="699831"/>
                </a:cubicBezTo>
                <a:cubicBezTo>
                  <a:pt x="252205" y="678750"/>
                  <a:pt x="268305" y="588723"/>
                  <a:pt x="213396" y="556226"/>
                </a:cubicBezTo>
                <a:cubicBezTo>
                  <a:pt x="158487" y="523729"/>
                  <a:pt x="225825" y="465489"/>
                  <a:pt x="211257" y="414397"/>
                </a:cubicBezTo>
                <a:cubicBezTo>
                  <a:pt x="196689" y="363305"/>
                  <a:pt x="-4358" y="387990"/>
                  <a:pt x="73" y="359663"/>
                </a:cubicBezTo>
                <a:close/>
              </a:path>
            </a:pathLst>
          </a:cu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Oval 288">
            <a:extLst>
              <a:ext uri="{FF2B5EF4-FFF2-40B4-BE49-F238E27FC236}">
                <a16:creationId xmlns:a16="http://schemas.microsoft.com/office/drawing/2014/main" id="{CD3A5AC1-78DD-AB4C-BA91-289044E85F6D}"/>
              </a:ext>
            </a:extLst>
          </p:cNvPr>
          <p:cNvSpPr/>
          <p:nvPr/>
        </p:nvSpPr>
        <p:spPr>
          <a:xfrm>
            <a:off x="4436058" y="6472615"/>
            <a:ext cx="81523" cy="6766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Oval 289">
            <a:extLst>
              <a:ext uri="{FF2B5EF4-FFF2-40B4-BE49-F238E27FC236}">
                <a16:creationId xmlns:a16="http://schemas.microsoft.com/office/drawing/2014/main" id="{EEC11E99-CA1D-3DEC-25F2-A8D7C8A006AA}"/>
              </a:ext>
            </a:extLst>
          </p:cNvPr>
          <p:cNvSpPr/>
          <p:nvPr/>
        </p:nvSpPr>
        <p:spPr>
          <a:xfrm>
            <a:off x="4561193" y="6559609"/>
            <a:ext cx="81523" cy="6766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Oval 290">
            <a:extLst>
              <a:ext uri="{FF2B5EF4-FFF2-40B4-BE49-F238E27FC236}">
                <a16:creationId xmlns:a16="http://schemas.microsoft.com/office/drawing/2014/main" id="{FD3E6F09-B0DF-C89C-BE25-15FA9713FB50}"/>
              </a:ext>
            </a:extLst>
          </p:cNvPr>
          <p:cNvSpPr/>
          <p:nvPr/>
        </p:nvSpPr>
        <p:spPr>
          <a:xfrm>
            <a:off x="4262580" y="6635666"/>
            <a:ext cx="81523" cy="6766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Oval 291">
            <a:extLst>
              <a:ext uri="{FF2B5EF4-FFF2-40B4-BE49-F238E27FC236}">
                <a16:creationId xmlns:a16="http://schemas.microsoft.com/office/drawing/2014/main" id="{E0EE4357-DB84-7FDA-2295-79E4880E78AD}"/>
              </a:ext>
            </a:extLst>
          </p:cNvPr>
          <p:cNvSpPr/>
          <p:nvPr/>
        </p:nvSpPr>
        <p:spPr>
          <a:xfrm>
            <a:off x="4311134" y="6525777"/>
            <a:ext cx="81523" cy="6766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Oval 292">
            <a:extLst>
              <a:ext uri="{FF2B5EF4-FFF2-40B4-BE49-F238E27FC236}">
                <a16:creationId xmlns:a16="http://schemas.microsoft.com/office/drawing/2014/main" id="{F1D2727B-640B-D03C-6B92-0C2181516ECB}"/>
              </a:ext>
            </a:extLst>
          </p:cNvPr>
          <p:cNvSpPr/>
          <p:nvPr/>
        </p:nvSpPr>
        <p:spPr>
          <a:xfrm>
            <a:off x="4431662" y="6620322"/>
            <a:ext cx="81523" cy="6766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4" name="Picture 293" descr="A red and yellow star&#10;&#10;Description automatically generated with medium confidence">
            <a:extLst>
              <a:ext uri="{FF2B5EF4-FFF2-40B4-BE49-F238E27FC236}">
                <a16:creationId xmlns:a16="http://schemas.microsoft.com/office/drawing/2014/main" id="{38711900-43D3-4F3C-A00A-D355304C0CE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22415" y="6851771"/>
            <a:ext cx="613506" cy="631660"/>
          </a:xfrm>
          <a:prstGeom prst="rect">
            <a:avLst/>
          </a:prstGeom>
        </p:spPr>
      </p:pic>
      <p:pic>
        <p:nvPicPr>
          <p:cNvPr id="295" name="Picture 294" descr="A red and yellow star&#10;&#10;Description automatically generated with medium confidence">
            <a:extLst>
              <a:ext uri="{FF2B5EF4-FFF2-40B4-BE49-F238E27FC236}">
                <a16:creationId xmlns:a16="http://schemas.microsoft.com/office/drawing/2014/main" id="{D4E5F09D-D0FD-6BCB-E31E-7D704A7EF12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55348" y="7533523"/>
            <a:ext cx="1289971" cy="825769"/>
          </a:xfrm>
          <a:prstGeom prst="rect">
            <a:avLst/>
          </a:prstGeom>
        </p:spPr>
      </p:pic>
      <p:grpSp>
        <p:nvGrpSpPr>
          <p:cNvPr id="296" name="Group 295">
            <a:extLst>
              <a:ext uri="{FF2B5EF4-FFF2-40B4-BE49-F238E27FC236}">
                <a16:creationId xmlns:a16="http://schemas.microsoft.com/office/drawing/2014/main" id="{9309147D-742A-162B-BD95-5F61217B91D1}"/>
              </a:ext>
            </a:extLst>
          </p:cNvPr>
          <p:cNvGrpSpPr/>
          <p:nvPr/>
        </p:nvGrpSpPr>
        <p:grpSpPr>
          <a:xfrm rot="21103760">
            <a:off x="3373745" y="7687565"/>
            <a:ext cx="424991" cy="378512"/>
            <a:chOff x="688105" y="647054"/>
            <a:chExt cx="1569078" cy="1566515"/>
          </a:xfrm>
        </p:grpSpPr>
        <p:sp>
          <p:nvSpPr>
            <p:cNvPr id="297" name="Oval 4">
              <a:extLst>
                <a:ext uri="{FF2B5EF4-FFF2-40B4-BE49-F238E27FC236}">
                  <a16:creationId xmlns:a16="http://schemas.microsoft.com/office/drawing/2014/main" id="{7893F226-206E-3B06-A531-2F19E7670D6E}"/>
                </a:ext>
              </a:extLst>
            </p:cNvPr>
            <p:cNvSpPr/>
            <p:nvPr/>
          </p:nvSpPr>
          <p:spPr>
            <a:xfrm>
              <a:off x="688105" y="647054"/>
              <a:ext cx="1569078" cy="1566515"/>
            </a:xfrm>
            <a:custGeom>
              <a:avLst/>
              <a:gdLst>
                <a:gd name="connsiteX0" fmla="*/ 0 w 747423"/>
                <a:gd name="connsiteY0" fmla="*/ 492981 h 985962"/>
                <a:gd name="connsiteX1" fmla="*/ 373712 w 747423"/>
                <a:gd name="connsiteY1" fmla="*/ 0 h 985962"/>
                <a:gd name="connsiteX2" fmla="*/ 747424 w 747423"/>
                <a:gd name="connsiteY2" fmla="*/ 492981 h 985962"/>
                <a:gd name="connsiteX3" fmla="*/ 373712 w 747423"/>
                <a:gd name="connsiteY3" fmla="*/ 985962 h 985962"/>
                <a:gd name="connsiteX4" fmla="*/ 0 w 747423"/>
                <a:gd name="connsiteY4" fmla="*/ 492981 h 985962"/>
                <a:gd name="connsiteX0" fmla="*/ 0 w 747424"/>
                <a:gd name="connsiteY0" fmla="*/ 755374 h 1248355"/>
                <a:gd name="connsiteX1" fmla="*/ 373712 w 747424"/>
                <a:gd name="connsiteY1" fmla="*/ 0 h 1248355"/>
                <a:gd name="connsiteX2" fmla="*/ 747424 w 747424"/>
                <a:gd name="connsiteY2" fmla="*/ 755374 h 1248355"/>
                <a:gd name="connsiteX3" fmla="*/ 373712 w 747424"/>
                <a:gd name="connsiteY3" fmla="*/ 1248355 h 1248355"/>
                <a:gd name="connsiteX4" fmla="*/ 0 w 747424"/>
                <a:gd name="connsiteY4" fmla="*/ 755374 h 1248355"/>
                <a:gd name="connsiteX0" fmla="*/ 0 w 747424"/>
                <a:gd name="connsiteY0" fmla="*/ 755374 h 1566407"/>
                <a:gd name="connsiteX1" fmla="*/ 373712 w 747424"/>
                <a:gd name="connsiteY1" fmla="*/ 0 h 1566407"/>
                <a:gd name="connsiteX2" fmla="*/ 747424 w 747424"/>
                <a:gd name="connsiteY2" fmla="*/ 755374 h 1566407"/>
                <a:gd name="connsiteX3" fmla="*/ 373712 w 747424"/>
                <a:gd name="connsiteY3" fmla="*/ 1566407 h 1566407"/>
                <a:gd name="connsiteX4" fmla="*/ 0 w 747424"/>
                <a:gd name="connsiteY4" fmla="*/ 755374 h 1566407"/>
                <a:gd name="connsiteX0" fmla="*/ 0 w 1176794"/>
                <a:gd name="connsiteY0" fmla="*/ 763327 h 1566411"/>
                <a:gd name="connsiteX1" fmla="*/ 803082 w 1176794"/>
                <a:gd name="connsiteY1" fmla="*/ 2 h 1566411"/>
                <a:gd name="connsiteX2" fmla="*/ 1176794 w 1176794"/>
                <a:gd name="connsiteY2" fmla="*/ 755376 h 1566411"/>
                <a:gd name="connsiteX3" fmla="*/ 803082 w 1176794"/>
                <a:gd name="connsiteY3" fmla="*/ 1566409 h 1566411"/>
                <a:gd name="connsiteX4" fmla="*/ 0 w 1176794"/>
                <a:gd name="connsiteY4" fmla="*/ 763327 h 1566411"/>
                <a:gd name="connsiteX0" fmla="*/ 0 w 1582310"/>
                <a:gd name="connsiteY0" fmla="*/ 763428 h 1566595"/>
                <a:gd name="connsiteX1" fmla="*/ 803082 w 1582310"/>
                <a:gd name="connsiteY1" fmla="*/ 103 h 1566595"/>
                <a:gd name="connsiteX2" fmla="*/ 1582310 w 1582310"/>
                <a:gd name="connsiteY2" fmla="*/ 715721 h 1566595"/>
                <a:gd name="connsiteX3" fmla="*/ 803082 w 1582310"/>
                <a:gd name="connsiteY3" fmla="*/ 1566510 h 1566595"/>
                <a:gd name="connsiteX4" fmla="*/ 0 w 1582310"/>
                <a:gd name="connsiteY4" fmla="*/ 763428 h 1566595"/>
                <a:gd name="connsiteX0" fmla="*/ 1056 w 1583366"/>
                <a:gd name="connsiteY0" fmla="*/ 764563 h 1567718"/>
                <a:gd name="connsiteX1" fmla="*/ 637159 w 1583366"/>
                <a:gd name="connsiteY1" fmla="*/ 549879 h 1567718"/>
                <a:gd name="connsiteX2" fmla="*/ 804138 w 1583366"/>
                <a:gd name="connsiteY2" fmla="*/ 1238 h 1567718"/>
                <a:gd name="connsiteX3" fmla="*/ 1583366 w 1583366"/>
                <a:gd name="connsiteY3" fmla="*/ 716856 h 1567718"/>
                <a:gd name="connsiteX4" fmla="*/ 804138 w 1583366"/>
                <a:gd name="connsiteY4" fmla="*/ 1567645 h 1567718"/>
                <a:gd name="connsiteX5" fmla="*/ 1056 w 1583366"/>
                <a:gd name="connsiteY5" fmla="*/ 764563 h 1567718"/>
                <a:gd name="connsiteX0" fmla="*/ 1056 w 1590327"/>
                <a:gd name="connsiteY0" fmla="*/ 763374 h 1566529"/>
                <a:gd name="connsiteX1" fmla="*/ 637159 w 1590327"/>
                <a:gd name="connsiteY1" fmla="*/ 548690 h 1566529"/>
                <a:gd name="connsiteX2" fmla="*/ 804138 w 1590327"/>
                <a:gd name="connsiteY2" fmla="*/ 49 h 1566529"/>
                <a:gd name="connsiteX3" fmla="*/ 987016 w 1590327"/>
                <a:gd name="connsiteY3" fmla="*/ 580496 h 1566529"/>
                <a:gd name="connsiteX4" fmla="*/ 1583366 w 1590327"/>
                <a:gd name="connsiteY4" fmla="*/ 715667 h 1566529"/>
                <a:gd name="connsiteX5" fmla="*/ 804138 w 1590327"/>
                <a:gd name="connsiteY5" fmla="*/ 1566456 h 1566529"/>
                <a:gd name="connsiteX6" fmla="*/ 1056 w 1590327"/>
                <a:gd name="connsiteY6" fmla="*/ 763374 h 1566529"/>
                <a:gd name="connsiteX0" fmla="*/ 1056 w 1586506"/>
                <a:gd name="connsiteY0" fmla="*/ 763374 h 1566559"/>
                <a:gd name="connsiteX1" fmla="*/ 637159 w 1586506"/>
                <a:gd name="connsiteY1" fmla="*/ 548690 h 1566559"/>
                <a:gd name="connsiteX2" fmla="*/ 804138 w 1586506"/>
                <a:gd name="connsiteY2" fmla="*/ 49 h 1566559"/>
                <a:gd name="connsiteX3" fmla="*/ 987016 w 1586506"/>
                <a:gd name="connsiteY3" fmla="*/ 580496 h 1566559"/>
                <a:gd name="connsiteX4" fmla="*/ 1583366 w 1586506"/>
                <a:gd name="connsiteY4" fmla="*/ 715667 h 1566559"/>
                <a:gd name="connsiteX5" fmla="*/ 963162 w 1586506"/>
                <a:gd name="connsiteY5" fmla="*/ 819035 h 1566559"/>
                <a:gd name="connsiteX6" fmla="*/ 804138 w 1586506"/>
                <a:gd name="connsiteY6" fmla="*/ 1566456 h 1566559"/>
                <a:gd name="connsiteX7" fmla="*/ 1056 w 1586506"/>
                <a:gd name="connsiteY7" fmla="*/ 763374 h 1566559"/>
                <a:gd name="connsiteX0" fmla="*/ 125 w 1585575"/>
                <a:gd name="connsiteY0" fmla="*/ 763374 h 1566456"/>
                <a:gd name="connsiteX1" fmla="*/ 636228 w 1585575"/>
                <a:gd name="connsiteY1" fmla="*/ 548690 h 1566456"/>
                <a:gd name="connsiteX2" fmla="*/ 803207 w 1585575"/>
                <a:gd name="connsiteY2" fmla="*/ 49 h 1566456"/>
                <a:gd name="connsiteX3" fmla="*/ 986085 w 1585575"/>
                <a:gd name="connsiteY3" fmla="*/ 580496 h 1566456"/>
                <a:gd name="connsiteX4" fmla="*/ 1582435 w 1585575"/>
                <a:gd name="connsiteY4" fmla="*/ 715667 h 1566456"/>
                <a:gd name="connsiteX5" fmla="*/ 962231 w 1585575"/>
                <a:gd name="connsiteY5" fmla="*/ 819035 h 1566456"/>
                <a:gd name="connsiteX6" fmla="*/ 803207 w 1585575"/>
                <a:gd name="connsiteY6" fmla="*/ 1566456 h 1566456"/>
                <a:gd name="connsiteX7" fmla="*/ 691887 w 1585575"/>
                <a:gd name="connsiteY7" fmla="*/ 819035 h 1566456"/>
                <a:gd name="connsiteX8" fmla="*/ 125 w 1585575"/>
                <a:gd name="connsiteY8" fmla="*/ 763374 h 1566456"/>
                <a:gd name="connsiteX0" fmla="*/ 459 w 1585909"/>
                <a:gd name="connsiteY0" fmla="*/ 763328 h 1566410"/>
                <a:gd name="connsiteX1" fmla="*/ 588854 w 1585909"/>
                <a:gd name="connsiteY1" fmla="*/ 588401 h 1566410"/>
                <a:gd name="connsiteX2" fmla="*/ 803541 w 1585909"/>
                <a:gd name="connsiteY2" fmla="*/ 3 h 1566410"/>
                <a:gd name="connsiteX3" fmla="*/ 986419 w 1585909"/>
                <a:gd name="connsiteY3" fmla="*/ 580450 h 1566410"/>
                <a:gd name="connsiteX4" fmla="*/ 1582769 w 1585909"/>
                <a:gd name="connsiteY4" fmla="*/ 715621 h 1566410"/>
                <a:gd name="connsiteX5" fmla="*/ 962565 w 1585909"/>
                <a:gd name="connsiteY5" fmla="*/ 818989 h 1566410"/>
                <a:gd name="connsiteX6" fmla="*/ 803541 w 1585909"/>
                <a:gd name="connsiteY6" fmla="*/ 1566410 h 1566410"/>
                <a:gd name="connsiteX7" fmla="*/ 692221 w 1585909"/>
                <a:gd name="connsiteY7" fmla="*/ 818989 h 1566410"/>
                <a:gd name="connsiteX8" fmla="*/ 459 w 1585909"/>
                <a:gd name="connsiteY8" fmla="*/ 763328 h 1566410"/>
                <a:gd name="connsiteX0" fmla="*/ 459 w 1585909"/>
                <a:gd name="connsiteY0" fmla="*/ 774187 h 1577269"/>
                <a:gd name="connsiteX1" fmla="*/ 588854 w 1585909"/>
                <a:gd name="connsiteY1" fmla="*/ 599260 h 1577269"/>
                <a:gd name="connsiteX2" fmla="*/ 231045 w 1585909"/>
                <a:gd name="connsiteY2" fmla="*/ 241451 h 1577269"/>
                <a:gd name="connsiteX3" fmla="*/ 803541 w 1585909"/>
                <a:gd name="connsiteY3" fmla="*/ 10862 h 1577269"/>
                <a:gd name="connsiteX4" fmla="*/ 986419 w 1585909"/>
                <a:gd name="connsiteY4" fmla="*/ 591309 h 1577269"/>
                <a:gd name="connsiteX5" fmla="*/ 1582769 w 1585909"/>
                <a:gd name="connsiteY5" fmla="*/ 726480 h 1577269"/>
                <a:gd name="connsiteX6" fmla="*/ 962565 w 1585909"/>
                <a:gd name="connsiteY6" fmla="*/ 829848 h 1577269"/>
                <a:gd name="connsiteX7" fmla="*/ 803541 w 1585909"/>
                <a:gd name="connsiteY7" fmla="*/ 1577269 h 1577269"/>
                <a:gd name="connsiteX8" fmla="*/ 692221 w 1585909"/>
                <a:gd name="connsiteY8" fmla="*/ 829848 h 1577269"/>
                <a:gd name="connsiteX9" fmla="*/ 459 w 1585909"/>
                <a:gd name="connsiteY9" fmla="*/ 774187 h 1577269"/>
                <a:gd name="connsiteX0" fmla="*/ 1798 w 1587248"/>
                <a:gd name="connsiteY0" fmla="*/ 774187 h 1577269"/>
                <a:gd name="connsiteX1" fmla="*/ 502729 w 1587248"/>
                <a:gd name="connsiteY1" fmla="*/ 631065 h 1577269"/>
                <a:gd name="connsiteX2" fmla="*/ 232384 w 1587248"/>
                <a:gd name="connsiteY2" fmla="*/ 241451 h 1577269"/>
                <a:gd name="connsiteX3" fmla="*/ 804880 w 1587248"/>
                <a:gd name="connsiteY3" fmla="*/ 10862 h 1577269"/>
                <a:gd name="connsiteX4" fmla="*/ 987758 w 1587248"/>
                <a:gd name="connsiteY4" fmla="*/ 591309 h 1577269"/>
                <a:gd name="connsiteX5" fmla="*/ 1584108 w 1587248"/>
                <a:gd name="connsiteY5" fmla="*/ 726480 h 1577269"/>
                <a:gd name="connsiteX6" fmla="*/ 963904 w 1587248"/>
                <a:gd name="connsiteY6" fmla="*/ 829848 h 1577269"/>
                <a:gd name="connsiteX7" fmla="*/ 804880 w 1587248"/>
                <a:gd name="connsiteY7" fmla="*/ 1577269 h 1577269"/>
                <a:gd name="connsiteX8" fmla="*/ 693560 w 1587248"/>
                <a:gd name="connsiteY8" fmla="*/ 829848 h 1577269"/>
                <a:gd name="connsiteX9" fmla="*/ 1798 w 1587248"/>
                <a:gd name="connsiteY9" fmla="*/ 774187 h 1577269"/>
                <a:gd name="connsiteX0" fmla="*/ 1798 w 1587248"/>
                <a:gd name="connsiteY0" fmla="*/ 764181 h 1567263"/>
                <a:gd name="connsiteX1" fmla="*/ 502729 w 1587248"/>
                <a:gd name="connsiteY1" fmla="*/ 621059 h 1567263"/>
                <a:gd name="connsiteX2" fmla="*/ 232384 w 1587248"/>
                <a:gd name="connsiteY2" fmla="*/ 231445 h 1567263"/>
                <a:gd name="connsiteX3" fmla="*/ 693560 w 1587248"/>
                <a:gd name="connsiteY3" fmla="*/ 446131 h 1567263"/>
                <a:gd name="connsiteX4" fmla="*/ 804880 w 1587248"/>
                <a:gd name="connsiteY4" fmla="*/ 856 h 1567263"/>
                <a:gd name="connsiteX5" fmla="*/ 987758 w 1587248"/>
                <a:gd name="connsiteY5" fmla="*/ 581303 h 1567263"/>
                <a:gd name="connsiteX6" fmla="*/ 1584108 w 1587248"/>
                <a:gd name="connsiteY6" fmla="*/ 716474 h 1567263"/>
                <a:gd name="connsiteX7" fmla="*/ 963904 w 1587248"/>
                <a:gd name="connsiteY7" fmla="*/ 819842 h 1567263"/>
                <a:gd name="connsiteX8" fmla="*/ 804880 w 1587248"/>
                <a:gd name="connsiteY8" fmla="*/ 1567263 h 1567263"/>
                <a:gd name="connsiteX9" fmla="*/ 693560 w 1587248"/>
                <a:gd name="connsiteY9" fmla="*/ 819842 h 1567263"/>
                <a:gd name="connsiteX10" fmla="*/ 1798 w 1587248"/>
                <a:gd name="connsiteY10" fmla="*/ 764181 h 1567263"/>
                <a:gd name="connsiteX0" fmla="*/ 1702 w 1611006"/>
                <a:gd name="connsiteY0" fmla="*/ 748278 h 1567263"/>
                <a:gd name="connsiteX1" fmla="*/ 526487 w 1611006"/>
                <a:gd name="connsiteY1" fmla="*/ 621059 h 1567263"/>
                <a:gd name="connsiteX2" fmla="*/ 256142 w 1611006"/>
                <a:gd name="connsiteY2" fmla="*/ 231445 h 1567263"/>
                <a:gd name="connsiteX3" fmla="*/ 717318 w 1611006"/>
                <a:gd name="connsiteY3" fmla="*/ 446131 h 1567263"/>
                <a:gd name="connsiteX4" fmla="*/ 828638 w 1611006"/>
                <a:gd name="connsiteY4" fmla="*/ 856 h 1567263"/>
                <a:gd name="connsiteX5" fmla="*/ 1011516 w 1611006"/>
                <a:gd name="connsiteY5" fmla="*/ 581303 h 1567263"/>
                <a:gd name="connsiteX6" fmla="*/ 1607866 w 1611006"/>
                <a:gd name="connsiteY6" fmla="*/ 716474 h 1567263"/>
                <a:gd name="connsiteX7" fmla="*/ 987662 w 1611006"/>
                <a:gd name="connsiteY7" fmla="*/ 819842 h 1567263"/>
                <a:gd name="connsiteX8" fmla="*/ 828638 w 1611006"/>
                <a:gd name="connsiteY8" fmla="*/ 1567263 h 1567263"/>
                <a:gd name="connsiteX9" fmla="*/ 717318 w 1611006"/>
                <a:gd name="connsiteY9" fmla="*/ 819842 h 1567263"/>
                <a:gd name="connsiteX10" fmla="*/ 1702 w 1611006"/>
                <a:gd name="connsiteY10" fmla="*/ 748278 h 1567263"/>
                <a:gd name="connsiteX0" fmla="*/ 207 w 1609511"/>
                <a:gd name="connsiteY0" fmla="*/ 748278 h 1567271"/>
                <a:gd name="connsiteX1" fmla="*/ 524992 w 1609511"/>
                <a:gd name="connsiteY1" fmla="*/ 621059 h 1567271"/>
                <a:gd name="connsiteX2" fmla="*/ 254647 w 1609511"/>
                <a:gd name="connsiteY2" fmla="*/ 231445 h 1567271"/>
                <a:gd name="connsiteX3" fmla="*/ 715823 w 1609511"/>
                <a:gd name="connsiteY3" fmla="*/ 446131 h 1567271"/>
                <a:gd name="connsiteX4" fmla="*/ 827143 w 1609511"/>
                <a:gd name="connsiteY4" fmla="*/ 856 h 1567271"/>
                <a:gd name="connsiteX5" fmla="*/ 1010021 w 1609511"/>
                <a:gd name="connsiteY5" fmla="*/ 581303 h 1567271"/>
                <a:gd name="connsiteX6" fmla="*/ 1606371 w 1609511"/>
                <a:gd name="connsiteY6" fmla="*/ 716474 h 1567271"/>
                <a:gd name="connsiteX7" fmla="*/ 986167 w 1609511"/>
                <a:gd name="connsiteY7" fmla="*/ 819842 h 1567271"/>
                <a:gd name="connsiteX8" fmla="*/ 827143 w 1609511"/>
                <a:gd name="connsiteY8" fmla="*/ 1567263 h 1567271"/>
                <a:gd name="connsiteX9" fmla="*/ 588602 w 1609511"/>
                <a:gd name="connsiteY9" fmla="*/ 803940 h 1567271"/>
                <a:gd name="connsiteX10" fmla="*/ 207 w 1609511"/>
                <a:gd name="connsiteY10" fmla="*/ 748278 h 1567271"/>
                <a:gd name="connsiteX0" fmla="*/ 207 w 1609511"/>
                <a:gd name="connsiteY0" fmla="*/ 748278 h 1572967"/>
                <a:gd name="connsiteX1" fmla="*/ 524992 w 1609511"/>
                <a:gd name="connsiteY1" fmla="*/ 621059 h 1572967"/>
                <a:gd name="connsiteX2" fmla="*/ 254647 w 1609511"/>
                <a:gd name="connsiteY2" fmla="*/ 231445 h 1572967"/>
                <a:gd name="connsiteX3" fmla="*/ 715823 w 1609511"/>
                <a:gd name="connsiteY3" fmla="*/ 446131 h 1572967"/>
                <a:gd name="connsiteX4" fmla="*/ 827143 w 1609511"/>
                <a:gd name="connsiteY4" fmla="*/ 856 h 1572967"/>
                <a:gd name="connsiteX5" fmla="*/ 1010021 w 1609511"/>
                <a:gd name="connsiteY5" fmla="*/ 581303 h 1572967"/>
                <a:gd name="connsiteX6" fmla="*/ 1606371 w 1609511"/>
                <a:gd name="connsiteY6" fmla="*/ 716474 h 1572967"/>
                <a:gd name="connsiteX7" fmla="*/ 986167 w 1609511"/>
                <a:gd name="connsiteY7" fmla="*/ 819842 h 1572967"/>
                <a:gd name="connsiteX8" fmla="*/ 827143 w 1609511"/>
                <a:gd name="connsiteY8" fmla="*/ 1567263 h 1572967"/>
                <a:gd name="connsiteX9" fmla="*/ 143329 w 1609511"/>
                <a:gd name="connsiteY9" fmla="*/ 1145846 h 1572967"/>
                <a:gd name="connsiteX10" fmla="*/ 588602 w 1609511"/>
                <a:gd name="connsiteY10" fmla="*/ 803940 h 1572967"/>
                <a:gd name="connsiteX11" fmla="*/ 207 w 1609511"/>
                <a:gd name="connsiteY11" fmla="*/ 748278 h 1572967"/>
                <a:gd name="connsiteX0" fmla="*/ 207 w 1609511"/>
                <a:gd name="connsiteY0" fmla="*/ 748278 h 1567764"/>
                <a:gd name="connsiteX1" fmla="*/ 524992 w 1609511"/>
                <a:gd name="connsiteY1" fmla="*/ 621059 h 1567764"/>
                <a:gd name="connsiteX2" fmla="*/ 254647 w 1609511"/>
                <a:gd name="connsiteY2" fmla="*/ 231445 h 1567764"/>
                <a:gd name="connsiteX3" fmla="*/ 715823 w 1609511"/>
                <a:gd name="connsiteY3" fmla="*/ 446131 h 1567764"/>
                <a:gd name="connsiteX4" fmla="*/ 827143 w 1609511"/>
                <a:gd name="connsiteY4" fmla="*/ 856 h 1567764"/>
                <a:gd name="connsiteX5" fmla="*/ 1010021 w 1609511"/>
                <a:gd name="connsiteY5" fmla="*/ 581303 h 1567764"/>
                <a:gd name="connsiteX6" fmla="*/ 1606371 w 1609511"/>
                <a:gd name="connsiteY6" fmla="*/ 716474 h 1567764"/>
                <a:gd name="connsiteX7" fmla="*/ 986167 w 1609511"/>
                <a:gd name="connsiteY7" fmla="*/ 819842 h 1567764"/>
                <a:gd name="connsiteX8" fmla="*/ 827143 w 1609511"/>
                <a:gd name="connsiteY8" fmla="*/ 1567263 h 1567764"/>
                <a:gd name="connsiteX9" fmla="*/ 763531 w 1609511"/>
                <a:gd name="connsiteY9" fmla="*/ 939112 h 1567764"/>
                <a:gd name="connsiteX10" fmla="*/ 143329 w 1609511"/>
                <a:gd name="connsiteY10" fmla="*/ 1145846 h 1567764"/>
                <a:gd name="connsiteX11" fmla="*/ 588602 w 1609511"/>
                <a:gd name="connsiteY11" fmla="*/ 803940 h 1567764"/>
                <a:gd name="connsiteX12" fmla="*/ 207 w 1609511"/>
                <a:gd name="connsiteY12" fmla="*/ 748278 h 1567764"/>
                <a:gd name="connsiteX0" fmla="*/ 207 w 1609347"/>
                <a:gd name="connsiteY0" fmla="*/ 748278 h 1567320"/>
                <a:gd name="connsiteX1" fmla="*/ 524992 w 1609347"/>
                <a:gd name="connsiteY1" fmla="*/ 621059 h 1567320"/>
                <a:gd name="connsiteX2" fmla="*/ 254647 w 1609347"/>
                <a:gd name="connsiteY2" fmla="*/ 231445 h 1567320"/>
                <a:gd name="connsiteX3" fmla="*/ 715823 w 1609347"/>
                <a:gd name="connsiteY3" fmla="*/ 446131 h 1567320"/>
                <a:gd name="connsiteX4" fmla="*/ 827143 w 1609347"/>
                <a:gd name="connsiteY4" fmla="*/ 856 h 1567320"/>
                <a:gd name="connsiteX5" fmla="*/ 1010021 w 1609347"/>
                <a:gd name="connsiteY5" fmla="*/ 581303 h 1567320"/>
                <a:gd name="connsiteX6" fmla="*/ 1606371 w 1609347"/>
                <a:gd name="connsiteY6" fmla="*/ 716474 h 1567320"/>
                <a:gd name="connsiteX7" fmla="*/ 954362 w 1609347"/>
                <a:gd name="connsiteY7" fmla="*/ 899355 h 1567320"/>
                <a:gd name="connsiteX8" fmla="*/ 827143 w 1609347"/>
                <a:gd name="connsiteY8" fmla="*/ 1567263 h 1567320"/>
                <a:gd name="connsiteX9" fmla="*/ 763531 w 1609347"/>
                <a:gd name="connsiteY9" fmla="*/ 939112 h 1567320"/>
                <a:gd name="connsiteX10" fmla="*/ 143329 w 1609347"/>
                <a:gd name="connsiteY10" fmla="*/ 1145846 h 1567320"/>
                <a:gd name="connsiteX11" fmla="*/ 588602 w 1609347"/>
                <a:gd name="connsiteY11" fmla="*/ 803940 h 1567320"/>
                <a:gd name="connsiteX12" fmla="*/ 207 w 1609347"/>
                <a:gd name="connsiteY12" fmla="*/ 748278 h 1567320"/>
                <a:gd name="connsiteX0" fmla="*/ 207 w 1606795"/>
                <a:gd name="connsiteY0" fmla="*/ 748278 h 1567320"/>
                <a:gd name="connsiteX1" fmla="*/ 524992 w 1606795"/>
                <a:gd name="connsiteY1" fmla="*/ 621059 h 1567320"/>
                <a:gd name="connsiteX2" fmla="*/ 254647 w 1606795"/>
                <a:gd name="connsiteY2" fmla="*/ 231445 h 1567320"/>
                <a:gd name="connsiteX3" fmla="*/ 715823 w 1606795"/>
                <a:gd name="connsiteY3" fmla="*/ 446131 h 1567320"/>
                <a:gd name="connsiteX4" fmla="*/ 827143 w 1606795"/>
                <a:gd name="connsiteY4" fmla="*/ 856 h 1567320"/>
                <a:gd name="connsiteX5" fmla="*/ 1010021 w 1606795"/>
                <a:gd name="connsiteY5" fmla="*/ 581303 h 1567320"/>
                <a:gd name="connsiteX6" fmla="*/ 1606371 w 1606795"/>
                <a:gd name="connsiteY6" fmla="*/ 716474 h 1567320"/>
                <a:gd name="connsiteX7" fmla="*/ 1479148 w 1606795"/>
                <a:gd name="connsiteY7" fmla="*/ 1400288 h 1567320"/>
                <a:gd name="connsiteX8" fmla="*/ 954362 w 1606795"/>
                <a:gd name="connsiteY8" fmla="*/ 899355 h 1567320"/>
                <a:gd name="connsiteX9" fmla="*/ 827143 w 1606795"/>
                <a:gd name="connsiteY9" fmla="*/ 1567263 h 1567320"/>
                <a:gd name="connsiteX10" fmla="*/ 763531 w 1606795"/>
                <a:gd name="connsiteY10" fmla="*/ 939112 h 1567320"/>
                <a:gd name="connsiteX11" fmla="*/ 143329 w 1606795"/>
                <a:gd name="connsiteY11" fmla="*/ 1145846 h 1567320"/>
                <a:gd name="connsiteX12" fmla="*/ 588602 w 1606795"/>
                <a:gd name="connsiteY12" fmla="*/ 803940 h 1567320"/>
                <a:gd name="connsiteX13" fmla="*/ 207 w 1606795"/>
                <a:gd name="connsiteY13" fmla="*/ 748278 h 1567320"/>
                <a:gd name="connsiteX0" fmla="*/ 207 w 1616062"/>
                <a:gd name="connsiteY0" fmla="*/ 748278 h 1567320"/>
                <a:gd name="connsiteX1" fmla="*/ 524992 w 1616062"/>
                <a:gd name="connsiteY1" fmla="*/ 621059 h 1567320"/>
                <a:gd name="connsiteX2" fmla="*/ 254647 w 1616062"/>
                <a:gd name="connsiteY2" fmla="*/ 231445 h 1567320"/>
                <a:gd name="connsiteX3" fmla="*/ 715823 w 1616062"/>
                <a:gd name="connsiteY3" fmla="*/ 446131 h 1567320"/>
                <a:gd name="connsiteX4" fmla="*/ 827143 w 1616062"/>
                <a:gd name="connsiteY4" fmla="*/ 856 h 1567320"/>
                <a:gd name="connsiteX5" fmla="*/ 1010021 w 1616062"/>
                <a:gd name="connsiteY5" fmla="*/ 581303 h 1567320"/>
                <a:gd name="connsiteX6" fmla="*/ 1606371 w 1616062"/>
                <a:gd name="connsiteY6" fmla="*/ 716474 h 1567320"/>
                <a:gd name="connsiteX7" fmla="*/ 1057729 w 1616062"/>
                <a:gd name="connsiteY7" fmla="*/ 772135 h 1567320"/>
                <a:gd name="connsiteX8" fmla="*/ 1479148 w 1616062"/>
                <a:gd name="connsiteY8" fmla="*/ 1400288 h 1567320"/>
                <a:gd name="connsiteX9" fmla="*/ 954362 w 1616062"/>
                <a:gd name="connsiteY9" fmla="*/ 899355 h 1567320"/>
                <a:gd name="connsiteX10" fmla="*/ 827143 w 1616062"/>
                <a:gd name="connsiteY10" fmla="*/ 1567263 h 1567320"/>
                <a:gd name="connsiteX11" fmla="*/ 763531 w 1616062"/>
                <a:gd name="connsiteY11" fmla="*/ 939112 h 1567320"/>
                <a:gd name="connsiteX12" fmla="*/ 143329 w 1616062"/>
                <a:gd name="connsiteY12" fmla="*/ 1145846 h 1567320"/>
                <a:gd name="connsiteX13" fmla="*/ 588602 w 1616062"/>
                <a:gd name="connsiteY13" fmla="*/ 803940 h 1567320"/>
                <a:gd name="connsiteX14" fmla="*/ 207 w 1616062"/>
                <a:gd name="connsiteY14" fmla="*/ 748278 h 1567320"/>
                <a:gd name="connsiteX0" fmla="*/ 207 w 1569078"/>
                <a:gd name="connsiteY0" fmla="*/ 748278 h 1567320"/>
                <a:gd name="connsiteX1" fmla="*/ 524992 w 1569078"/>
                <a:gd name="connsiteY1" fmla="*/ 621059 h 1567320"/>
                <a:gd name="connsiteX2" fmla="*/ 254647 w 1569078"/>
                <a:gd name="connsiteY2" fmla="*/ 231445 h 1567320"/>
                <a:gd name="connsiteX3" fmla="*/ 715823 w 1569078"/>
                <a:gd name="connsiteY3" fmla="*/ 446131 h 1567320"/>
                <a:gd name="connsiteX4" fmla="*/ 827143 w 1569078"/>
                <a:gd name="connsiteY4" fmla="*/ 856 h 1567320"/>
                <a:gd name="connsiteX5" fmla="*/ 1010021 w 1569078"/>
                <a:gd name="connsiteY5" fmla="*/ 581303 h 1567320"/>
                <a:gd name="connsiteX6" fmla="*/ 1558663 w 1569078"/>
                <a:gd name="connsiteY6" fmla="*/ 629009 h 1567320"/>
                <a:gd name="connsiteX7" fmla="*/ 1057729 w 1569078"/>
                <a:gd name="connsiteY7" fmla="*/ 772135 h 1567320"/>
                <a:gd name="connsiteX8" fmla="*/ 1479148 w 1569078"/>
                <a:gd name="connsiteY8" fmla="*/ 1400288 h 1567320"/>
                <a:gd name="connsiteX9" fmla="*/ 954362 w 1569078"/>
                <a:gd name="connsiteY9" fmla="*/ 899355 h 1567320"/>
                <a:gd name="connsiteX10" fmla="*/ 827143 w 1569078"/>
                <a:gd name="connsiteY10" fmla="*/ 1567263 h 1567320"/>
                <a:gd name="connsiteX11" fmla="*/ 763531 w 1569078"/>
                <a:gd name="connsiteY11" fmla="*/ 939112 h 1567320"/>
                <a:gd name="connsiteX12" fmla="*/ 143329 w 1569078"/>
                <a:gd name="connsiteY12" fmla="*/ 1145846 h 1567320"/>
                <a:gd name="connsiteX13" fmla="*/ 588602 w 1569078"/>
                <a:gd name="connsiteY13" fmla="*/ 803940 h 1567320"/>
                <a:gd name="connsiteX14" fmla="*/ 207 w 1569078"/>
                <a:gd name="connsiteY14" fmla="*/ 748278 h 1567320"/>
                <a:gd name="connsiteX0" fmla="*/ 207 w 1569078"/>
                <a:gd name="connsiteY0" fmla="*/ 748589 h 1567631"/>
                <a:gd name="connsiteX1" fmla="*/ 524992 w 1569078"/>
                <a:gd name="connsiteY1" fmla="*/ 621370 h 1567631"/>
                <a:gd name="connsiteX2" fmla="*/ 254647 w 1569078"/>
                <a:gd name="connsiteY2" fmla="*/ 231756 h 1567631"/>
                <a:gd name="connsiteX3" fmla="*/ 715823 w 1569078"/>
                <a:gd name="connsiteY3" fmla="*/ 446442 h 1567631"/>
                <a:gd name="connsiteX4" fmla="*/ 827143 w 1569078"/>
                <a:gd name="connsiteY4" fmla="*/ 1167 h 1567631"/>
                <a:gd name="connsiteX5" fmla="*/ 1137242 w 1569078"/>
                <a:gd name="connsiteY5" fmla="*/ 605468 h 1567631"/>
                <a:gd name="connsiteX6" fmla="*/ 1558663 w 1569078"/>
                <a:gd name="connsiteY6" fmla="*/ 629320 h 1567631"/>
                <a:gd name="connsiteX7" fmla="*/ 1057729 w 1569078"/>
                <a:gd name="connsiteY7" fmla="*/ 772446 h 1567631"/>
                <a:gd name="connsiteX8" fmla="*/ 1479148 w 1569078"/>
                <a:gd name="connsiteY8" fmla="*/ 1400599 h 1567631"/>
                <a:gd name="connsiteX9" fmla="*/ 954362 w 1569078"/>
                <a:gd name="connsiteY9" fmla="*/ 899666 h 1567631"/>
                <a:gd name="connsiteX10" fmla="*/ 827143 w 1569078"/>
                <a:gd name="connsiteY10" fmla="*/ 1567574 h 1567631"/>
                <a:gd name="connsiteX11" fmla="*/ 763531 w 1569078"/>
                <a:gd name="connsiteY11" fmla="*/ 939423 h 1567631"/>
                <a:gd name="connsiteX12" fmla="*/ 143329 w 1569078"/>
                <a:gd name="connsiteY12" fmla="*/ 1146157 h 1567631"/>
                <a:gd name="connsiteX13" fmla="*/ 588602 w 1569078"/>
                <a:gd name="connsiteY13" fmla="*/ 804251 h 1567631"/>
                <a:gd name="connsiteX14" fmla="*/ 207 w 1569078"/>
                <a:gd name="connsiteY14" fmla="*/ 748589 h 1567631"/>
                <a:gd name="connsiteX0" fmla="*/ 207 w 1569078"/>
                <a:gd name="connsiteY0" fmla="*/ 752924 h 1571966"/>
                <a:gd name="connsiteX1" fmla="*/ 524992 w 1569078"/>
                <a:gd name="connsiteY1" fmla="*/ 625705 h 1571966"/>
                <a:gd name="connsiteX2" fmla="*/ 254647 w 1569078"/>
                <a:gd name="connsiteY2" fmla="*/ 236091 h 1571966"/>
                <a:gd name="connsiteX3" fmla="*/ 715823 w 1569078"/>
                <a:gd name="connsiteY3" fmla="*/ 450777 h 1571966"/>
                <a:gd name="connsiteX4" fmla="*/ 827143 w 1569078"/>
                <a:gd name="connsiteY4" fmla="*/ 5502 h 1571966"/>
                <a:gd name="connsiteX5" fmla="*/ 1399634 w 1569078"/>
                <a:gd name="connsiteY5" fmla="*/ 228142 h 1571966"/>
                <a:gd name="connsiteX6" fmla="*/ 1137242 w 1569078"/>
                <a:gd name="connsiteY6" fmla="*/ 609803 h 1571966"/>
                <a:gd name="connsiteX7" fmla="*/ 1558663 w 1569078"/>
                <a:gd name="connsiteY7" fmla="*/ 633655 h 1571966"/>
                <a:gd name="connsiteX8" fmla="*/ 1057729 w 1569078"/>
                <a:gd name="connsiteY8" fmla="*/ 776781 h 1571966"/>
                <a:gd name="connsiteX9" fmla="*/ 1479148 w 1569078"/>
                <a:gd name="connsiteY9" fmla="*/ 1404934 h 1571966"/>
                <a:gd name="connsiteX10" fmla="*/ 954362 w 1569078"/>
                <a:gd name="connsiteY10" fmla="*/ 904001 h 1571966"/>
                <a:gd name="connsiteX11" fmla="*/ 827143 w 1569078"/>
                <a:gd name="connsiteY11" fmla="*/ 1571909 h 1571966"/>
                <a:gd name="connsiteX12" fmla="*/ 763531 w 1569078"/>
                <a:gd name="connsiteY12" fmla="*/ 943758 h 1571966"/>
                <a:gd name="connsiteX13" fmla="*/ 143329 w 1569078"/>
                <a:gd name="connsiteY13" fmla="*/ 1150492 h 1571966"/>
                <a:gd name="connsiteX14" fmla="*/ 588602 w 1569078"/>
                <a:gd name="connsiteY14" fmla="*/ 808586 h 1571966"/>
                <a:gd name="connsiteX15" fmla="*/ 207 w 1569078"/>
                <a:gd name="connsiteY15" fmla="*/ 752924 h 1571966"/>
                <a:gd name="connsiteX0" fmla="*/ 207 w 1569078"/>
                <a:gd name="connsiteY0" fmla="*/ 747473 h 1566515"/>
                <a:gd name="connsiteX1" fmla="*/ 524992 w 1569078"/>
                <a:gd name="connsiteY1" fmla="*/ 620254 h 1566515"/>
                <a:gd name="connsiteX2" fmla="*/ 254647 w 1569078"/>
                <a:gd name="connsiteY2" fmla="*/ 230640 h 1566515"/>
                <a:gd name="connsiteX3" fmla="*/ 715823 w 1569078"/>
                <a:gd name="connsiteY3" fmla="*/ 445326 h 1566515"/>
                <a:gd name="connsiteX4" fmla="*/ 827143 w 1569078"/>
                <a:gd name="connsiteY4" fmla="*/ 51 h 1566515"/>
                <a:gd name="connsiteX5" fmla="*/ 962312 w 1569078"/>
                <a:gd name="connsiteY5" fmla="*/ 477133 h 1566515"/>
                <a:gd name="connsiteX6" fmla="*/ 1399634 w 1569078"/>
                <a:gd name="connsiteY6" fmla="*/ 222691 h 1566515"/>
                <a:gd name="connsiteX7" fmla="*/ 1137242 w 1569078"/>
                <a:gd name="connsiteY7" fmla="*/ 604352 h 1566515"/>
                <a:gd name="connsiteX8" fmla="*/ 1558663 w 1569078"/>
                <a:gd name="connsiteY8" fmla="*/ 628204 h 1566515"/>
                <a:gd name="connsiteX9" fmla="*/ 1057729 w 1569078"/>
                <a:gd name="connsiteY9" fmla="*/ 771330 h 1566515"/>
                <a:gd name="connsiteX10" fmla="*/ 1479148 w 1569078"/>
                <a:gd name="connsiteY10" fmla="*/ 1399483 h 1566515"/>
                <a:gd name="connsiteX11" fmla="*/ 954362 w 1569078"/>
                <a:gd name="connsiteY11" fmla="*/ 898550 h 1566515"/>
                <a:gd name="connsiteX12" fmla="*/ 827143 w 1569078"/>
                <a:gd name="connsiteY12" fmla="*/ 1566458 h 1566515"/>
                <a:gd name="connsiteX13" fmla="*/ 763531 w 1569078"/>
                <a:gd name="connsiteY13" fmla="*/ 938307 h 1566515"/>
                <a:gd name="connsiteX14" fmla="*/ 143329 w 1569078"/>
                <a:gd name="connsiteY14" fmla="*/ 1145041 h 1566515"/>
                <a:gd name="connsiteX15" fmla="*/ 588602 w 1569078"/>
                <a:gd name="connsiteY15" fmla="*/ 803135 h 1566515"/>
                <a:gd name="connsiteX16" fmla="*/ 207 w 1569078"/>
                <a:gd name="connsiteY16" fmla="*/ 747473 h 15665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1569078" h="1566515">
                  <a:moveTo>
                    <a:pt x="207" y="747473"/>
                  </a:moveTo>
                  <a:cubicBezTo>
                    <a:pt x="-10395" y="716993"/>
                    <a:pt x="391145" y="747475"/>
                    <a:pt x="524992" y="620254"/>
                  </a:cubicBezTo>
                  <a:cubicBezTo>
                    <a:pt x="634985" y="564595"/>
                    <a:pt x="218866" y="328706"/>
                    <a:pt x="254647" y="230640"/>
                  </a:cubicBezTo>
                  <a:cubicBezTo>
                    <a:pt x="249346" y="136550"/>
                    <a:pt x="620407" y="483758"/>
                    <a:pt x="715823" y="445326"/>
                  </a:cubicBezTo>
                  <a:cubicBezTo>
                    <a:pt x="811239" y="406895"/>
                    <a:pt x="786062" y="-5250"/>
                    <a:pt x="827143" y="51"/>
                  </a:cubicBezTo>
                  <a:cubicBezTo>
                    <a:pt x="868224" y="5352"/>
                    <a:pt x="866897" y="440026"/>
                    <a:pt x="962312" y="477133"/>
                  </a:cubicBezTo>
                  <a:cubicBezTo>
                    <a:pt x="1057727" y="514240"/>
                    <a:pt x="1393008" y="127276"/>
                    <a:pt x="1399634" y="222691"/>
                  </a:cubicBezTo>
                  <a:cubicBezTo>
                    <a:pt x="1406260" y="318106"/>
                    <a:pt x="1052428" y="580499"/>
                    <a:pt x="1137242" y="604352"/>
                  </a:cubicBezTo>
                  <a:cubicBezTo>
                    <a:pt x="1222056" y="628205"/>
                    <a:pt x="1464573" y="536764"/>
                    <a:pt x="1558663" y="628204"/>
                  </a:cubicBezTo>
                  <a:cubicBezTo>
                    <a:pt x="1652754" y="719644"/>
                    <a:pt x="1078933" y="657361"/>
                    <a:pt x="1057729" y="771330"/>
                  </a:cubicBezTo>
                  <a:cubicBezTo>
                    <a:pt x="1036525" y="885299"/>
                    <a:pt x="1582515" y="1437914"/>
                    <a:pt x="1479148" y="1399483"/>
                  </a:cubicBezTo>
                  <a:cubicBezTo>
                    <a:pt x="1375781" y="1361052"/>
                    <a:pt x="988817" y="777956"/>
                    <a:pt x="954362" y="898550"/>
                  </a:cubicBezTo>
                  <a:cubicBezTo>
                    <a:pt x="919907" y="1019144"/>
                    <a:pt x="858948" y="1559832"/>
                    <a:pt x="827143" y="1566458"/>
                  </a:cubicBezTo>
                  <a:cubicBezTo>
                    <a:pt x="795338" y="1573084"/>
                    <a:pt x="877500" y="1008543"/>
                    <a:pt x="763531" y="938307"/>
                  </a:cubicBezTo>
                  <a:cubicBezTo>
                    <a:pt x="649562" y="868071"/>
                    <a:pt x="108873" y="1240457"/>
                    <a:pt x="143329" y="1145041"/>
                  </a:cubicBezTo>
                  <a:cubicBezTo>
                    <a:pt x="177785" y="1049625"/>
                    <a:pt x="698595" y="837591"/>
                    <a:pt x="588602" y="803135"/>
                  </a:cubicBezTo>
                  <a:cubicBezTo>
                    <a:pt x="454755" y="669288"/>
                    <a:pt x="10809" y="777953"/>
                    <a:pt x="207" y="747473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Oval 297">
              <a:extLst>
                <a:ext uri="{FF2B5EF4-FFF2-40B4-BE49-F238E27FC236}">
                  <a16:creationId xmlns:a16="http://schemas.microsoft.com/office/drawing/2014/main" id="{B590F2A8-7A5E-30D3-BA19-7DE89FBCB955}"/>
                </a:ext>
              </a:extLst>
            </p:cNvPr>
            <p:cNvSpPr/>
            <p:nvPr/>
          </p:nvSpPr>
          <p:spPr>
            <a:xfrm>
              <a:off x="1579898" y="1235052"/>
              <a:ext cx="111967" cy="111967"/>
            </a:xfrm>
            <a:prstGeom prst="ellips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947D5AAB-1656-B77C-598D-550AB7EE961B}"/>
              </a:ext>
            </a:extLst>
          </p:cNvPr>
          <p:cNvGrpSpPr/>
          <p:nvPr/>
        </p:nvGrpSpPr>
        <p:grpSpPr>
          <a:xfrm>
            <a:off x="3810010" y="7882854"/>
            <a:ext cx="288244" cy="277000"/>
            <a:chOff x="688105" y="647054"/>
            <a:chExt cx="1569078" cy="1566515"/>
          </a:xfrm>
        </p:grpSpPr>
        <p:sp>
          <p:nvSpPr>
            <p:cNvPr id="300" name="Oval 4">
              <a:extLst>
                <a:ext uri="{FF2B5EF4-FFF2-40B4-BE49-F238E27FC236}">
                  <a16:creationId xmlns:a16="http://schemas.microsoft.com/office/drawing/2014/main" id="{60072074-3C40-AEAA-5456-1FEDAA626A47}"/>
                </a:ext>
              </a:extLst>
            </p:cNvPr>
            <p:cNvSpPr/>
            <p:nvPr/>
          </p:nvSpPr>
          <p:spPr>
            <a:xfrm>
              <a:off x="688105" y="647054"/>
              <a:ext cx="1569078" cy="1566515"/>
            </a:xfrm>
            <a:custGeom>
              <a:avLst/>
              <a:gdLst>
                <a:gd name="connsiteX0" fmla="*/ 0 w 747423"/>
                <a:gd name="connsiteY0" fmla="*/ 492981 h 985962"/>
                <a:gd name="connsiteX1" fmla="*/ 373712 w 747423"/>
                <a:gd name="connsiteY1" fmla="*/ 0 h 985962"/>
                <a:gd name="connsiteX2" fmla="*/ 747424 w 747423"/>
                <a:gd name="connsiteY2" fmla="*/ 492981 h 985962"/>
                <a:gd name="connsiteX3" fmla="*/ 373712 w 747423"/>
                <a:gd name="connsiteY3" fmla="*/ 985962 h 985962"/>
                <a:gd name="connsiteX4" fmla="*/ 0 w 747423"/>
                <a:gd name="connsiteY4" fmla="*/ 492981 h 985962"/>
                <a:gd name="connsiteX0" fmla="*/ 0 w 747424"/>
                <a:gd name="connsiteY0" fmla="*/ 755374 h 1248355"/>
                <a:gd name="connsiteX1" fmla="*/ 373712 w 747424"/>
                <a:gd name="connsiteY1" fmla="*/ 0 h 1248355"/>
                <a:gd name="connsiteX2" fmla="*/ 747424 w 747424"/>
                <a:gd name="connsiteY2" fmla="*/ 755374 h 1248355"/>
                <a:gd name="connsiteX3" fmla="*/ 373712 w 747424"/>
                <a:gd name="connsiteY3" fmla="*/ 1248355 h 1248355"/>
                <a:gd name="connsiteX4" fmla="*/ 0 w 747424"/>
                <a:gd name="connsiteY4" fmla="*/ 755374 h 1248355"/>
                <a:gd name="connsiteX0" fmla="*/ 0 w 747424"/>
                <a:gd name="connsiteY0" fmla="*/ 755374 h 1566407"/>
                <a:gd name="connsiteX1" fmla="*/ 373712 w 747424"/>
                <a:gd name="connsiteY1" fmla="*/ 0 h 1566407"/>
                <a:gd name="connsiteX2" fmla="*/ 747424 w 747424"/>
                <a:gd name="connsiteY2" fmla="*/ 755374 h 1566407"/>
                <a:gd name="connsiteX3" fmla="*/ 373712 w 747424"/>
                <a:gd name="connsiteY3" fmla="*/ 1566407 h 1566407"/>
                <a:gd name="connsiteX4" fmla="*/ 0 w 747424"/>
                <a:gd name="connsiteY4" fmla="*/ 755374 h 1566407"/>
                <a:gd name="connsiteX0" fmla="*/ 0 w 1176794"/>
                <a:gd name="connsiteY0" fmla="*/ 763327 h 1566411"/>
                <a:gd name="connsiteX1" fmla="*/ 803082 w 1176794"/>
                <a:gd name="connsiteY1" fmla="*/ 2 h 1566411"/>
                <a:gd name="connsiteX2" fmla="*/ 1176794 w 1176794"/>
                <a:gd name="connsiteY2" fmla="*/ 755376 h 1566411"/>
                <a:gd name="connsiteX3" fmla="*/ 803082 w 1176794"/>
                <a:gd name="connsiteY3" fmla="*/ 1566409 h 1566411"/>
                <a:gd name="connsiteX4" fmla="*/ 0 w 1176794"/>
                <a:gd name="connsiteY4" fmla="*/ 763327 h 1566411"/>
                <a:gd name="connsiteX0" fmla="*/ 0 w 1582310"/>
                <a:gd name="connsiteY0" fmla="*/ 763428 h 1566595"/>
                <a:gd name="connsiteX1" fmla="*/ 803082 w 1582310"/>
                <a:gd name="connsiteY1" fmla="*/ 103 h 1566595"/>
                <a:gd name="connsiteX2" fmla="*/ 1582310 w 1582310"/>
                <a:gd name="connsiteY2" fmla="*/ 715721 h 1566595"/>
                <a:gd name="connsiteX3" fmla="*/ 803082 w 1582310"/>
                <a:gd name="connsiteY3" fmla="*/ 1566510 h 1566595"/>
                <a:gd name="connsiteX4" fmla="*/ 0 w 1582310"/>
                <a:gd name="connsiteY4" fmla="*/ 763428 h 1566595"/>
                <a:gd name="connsiteX0" fmla="*/ 1056 w 1583366"/>
                <a:gd name="connsiteY0" fmla="*/ 764563 h 1567718"/>
                <a:gd name="connsiteX1" fmla="*/ 637159 w 1583366"/>
                <a:gd name="connsiteY1" fmla="*/ 549879 h 1567718"/>
                <a:gd name="connsiteX2" fmla="*/ 804138 w 1583366"/>
                <a:gd name="connsiteY2" fmla="*/ 1238 h 1567718"/>
                <a:gd name="connsiteX3" fmla="*/ 1583366 w 1583366"/>
                <a:gd name="connsiteY3" fmla="*/ 716856 h 1567718"/>
                <a:gd name="connsiteX4" fmla="*/ 804138 w 1583366"/>
                <a:gd name="connsiteY4" fmla="*/ 1567645 h 1567718"/>
                <a:gd name="connsiteX5" fmla="*/ 1056 w 1583366"/>
                <a:gd name="connsiteY5" fmla="*/ 764563 h 1567718"/>
                <a:gd name="connsiteX0" fmla="*/ 1056 w 1590327"/>
                <a:gd name="connsiteY0" fmla="*/ 763374 h 1566529"/>
                <a:gd name="connsiteX1" fmla="*/ 637159 w 1590327"/>
                <a:gd name="connsiteY1" fmla="*/ 548690 h 1566529"/>
                <a:gd name="connsiteX2" fmla="*/ 804138 w 1590327"/>
                <a:gd name="connsiteY2" fmla="*/ 49 h 1566529"/>
                <a:gd name="connsiteX3" fmla="*/ 987016 w 1590327"/>
                <a:gd name="connsiteY3" fmla="*/ 580496 h 1566529"/>
                <a:gd name="connsiteX4" fmla="*/ 1583366 w 1590327"/>
                <a:gd name="connsiteY4" fmla="*/ 715667 h 1566529"/>
                <a:gd name="connsiteX5" fmla="*/ 804138 w 1590327"/>
                <a:gd name="connsiteY5" fmla="*/ 1566456 h 1566529"/>
                <a:gd name="connsiteX6" fmla="*/ 1056 w 1590327"/>
                <a:gd name="connsiteY6" fmla="*/ 763374 h 1566529"/>
                <a:gd name="connsiteX0" fmla="*/ 1056 w 1586506"/>
                <a:gd name="connsiteY0" fmla="*/ 763374 h 1566559"/>
                <a:gd name="connsiteX1" fmla="*/ 637159 w 1586506"/>
                <a:gd name="connsiteY1" fmla="*/ 548690 h 1566559"/>
                <a:gd name="connsiteX2" fmla="*/ 804138 w 1586506"/>
                <a:gd name="connsiteY2" fmla="*/ 49 h 1566559"/>
                <a:gd name="connsiteX3" fmla="*/ 987016 w 1586506"/>
                <a:gd name="connsiteY3" fmla="*/ 580496 h 1566559"/>
                <a:gd name="connsiteX4" fmla="*/ 1583366 w 1586506"/>
                <a:gd name="connsiteY4" fmla="*/ 715667 h 1566559"/>
                <a:gd name="connsiteX5" fmla="*/ 963162 w 1586506"/>
                <a:gd name="connsiteY5" fmla="*/ 819035 h 1566559"/>
                <a:gd name="connsiteX6" fmla="*/ 804138 w 1586506"/>
                <a:gd name="connsiteY6" fmla="*/ 1566456 h 1566559"/>
                <a:gd name="connsiteX7" fmla="*/ 1056 w 1586506"/>
                <a:gd name="connsiteY7" fmla="*/ 763374 h 1566559"/>
                <a:gd name="connsiteX0" fmla="*/ 125 w 1585575"/>
                <a:gd name="connsiteY0" fmla="*/ 763374 h 1566456"/>
                <a:gd name="connsiteX1" fmla="*/ 636228 w 1585575"/>
                <a:gd name="connsiteY1" fmla="*/ 548690 h 1566456"/>
                <a:gd name="connsiteX2" fmla="*/ 803207 w 1585575"/>
                <a:gd name="connsiteY2" fmla="*/ 49 h 1566456"/>
                <a:gd name="connsiteX3" fmla="*/ 986085 w 1585575"/>
                <a:gd name="connsiteY3" fmla="*/ 580496 h 1566456"/>
                <a:gd name="connsiteX4" fmla="*/ 1582435 w 1585575"/>
                <a:gd name="connsiteY4" fmla="*/ 715667 h 1566456"/>
                <a:gd name="connsiteX5" fmla="*/ 962231 w 1585575"/>
                <a:gd name="connsiteY5" fmla="*/ 819035 h 1566456"/>
                <a:gd name="connsiteX6" fmla="*/ 803207 w 1585575"/>
                <a:gd name="connsiteY6" fmla="*/ 1566456 h 1566456"/>
                <a:gd name="connsiteX7" fmla="*/ 691887 w 1585575"/>
                <a:gd name="connsiteY7" fmla="*/ 819035 h 1566456"/>
                <a:gd name="connsiteX8" fmla="*/ 125 w 1585575"/>
                <a:gd name="connsiteY8" fmla="*/ 763374 h 1566456"/>
                <a:gd name="connsiteX0" fmla="*/ 459 w 1585909"/>
                <a:gd name="connsiteY0" fmla="*/ 763328 h 1566410"/>
                <a:gd name="connsiteX1" fmla="*/ 588854 w 1585909"/>
                <a:gd name="connsiteY1" fmla="*/ 588401 h 1566410"/>
                <a:gd name="connsiteX2" fmla="*/ 803541 w 1585909"/>
                <a:gd name="connsiteY2" fmla="*/ 3 h 1566410"/>
                <a:gd name="connsiteX3" fmla="*/ 986419 w 1585909"/>
                <a:gd name="connsiteY3" fmla="*/ 580450 h 1566410"/>
                <a:gd name="connsiteX4" fmla="*/ 1582769 w 1585909"/>
                <a:gd name="connsiteY4" fmla="*/ 715621 h 1566410"/>
                <a:gd name="connsiteX5" fmla="*/ 962565 w 1585909"/>
                <a:gd name="connsiteY5" fmla="*/ 818989 h 1566410"/>
                <a:gd name="connsiteX6" fmla="*/ 803541 w 1585909"/>
                <a:gd name="connsiteY6" fmla="*/ 1566410 h 1566410"/>
                <a:gd name="connsiteX7" fmla="*/ 692221 w 1585909"/>
                <a:gd name="connsiteY7" fmla="*/ 818989 h 1566410"/>
                <a:gd name="connsiteX8" fmla="*/ 459 w 1585909"/>
                <a:gd name="connsiteY8" fmla="*/ 763328 h 1566410"/>
                <a:gd name="connsiteX0" fmla="*/ 459 w 1585909"/>
                <a:gd name="connsiteY0" fmla="*/ 774187 h 1577269"/>
                <a:gd name="connsiteX1" fmla="*/ 588854 w 1585909"/>
                <a:gd name="connsiteY1" fmla="*/ 599260 h 1577269"/>
                <a:gd name="connsiteX2" fmla="*/ 231045 w 1585909"/>
                <a:gd name="connsiteY2" fmla="*/ 241451 h 1577269"/>
                <a:gd name="connsiteX3" fmla="*/ 803541 w 1585909"/>
                <a:gd name="connsiteY3" fmla="*/ 10862 h 1577269"/>
                <a:gd name="connsiteX4" fmla="*/ 986419 w 1585909"/>
                <a:gd name="connsiteY4" fmla="*/ 591309 h 1577269"/>
                <a:gd name="connsiteX5" fmla="*/ 1582769 w 1585909"/>
                <a:gd name="connsiteY5" fmla="*/ 726480 h 1577269"/>
                <a:gd name="connsiteX6" fmla="*/ 962565 w 1585909"/>
                <a:gd name="connsiteY6" fmla="*/ 829848 h 1577269"/>
                <a:gd name="connsiteX7" fmla="*/ 803541 w 1585909"/>
                <a:gd name="connsiteY7" fmla="*/ 1577269 h 1577269"/>
                <a:gd name="connsiteX8" fmla="*/ 692221 w 1585909"/>
                <a:gd name="connsiteY8" fmla="*/ 829848 h 1577269"/>
                <a:gd name="connsiteX9" fmla="*/ 459 w 1585909"/>
                <a:gd name="connsiteY9" fmla="*/ 774187 h 1577269"/>
                <a:gd name="connsiteX0" fmla="*/ 1798 w 1587248"/>
                <a:gd name="connsiteY0" fmla="*/ 774187 h 1577269"/>
                <a:gd name="connsiteX1" fmla="*/ 502729 w 1587248"/>
                <a:gd name="connsiteY1" fmla="*/ 631065 h 1577269"/>
                <a:gd name="connsiteX2" fmla="*/ 232384 w 1587248"/>
                <a:gd name="connsiteY2" fmla="*/ 241451 h 1577269"/>
                <a:gd name="connsiteX3" fmla="*/ 804880 w 1587248"/>
                <a:gd name="connsiteY3" fmla="*/ 10862 h 1577269"/>
                <a:gd name="connsiteX4" fmla="*/ 987758 w 1587248"/>
                <a:gd name="connsiteY4" fmla="*/ 591309 h 1577269"/>
                <a:gd name="connsiteX5" fmla="*/ 1584108 w 1587248"/>
                <a:gd name="connsiteY5" fmla="*/ 726480 h 1577269"/>
                <a:gd name="connsiteX6" fmla="*/ 963904 w 1587248"/>
                <a:gd name="connsiteY6" fmla="*/ 829848 h 1577269"/>
                <a:gd name="connsiteX7" fmla="*/ 804880 w 1587248"/>
                <a:gd name="connsiteY7" fmla="*/ 1577269 h 1577269"/>
                <a:gd name="connsiteX8" fmla="*/ 693560 w 1587248"/>
                <a:gd name="connsiteY8" fmla="*/ 829848 h 1577269"/>
                <a:gd name="connsiteX9" fmla="*/ 1798 w 1587248"/>
                <a:gd name="connsiteY9" fmla="*/ 774187 h 1577269"/>
                <a:gd name="connsiteX0" fmla="*/ 1798 w 1587248"/>
                <a:gd name="connsiteY0" fmla="*/ 764181 h 1567263"/>
                <a:gd name="connsiteX1" fmla="*/ 502729 w 1587248"/>
                <a:gd name="connsiteY1" fmla="*/ 621059 h 1567263"/>
                <a:gd name="connsiteX2" fmla="*/ 232384 w 1587248"/>
                <a:gd name="connsiteY2" fmla="*/ 231445 h 1567263"/>
                <a:gd name="connsiteX3" fmla="*/ 693560 w 1587248"/>
                <a:gd name="connsiteY3" fmla="*/ 446131 h 1567263"/>
                <a:gd name="connsiteX4" fmla="*/ 804880 w 1587248"/>
                <a:gd name="connsiteY4" fmla="*/ 856 h 1567263"/>
                <a:gd name="connsiteX5" fmla="*/ 987758 w 1587248"/>
                <a:gd name="connsiteY5" fmla="*/ 581303 h 1567263"/>
                <a:gd name="connsiteX6" fmla="*/ 1584108 w 1587248"/>
                <a:gd name="connsiteY6" fmla="*/ 716474 h 1567263"/>
                <a:gd name="connsiteX7" fmla="*/ 963904 w 1587248"/>
                <a:gd name="connsiteY7" fmla="*/ 819842 h 1567263"/>
                <a:gd name="connsiteX8" fmla="*/ 804880 w 1587248"/>
                <a:gd name="connsiteY8" fmla="*/ 1567263 h 1567263"/>
                <a:gd name="connsiteX9" fmla="*/ 693560 w 1587248"/>
                <a:gd name="connsiteY9" fmla="*/ 819842 h 1567263"/>
                <a:gd name="connsiteX10" fmla="*/ 1798 w 1587248"/>
                <a:gd name="connsiteY10" fmla="*/ 764181 h 1567263"/>
                <a:gd name="connsiteX0" fmla="*/ 1702 w 1611006"/>
                <a:gd name="connsiteY0" fmla="*/ 748278 h 1567263"/>
                <a:gd name="connsiteX1" fmla="*/ 526487 w 1611006"/>
                <a:gd name="connsiteY1" fmla="*/ 621059 h 1567263"/>
                <a:gd name="connsiteX2" fmla="*/ 256142 w 1611006"/>
                <a:gd name="connsiteY2" fmla="*/ 231445 h 1567263"/>
                <a:gd name="connsiteX3" fmla="*/ 717318 w 1611006"/>
                <a:gd name="connsiteY3" fmla="*/ 446131 h 1567263"/>
                <a:gd name="connsiteX4" fmla="*/ 828638 w 1611006"/>
                <a:gd name="connsiteY4" fmla="*/ 856 h 1567263"/>
                <a:gd name="connsiteX5" fmla="*/ 1011516 w 1611006"/>
                <a:gd name="connsiteY5" fmla="*/ 581303 h 1567263"/>
                <a:gd name="connsiteX6" fmla="*/ 1607866 w 1611006"/>
                <a:gd name="connsiteY6" fmla="*/ 716474 h 1567263"/>
                <a:gd name="connsiteX7" fmla="*/ 987662 w 1611006"/>
                <a:gd name="connsiteY7" fmla="*/ 819842 h 1567263"/>
                <a:gd name="connsiteX8" fmla="*/ 828638 w 1611006"/>
                <a:gd name="connsiteY8" fmla="*/ 1567263 h 1567263"/>
                <a:gd name="connsiteX9" fmla="*/ 717318 w 1611006"/>
                <a:gd name="connsiteY9" fmla="*/ 819842 h 1567263"/>
                <a:gd name="connsiteX10" fmla="*/ 1702 w 1611006"/>
                <a:gd name="connsiteY10" fmla="*/ 748278 h 1567263"/>
                <a:gd name="connsiteX0" fmla="*/ 207 w 1609511"/>
                <a:gd name="connsiteY0" fmla="*/ 748278 h 1567271"/>
                <a:gd name="connsiteX1" fmla="*/ 524992 w 1609511"/>
                <a:gd name="connsiteY1" fmla="*/ 621059 h 1567271"/>
                <a:gd name="connsiteX2" fmla="*/ 254647 w 1609511"/>
                <a:gd name="connsiteY2" fmla="*/ 231445 h 1567271"/>
                <a:gd name="connsiteX3" fmla="*/ 715823 w 1609511"/>
                <a:gd name="connsiteY3" fmla="*/ 446131 h 1567271"/>
                <a:gd name="connsiteX4" fmla="*/ 827143 w 1609511"/>
                <a:gd name="connsiteY4" fmla="*/ 856 h 1567271"/>
                <a:gd name="connsiteX5" fmla="*/ 1010021 w 1609511"/>
                <a:gd name="connsiteY5" fmla="*/ 581303 h 1567271"/>
                <a:gd name="connsiteX6" fmla="*/ 1606371 w 1609511"/>
                <a:gd name="connsiteY6" fmla="*/ 716474 h 1567271"/>
                <a:gd name="connsiteX7" fmla="*/ 986167 w 1609511"/>
                <a:gd name="connsiteY7" fmla="*/ 819842 h 1567271"/>
                <a:gd name="connsiteX8" fmla="*/ 827143 w 1609511"/>
                <a:gd name="connsiteY8" fmla="*/ 1567263 h 1567271"/>
                <a:gd name="connsiteX9" fmla="*/ 588602 w 1609511"/>
                <a:gd name="connsiteY9" fmla="*/ 803940 h 1567271"/>
                <a:gd name="connsiteX10" fmla="*/ 207 w 1609511"/>
                <a:gd name="connsiteY10" fmla="*/ 748278 h 1567271"/>
                <a:gd name="connsiteX0" fmla="*/ 207 w 1609511"/>
                <a:gd name="connsiteY0" fmla="*/ 748278 h 1572967"/>
                <a:gd name="connsiteX1" fmla="*/ 524992 w 1609511"/>
                <a:gd name="connsiteY1" fmla="*/ 621059 h 1572967"/>
                <a:gd name="connsiteX2" fmla="*/ 254647 w 1609511"/>
                <a:gd name="connsiteY2" fmla="*/ 231445 h 1572967"/>
                <a:gd name="connsiteX3" fmla="*/ 715823 w 1609511"/>
                <a:gd name="connsiteY3" fmla="*/ 446131 h 1572967"/>
                <a:gd name="connsiteX4" fmla="*/ 827143 w 1609511"/>
                <a:gd name="connsiteY4" fmla="*/ 856 h 1572967"/>
                <a:gd name="connsiteX5" fmla="*/ 1010021 w 1609511"/>
                <a:gd name="connsiteY5" fmla="*/ 581303 h 1572967"/>
                <a:gd name="connsiteX6" fmla="*/ 1606371 w 1609511"/>
                <a:gd name="connsiteY6" fmla="*/ 716474 h 1572967"/>
                <a:gd name="connsiteX7" fmla="*/ 986167 w 1609511"/>
                <a:gd name="connsiteY7" fmla="*/ 819842 h 1572967"/>
                <a:gd name="connsiteX8" fmla="*/ 827143 w 1609511"/>
                <a:gd name="connsiteY8" fmla="*/ 1567263 h 1572967"/>
                <a:gd name="connsiteX9" fmla="*/ 143329 w 1609511"/>
                <a:gd name="connsiteY9" fmla="*/ 1145846 h 1572967"/>
                <a:gd name="connsiteX10" fmla="*/ 588602 w 1609511"/>
                <a:gd name="connsiteY10" fmla="*/ 803940 h 1572967"/>
                <a:gd name="connsiteX11" fmla="*/ 207 w 1609511"/>
                <a:gd name="connsiteY11" fmla="*/ 748278 h 1572967"/>
                <a:gd name="connsiteX0" fmla="*/ 207 w 1609511"/>
                <a:gd name="connsiteY0" fmla="*/ 748278 h 1567764"/>
                <a:gd name="connsiteX1" fmla="*/ 524992 w 1609511"/>
                <a:gd name="connsiteY1" fmla="*/ 621059 h 1567764"/>
                <a:gd name="connsiteX2" fmla="*/ 254647 w 1609511"/>
                <a:gd name="connsiteY2" fmla="*/ 231445 h 1567764"/>
                <a:gd name="connsiteX3" fmla="*/ 715823 w 1609511"/>
                <a:gd name="connsiteY3" fmla="*/ 446131 h 1567764"/>
                <a:gd name="connsiteX4" fmla="*/ 827143 w 1609511"/>
                <a:gd name="connsiteY4" fmla="*/ 856 h 1567764"/>
                <a:gd name="connsiteX5" fmla="*/ 1010021 w 1609511"/>
                <a:gd name="connsiteY5" fmla="*/ 581303 h 1567764"/>
                <a:gd name="connsiteX6" fmla="*/ 1606371 w 1609511"/>
                <a:gd name="connsiteY6" fmla="*/ 716474 h 1567764"/>
                <a:gd name="connsiteX7" fmla="*/ 986167 w 1609511"/>
                <a:gd name="connsiteY7" fmla="*/ 819842 h 1567764"/>
                <a:gd name="connsiteX8" fmla="*/ 827143 w 1609511"/>
                <a:gd name="connsiteY8" fmla="*/ 1567263 h 1567764"/>
                <a:gd name="connsiteX9" fmla="*/ 763531 w 1609511"/>
                <a:gd name="connsiteY9" fmla="*/ 939112 h 1567764"/>
                <a:gd name="connsiteX10" fmla="*/ 143329 w 1609511"/>
                <a:gd name="connsiteY10" fmla="*/ 1145846 h 1567764"/>
                <a:gd name="connsiteX11" fmla="*/ 588602 w 1609511"/>
                <a:gd name="connsiteY11" fmla="*/ 803940 h 1567764"/>
                <a:gd name="connsiteX12" fmla="*/ 207 w 1609511"/>
                <a:gd name="connsiteY12" fmla="*/ 748278 h 1567764"/>
                <a:gd name="connsiteX0" fmla="*/ 207 w 1609347"/>
                <a:gd name="connsiteY0" fmla="*/ 748278 h 1567320"/>
                <a:gd name="connsiteX1" fmla="*/ 524992 w 1609347"/>
                <a:gd name="connsiteY1" fmla="*/ 621059 h 1567320"/>
                <a:gd name="connsiteX2" fmla="*/ 254647 w 1609347"/>
                <a:gd name="connsiteY2" fmla="*/ 231445 h 1567320"/>
                <a:gd name="connsiteX3" fmla="*/ 715823 w 1609347"/>
                <a:gd name="connsiteY3" fmla="*/ 446131 h 1567320"/>
                <a:gd name="connsiteX4" fmla="*/ 827143 w 1609347"/>
                <a:gd name="connsiteY4" fmla="*/ 856 h 1567320"/>
                <a:gd name="connsiteX5" fmla="*/ 1010021 w 1609347"/>
                <a:gd name="connsiteY5" fmla="*/ 581303 h 1567320"/>
                <a:gd name="connsiteX6" fmla="*/ 1606371 w 1609347"/>
                <a:gd name="connsiteY6" fmla="*/ 716474 h 1567320"/>
                <a:gd name="connsiteX7" fmla="*/ 954362 w 1609347"/>
                <a:gd name="connsiteY7" fmla="*/ 899355 h 1567320"/>
                <a:gd name="connsiteX8" fmla="*/ 827143 w 1609347"/>
                <a:gd name="connsiteY8" fmla="*/ 1567263 h 1567320"/>
                <a:gd name="connsiteX9" fmla="*/ 763531 w 1609347"/>
                <a:gd name="connsiteY9" fmla="*/ 939112 h 1567320"/>
                <a:gd name="connsiteX10" fmla="*/ 143329 w 1609347"/>
                <a:gd name="connsiteY10" fmla="*/ 1145846 h 1567320"/>
                <a:gd name="connsiteX11" fmla="*/ 588602 w 1609347"/>
                <a:gd name="connsiteY11" fmla="*/ 803940 h 1567320"/>
                <a:gd name="connsiteX12" fmla="*/ 207 w 1609347"/>
                <a:gd name="connsiteY12" fmla="*/ 748278 h 1567320"/>
                <a:gd name="connsiteX0" fmla="*/ 207 w 1606795"/>
                <a:gd name="connsiteY0" fmla="*/ 748278 h 1567320"/>
                <a:gd name="connsiteX1" fmla="*/ 524992 w 1606795"/>
                <a:gd name="connsiteY1" fmla="*/ 621059 h 1567320"/>
                <a:gd name="connsiteX2" fmla="*/ 254647 w 1606795"/>
                <a:gd name="connsiteY2" fmla="*/ 231445 h 1567320"/>
                <a:gd name="connsiteX3" fmla="*/ 715823 w 1606795"/>
                <a:gd name="connsiteY3" fmla="*/ 446131 h 1567320"/>
                <a:gd name="connsiteX4" fmla="*/ 827143 w 1606795"/>
                <a:gd name="connsiteY4" fmla="*/ 856 h 1567320"/>
                <a:gd name="connsiteX5" fmla="*/ 1010021 w 1606795"/>
                <a:gd name="connsiteY5" fmla="*/ 581303 h 1567320"/>
                <a:gd name="connsiteX6" fmla="*/ 1606371 w 1606795"/>
                <a:gd name="connsiteY6" fmla="*/ 716474 h 1567320"/>
                <a:gd name="connsiteX7" fmla="*/ 1479148 w 1606795"/>
                <a:gd name="connsiteY7" fmla="*/ 1400288 h 1567320"/>
                <a:gd name="connsiteX8" fmla="*/ 954362 w 1606795"/>
                <a:gd name="connsiteY8" fmla="*/ 899355 h 1567320"/>
                <a:gd name="connsiteX9" fmla="*/ 827143 w 1606795"/>
                <a:gd name="connsiteY9" fmla="*/ 1567263 h 1567320"/>
                <a:gd name="connsiteX10" fmla="*/ 763531 w 1606795"/>
                <a:gd name="connsiteY10" fmla="*/ 939112 h 1567320"/>
                <a:gd name="connsiteX11" fmla="*/ 143329 w 1606795"/>
                <a:gd name="connsiteY11" fmla="*/ 1145846 h 1567320"/>
                <a:gd name="connsiteX12" fmla="*/ 588602 w 1606795"/>
                <a:gd name="connsiteY12" fmla="*/ 803940 h 1567320"/>
                <a:gd name="connsiteX13" fmla="*/ 207 w 1606795"/>
                <a:gd name="connsiteY13" fmla="*/ 748278 h 1567320"/>
                <a:gd name="connsiteX0" fmla="*/ 207 w 1616062"/>
                <a:gd name="connsiteY0" fmla="*/ 748278 h 1567320"/>
                <a:gd name="connsiteX1" fmla="*/ 524992 w 1616062"/>
                <a:gd name="connsiteY1" fmla="*/ 621059 h 1567320"/>
                <a:gd name="connsiteX2" fmla="*/ 254647 w 1616062"/>
                <a:gd name="connsiteY2" fmla="*/ 231445 h 1567320"/>
                <a:gd name="connsiteX3" fmla="*/ 715823 w 1616062"/>
                <a:gd name="connsiteY3" fmla="*/ 446131 h 1567320"/>
                <a:gd name="connsiteX4" fmla="*/ 827143 w 1616062"/>
                <a:gd name="connsiteY4" fmla="*/ 856 h 1567320"/>
                <a:gd name="connsiteX5" fmla="*/ 1010021 w 1616062"/>
                <a:gd name="connsiteY5" fmla="*/ 581303 h 1567320"/>
                <a:gd name="connsiteX6" fmla="*/ 1606371 w 1616062"/>
                <a:gd name="connsiteY6" fmla="*/ 716474 h 1567320"/>
                <a:gd name="connsiteX7" fmla="*/ 1057729 w 1616062"/>
                <a:gd name="connsiteY7" fmla="*/ 772135 h 1567320"/>
                <a:gd name="connsiteX8" fmla="*/ 1479148 w 1616062"/>
                <a:gd name="connsiteY8" fmla="*/ 1400288 h 1567320"/>
                <a:gd name="connsiteX9" fmla="*/ 954362 w 1616062"/>
                <a:gd name="connsiteY9" fmla="*/ 899355 h 1567320"/>
                <a:gd name="connsiteX10" fmla="*/ 827143 w 1616062"/>
                <a:gd name="connsiteY10" fmla="*/ 1567263 h 1567320"/>
                <a:gd name="connsiteX11" fmla="*/ 763531 w 1616062"/>
                <a:gd name="connsiteY11" fmla="*/ 939112 h 1567320"/>
                <a:gd name="connsiteX12" fmla="*/ 143329 w 1616062"/>
                <a:gd name="connsiteY12" fmla="*/ 1145846 h 1567320"/>
                <a:gd name="connsiteX13" fmla="*/ 588602 w 1616062"/>
                <a:gd name="connsiteY13" fmla="*/ 803940 h 1567320"/>
                <a:gd name="connsiteX14" fmla="*/ 207 w 1616062"/>
                <a:gd name="connsiteY14" fmla="*/ 748278 h 1567320"/>
                <a:gd name="connsiteX0" fmla="*/ 207 w 1569078"/>
                <a:gd name="connsiteY0" fmla="*/ 748278 h 1567320"/>
                <a:gd name="connsiteX1" fmla="*/ 524992 w 1569078"/>
                <a:gd name="connsiteY1" fmla="*/ 621059 h 1567320"/>
                <a:gd name="connsiteX2" fmla="*/ 254647 w 1569078"/>
                <a:gd name="connsiteY2" fmla="*/ 231445 h 1567320"/>
                <a:gd name="connsiteX3" fmla="*/ 715823 w 1569078"/>
                <a:gd name="connsiteY3" fmla="*/ 446131 h 1567320"/>
                <a:gd name="connsiteX4" fmla="*/ 827143 w 1569078"/>
                <a:gd name="connsiteY4" fmla="*/ 856 h 1567320"/>
                <a:gd name="connsiteX5" fmla="*/ 1010021 w 1569078"/>
                <a:gd name="connsiteY5" fmla="*/ 581303 h 1567320"/>
                <a:gd name="connsiteX6" fmla="*/ 1558663 w 1569078"/>
                <a:gd name="connsiteY6" fmla="*/ 629009 h 1567320"/>
                <a:gd name="connsiteX7" fmla="*/ 1057729 w 1569078"/>
                <a:gd name="connsiteY7" fmla="*/ 772135 h 1567320"/>
                <a:gd name="connsiteX8" fmla="*/ 1479148 w 1569078"/>
                <a:gd name="connsiteY8" fmla="*/ 1400288 h 1567320"/>
                <a:gd name="connsiteX9" fmla="*/ 954362 w 1569078"/>
                <a:gd name="connsiteY9" fmla="*/ 899355 h 1567320"/>
                <a:gd name="connsiteX10" fmla="*/ 827143 w 1569078"/>
                <a:gd name="connsiteY10" fmla="*/ 1567263 h 1567320"/>
                <a:gd name="connsiteX11" fmla="*/ 763531 w 1569078"/>
                <a:gd name="connsiteY11" fmla="*/ 939112 h 1567320"/>
                <a:gd name="connsiteX12" fmla="*/ 143329 w 1569078"/>
                <a:gd name="connsiteY12" fmla="*/ 1145846 h 1567320"/>
                <a:gd name="connsiteX13" fmla="*/ 588602 w 1569078"/>
                <a:gd name="connsiteY13" fmla="*/ 803940 h 1567320"/>
                <a:gd name="connsiteX14" fmla="*/ 207 w 1569078"/>
                <a:gd name="connsiteY14" fmla="*/ 748278 h 1567320"/>
                <a:gd name="connsiteX0" fmla="*/ 207 w 1569078"/>
                <a:gd name="connsiteY0" fmla="*/ 748589 h 1567631"/>
                <a:gd name="connsiteX1" fmla="*/ 524992 w 1569078"/>
                <a:gd name="connsiteY1" fmla="*/ 621370 h 1567631"/>
                <a:gd name="connsiteX2" fmla="*/ 254647 w 1569078"/>
                <a:gd name="connsiteY2" fmla="*/ 231756 h 1567631"/>
                <a:gd name="connsiteX3" fmla="*/ 715823 w 1569078"/>
                <a:gd name="connsiteY3" fmla="*/ 446442 h 1567631"/>
                <a:gd name="connsiteX4" fmla="*/ 827143 w 1569078"/>
                <a:gd name="connsiteY4" fmla="*/ 1167 h 1567631"/>
                <a:gd name="connsiteX5" fmla="*/ 1137242 w 1569078"/>
                <a:gd name="connsiteY5" fmla="*/ 605468 h 1567631"/>
                <a:gd name="connsiteX6" fmla="*/ 1558663 w 1569078"/>
                <a:gd name="connsiteY6" fmla="*/ 629320 h 1567631"/>
                <a:gd name="connsiteX7" fmla="*/ 1057729 w 1569078"/>
                <a:gd name="connsiteY7" fmla="*/ 772446 h 1567631"/>
                <a:gd name="connsiteX8" fmla="*/ 1479148 w 1569078"/>
                <a:gd name="connsiteY8" fmla="*/ 1400599 h 1567631"/>
                <a:gd name="connsiteX9" fmla="*/ 954362 w 1569078"/>
                <a:gd name="connsiteY9" fmla="*/ 899666 h 1567631"/>
                <a:gd name="connsiteX10" fmla="*/ 827143 w 1569078"/>
                <a:gd name="connsiteY10" fmla="*/ 1567574 h 1567631"/>
                <a:gd name="connsiteX11" fmla="*/ 763531 w 1569078"/>
                <a:gd name="connsiteY11" fmla="*/ 939423 h 1567631"/>
                <a:gd name="connsiteX12" fmla="*/ 143329 w 1569078"/>
                <a:gd name="connsiteY12" fmla="*/ 1146157 h 1567631"/>
                <a:gd name="connsiteX13" fmla="*/ 588602 w 1569078"/>
                <a:gd name="connsiteY13" fmla="*/ 804251 h 1567631"/>
                <a:gd name="connsiteX14" fmla="*/ 207 w 1569078"/>
                <a:gd name="connsiteY14" fmla="*/ 748589 h 1567631"/>
                <a:gd name="connsiteX0" fmla="*/ 207 w 1569078"/>
                <a:gd name="connsiteY0" fmla="*/ 752924 h 1571966"/>
                <a:gd name="connsiteX1" fmla="*/ 524992 w 1569078"/>
                <a:gd name="connsiteY1" fmla="*/ 625705 h 1571966"/>
                <a:gd name="connsiteX2" fmla="*/ 254647 w 1569078"/>
                <a:gd name="connsiteY2" fmla="*/ 236091 h 1571966"/>
                <a:gd name="connsiteX3" fmla="*/ 715823 w 1569078"/>
                <a:gd name="connsiteY3" fmla="*/ 450777 h 1571966"/>
                <a:gd name="connsiteX4" fmla="*/ 827143 w 1569078"/>
                <a:gd name="connsiteY4" fmla="*/ 5502 h 1571966"/>
                <a:gd name="connsiteX5" fmla="*/ 1399634 w 1569078"/>
                <a:gd name="connsiteY5" fmla="*/ 228142 h 1571966"/>
                <a:gd name="connsiteX6" fmla="*/ 1137242 w 1569078"/>
                <a:gd name="connsiteY6" fmla="*/ 609803 h 1571966"/>
                <a:gd name="connsiteX7" fmla="*/ 1558663 w 1569078"/>
                <a:gd name="connsiteY7" fmla="*/ 633655 h 1571966"/>
                <a:gd name="connsiteX8" fmla="*/ 1057729 w 1569078"/>
                <a:gd name="connsiteY8" fmla="*/ 776781 h 1571966"/>
                <a:gd name="connsiteX9" fmla="*/ 1479148 w 1569078"/>
                <a:gd name="connsiteY9" fmla="*/ 1404934 h 1571966"/>
                <a:gd name="connsiteX10" fmla="*/ 954362 w 1569078"/>
                <a:gd name="connsiteY10" fmla="*/ 904001 h 1571966"/>
                <a:gd name="connsiteX11" fmla="*/ 827143 w 1569078"/>
                <a:gd name="connsiteY11" fmla="*/ 1571909 h 1571966"/>
                <a:gd name="connsiteX12" fmla="*/ 763531 w 1569078"/>
                <a:gd name="connsiteY12" fmla="*/ 943758 h 1571966"/>
                <a:gd name="connsiteX13" fmla="*/ 143329 w 1569078"/>
                <a:gd name="connsiteY13" fmla="*/ 1150492 h 1571966"/>
                <a:gd name="connsiteX14" fmla="*/ 588602 w 1569078"/>
                <a:gd name="connsiteY14" fmla="*/ 808586 h 1571966"/>
                <a:gd name="connsiteX15" fmla="*/ 207 w 1569078"/>
                <a:gd name="connsiteY15" fmla="*/ 752924 h 1571966"/>
                <a:gd name="connsiteX0" fmla="*/ 207 w 1569078"/>
                <a:gd name="connsiteY0" fmla="*/ 747473 h 1566515"/>
                <a:gd name="connsiteX1" fmla="*/ 524992 w 1569078"/>
                <a:gd name="connsiteY1" fmla="*/ 620254 h 1566515"/>
                <a:gd name="connsiteX2" fmla="*/ 254647 w 1569078"/>
                <a:gd name="connsiteY2" fmla="*/ 230640 h 1566515"/>
                <a:gd name="connsiteX3" fmla="*/ 715823 w 1569078"/>
                <a:gd name="connsiteY3" fmla="*/ 445326 h 1566515"/>
                <a:gd name="connsiteX4" fmla="*/ 827143 w 1569078"/>
                <a:gd name="connsiteY4" fmla="*/ 51 h 1566515"/>
                <a:gd name="connsiteX5" fmla="*/ 962312 w 1569078"/>
                <a:gd name="connsiteY5" fmla="*/ 477133 h 1566515"/>
                <a:gd name="connsiteX6" fmla="*/ 1399634 w 1569078"/>
                <a:gd name="connsiteY6" fmla="*/ 222691 h 1566515"/>
                <a:gd name="connsiteX7" fmla="*/ 1137242 w 1569078"/>
                <a:gd name="connsiteY7" fmla="*/ 604352 h 1566515"/>
                <a:gd name="connsiteX8" fmla="*/ 1558663 w 1569078"/>
                <a:gd name="connsiteY8" fmla="*/ 628204 h 1566515"/>
                <a:gd name="connsiteX9" fmla="*/ 1057729 w 1569078"/>
                <a:gd name="connsiteY9" fmla="*/ 771330 h 1566515"/>
                <a:gd name="connsiteX10" fmla="*/ 1479148 w 1569078"/>
                <a:gd name="connsiteY10" fmla="*/ 1399483 h 1566515"/>
                <a:gd name="connsiteX11" fmla="*/ 954362 w 1569078"/>
                <a:gd name="connsiteY11" fmla="*/ 898550 h 1566515"/>
                <a:gd name="connsiteX12" fmla="*/ 827143 w 1569078"/>
                <a:gd name="connsiteY12" fmla="*/ 1566458 h 1566515"/>
                <a:gd name="connsiteX13" fmla="*/ 763531 w 1569078"/>
                <a:gd name="connsiteY13" fmla="*/ 938307 h 1566515"/>
                <a:gd name="connsiteX14" fmla="*/ 143329 w 1569078"/>
                <a:gd name="connsiteY14" fmla="*/ 1145041 h 1566515"/>
                <a:gd name="connsiteX15" fmla="*/ 588602 w 1569078"/>
                <a:gd name="connsiteY15" fmla="*/ 803135 h 1566515"/>
                <a:gd name="connsiteX16" fmla="*/ 207 w 1569078"/>
                <a:gd name="connsiteY16" fmla="*/ 747473 h 15665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1569078" h="1566515">
                  <a:moveTo>
                    <a:pt x="207" y="747473"/>
                  </a:moveTo>
                  <a:cubicBezTo>
                    <a:pt x="-10395" y="716993"/>
                    <a:pt x="391145" y="747475"/>
                    <a:pt x="524992" y="620254"/>
                  </a:cubicBezTo>
                  <a:cubicBezTo>
                    <a:pt x="634985" y="564595"/>
                    <a:pt x="218866" y="328706"/>
                    <a:pt x="254647" y="230640"/>
                  </a:cubicBezTo>
                  <a:cubicBezTo>
                    <a:pt x="249346" y="136550"/>
                    <a:pt x="620407" y="483758"/>
                    <a:pt x="715823" y="445326"/>
                  </a:cubicBezTo>
                  <a:cubicBezTo>
                    <a:pt x="811239" y="406895"/>
                    <a:pt x="786062" y="-5250"/>
                    <a:pt x="827143" y="51"/>
                  </a:cubicBezTo>
                  <a:cubicBezTo>
                    <a:pt x="868224" y="5352"/>
                    <a:pt x="866897" y="440026"/>
                    <a:pt x="962312" y="477133"/>
                  </a:cubicBezTo>
                  <a:cubicBezTo>
                    <a:pt x="1057727" y="514240"/>
                    <a:pt x="1393008" y="127276"/>
                    <a:pt x="1399634" y="222691"/>
                  </a:cubicBezTo>
                  <a:cubicBezTo>
                    <a:pt x="1406260" y="318106"/>
                    <a:pt x="1052428" y="580499"/>
                    <a:pt x="1137242" y="604352"/>
                  </a:cubicBezTo>
                  <a:cubicBezTo>
                    <a:pt x="1222056" y="628205"/>
                    <a:pt x="1464573" y="536764"/>
                    <a:pt x="1558663" y="628204"/>
                  </a:cubicBezTo>
                  <a:cubicBezTo>
                    <a:pt x="1652754" y="719644"/>
                    <a:pt x="1078933" y="657361"/>
                    <a:pt x="1057729" y="771330"/>
                  </a:cubicBezTo>
                  <a:cubicBezTo>
                    <a:pt x="1036525" y="885299"/>
                    <a:pt x="1582515" y="1437914"/>
                    <a:pt x="1479148" y="1399483"/>
                  </a:cubicBezTo>
                  <a:cubicBezTo>
                    <a:pt x="1375781" y="1361052"/>
                    <a:pt x="988817" y="777956"/>
                    <a:pt x="954362" y="898550"/>
                  </a:cubicBezTo>
                  <a:cubicBezTo>
                    <a:pt x="919907" y="1019144"/>
                    <a:pt x="858948" y="1559832"/>
                    <a:pt x="827143" y="1566458"/>
                  </a:cubicBezTo>
                  <a:cubicBezTo>
                    <a:pt x="795338" y="1573084"/>
                    <a:pt x="877500" y="1008543"/>
                    <a:pt x="763531" y="938307"/>
                  </a:cubicBezTo>
                  <a:cubicBezTo>
                    <a:pt x="649562" y="868071"/>
                    <a:pt x="108873" y="1240457"/>
                    <a:pt x="143329" y="1145041"/>
                  </a:cubicBezTo>
                  <a:cubicBezTo>
                    <a:pt x="177785" y="1049625"/>
                    <a:pt x="698595" y="837591"/>
                    <a:pt x="588602" y="803135"/>
                  </a:cubicBezTo>
                  <a:cubicBezTo>
                    <a:pt x="454755" y="669288"/>
                    <a:pt x="10809" y="777953"/>
                    <a:pt x="207" y="747473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Oval 300">
              <a:extLst>
                <a:ext uri="{FF2B5EF4-FFF2-40B4-BE49-F238E27FC236}">
                  <a16:creationId xmlns:a16="http://schemas.microsoft.com/office/drawing/2014/main" id="{3ACBCD05-3F35-07B8-DF4B-291BC859BE14}"/>
                </a:ext>
              </a:extLst>
            </p:cNvPr>
            <p:cNvSpPr/>
            <p:nvPr/>
          </p:nvSpPr>
          <p:spPr>
            <a:xfrm>
              <a:off x="1579898" y="1235052"/>
              <a:ext cx="111967" cy="111967"/>
            </a:xfrm>
            <a:prstGeom prst="ellips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7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2" name="Oval 254">
            <a:extLst>
              <a:ext uri="{FF2B5EF4-FFF2-40B4-BE49-F238E27FC236}">
                <a16:creationId xmlns:a16="http://schemas.microsoft.com/office/drawing/2014/main" id="{7119BED8-847A-6438-C740-EE22E0C76544}"/>
              </a:ext>
            </a:extLst>
          </p:cNvPr>
          <p:cNvSpPr/>
          <p:nvPr/>
        </p:nvSpPr>
        <p:spPr>
          <a:xfrm>
            <a:off x="3885129" y="7658965"/>
            <a:ext cx="227651" cy="198320"/>
          </a:xfrm>
          <a:custGeom>
            <a:avLst/>
            <a:gdLst>
              <a:gd name="connsiteX0" fmla="*/ 0 w 1021977"/>
              <a:gd name="connsiteY0" fmla="*/ 433038 h 866076"/>
              <a:gd name="connsiteX1" fmla="*/ 510989 w 1021977"/>
              <a:gd name="connsiteY1" fmla="*/ 0 h 866076"/>
              <a:gd name="connsiteX2" fmla="*/ 1021978 w 1021977"/>
              <a:gd name="connsiteY2" fmla="*/ 433038 h 866076"/>
              <a:gd name="connsiteX3" fmla="*/ 510989 w 1021977"/>
              <a:gd name="connsiteY3" fmla="*/ 866076 h 866076"/>
              <a:gd name="connsiteX4" fmla="*/ 0 w 1021977"/>
              <a:gd name="connsiteY4" fmla="*/ 433038 h 866076"/>
              <a:gd name="connsiteX0" fmla="*/ 4 w 1021982"/>
              <a:gd name="connsiteY0" fmla="*/ 359079 h 792117"/>
              <a:gd name="connsiteX1" fmla="*/ 517717 w 1021982"/>
              <a:gd name="connsiteY1" fmla="*/ 0 h 792117"/>
              <a:gd name="connsiteX2" fmla="*/ 1021982 w 1021982"/>
              <a:gd name="connsiteY2" fmla="*/ 359079 h 792117"/>
              <a:gd name="connsiteX3" fmla="*/ 510993 w 1021982"/>
              <a:gd name="connsiteY3" fmla="*/ 792117 h 792117"/>
              <a:gd name="connsiteX4" fmla="*/ 4 w 1021982"/>
              <a:gd name="connsiteY4" fmla="*/ 359079 h 792117"/>
              <a:gd name="connsiteX0" fmla="*/ 9682 w 1031660"/>
              <a:gd name="connsiteY0" fmla="*/ 400301 h 833339"/>
              <a:gd name="connsiteX1" fmla="*/ 211387 w 1031660"/>
              <a:gd name="connsiteY1" fmla="*/ 47945 h 833339"/>
              <a:gd name="connsiteX2" fmla="*/ 527395 w 1031660"/>
              <a:gd name="connsiteY2" fmla="*/ 41222 h 833339"/>
              <a:gd name="connsiteX3" fmla="*/ 1031660 w 1031660"/>
              <a:gd name="connsiteY3" fmla="*/ 400301 h 833339"/>
              <a:gd name="connsiteX4" fmla="*/ 520671 w 1031660"/>
              <a:gd name="connsiteY4" fmla="*/ 833339 h 833339"/>
              <a:gd name="connsiteX5" fmla="*/ 9682 w 1031660"/>
              <a:gd name="connsiteY5" fmla="*/ 400301 h 833339"/>
              <a:gd name="connsiteX0" fmla="*/ 6466 w 1028444"/>
              <a:gd name="connsiteY0" fmla="*/ 400301 h 846828"/>
              <a:gd name="connsiteX1" fmla="*/ 208171 w 1028444"/>
              <a:gd name="connsiteY1" fmla="*/ 47945 h 846828"/>
              <a:gd name="connsiteX2" fmla="*/ 524179 w 1028444"/>
              <a:gd name="connsiteY2" fmla="*/ 41222 h 846828"/>
              <a:gd name="connsiteX3" fmla="*/ 1028444 w 1028444"/>
              <a:gd name="connsiteY3" fmla="*/ 400301 h 846828"/>
              <a:gd name="connsiteX4" fmla="*/ 517455 w 1028444"/>
              <a:gd name="connsiteY4" fmla="*/ 833339 h 846828"/>
              <a:gd name="connsiteX5" fmla="*/ 93871 w 1028444"/>
              <a:gd name="connsiteY5" fmla="*/ 706851 h 846828"/>
              <a:gd name="connsiteX6" fmla="*/ 6466 w 1028444"/>
              <a:gd name="connsiteY6" fmla="*/ 400301 h 846828"/>
              <a:gd name="connsiteX0" fmla="*/ 6466 w 1030468"/>
              <a:gd name="connsiteY0" fmla="*/ 400301 h 833403"/>
              <a:gd name="connsiteX1" fmla="*/ 208171 w 1030468"/>
              <a:gd name="connsiteY1" fmla="*/ 47945 h 833403"/>
              <a:gd name="connsiteX2" fmla="*/ 524179 w 1030468"/>
              <a:gd name="connsiteY2" fmla="*/ 41222 h 833403"/>
              <a:gd name="connsiteX3" fmla="*/ 1028444 w 1030468"/>
              <a:gd name="connsiteY3" fmla="*/ 400301 h 833403"/>
              <a:gd name="connsiteX4" fmla="*/ 678818 w 1030468"/>
              <a:gd name="connsiteY4" fmla="*/ 693403 h 833403"/>
              <a:gd name="connsiteX5" fmla="*/ 517455 w 1030468"/>
              <a:gd name="connsiteY5" fmla="*/ 833339 h 833403"/>
              <a:gd name="connsiteX6" fmla="*/ 93871 w 1030468"/>
              <a:gd name="connsiteY6" fmla="*/ 706851 h 833403"/>
              <a:gd name="connsiteX7" fmla="*/ 6466 w 1030468"/>
              <a:gd name="connsiteY7" fmla="*/ 400301 h 833403"/>
              <a:gd name="connsiteX0" fmla="*/ 6466 w 1040938"/>
              <a:gd name="connsiteY0" fmla="*/ 386831 h 819933"/>
              <a:gd name="connsiteX1" fmla="*/ 208171 w 1040938"/>
              <a:gd name="connsiteY1" fmla="*/ 34475 h 819933"/>
              <a:gd name="connsiteX2" fmla="*/ 524179 w 1040938"/>
              <a:gd name="connsiteY2" fmla="*/ 27752 h 819933"/>
              <a:gd name="connsiteX3" fmla="*/ 947759 w 1040938"/>
              <a:gd name="connsiteY3" fmla="*/ 162222 h 819933"/>
              <a:gd name="connsiteX4" fmla="*/ 1028444 w 1040938"/>
              <a:gd name="connsiteY4" fmla="*/ 386831 h 819933"/>
              <a:gd name="connsiteX5" fmla="*/ 678818 w 1040938"/>
              <a:gd name="connsiteY5" fmla="*/ 679933 h 819933"/>
              <a:gd name="connsiteX6" fmla="*/ 517455 w 1040938"/>
              <a:gd name="connsiteY6" fmla="*/ 819869 h 819933"/>
              <a:gd name="connsiteX7" fmla="*/ 93871 w 1040938"/>
              <a:gd name="connsiteY7" fmla="*/ 693381 h 819933"/>
              <a:gd name="connsiteX8" fmla="*/ 6466 w 1040938"/>
              <a:gd name="connsiteY8" fmla="*/ 386831 h 819933"/>
              <a:gd name="connsiteX0" fmla="*/ 6466 w 1037480"/>
              <a:gd name="connsiteY0" fmla="*/ 417473 h 850575"/>
              <a:gd name="connsiteX1" fmla="*/ 208171 w 1037480"/>
              <a:gd name="connsiteY1" fmla="*/ 65117 h 850575"/>
              <a:gd name="connsiteX2" fmla="*/ 524179 w 1037480"/>
              <a:gd name="connsiteY2" fmla="*/ 58394 h 850575"/>
              <a:gd name="connsiteX3" fmla="*/ 698989 w 1037480"/>
              <a:gd name="connsiteY3" fmla="*/ 4606 h 850575"/>
              <a:gd name="connsiteX4" fmla="*/ 947759 w 1037480"/>
              <a:gd name="connsiteY4" fmla="*/ 192864 h 850575"/>
              <a:gd name="connsiteX5" fmla="*/ 1028444 w 1037480"/>
              <a:gd name="connsiteY5" fmla="*/ 417473 h 850575"/>
              <a:gd name="connsiteX6" fmla="*/ 678818 w 1037480"/>
              <a:gd name="connsiteY6" fmla="*/ 710575 h 850575"/>
              <a:gd name="connsiteX7" fmla="*/ 517455 w 1037480"/>
              <a:gd name="connsiteY7" fmla="*/ 850511 h 850575"/>
              <a:gd name="connsiteX8" fmla="*/ 93871 w 1037480"/>
              <a:gd name="connsiteY8" fmla="*/ 724023 h 850575"/>
              <a:gd name="connsiteX9" fmla="*/ 6466 w 1037480"/>
              <a:gd name="connsiteY9" fmla="*/ 417473 h 850575"/>
              <a:gd name="connsiteX0" fmla="*/ 6466 w 1033753"/>
              <a:gd name="connsiteY0" fmla="*/ 417473 h 850575"/>
              <a:gd name="connsiteX1" fmla="*/ 208171 w 1033753"/>
              <a:gd name="connsiteY1" fmla="*/ 65117 h 850575"/>
              <a:gd name="connsiteX2" fmla="*/ 524179 w 1033753"/>
              <a:gd name="connsiteY2" fmla="*/ 58394 h 850575"/>
              <a:gd name="connsiteX3" fmla="*/ 698989 w 1033753"/>
              <a:gd name="connsiteY3" fmla="*/ 4606 h 850575"/>
              <a:gd name="connsiteX4" fmla="*/ 947759 w 1033753"/>
              <a:gd name="connsiteY4" fmla="*/ 192864 h 850575"/>
              <a:gd name="connsiteX5" fmla="*/ 1028444 w 1033753"/>
              <a:gd name="connsiteY5" fmla="*/ 417473 h 850575"/>
              <a:gd name="connsiteX6" fmla="*/ 887247 w 1033753"/>
              <a:gd name="connsiteY6" fmla="*/ 650064 h 850575"/>
              <a:gd name="connsiteX7" fmla="*/ 678818 w 1033753"/>
              <a:gd name="connsiteY7" fmla="*/ 710575 h 850575"/>
              <a:gd name="connsiteX8" fmla="*/ 517455 w 1033753"/>
              <a:gd name="connsiteY8" fmla="*/ 850511 h 850575"/>
              <a:gd name="connsiteX9" fmla="*/ 93871 w 1033753"/>
              <a:gd name="connsiteY9" fmla="*/ 724023 h 850575"/>
              <a:gd name="connsiteX10" fmla="*/ 6466 w 1033753"/>
              <a:gd name="connsiteY10" fmla="*/ 417473 h 850575"/>
              <a:gd name="connsiteX0" fmla="*/ 6466 w 1033753"/>
              <a:gd name="connsiteY0" fmla="*/ 417473 h 851052"/>
              <a:gd name="connsiteX1" fmla="*/ 208171 w 1033753"/>
              <a:gd name="connsiteY1" fmla="*/ 65117 h 851052"/>
              <a:gd name="connsiteX2" fmla="*/ 524179 w 1033753"/>
              <a:gd name="connsiteY2" fmla="*/ 58394 h 851052"/>
              <a:gd name="connsiteX3" fmla="*/ 698989 w 1033753"/>
              <a:gd name="connsiteY3" fmla="*/ 4606 h 851052"/>
              <a:gd name="connsiteX4" fmla="*/ 947759 w 1033753"/>
              <a:gd name="connsiteY4" fmla="*/ 192864 h 851052"/>
              <a:gd name="connsiteX5" fmla="*/ 1028444 w 1033753"/>
              <a:gd name="connsiteY5" fmla="*/ 417473 h 851052"/>
              <a:gd name="connsiteX6" fmla="*/ 887247 w 1033753"/>
              <a:gd name="connsiteY6" fmla="*/ 650064 h 851052"/>
              <a:gd name="connsiteX7" fmla="*/ 678818 w 1033753"/>
              <a:gd name="connsiteY7" fmla="*/ 710575 h 851052"/>
              <a:gd name="connsiteX8" fmla="*/ 517455 w 1033753"/>
              <a:gd name="connsiteY8" fmla="*/ 850511 h 851052"/>
              <a:gd name="connsiteX9" fmla="*/ 329195 w 1033753"/>
              <a:gd name="connsiteY9" fmla="*/ 757641 h 851052"/>
              <a:gd name="connsiteX10" fmla="*/ 93871 w 1033753"/>
              <a:gd name="connsiteY10" fmla="*/ 724023 h 851052"/>
              <a:gd name="connsiteX11" fmla="*/ 6466 w 1033753"/>
              <a:gd name="connsiteY11" fmla="*/ 417473 h 851052"/>
              <a:gd name="connsiteX0" fmla="*/ 5600 w 1032887"/>
              <a:gd name="connsiteY0" fmla="*/ 417473 h 851052"/>
              <a:gd name="connsiteX1" fmla="*/ 207305 w 1032887"/>
              <a:gd name="connsiteY1" fmla="*/ 65117 h 851052"/>
              <a:gd name="connsiteX2" fmla="*/ 523313 w 1032887"/>
              <a:gd name="connsiteY2" fmla="*/ 58394 h 851052"/>
              <a:gd name="connsiteX3" fmla="*/ 698123 w 1032887"/>
              <a:gd name="connsiteY3" fmla="*/ 4606 h 851052"/>
              <a:gd name="connsiteX4" fmla="*/ 946893 w 1032887"/>
              <a:gd name="connsiteY4" fmla="*/ 192864 h 851052"/>
              <a:gd name="connsiteX5" fmla="*/ 1027578 w 1032887"/>
              <a:gd name="connsiteY5" fmla="*/ 417473 h 851052"/>
              <a:gd name="connsiteX6" fmla="*/ 886381 w 1032887"/>
              <a:gd name="connsiteY6" fmla="*/ 650064 h 851052"/>
              <a:gd name="connsiteX7" fmla="*/ 677952 w 1032887"/>
              <a:gd name="connsiteY7" fmla="*/ 710575 h 851052"/>
              <a:gd name="connsiteX8" fmla="*/ 516589 w 1032887"/>
              <a:gd name="connsiteY8" fmla="*/ 850511 h 851052"/>
              <a:gd name="connsiteX9" fmla="*/ 328329 w 1032887"/>
              <a:gd name="connsiteY9" fmla="*/ 757641 h 851052"/>
              <a:gd name="connsiteX10" fmla="*/ 93005 w 1032887"/>
              <a:gd name="connsiteY10" fmla="*/ 724023 h 851052"/>
              <a:gd name="connsiteX11" fmla="*/ 59388 w 1032887"/>
              <a:gd name="connsiteY11" fmla="*/ 508869 h 851052"/>
              <a:gd name="connsiteX12" fmla="*/ 5600 w 1032887"/>
              <a:gd name="connsiteY12" fmla="*/ 417473 h 851052"/>
              <a:gd name="connsiteX0" fmla="*/ 4137 w 1031424"/>
              <a:gd name="connsiteY0" fmla="*/ 417473 h 851052"/>
              <a:gd name="connsiteX1" fmla="*/ 178949 w 1031424"/>
              <a:gd name="connsiteY1" fmla="*/ 219758 h 851052"/>
              <a:gd name="connsiteX2" fmla="*/ 205842 w 1031424"/>
              <a:gd name="connsiteY2" fmla="*/ 65117 h 851052"/>
              <a:gd name="connsiteX3" fmla="*/ 521850 w 1031424"/>
              <a:gd name="connsiteY3" fmla="*/ 58394 h 851052"/>
              <a:gd name="connsiteX4" fmla="*/ 696660 w 1031424"/>
              <a:gd name="connsiteY4" fmla="*/ 4606 h 851052"/>
              <a:gd name="connsiteX5" fmla="*/ 945430 w 1031424"/>
              <a:gd name="connsiteY5" fmla="*/ 192864 h 851052"/>
              <a:gd name="connsiteX6" fmla="*/ 1026115 w 1031424"/>
              <a:gd name="connsiteY6" fmla="*/ 417473 h 851052"/>
              <a:gd name="connsiteX7" fmla="*/ 884918 w 1031424"/>
              <a:gd name="connsiteY7" fmla="*/ 650064 h 851052"/>
              <a:gd name="connsiteX8" fmla="*/ 676489 w 1031424"/>
              <a:gd name="connsiteY8" fmla="*/ 710575 h 851052"/>
              <a:gd name="connsiteX9" fmla="*/ 515126 w 1031424"/>
              <a:gd name="connsiteY9" fmla="*/ 850511 h 851052"/>
              <a:gd name="connsiteX10" fmla="*/ 326866 w 1031424"/>
              <a:gd name="connsiteY10" fmla="*/ 757641 h 851052"/>
              <a:gd name="connsiteX11" fmla="*/ 91542 w 1031424"/>
              <a:gd name="connsiteY11" fmla="*/ 724023 h 851052"/>
              <a:gd name="connsiteX12" fmla="*/ 57925 w 1031424"/>
              <a:gd name="connsiteY12" fmla="*/ 508869 h 851052"/>
              <a:gd name="connsiteX13" fmla="*/ 4137 w 1031424"/>
              <a:gd name="connsiteY13" fmla="*/ 417473 h 851052"/>
              <a:gd name="connsiteX0" fmla="*/ 4137 w 1031424"/>
              <a:gd name="connsiteY0" fmla="*/ 416993 h 850572"/>
              <a:gd name="connsiteX1" fmla="*/ 178949 w 1031424"/>
              <a:gd name="connsiteY1" fmla="*/ 219278 h 850572"/>
              <a:gd name="connsiteX2" fmla="*/ 246183 w 1031424"/>
              <a:gd name="connsiteY2" fmla="*/ 4125 h 850572"/>
              <a:gd name="connsiteX3" fmla="*/ 521850 w 1031424"/>
              <a:gd name="connsiteY3" fmla="*/ 57914 h 850572"/>
              <a:gd name="connsiteX4" fmla="*/ 696660 w 1031424"/>
              <a:gd name="connsiteY4" fmla="*/ 4126 h 850572"/>
              <a:gd name="connsiteX5" fmla="*/ 945430 w 1031424"/>
              <a:gd name="connsiteY5" fmla="*/ 192384 h 850572"/>
              <a:gd name="connsiteX6" fmla="*/ 1026115 w 1031424"/>
              <a:gd name="connsiteY6" fmla="*/ 416993 h 850572"/>
              <a:gd name="connsiteX7" fmla="*/ 884918 w 1031424"/>
              <a:gd name="connsiteY7" fmla="*/ 649584 h 850572"/>
              <a:gd name="connsiteX8" fmla="*/ 676489 w 1031424"/>
              <a:gd name="connsiteY8" fmla="*/ 710095 h 850572"/>
              <a:gd name="connsiteX9" fmla="*/ 515126 w 1031424"/>
              <a:gd name="connsiteY9" fmla="*/ 850031 h 850572"/>
              <a:gd name="connsiteX10" fmla="*/ 326866 w 1031424"/>
              <a:gd name="connsiteY10" fmla="*/ 757161 h 850572"/>
              <a:gd name="connsiteX11" fmla="*/ 91542 w 1031424"/>
              <a:gd name="connsiteY11" fmla="*/ 723543 h 850572"/>
              <a:gd name="connsiteX12" fmla="*/ 57925 w 1031424"/>
              <a:gd name="connsiteY12" fmla="*/ 508389 h 850572"/>
              <a:gd name="connsiteX13" fmla="*/ 4137 w 1031424"/>
              <a:gd name="connsiteY13" fmla="*/ 416993 h 850572"/>
              <a:gd name="connsiteX0" fmla="*/ 4137 w 1030097"/>
              <a:gd name="connsiteY0" fmla="*/ 416670 h 850249"/>
              <a:gd name="connsiteX1" fmla="*/ 178949 w 1030097"/>
              <a:gd name="connsiteY1" fmla="*/ 218955 h 850249"/>
              <a:gd name="connsiteX2" fmla="*/ 246183 w 1030097"/>
              <a:gd name="connsiteY2" fmla="*/ 3802 h 850249"/>
              <a:gd name="connsiteX3" fmla="*/ 521850 w 1030097"/>
              <a:gd name="connsiteY3" fmla="*/ 57591 h 850249"/>
              <a:gd name="connsiteX4" fmla="*/ 696660 w 1030097"/>
              <a:gd name="connsiteY4" fmla="*/ 3803 h 850249"/>
              <a:gd name="connsiteX5" fmla="*/ 797513 w 1030097"/>
              <a:gd name="connsiteY5" fmla="*/ 144996 h 850249"/>
              <a:gd name="connsiteX6" fmla="*/ 945430 w 1030097"/>
              <a:gd name="connsiteY6" fmla="*/ 192061 h 850249"/>
              <a:gd name="connsiteX7" fmla="*/ 1026115 w 1030097"/>
              <a:gd name="connsiteY7" fmla="*/ 416670 h 850249"/>
              <a:gd name="connsiteX8" fmla="*/ 884918 w 1030097"/>
              <a:gd name="connsiteY8" fmla="*/ 649261 h 850249"/>
              <a:gd name="connsiteX9" fmla="*/ 676489 w 1030097"/>
              <a:gd name="connsiteY9" fmla="*/ 709772 h 850249"/>
              <a:gd name="connsiteX10" fmla="*/ 515126 w 1030097"/>
              <a:gd name="connsiteY10" fmla="*/ 849708 h 850249"/>
              <a:gd name="connsiteX11" fmla="*/ 326866 w 1030097"/>
              <a:gd name="connsiteY11" fmla="*/ 756838 h 850249"/>
              <a:gd name="connsiteX12" fmla="*/ 91542 w 1030097"/>
              <a:gd name="connsiteY12" fmla="*/ 723220 h 850249"/>
              <a:gd name="connsiteX13" fmla="*/ 57925 w 1030097"/>
              <a:gd name="connsiteY13" fmla="*/ 508066 h 850249"/>
              <a:gd name="connsiteX14" fmla="*/ 4137 w 1030097"/>
              <a:gd name="connsiteY14" fmla="*/ 416670 h 850249"/>
              <a:gd name="connsiteX0" fmla="*/ 4137 w 977150"/>
              <a:gd name="connsiteY0" fmla="*/ 416670 h 850249"/>
              <a:gd name="connsiteX1" fmla="*/ 178949 w 977150"/>
              <a:gd name="connsiteY1" fmla="*/ 218955 h 850249"/>
              <a:gd name="connsiteX2" fmla="*/ 246183 w 977150"/>
              <a:gd name="connsiteY2" fmla="*/ 3802 h 850249"/>
              <a:gd name="connsiteX3" fmla="*/ 521850 w 977150"/>
              <a:gd name="connsiteY3" fmla="*/ 57591 h 850249"/>
              <a:gd name="connsiteX4" fmla="*/ 696660 w 977150"/>
              <a:gd name="connsiteY4" fmla="*/ 3803 h 850249"/>
              <a:gd name="connsiteX5" fmla="*/ 797513 w 977150"/>
              <a:gd name="connsiteY5" fmla="*/ 144996 h 850249"/>
              <a:gd name="connsiteX6" fmla="*/ 945430 w 977150"/>
              <a:gd name="connsiteY6" fmla="*/ 192061 h 850249"/>
              <a:gd name="connsiteX7" fmla="*/ 965603 w 977150"/>
              <a:gd name="connsiteY7" fmla="*/ 396500 h 850249"/>
              <a:gd name="connsiteX8" fmla="*/ 884918 w 977150"/>
              <a:gd name="connsiteY8" fmla="*/ 649261 h 850249"/>
              <a:gd name="connsiteX9" fmla="*/ 676489 w 977150"/>
              <a:gd name="connsiteY9" fmla="*/ 709772 h 850249"/>
              <a:gd name="connsiteX10" fmla="*/ 515126 w 977150"/>
              <a:gd name="connsiteY10" fmla="*/ 849708 h 850249"/>
              <a:gd name="connsiteX11" fmla="*/ 326866 w 977150"/>
              <a:gd name="connsiteY11" fmla="*/ 756838 h 850249"/>
              <a:gd name="connsiteX12" fmla="*/ 91542 w 977150"/>
              <a:gd name="connsiteY12" fmla="*/ 723220 h 850249"/>
              <a:gd name="connsiteX13" fmla="*/ 57925 w 977150"/>
              <a:gd name="connsiteY13" fmla="*/ 508066 h 850249"/>
              <a:gd name="connsiteX14" fmla="*/ 4137 w 977150"/>
              <a:gd name="connsiteY14" fmla="*/ 416670 h 850249"/>
              <a:gd name="connsiteX0" fmla="*/ 4137 w 1019578"/>
              <a:gd name="connsiteY0" fmla="*/ 416670 h 850249"/>
              <a:gd name="connsiteX1" fmla="*/ 178949 w 1019578"/>
              <a:gd name="connsiteY1" fmla="*/ 218955 h 850249"/>
              <a:gd name="connsiteX2" fmla="*/ 246183 w 1019578"/>
              <a:gd name="connsiteY2" fmla="*/ 3802 h 850249"/>
              <a:gd name="connsiteX3" fmla="*/ 521850 w 1019578"/>
              <a:gd name="connsiteY3" fmla="*/ 57591 h 850249"/>
              <a:gd name="connsiteX4" fmla="*/ 696660 w 1019578"/>
              <a:gd name="connsiteY4" fmla="*/ 3803 h 850249"/>
              <a:gd name="connsiteX5" fmla="*/ 797513 w 1019578"/>
              <a:gd name="connsiteY5" fmla="*/ 144996 h 850249"/>
              <a:gd name="connsiteX6" fmla="*/ 945430 w 1019578"/>
              <a:gd name="connsiteY6" fmla="*/ 192061 h 850249"/>
              <a:gd name="connsiteX7" fmla="*/ 1019390 w 1019578"/>
              <a:gd name="connsiteY7" fmla="*/ 319807 h 850249"/>
              <a:gd name="connsiteX8" fmla="*/ 965603 w 1019578"/>
              <a:gd name="connsiteY8" fmla="*/ 396500 h 850249"/>
              <a:gd name="connsiteX9" fmla="*/ 884918 w 1019578"/>
              <a:gd name="connsiteY9" fmla="*/ 649261 h 850249"/>
              <a:gd name="connsiteX10" fmla="*/ 676489 w 1019578"/>
              <a:gd name="connsiteY10" fmla="*/ 709772 h 850249"/>
              <a:gd name="connsiteX11" fmla="*/ 515126 w 1019578"/>
              <a:gd name="connsiteY11" fmla="*/ 849708 h 850249"/>
              <a:gd name="connsiteX12" fmla="*/ 326866 w 1019578"/>
              <a:gd name="connsiteY12" fmla="*/ 756838 h 850249"/>
              <a:gd name="connsiteX13" fmla="*/ 91542 w 1019578"/>
              <a:gd name="connsiteY13" fmla="*/ 723220 h 850249"/>
              <a:gd name="connsiteX14" fmla="*/ 57925 w 1019578"/>
              <a:gd name="connsiteY14" fmla="*/ 508066 h 850249"/>
              <a:gd name="connsiteX15" fmla="*/ 4137 w 1019578"/>
              <a:gd name="connsiteY15" fmla="*/ 416670 h 850249"/>
              <a:gd name="connsiteX0" fmla="*/ 12018 w 1027459"/>
              <a:gd name="connsiteY0" fmla="*/ 416670 h 850249"/>
              <a:gd name="connsiteX1" fmla="*/ 319129 w 1027459"/>
              <a:gd name="connsiteY1" fmla="*/ 231604 h 850249"/>
              <a:gd name="connsiteX2" fmla="*/ 254064 w 1027459"/>
              <a:gd name="connsiteY2" fmla="*/ 3802 h 850249"/>
              <a:gd name="connsiteX3" fmla="*/ 529731 w 1027459"/>
              <a:gd name="connsiteY3" fmla="*/ 57591 h 850249"/>
              <a:gd name="connsiteX4" fmla="*/ 704541 w 1027459"/>
              <a:gd name="connsiteY4" fmla="*/ 3803 h 850249"/>
              <a:gd name="connsiteX5" fmla="*/ 805394 w 1027459"/>
              <a:gd name="connsiteY5" fmla="*/ 144996 h 850249"/>
              <a:gd name="connsiteX6" fmla="*/ 953311 w 1027459"/>
              <a:gd name="connsiteY6" fmla="*/ 192061 h 850249"/>
              <a:gd name="connsiteX7" fmla="*/ 1027271 w 1027459"/>
              <a:gd name="connsiteY7" fmla="*/ 319807 h 850249"/>
              <a:gd name="connsiteX8" fmla="*/ 973484 w 1027459"/>
              <a:gd name="connsiteY8" fmla="*/ 396500 h 850249"/>
              <a:gd name="connsiteX9" fmla="*/ 892799 w 1027459"/>
              <a:gd name="connsiteY9" fmla="*/ 649261 h 850249"/>
              <a:gd name="connsiteX10" fmla="*/ 684370 w 1027459"/>
              <a:gd name="connsiteY10" fmla="*/ 709772 h 850249"/>
              <a:gd name="connsiteX11" fmla="*/ 523007 w 1027459"/>
              <a:gd name="connsiteY11" fmla="*/ 849708 h 850249"/>
              <a:gd name="connsiteX12" fmla="*/ 334747 w 1027459"/>
              <a:gd name="connsiteY12" fmla="*/ 756838 h 850249"/>
              <a:gd name="connsiteX13" fmla="*/ 99423 w 1027459"/>
              <a:gd name="connsiteY13" fmla="*/ 723220 h 850249"/>
              <a:gd name="connsiteX14" fmla="*/ 65806 w 1027459"/>
              <a:gd name="connsiteY14" fmla="*/ 508066 h 850249"/>
              <a:gd name="connsiteX15" fmla="*/ 12018 w 1027459"/>
              <a:gd name="connsiteY15" fmla="*/ 416670 h 850249"/>
              <a:gd name="connsiteX0" fmla="*/ 5053 w 1174843"/>
              <a:gd name="connsiteY0" fmla="*/ 416669 h 850249"/>
              <a:gd name="connsiteX1" fmla="*/ 466513 w 1174843"/>
              <a:gd name="connsiteY1" fmla="*/ 231604 h 850249"/>
              <a:gd name="connsiteX2" fmla="*/ 401448 w 1174843"/>
              <a:gd name="connsiteY2" fmla="*/ 3802 h 850249"/>
              <a:gd name="connsiteX3" fmla="*/ 677115 w 1174843"/>
              <a:gd name="connsiteY3" fmla="*/ 57591 h 850249"/>
              <a:gd name="connsiteX4" fmla="*/ 851925 w 1174843"/>
              <a:gd name="connsiteY4" fmla="*/ 3803 h 850249"/>
              <a:gd name="connsiteX5" fmla="*/ 952778 w 1174843"/>
              <a:gd name="connsiteY5" fmla="*/ 144996 h 850249"/>
              <a:gd name="connsiteX6" fmla="*/ 1100695 w 1174843"/>
              <a:gd name="connsiteY6" fmla="*/ 192061 h 850249"/>
              <a:gd name="connsiteX7" fmla="*/ 1174655 w 1174843"/>
              <a:gd name="connsiteY7" fmla="*/ 319807 h 850249"/>
              <a:gd name="connsiteX8" fmla="*/ 1120868 w 1174843"/>
              <a:gd name="connsiteY8" fmla="*/ 396500 h 850249"/>
              <a:gd name="connsiteX9" fmla="*/ 1040183 w 1174843"/>
              <a:gd name="connsiteY9" fmla="*/ 649261 h 850249"/>
              <a:gd name="connsiteX10" fmla="*/ 831754 w 1174843"/>
              <a:gd name="connsiteY10" fmla="*/ 709772 h 850249"/>
              <a:gd name="connsiteX11" fmla="*/ 670391 w 1174843"/>
              <a:gd name="connsiteY11" fmla="*/ 849708 h 850249"/>
              <a:gd name="connsiteX12" fmla="*/ 482131 w 1174843"/>
              <a:gd name="connsiteY12" fmla="*/ 756838 h 850249"/>
              <a:gd name="connsiteX13" fmla="*/ 246807 w 1174843"/>
              <a:gd name="connsiteY13" fmla="*/ 723220 h 850249"/>
              <a:gd name="connsiteX14" fmla="*/ 213190 w 1174843"/>
              <a:gd name="connsiteY14" fmla="*/ 508066 h 850249"/>
              <a:gd name="connsiteX15" fmla="*/ 5053 w 1174843"/>
              <a:gd name="connsiteY15" fmla="*/ 416669 h 850249"/>
              <a:gd name="connsiteX0" fmla="*/ 5053 w 1174843"/>
              <a:gd name="connsiteY0" fmla="*/ 416669 h 850249"/>
              <a:gd name="connsiteX1" fmla="*/ 466513 w 1174843"/>
              <a:gd name="connsiteY1" fmla="*/ 231604 h 850249"/>
              <a:gd name="connsiteX2" fmla="*/ 401448 w 1174843"/>
              <a:gd name="connsiteY2" fmla="*/ 3802 h 850249"/>
              <a:gd name="connsiteX3" fmla="*/ 677115 w 1174843"/>
              <a:gd name="connsiteY3" fmla="*/ 57591 h 850249"/>
              <a:gd name="connsiteX4" fmla="*/ 851925 w 1174843"/>
              <a:gd name="connsiteY4" fmla="*/ 3803 h 850249"/>
              <a:gd name="connsiteX5" fmla="*/ 952778 w 1174843"/>
              <a:gd name="connsiteY5" fmla="*/ 144996 h 850249"/>
              <a:gd name="connsiteX6" fmla="*/ 1100695 w 1174843"/>
              <a:gd name="connsiteY6" fmla="*/ 192061 h 850249"/>
              <a:gd name="connsiteX7" fmla="*/ 1174655 w 1174843"/>
              <a:gd name="connsiteY7" fmla="*/ 319807 h 850249"/>
              <a:gd name="connsiteX8" fmla="*/ 1120868 w 1174843"/>
              <a:gd name="connsiteY8" fmla="*/ 396500 h 850249"/>
              <a:gd name="connsiteX9" fmla="*/ 1040183 w 1174843"/>
              <a:gd name="connsiteY9" fmla="*/ 649261 h 850249"/>
              <a:gd name="connsiteX10" fmla="*/ 831754 w 1174843"/>
              <a:gd name="connsiteY10" fmla="*/ 709772 h 850249"/>
              <a:gd name="connsiteX11" fmla="*/ 670391 w 1174843"/>
              <a:gd name="connsiteY11" fmla="*/ 849708 h 850249"/>
              <a:gd name="connsiteX12" fmla="*/ 482131 w 1174843"/>
              <a:gd name="connsiteY12" fmla="*/ 756838 h 850249"/>
              <a:gd name="connsiteX13" fmla="*/ 92455 w 1174843"/>
              <a:gd name="connsiteY13" fmla="*/ 773818 h 850249"/>
              <a:gd name="connsiteX14" fmla="*/ 213190 w 1174843"/>
              <a:gd name="connsiteY14" fmla="*/ 508066 h 850249"/>
              <a:gd name="connsiteX15" fmla="*/ 5053 w 1174843"/>
              <a:gd name="connsiteY15" fmla="*/ 416669 h 850249"/>
              <a:gd name="connsiteX0" fmla="*/ 5053 w 1346132"/>
              <a:gd name="connsiteY0" fmla="*/ 416669 h 850249"/>
              <a:gd name="connsiteX1" fmla="*/ 466513 w 1346132"/>
              <a:gd name="connsiteY1" fmla="*/ 231604 h 850249"/>
              <a:gd name="connsiteX2" fmla="*/ 401448 w 1346132"/>
              <a:gd name="connsiteY2" fmla="*/ 3802 h 850249"/>
              <a:gd name="connsiteX3" fmla="*/ 677115 w 1346132"/>
              <a:gd name="connsiteY3" fmla="*/ 57591 h 850249"/>
              <a:gd name="connsiteX4" fmla="*/ 851925 w 1346132"/>
              <a:gd name="connsiteY4" fmla="*/ 3803 h 850249"/>
              <a:gd name="connsiteX5" fmla="*/ 952778 w 1346132"/>
              <a:gd name="connsiteY5" fmla="*/ 144996 h 850249"/>
              <a:gd name="connsiteX6" fmla="*/ 1343246 w 1346132"/>
              <a:gd name="connsiteY6" fmla="*/ 204710 h 850249"/>
              <a:gd name="connsiteX7" fmla="*/ 1174655 w 1346132"/>
              <a:gd name="connsiteY7" fmla="*/ 319807 h 850249"/>
              <a:gd name="connsiteX8" fmla="*/ 1120868 w 1346132"/>
              <a:gd name="connsiteY8" fmla="*/ 396500 h 850249"/>
              <a:gd name="connsiteX9" fmla="*/ 1040183 w 1346132"/>
              <a:gd name="connsiteY9" fmla="*/ 649261 h 850249"/>
              <a:gd name="connsiteX10" fmla="*/ 831754 w 1346132"/>
              <a:gd name="connsiteY10" fmla="*/ 709772 h 850249"/>
              <a:gd name="connsiteX11" fmla="*/ 670391 w 1346132"/>
              <a:gd name="connsiteY11" fmla="*/ 849708 h 850249"/>
              <a:gd name="connsiteX12" fmla="*/ 482131 w 1346132"/>
              <a:gd name="connsiteY12" fmla="*/ 756838 h 850249"/>
              <a:gd name="connsiteX13" fmla="*/ 92455 w 1346132"/>
              <a:gd name="connsiteY13" fmla="*/ 773818 h 850249"/>
              <a:gd name="connsiteX14" fmla="*/ 213190 w 1346132"/>
              <a:gd name="connsiteY14" fmla="*/ 508066 h 850249"/>
              <a:gd name="connsiteX15" fmla="*/ 5053 w 1346132"/>
              <a:gd name="connsiteY15" fmla="*/ 416669 h 850249"/>
              <a:gd name="connsiteX0" fmla="*/ 5053 w 1346132"/>
              <a:gd name="connsiteY0" fmla="*/ 416669 h 850249"/>
              <a:gd name="connsiteX1" fmla="*/ 466513 w 1346132"/>
              <a:gd name="connsiteY1" fmla="*/ 231604 h 850249"/>
              <a:gd name="connsiteX2" fmla="*/ 401448 w 1346132"/>
              <a:gd name="connsiteY2" fmla="*/ 3802 h 850249"/>
              <a:gd name="connsiteX3" fmla="*/ 677115 w 1346132"/>
              <a:gd name="connsiteY3" fmla="*/ 57591 h 850249"/>
              <a:gd name="connsiteX4" fmla="*/ 851925 w 1346132"/>
              <a:gd name="connsiteY4" fmla="*/ 3803 h 850249"/>
              <a:gd name="connsiteX5" fmla="*/ 952778 w 1346132"/>
              <a:gd name="connsiteY5" fmla="*/ 144996 h 850249"/>
              <a:gd name="connsiteX6" fmla="*/ 1343246 w 1346132"/>
              <a:gd name="connsiteY6" fmla="*/ 204710 h 850249"/>
              <a:gd name="connsiteX7" fmla="*/ 1174655 w 1346132"/>
              <a:gd name="connsiteY7" fmla="*/ 319807 h 850249"/>
              <a:gd name="connsiteX8" fmla="*/ 1297271 w 1346132"/>
              <a:gd name="connsiteY8" fmla="*/ 485043 h 850249"/>
              <a:gd name="connsiteX9" fmla="*/ 1040183 w 1346132"/>
              <a:gd name="connsiteY9" fmla="*/ 649261 h 850249"/>
              <a:gd name="connsiteX10" fmla="*/ 831754 w 1346132"/>
              <a:gd name="connsiteY10" fmla="*/ 709772 h 850249"/>
              <a:gd name="connsiteX11" fmla="*/ 670391 w 1346132"/>
              <a:gd name="connsiteY11" fmla="*/ 849708 h 850249"/>
              <a:gd name="connsiteX12" fmla="*/ 482131 w 1346132"/>
              <a:gd name="connsiteY12" fmla="*/ 756838 h 850249"/>
              <a:gd name="connsiteX13" fmla="*/ 92455 w 1346132"/>
              <a:gd name="connsiteY13" fmla="*/ 773818 h 850249"/>
              <a:gd name="connsiteX14" fmla="*/ 213190 w 1346132"/>
              <a:gd name="connsiteY14" fmla="*/ 508066 h 850249"/>
              <a:gd name="connsiteX15" fmla="*/ 5053 w 1346132"/>
              <a:gd name="connsiteY15" fmla="*/ 416669 h 8502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346132" h="850249">
                <a:moveTo>
                  <a:pt x="5053" y="416669"/>
                </a:moveTo>
                <a:cubicBezTo>
                  <a:pt x="47274" y="370592"/>
                  <a:pt x="432896" y="290330"/>
                  <a:pt x="466513" y="231604"/>
                </a:cubicBezTo>
                <a:cubicBezTo>
                  <a:pt x="500130" y="172878"/>
                  <a:pt x="331971" y="25093"/>
                  <a:pt x="401448" y="3802"/>
                </a:cubicBezTo>
                <a:cubicBezTo>
                  <a:pt x="470925" y="-17489"/>
                  <a:pt x="602036" y="57591"/>
                  <a:pt x="677115" y="57591"/>
                </a:cubicBezTo>
                <a:cubicBezTo>
                  <a:pt x="752194" y="57591"/>
                  <a:pt x="800378" y="-679"/>
                  <a:pt x="851925" y="3803"/>
                </a:cubicBezTo>
                <a:cubicBezTo>
                  <a:pt x="903472" y="8285"/>
                  <a:pt x="911316" y="113620"/>
                  <a:pt x="952778" y="144996"/>
                </a:cubicBezTo>
                <a:cubicBezTo>
                  <a:pt x="994240" y="176372"/>
                  <a:pt x="1314111" y="183419"/>
                  <a:pt x="1343246" y="204710"/>
                </a:cubicBezTo>
                <a:cubicBezTo>
                  <a:pt x="1372381" y="226001"/>
                  <a:pt x="1171293" y="285734"/>
                  <a:pt x="1174655" y="319807"/>
                </a:cubicBezTo>
                <a:cubicBezTo>
                  <a:pt x="1178017" y="353880"/>
                  <a:pt x="1311839" y="422290"/>
                  <a:pt x="1297271" y="485043"/>
                </a:cubicBezTo>
                <a:cubicBezTo>
                  <a:pt x="1282703" y="547796"/>
                  <a:pt x="1098454" y="600411"/>
                  <a:pt x="1040183" y="649261"/>
                </a:cubicBezTo>
                <a:cubicBezTo>
                  <a:pt x="981912" y="698111"/>
                  <a:pt x="882180" y="668520"/>
                  <a:pt x="831754" y="709772"/>
                </a:cubicBezTo>
                <a:cubicBezTo>
                  <a:pt x="781328" y="751024"/>
                  <a:pt x="728661" y="841864"/>
                  <a:pt x="670391" y="849708"/>
                </a:cubicBezTo>
                <a:cubicBezTo>
                  <a:pt x="612121" y="857552"/>
                  <a:pt x="552728" y="777919"/>
                  <a:pt x="482131" y="756838"/>
                </a:cubicBezTo>
                <a:cubicBezTo>
                  <a:pt x="411534" y="735757"/>
                  <a:pt x="147364" y="806315"/>
                  <a:pt x="92455" y="773818"/>
                </a:cubicBezTo>
                <a:cubicBezTo>
                  <a:pt x="37546" y="741321"/>
                  <a:pt x="227758" y="559158"/>
                  <a:pt x="213190" y="508066"/>
                </a:cubicBezTo>
                <a:cubicBezTo>
                  <a:pt x="198622" y="456974"/>
                  <a:pt x="-37168" y="462746"/>
                  <a:pt x="5053" y="416669"/>
                </a:cubicBezTo>
                <a:close/>
              </a:path>
            </a:pathLst>
          </a:custGeom>
          <a:solidFill>
            <a:schemeClr val="accent2">
              <a:lumMod val="20000"/>
              <a:lumOff val="80000"/>
            </a:schemeClr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Oval 254">
            <a:extLst>
              <a:ext uri="{FF2B5EF4-FFF2-40B4-BE49-F238E27FC236}">
                <a16:creationId xmlns:a16="http://schemas.microsoft.com/office/drawing/2014/main" id="{BF29E020-3E6F-C8BF-0062-A9AE7034EA54}"/>
              </a:ext>
            </a:extLst>
          </p:cNvPr>
          <p:cNvSpPr/>
          <p:nvPr/>
        </p:nvSpPr>
        <p:spPr>
          <a:xfrm>
            <a:off x="4141880" y="7852726"/>
            <a:ext cx="288244" cy="255696"/>
          </a:xfrm>
          <a:custGeom>
            <a:avLst/>
            <a:gdLst>
              <a:gd name="connsiteX0" fmla="*/ 0 w 1021977"/>
              <a:gd name="connsiteY0" fmla="*/ 433038 h 866076"/>
              <a:gd name="connsiteX1" fmla="*/ 510989 w 1021977"/>
              <a:gd name="connsiteY1" fmla="*/ 0 h 866076"/>
              <a:gd name="connsiteX2" fmla="*/ 1021978 w 1021977"/>
              <a:gd name="connsiteY2" fmla="*/ 433038 h 866076"/>
              <a:gd name="connsiteX3" fmla="*/ 510989 w 1021977"/>
              <a:gd name="connsiteY3" fmla="*/ 866076 h 866076"/>
              <a:gd name="connsiteX4" fmla="*/ 0 w 1021977"/>
              <a:gd name="connsiteY4" fmla="*/ 433038 h 866076"/>
              <a:gd name="connsiteX0" fmla="*/ 4 w 1021982"/>
              <a:gd name="connsiteY0" fmla="*/ 359079 h 792117"/>
              <a:gd name="connsiteX1" fmla="*/ 517717 w 1021982"/>
              <a:gd name="connsiteY1" fmla="*/ 0 h 792117"/>
              <a:gd name="connsiteX2" fmla="*/ 1021982 w 1021982"/>
              <a:gd name="connsiteY2" fmla="*/ 359079 h 792117"/>
              <a:gd name="connsiteX3" fmla="*/ 510993 w 1021982"/>
              <a:gd name="connsiteY3" fmla="*/ 792117 h 792117"/>
              <a:gd name="connsiteX4" fmla="*/ 4 w 1021982"/>
              <a:gd name="connsiteY4" fmla="*/ 359079 h 792117"/>
              <a:gd name="connsiteX0" fmla="*/ 9682 w 1031660"/>
              <a:gd name="connsiteY0" fmla="*/ 400301 h 833339"/>
              <a:gd name="connsiteX1" fmla="*/ 211387 w 1031660"/>
              <a:gd name="connsiteY1" fmla="*/ 47945 h 833339"/>
              <a:gd name="connsiteX2" fmla="*/ 527395 w 1031660"/>
              <a:gd name="connsiteY2" fmla="*/ 41222 h 833339"/>
              <a:gd name="connsiteX3" fmla="*/ 1031660 w 1031660"/>
              <a:gd name="connsiteY3" fmla="*/ 400301 h 833339"/>
              <a:gd name="connsiteX4" fmla="*/ 520671 w 1031660"/>
              <a:gd name="connsiteY4" fmla="*/ 833339 h 833339"/>
              <a:gd name="connsiteX5" fmla="*/ 9682 w 1031660"/>
              <a:gd name="connsiteY5" fmla="*/ 400301 h 833339"/>
              <a:gd name="connsiteX0" fmla="*/ 6466 w 1028444"/>
              <a:gd name="connsiteY0" fmla="*/ 400301 h 846828"/>
              <a:gd name="connsiteX1" fmla="*/ 208171 w 1028444"/>
              <a:gd name="connsiteY1" fmla="*/ 47945 h 846828"/>
              <a:gd name="connsiteX2" fmla="*/ 524179 w 1028444"/>
              <a:gd name="connsiteY2" fmla="*/ 41222 h 846828"/>
              <a:gd name="connsiteX3" fmla="*/ 1028444 w 1028444"/>
              <a:gd name="connsiteY3" fmla="*/ 400301 h 846828"/>
              <a:gd name="connsiteX4" fmla="*/ 517455 w 1028444"/>
              <a:gd name="connsiteY4" fmla="*/ 833339 h 846828"/>
              <a:gd name="connsiteX5" fmla="*/ 93871 w 1028444"/>
              <a:gd name="connsiteY5" fmla="*/ 706851 h 846828"/>
              <a:gd name="connsiteX6" fmla="*/ 6466 w 1028444"/>
              <a:gd name="connsiteY6" fmla="*/ 400301 h 846828"/>
              <a:gd name="connsiteX0" fmla="*/ 6466 w 1030468"/>
              <a:gd name="connsiteY0" fmla="*/ 400301 h 833403"/>
              <a:gd name="connsiteX1" fmla="*/ 208171 w 1030468"/>
              <a:gd name="connsiteY1" fmla="*/ 47945 h 833403"/>
              <a:gd name="connsiteX2" fmla="*/ 524179 w 1030468"/>
              <a:gd name="connsiteY2" fmla="*/ 41222 h 833403"/>
              <a:gd name="connsiteX3" fmla="*/ 1028444 w 1030468"/>
              <a:gd name="connsiteY3" fmla="*/ 400301 h 833403"/>
              <a:gd name="connsiteX4" fmla="*/ 678818 w 1030468"/>
              <a:gd name="connsiteY4" fmla="*/ 693403 h 833403"/>
              <a:gd name="connsiteX5" fmla="*/ 517455 w 1030468"/>
              <a:gd name="connsiteY5" fmla="*/ 833339 h 833403"/>
              <a:gd name="connsiteX6" fmla="*/ 93871 w 1030468"/>
              <a:gd name="connsiteY6" fmla="*/ 706851 h 833403"/>
              <a:gd name="connsiteX7" fmla="*/ 6466 w 1030468"/>
              <a:gd name="connsiteY7" fmla="*/ 400301 h 833403"/>
              <a:gd name="connsiteX0" fmla="*/ 6466 w 1040938"/>
              <a:gd name="connsiteY0" fmla="*/ 386831 h 819933"/>
              <a:gd name="connsiteX1" fmla="*/ 208171 w 1040938"/>
              <a:gd name="connsiteY1" fmla="*/ 34475 h 819933"/>
              <a:gd name="connsiteX2" fmla="*/ 524179 w 1040938"/>
              <a:gd name="connsiteY2" fmla="*/ 27752 h 819933"/>
              <a:gd name="connsiteX3" fmla="*/ 947759 w 1040938"/>
              <a:gd name="connsiteY3" fmla="*/ 162222 h 819933"/>
              <a:gd name="connsiteX4" fmla="*/ 1028444 w 1040938"/>
              <a:gd name="connsiteY4" fmla="*/ 386831 h 819933"/>
              <a:gd name="connsiteX5" fmla="*/ 678818 w 1040938"/>
              <a:gd name="connsiteY5" fmla="*/ 679933 h 819933"/>
              <a:gd name="connsiteX6" fmla="*/ 517455 w 1040938"/>
              <a:gd name="connsiteY6" fmla="*/ 819869 h 819933"/>
              <a:gd name="connsiteX7" fmla="*/ 93871 w 1040938"/>
              <a:gd name="connsiteY7" fmla="*/ 693381 h 819933"/>
              <a:gd name="connsiteX8" fmla="*/ 6466 w 1040938"/>
              <a:gd name="connsiteY8" fmla="*/ 386831 h 819933"/>
              <a:gd name="connsiteX0" fmla="*/ 6466 w 1037480"/>
              <a:gd name="connsiteY0" fmla="*/ 417473 h 850575"/>
              <a:gd name="connsiteX1" fmla="*/ 208171 w 1037480"/>
              <a:gd name="connsiteY1" fmla="*/ 65117 h 850575"/>
              <a:gd name="connsiteX2" fmla="*/ 524179 w 1037480"/>
              <a:gd name="connsiteY2" fmla="*/ 58394 h 850575"/>
              <a:gd name="connsiteX3" fmla="*/ 698989 w 1037480"/>
              <a:gd name="connsiteY3" fmla="*/ 4606 h 850575"/>
              <a:gd name="connsiteX4" fmla="*/ 947759 w 1037480"/>
              <a:gd name="connsiteY4" fmla="*/ 192864 h 850575"/>
              <a:gd name="connsiteX5" fmla="*/ 1028444 w 1037480"/>
              <a:gd name="connsiteY5" fmla="*/ 417473 h 850575"/>
              <a:gd name="connsiteX6" fmla="*/ 678818 w 1037480"/>
              <a:gd name="connsiteY6" fmla="*/ 710575 h 850575"/>
              <a:gd name="connsiteX7" fmla="*/ 517455 w 1037480"/>
              <a:gd name="connsiteY7" fmla="*/ 850511 h 850575"/>
              <a:gd name="connsiteX8" fmla="*/ 93871 w 1037480"/>
              <a:gd name="connsiteY8" fmla="*/ 724023 h 850575"/>
              <a:gd name="connsiteX9" fmla="*/ 6466 w 1037480"/>
              <a:gd name="connsiteY9" fmla="*/ 417473 h 850575"/>
              <a:gd name="connsiteX0" fmla="*/ 6466 w 1033753"/>
              <a:gd name="connsiteY0" fmla="*/ 417473 h 850575"/>
              <a:gd name="connsiteX1" fmla="*/ 208171 w 1033753"/>
              <a:gd name="connsiteY1" fmla="*/ 65117 h 850575"/>
              <a:gd name="connsiteX2" fmla="*/ 524179 w 1033753"/>
              <a:gd name="connsiteY2" fmla="*/ 58394 h 850575"/>
              <a:gd name="connsiteX3" fmla="*/ 698989 w 1033753"/>
              <a:gd name="connsiteY3" fmla="*/ 4606 h 850575"/>
              <a:gd name="connsiteX4" fmla="*/ 947759 w 1033753"/>
              <a:gd name="connsiteY4" fmla="*/ 192864 h 850575"/>
              <a:gd name="connsiteX5" fmla="*/ 1028444 w 1033753"/>
              <a:gd name="connsiteY5" fmla="*/ 417473 h 850575"/>
              <a:gd name="connsiteX6" fmla="*/ 887247 w 1033753"/>
              <a:gd name="connsiteY6" fmla="*/ 650064 h 850575"/>
              <a:gd name="connsiteX7" fmla="*/ 678818 w 1033753"/>
              <a:gd name="connsiteY7" fmla="*/ 710575 h 850575"/>
              <a:gd name="connsiteX8" fmla="*/ 517455 w 1033753"/>
              <a:gd name="connsiteY8" fmla="*/ 850511 h 850575"/>
              <a:gd name="connsiteX9" fmla="*/ 93871 w 1033753"/>
              <a:gd name="connsiteY9" fmla="*/ 724023 h 850575"/>
              <a:gd name="connsiteX10" fmla="*/ 6466 w 1033753"/>
              <a:gd name="connsiteY10" fmla="*/ 417473 h 850575"/>
              <a:gd name="connsiteX0" fmla="*/ 6466 w 1033753"/>
              <a:gd name="connsiteY0" fmla="*/ 417473 h 851052"/>
              <a:gd name="connsiteX1" fmla="*/ 208171 w 1033753"/>
              <a:gd name="connsiteY1" fmla="*/ 65117 h 851052"/>
              <a:gd name="connsiteX2" fmla="*/ 524179 w 1033753"/>
              <a:gd name="connsiteY2" fmla="*/ 58394 h 851052"/>
              <a:gd name="connsiteX3" fmla="*/ 698989 w 1033753"/>
              <a:gd name="connsiteY3" fmla="*/ 4606 h 851052"/>
              <a:gd name="connsiteX4" fmla="*/ 947759 w 1033753"/>
              <a:gd name="connsiteY4" fmla="*/ 192864 h 851052"/>
              <a:gd name="connsiteX5" fmla="*/ 1028444 w 1033753"/>
              <a:gd name="connsiteY5" fmla="*/ 417473 h 851052"/>
              <a:gd name="connsiteX6" fmla="*/ 887247 w 1033753"/>
              <a:gd name="connsiteY6" fmla="*/ 650064 h 851052"/>
              <a:gd name="connsiteX7" fmla="*/ 678818 w 1033753"/>
              <a:gd name="connsiteY7" fmla="*/ 710575 h 851052"/>
              <a:gd name="connsiteX8" fmla="*/ 517455 w 1033753"/>
              <a:gd name="connsiteY8" fmla="*/ 850511 h 851052"/>
              <a:gd name="connsiteX9" fmla="*/ 329195 w 1033753"/>
              <a:gd name="connsiteY9" fmla="*/ 757641 h 851052"/>
              <a:gd name="connsiteX10" fmla="*/ 93871 w 1033753"/>
              <a:gd name="connsiteY10" fmla="*/ 724023 h 851052"/>
              <a:gd name="connsiteX11" fmla="*/ 6466 w 1033753"/>
              <a:gd name="connsiteY11" fmla="*/ 417473 h 851052"/>
              <a:gd name="connsiteX0" fmla="*/ 5600 w 1032887"/>
              <a:gd name="connsiteY0" fmla="*/ 417473 h 851052"/>
              <a:gd name="connsiteX1" fmla="*/ 207305 w 1032887"/>
              <a:gd name="connsiteY1" fmla="*/ 65117 h 851052"/>
              <a:gd name="connsiteX2" fmla="*/ 523313 w 1032887"/>
              <a:gd name="connsiteY2" fmla="*/ 58394 h 851052"/>
              <a:gd name="connsiteX3" fmla="*/ 698123 w 1032887"/>
              <a:gd name="connsiteY3" fmla="*/ 4606 h 851052"/>
              <a:gd name="connsiteX4" fmla="*/ 946893 w 1032887"/>
              <a:gd name="connsiteY4" fmla="*/ 192864 h 851052"/>
              <a:gd name="connsiteX5" fmla="*/ 1027578 w 1032887"/>
              <a:gd name="connsiteY5" fmla="*/ 417473 h 851052"/>
              <a:gd name="connsiteX6" fmla="*/ 886381 w 1032887"/>
              <a:gd name="connsiteY6" fmla="*/ 650064 h 851052"/>
              <a:gd name="connsiteX7" fmla="*/ 677952 w 1032887"/>
              <a:gd name="connsiteY7" fmla="*/ 710575 h 851052"/>
              <a:gd name="connsiteX8" fmla="*/ 516589 w 1032887"/>
              <a:gd name="connsiteY8" fmla="*/ 850511 h 851052"/>
              <a:gd name="connsiteX9" fmla="*/ 328329 w 1032887"/>
              <a:gd name="connsiteY9" fmla="*/ 757641 h 851052"/>
              <a:gd name="connsiteX10" fmla="*/ 93005 w 1032887"/>
              <a:gd name="connsiteY10" fmla="*/ 724023 h 851052"/>
              <a:gd name="connsiteX11" fmla="*/ 59388 w 1032887"/>
              <a:gd name="connsiteY11" fmla="*/ 508869 h 851052"/>
              <a:gd name="connsiteX12" fmla="*/ 5600 w 1032887"/>
              <a:gd name="connsiteY12" fmla="*/ 417473 h 851052"/>
              <a:gd name="connsiteX0" fmla="*/ 4137 w 1031424"/>
              <a:gd name="connsiteY0" fmla="*/ 417473 h 851052"/>
              <a:gd name="connsiteX1" fmla="*/ 178949 w 1031424"/>
              <a:gd name="connsiteY1" fmla="*/ 219758 h 851052"/>
              <a:gd name="connsiteX2" fmla="*/ 205842 w 1031424"/>
              <a:gd name="connsiteY2" fmla="*/ 65117 h 851052"/>
              <a:gd name="connsiteX3" fmla="*/ 521850 w 1031424"/>
              <a:gd name="connsiteY3" fmla="*/ 58394 h 851052"/>
              <a:gd name="connsiteX4" fmla="*/ 696660 w 1031424"/>
              <a:gd name="connsiteY4" fmla="*/ 4606 h 851052"/>
              <a:gd name="connsiteX5" fmla="*/ 945430 w 1031424"/>
              <a:gd name="connsiteY5" fmla="*/ 192864 h 851052"/>
              <a:gd name="connsiteX6" fmla="*/ 1026115 w 1031424"/>
              <a:gd name="connsiteY6" fmla="*/ 417473 h 851052"/>
              <a:gd name="connsiteX7" fmla="*/ 884918 w 1031424"/>
              <a:gd name="connsiteY7" fmla="*/ 650064 h 851052"/>
              <a:gd name="connsiteX8" fmla="*/ 676489 w 1031424"/>
              <a:gd name="connsiteY8" fmla="*/ 710575 h 851052"/>
              <a:gd name="connsiteX9" fmla="*/ 515126 w 1031424"/>
              <a:gd name="connsiteY9" fmla="*/ 850511 h 851052"/>
              <a:gd name="connsiteX10" fmla="*/ 326866 w 1031424"/>
              <a:gd name="connsiteY10" fmla="*/ 757641 h 851052"/>
              <a:gd name="connsiteX11" fmla="*/ 91542 w 1031424"/>
              <a:gd name="connsiteY11" fmla="*/ 724023 h 851052"/>
              <a:gd name="connsiteX12" fmla="*/ 57925 w 1031424"/>
              <a:gd name="connsiteY12" fmla="*/ 508869 h 851052"/>
              <a:gd name="connsiteX13" fmla="*/ 4137 w 1031424"/>
              <a:gd name="connsiteY13" fmla="*/ 417473 h 851052"/>
              <a:gd name="connsiteX0" fmla="*/ 4137 w 1031424"/>
              <a:gd name="connsiteY0" fmla="*/ 416993 h 850572"/>
              <a:gd name="connsiteX1" fmla="*/ 178949 w 1031424"/>
              <a:gd name="connsiteY1" fmla="*/ 219278 h 850572"/>
              <a:gd name="connsiteX2" fmla="*/ 246183 w 1031424"/>
              <a:gd name="connsiteY2" fmla="*/ 4125 h 850572"/>
              <a:gd name="connsiteX3" fmla="*/ 521850 w 1031424"/>
              <a:gd name="connsiteY3" fmla="*/ 57914 h 850572"/>
              <a:gd name="connsiteX4" fmla="*/ 696660 w 1031424"/>
              <a:gd name="connsiteY4" fmla="*/ 4126 h 850572"/>
              <a:gd name="connsiteX5" fmla="*/ 945430 w 1031424"/>
              <a:gd name="connsiteY5" fmla="*/ 192384 h 850572"/>
              <a:gd name="connsiteX6" fmla="*/ 1026115 w 1031424"/>
              <a:gd name="connsiteY6" fmla="*/ 416993 h 850572"/>
              <a:gd name="connsiteX7" fmla="*/ 884918 w 1031424"/>
              <a:gd name="connsiteY7" fmla="*/ 649584 h 850572"/>
              <a:gd name="connsiteX8" fmla="*/ 676489 w 1031424"/>
              <a:gd name="connsiteY8" fmla="*/ 710095 h 850572"/>
              <a:gd name="connsiteX9" fmla="*/ 515126 w 1031424"/>
              <a:gd name="connsiteY9" fmla="*/ 850031 h 850572"/>
              <a:gd name="connsiteX10" fmla="*/ 326866 w 1031424"/>
              <a:gd name="connsiteY10" fmla="*/ 757161 h 850572"/>
              <a:gd name="connsiteX11" fmla="*/ 91542 w 1031424"/>
              <a:gd name="connsiteY11" fmla="*/ 723543 h 850572"/>
              <a:gd name="connsiteX12" fmla="*/ 57925 w 1031424"/>
              <a:gd name="connsiteY12" fmla="*/ 508389 h 850572"/>
              <a:gd name="connsiteX13" fmla="*/ 4137 w 1031424"/>
              <a:gd name="connsiteY13" fmla="*/ 416993 h 850572"/>
              <a:gd name="connsiteX0" fmla="*/ 4137 w 1030097"/>
              <a:gd name="connsiteY0" fmla="*/ 416670 h 850249"/>
              <a:gd name="connsiteX1" fmla="*/ 178949 w 1030097"/>
              <a:gd name="connsiteY1" fmla="*/ 218955 h 850249"/>
              <a:gd name="connsiteX2" fmla="*/ 246183 w 1030097"/>
              <a:gd name="connsiteY2" fmla="*/ 3802 h 850249"/>
              <a:gd name="connsiteX3" fmla="*/ 521850 w 1030097"/>
              <a:gd name="connsiteY3" fmla="*/ 57591 h 850249"/>
              <a:gd name="connsiteX4" fmla="*/ 696660 w 1030097"/>
              <a:gd name="connsiteY4" fmla="*/ 3803 h 850249"/>
              <a:gd name="connsiteX5" fmla="*/ 797513 w 1030097"/>
              <a:gd name="connsiteY5" fmla="*/ 144996 h 850249"/>
              <a:gd name="connsiteX6" fmla="*/ 945430 w 1030097"/>
              <a:gd name="connsiteY6" fmla="*/ 192061 h 850249"/>
              <a:gd name="connsiteX7" fmla="*/ 1026115 w 1030097"/>
              <a:gd name="connsiteY7" fmla="*/ 416670 h 850249"/>
              <a:gd name="connsiteX8" fmla="*/ 884918 w 1030097"/>
              <a:gd name="connsiteY8" fmla="*/ 649261 h 850249"/>
              <a:gd name="connsiteX9" fmla="*/ 676489 w 1030097"/>
              <a:gd name="connsiteY9" fmla="*/ 709772 h 850249"/>
              <a:gd name="connsiteX10" fmla="*/ 515126 w 1030097"/>
              <a:gd name="connsiteY10" fmla="*/ 849708 h 850249"/>
              <a:gd name="connsiteX11" fmla="*/ 326866 w 1030097"/>
              <a:gd name="connsiteY11" fmla="*/ 756838 h 850249"/>
              <a:gd name="connsiteX12" fmla="*/ 91542 w 1030097"/>
              <a:gd name="connsiteY12" fmla="*/ 723220 h 850249"/>
              <a:gd name="connsiteX13" fmla="*/ 57925 w 1030097"/>
              <a:gd name="connsiteY13" fmla="*/ 508066 h 850249"/>
              <a:gd name="connsiteX14" fmla="*/ 4137 w 1030097"/>
              <a:gd name="connsiteY14" fmla="*/ 416670 h 850249"/>
              <a:gd name="connsiteX0" fmla="*/ 4137 w 977150"/>
              <a:gd name="connsiteY0" fmla="*/ 416670 h 850249"/>
              <a:gd name="connsiteX1" fmla="*/ 178949 w 977150"/>
              <a:gd name="connsiteY1" fmla="*/ 218955 h 850249"/>
              <a:gd name="connsiteX2" fmla="*/ 246183 w 977150"/>
              <a:gd name="connsiteY2" fmla="*/ 3802 h 850249"/>
              <a:gd name="connsiteX3" fmla="*/ 521850 w 977150"/>
              <a:gd name="connsiteY3" fmla="*/ 57591 h 850249"/>
              <a:gd name="connsiteX4" fmla="*/ 696660 w 977150"/>
              <a:gd name="connsiteY4" fmla="*/ 3803 h 850249"/>
              <a:gd name="connsiteX5" fmla="*/ 797513 w 977150"/>
              <a:gd name="connsiteY5" fmla="*/ 144996 h 850249"/>
              <a:gd name="connsiteX6" fmla="*/ 945430 w 977150"/>
              <a:gd name="connsiteY6" fmla="*/ 192061 h 850249"/>
              <a:gd name="connsiteX7" fmla="*/ 965603 w 977150"/>
              <a:gd name="connsiteY7" fmla="*/ 396500 h 850249"/>
              <a:gd name="connsiteX8" fmla="*/ 884918 w 977150"/>
              <a:gd name="connsiteY8" fmla="*/ 649261 h 850249"/>
              <a:gd name="connsiteX9" fmla="*/ 676489 w 977150"/>
              <a:gd name="connsiteY9" fmla="*/ 709772 h 850249"/>
              <a:gd name="connsiteX10" fmla="*/ 515126 w 977150"/>
              <a:gd name="connsiteY10" fmla="*/ 849708 h 850249"/>
              <a:gd name="connsiteX11" fmla="*/ 326866 w 977150"/>
              <a:gd name="connsiteY11" fmla="*/ 756838 h 850249"/>
              <a:gd name="connsiteX12" fmla="*/ 91542 w 977150"/>
              <a:gd name="connsiteY12" fmla="*/ 723220 h 850249"/>
              <a:gd name="connsiteX13" fmla="*/ 57925 w 977150"/>
              <a:gd name="connsiteY13" fmla="*/ 508066 h 850249"/>
              <a:gd name="connsiteX14" fmla="*/ 4137 w 977150"/>
              <a:gd name="connsiteY14" fmla="*/ 416670 h 850249"/>
              <a:gd name="connsiteX0" fmla="*/ 4137 w 1019578"/>
              <a:gd name="connsiteY0" fmla="*/ 416670 h 850249"/>
              <a:gd name="connsiteX1" fmla="*/ 178949 w 1019578"/>
              <a:gd name="connsiteY1" fmla="*/ 218955 h 850249"/>
              <a:gd name="connsiteX2" fmla="*/ 246183 w 1019578"/>
              <a:gd name="connsiteY2" fmla="*/ 3802 h 850249"/>
              <a:gd name="connsiteX3" fmla="*/ 521850 w 1019578"/>
              <a:gd name="connsiteY3" fmla="*/ 57591 h 850249"/>
              <a:gd name="connsiteX4" fmla="*/ 696660 w 1019578"/>
              <a:gd name="connsiteY4" fmla="*/ 3803 h 850249"/>
              <a:gd name="connsiteX5" fmla="*/ 797513 w 1019578"/>
              <a:gd name="connsiteY5" fmla="*/ 144996 h 850249"/>
              <a:gd name="connsiteX6" fmla="*/ 945430 w 1019578"/>
              <a:gd name="connsiteY6" fmla="*/ 192061 h 850249"/>
              <a:gd name="connsiteX7" fmla="*/ 1019390 w 1019578"/>
              <a:gd name="connsiteY7" fmla="*/ 319807 h 850249"/>
              <a:gd name="connsiteX8" fmla="*/ 965603 w 1019578"/>
              <a:gd name="connsiteY8" fmla="*/ 396500 h 850249"/>
              <a:gd name="connsiteX9" fmla="*/ 884918 w 1019578"/>
              <a:gd name="connsiteY9" fmla="*/ 649261 h 850249"/>
              <a:gd name="connsiteX10" fmla="*/ 676489 w 1019578"/>
              <a:gd name="connsiteY10" fmla="*/ 709772 h 850249"/>
              <a:gd name="connsiteX11" fmla="*/ 515126 w 1019578"/>
              <a:gd name="connsiteY11" fmla="*/ 849708 h 850249"/>
              <a:gd name="connsiteX12" fmla="*/ 326866 w 1019578"/>
              <a:gd name="connsiteY12" fmla="*/ 756838 h 850249"/>
              <a:gd name="connsiteX13" fmla="*/ 91542 w 1019578"/>
              <a:gd name="connsiteY13" fmla="*/ 723220 h 850249"/>
              <a:gd name="connsiteX14" fmla="*/ 57925 w 1019578"/>
              <a:gd name="connsiteY14" fmla="*/ 508066 h 850249"/>
              <a:gd name="connsiteX15" fmla="*/ 4137 w 1019578"/>
              <a:gd name="connsiteY15" fmla="*/ 416670 h 850249"/>
              <a:gd name="connsiteX0" fmla="*/ 12018 w 1027459"/>
              <a:gd name="connsiteY0" fmla="*/ 416670 h 850249"/>
              <a:gd name="connsiteX1" fmla="*/ 319129 w 1027459"/>
              <a:gd name="connsiteY1" fmla="*/ 231604 h 850249"/>
              <a:gd name="connsiteX2" fmla="*/ 254064 w 1027459"/>
              <a:gd name="connsiteY2" fmla="*/ 3802 h 850249"/>
              <a:gd name="connsiteX3" fmla="*/ 529731 w 1027459"/>
              <a:gd name="connsiteY3" fmla="*/ 57591 h 850249"/>
              <a:gd name="connsiteX4" fmla="*/ 704541 w 1027459"/>
              <a:gd name="connsiteY4" fmla="*/ 3803 h 850249"/>
              <a:gd name="connsiteX5" fmla="*/ 805394 w 1027459"/>
              <a:gd name="connsiteY5" fmla="*/ 144996 h 850249"/>
              <a:gd name="connsiteX6" fmla="*/ 953311 w 1027459"/>
              <a:gd name="connsiteY6" fmla="*/ 192061 h 850249"/>
              <a:gd name="connsiteX7" fmla="*/ 1027271 w 1027459"/>
              <a:gd name="connsiteY7" fmla="*/ 319807 h 850249"/>
              <a:gd name="connsiteX8" fmla="*/ 973484 w 1027459"/>
              <a:gd name="connsiteY8" fmla="*/ 396500 h 850249"/>
              <a:gd name="connsiteX9" fmla="*/ 892799 w 1027459"/>
              <a:gd name="connsiteY9" fmla="*/ 649261 h 850249"/>
              <a:gd name="connsiteX10" fmla="*/ 684370 w 1027459"/>
              <a:gd name="connsiteY10" fmla="*/ 709772 h 850249"/>
              <a:gd name="connsiteX11" fmla="*/ 523007 w 1027459"/>
              <a:gd name="connsiteY11" fmla="*/ 849708 h 850249"/>
              <a:gd name="connsiteX12" fmla="*/ 334747 w 1027459"/>
              <a:gd name="connsiteY12" fmla="*/ 756838 h 850249"/>
              <a:gd name="connsiteX13" fmla="*/ 99423 w 1027459"/>
              <a:gd name="connsiteY13" fmla="*/ 723220 h 850249"/>
              <a:gd name="connsiteX14" fmla="*/ 65806 w 1027459"/>
              <a:gd name="connsiteY14" fmla="*/ 508066 h 850249"/>
              <a:gd name="connsiteX15" fmla="*/ 12018 w 1027459"/>
              <a:gd name="connsiteY15" fmla="*/ 416670 h 850249"/>
              <a:gd name="connsiteX0" fmla="*/ 5053 w 1174843"/>
              <a:gd name="connsiteY0" fmla="*/ 416669 h 850249"/>
              <a:gd name="connsiteX1" fmla="*/ 466513 w 1174843"/>
              <a:gd name="connsiteY1" fmla="*/ 231604 h 850249"/>
              <a:gd name="connsiteX2" fmla="*/ 401448 w 1174843"/>
              <a:gd name="connsiteY2" fmla="*/ 3802 h 850249"/>
              <a:gd name="connsiteX3" fmla="*/ 677115 w 1174843"/>
              <a:gd name="connsiteY3" fmla="*/ 57591 h 850249"/>
              <a:gd name="connsiteX4" fmla="*/ 851925 w 1174843"/>
              <a:gd name="connsiteY4" fmla="*/ 3803 h 850249"/>
              <a:gd name="connsiteX5" fmla="*/ 952778 w 1174843"/>
              <a:gd name="connsiteY5" fmla="*/ 144996 h 850249"/>
              <a:gd name="connsiteX6" fmla="*/ 1100695 w 1174843"/>
              <a:gd name="connsiteY6" fmla="*/ 192061 h 850249"/>
              <a:gd name="connsiteX7" fmla="*/ 1174655 w 1174843"/>
              <a:gd name="connsiteY7" fmla="*/ 319807 h 850249"/>
              <a:gd name="connsiteX8" fmla="*/ 1120868 w 1174843"/>
              <a:gd name="connsiteY8" fmla="*/ 396500 h 850249"/>
              <a:gd name="connsiteX9" fmla="*/ 1040183 w 1174843"/>
              <a:gd name="connsiteY9" fmla="*/ 649261 h 850249"/>
              <a:gd name="connsiteX10" fmla="*/ 831754 w 1174843"/>
              <a:gd name="connsiteY10" fmla="*/ 709772 h 850249"/>
              <a:gd name="connsiteX11" fmla="*/ 670391 w 1174843"/>
              <a:gd name="connsiteY11" fmla="*/ 849708 h 850249"/>
              <a:gd name="connsiteX12" fmla="*/ 482131 w 1174843"/>
              <a:gd name="connsiteY12" fmla="*/ 756838 h 850249"/>
              <a:gd name="connsiteX13" fmla="*/ 246807 w 1174843"/>
              <a:gd name="connsiteY13" fmla="*/ 723220 h 850249"/>
              <a:gd name="connsiteX14" fmla="*/ 213190 w 1174843"/>
              <a:gd name="connsiteY14" fmla="*/ 508066 h 850249"/>
              <a:gd name="connsiteX15" fmla="*/ 5053 w 1174843"/>
              <a:gd name="connsiteY15" fmla="*/ 416669 h 850249"/>
              <a:gd name="connsiteX0" fmla="*/ 5053 w 1174843"/>
              <a:gd name="connsiteY0" fmla="*/ 416669 h 850249"/>
              <a:gd name="connsiteX1" fmla="*/ 466513 w 1174843"/>
              <a:gd name="connsiteY1" fmla="*/ 231604 h 850249"/>
              <a:gd name="connsiteX2" fmla="*/ 401448 w 1174843"/>
              <a:gd name="connsiteY2" fmla="*/ 3802 h 850249"/>
              <a:gd name="connsiteX3" fmla="*/ 677115 w 1174843"/>
              <a:gd name="connsiteY3" fmla="*/ 57591 h 850249"/>
              <a:gd name="connsiteX4" fmla="*/ 851925 w 1174843"/>
              <a:gd name="connsiteY4" fmla="*/ 3803 h 850249"/>
              <a:gd name="connsiteX5" fmla="*/ 952778 w 1174843"/>
              <a:gd name="connsiteY5" fmla="*/ 144996 h 850249"/>
              <a:gd name="connsiteX6" fmla="*/ 1100695 w 1174843"/>
              <a:gd name="connsiteY6" fmla="*/ 192061 h 850249"/>
              <a:gd name="connsiteX7" fmla="*/ 1174655 w 1174843"/>
              <a:gd name="connsiteY7" fmla="*/ 319807 h 850249"/>
              <a:gd name="connsiteX8" fmla="*/ 1120868 w 1174843"/>
              <a:gd name="connsiteY8" fmla="*/ 396500 h 850249"/>
              <a:gd name="connsiteX9" fmla="*/ 1040183 w 1174843"/>
              <a:gd name="connsiteY9" fmla="*/ 649261 h 850249"/>
              <a:gd name="connsiteX10" fmla="*/ 831754 w 1174843"/>
              <a:gd name="connsiteY10" fmla="*/ 709772 h 850249"/>
              <a:gd name="connsiteX11" fmla="*/ 670391 w 1174843"/>
              <a:gd name="connsiteY11" fmla="*/ 849708 h 850249"/>
              <a:gd name="connsiteX12" fmla="*/ 482131 w 1174843"/>
              <a:gd name="connsiteY12" fmla="*/ 756838 h 850249"/>
              <a:gd name="connsiteX13" fmla="*/ 92455 w 1174843"/>
              <a:gd name="connsiteY13" fmla="*/ 773818 h 850249"/>
              <a:gd name="connsiteX14" fmla="*/ 213190 w 1174843"/>
              <a:gd name="connsiteY14" fmla="*/ 508066 h 850249"/>
              <a:gd name="connsiteX15" fmla="*/ 5053 w 1174843"/>
              <a:gd name="connsiteY15" fmla="*/ 416669 h 850249"/>
              <a:gd name="connsiteX0" fmla="*/ 5053 w 1346132"/>
              <a:gd name="connsiteY0" fmla="*/ 416669 h 850249"/>
              <a:gd name="connsiteX1" fmla="*/ 466513 w 1346132"/>
              <a:gd name="connsiteY1" fmla="*/ 231604 h 850249"/>
              <a:gd name="connsiteX2" fmla="*/ 401448 w 1346132"/>
              <a:gd name="connsiteY2" fmla="*/ 3802 h 850249"/>
              <a:gd name="connsiteX3" fmla="*/ 677115 w 1346132"/>
              <a:gd name="connsiteY3" fmla="*/ 57591 h 850249"/>
              <a:gd name="connsiteX4" fmla="*/ 851925 w 1346132"/>
              <a:gd name="connsiteY4" fmla="*/ 3803 h 850249"/>
              <a:gd name="connsiteX5" fmla="*/ 952778 w 1346132"/>
              <a:gd name="connsiteY5" fmla="*/ 144996 h 850249"/>
              <a:gd name="connsiteX6" fmla="*/ 1343246 w 1346132"/>
              <a:gd name="connsiteY6" fmla="*/ 204710 h 850249"/>
              <a:gd name="connsiteX7" fmla="*/ 1174655 w 1346132"/>
              <a:gd name="connsiteY7" fmla="*/ 319807 h 850249"/>
              <a:gd name="connsiteX8" fmla="*/ 1120868 w 1346132"/>
              <a:gd name="connsiteY8" fmla="*/ 396500 h 850249"/>
              <a:gd name="connsiteX9" fmla="*/ 1040183 w 1346132"/>
              <a:gd name="connsiteY9" fmla="*/ 649261 h 850249"/>
              <a:gd name="connsiteX10" fmla="*/ 831754 w 1346132"/>
              <a:gd name="connsiteY10" fmla="*/ 709772 h 850249"/>
              <a:gd name="connsiteX11" fmla="*/ 670391 w 1346132"/>
              <a:gd name="connsiteY11" fmla="*/ 849708 h 850249"/>
              <a:gd name="connsiteX12" fmla="*/ 482131 w 1346132"/>
              <a:gd name="connsiteY12" fmla="*/ 756838 h 850249"/>
              <a:gd name="connsiteX13" fmla="*/ 92455 w 1346132"/>
              <a:gd name="connsiteY13" fmla="*/ 773818 h 850249"/>
              <a:gd name="connsiteX14" fmla="*/ 213190 w 1346132"/>
              <a:gd name="connsiteY14" fmla="*/ 508066 h 850249"/>
              <a:gd name="connsiteX15" fmla="*/ 5053 w 1346132"/>
              <a:gd name="connsiteY15" fmla="*/ 416669 h 850249"/>
              <a:gd name="connsiteX0" fmla="*/ 5053 w 1346132"/>
              <a:gd name="connsiteY0" fmla="*/ 416669 h 850249"/>
              <a:gd name="connsiteX1" fmla="*/ 466513 w 1346132"/>
              <a:gd name="connsiteY1" fmla="*/ 231604 h 850249"/>
              <a:gd name="connsiteX2" fmla="*/ 401448 w 1346132"/>
              <a:gd name="connsiteY2" fmla="*/ 3802 h 850249"/>
              <a:gd name="connsiteX3" fmla="*/ 677115 w 1346132"/>
              <a:gd name="connsiteY3" fmla="*/ 57591 h 850249"/>
              <a:gd name="connsiteX4" fmla="*/ 851925 w 1346132"/>
              <a:gd name="connsiteY4" fmla="*/ 3803 h 850249"/>
              <a:gd name="connsiteX5" fmla="*/ 952778 w 1346132"/>
              <a:gd name="connsiteY5" fmla="*/ 144996 h 850249"/>
              <a:gd name="connsiteX6" fmla="*/ 1343246 w 1346132"/>
              <a:gd name="connsiteY6" fmla="*/ 204710 h 850249"/>
              <a:gd name="connsiteX7" fmla="*/ 1174655 w 1346132"/>
              <a:gd name="connsiteY7" fmla="*/ 319807 h 850249"/>
              <a:gd name="connsiteX8" fmla="*/ 1297271 w 1346132"/>
              <a:gd name="connsiteY8" fmla="*/ 485043 h 850249"/>
              <a:gd name="connsiteX9" fmla="*/ 1040183 w 1346132"/>
              <a:gd name="connsiteY9" fmla="*/ 649261 h 850249"/>
              <a:gd name="connsiteX10" fmla="*/ 831754 w 1346132"/>
              <a:gd name="connsiteY10" fmla="*/ 709772 h 850249"/>
              <a:gd name="connsiteX11" fmla="*/ 670391 w 1346132"/>
              <a:gd name="connsiteY11" fmla="*/ 849708 h 850249"/>
              <a:gd name="connsiteX12" fmla="*/ 482131 w 1346132"/>
              <a:gd name="connsiteY12" fmla="*/ 756838 h 850249"/>
              <a:gd name="connsiteX13" fmla="*/ 92455 w 1346132"/>
              <a:gd name="connsiteY13" fmla="*/ 773818 h 850249"/>
              <a:gd name="connsiteX14" fmla="*/ 213190 w 1346132"/>
              <a:gd name="connsiteY14" fmla="*/ 508066 h 850249"/>
              <a:gd name="connsiteX15" fmla="*/ 5053 w 1346132"/>
              <a:gd name="connsiteY15" fmla="*/ 416669 h 8502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346132" h="850249">
                <a:moveTo>
                  <a:pt x="5053" y="416669"/>
                </a:moveTo>
                <a:cubicBezTo>
                  <a:pt x="47274" y="370592"/>
                  <a:pt x="432896" y="290330"/>
                  <a:pt x="466513" y="231604"/>
                </a:cubicBezTo>
                <a:cubicBezTo>
                  <a:pt x="500130" y="172878"/>
                  <a:pt x="331971" y="25093"/>
                  <a:pt x="401448" y="3802"/>
                </a:cubicBezTo>
                <a:cubicBezTo>
                  <a:pt x="470925" y="-17489"/>
                  <a:pt x="602036" y="57591"/>
                  <a:pt x="677115" y="57591"/>
                </a:cubicBezTo>
                <a:cubicBezTo>
                  <a:pt x="752194" y="57591"/>
                  <a:pt x="800378" y="-679"/>
                  <a:pt x="851925" y="3803"/>
                </a:cubicBezTo>
                <a:cubicBezTo>
                  <a:pt x="903472" y="8285"/>
                  <a:pt x="911316" y="113620"/>
                  <a:pt x="952778" y="144996"/>
                </a:cubicBezTo>
                <a:cubicBezTo>
                  <a:pt x="994240" y="176372"/>
                  <a:pt x="1314111" y="183419"/>
                  <a:pt x="1343246" y="204710"/>
                </a:cubicBezTo>
                <a:cubicBezTo>
                  <a:pt x="1372381" y="226001"/>
                  <a:pt x="1171293" y="285734"/>
                  <a:pt x="1174655" y="319807"/>
                </a:cubicBezTo>
                <a:cubicBezTo>
                  <a:pt x="1178017" y="353880"/>
                  <a:pt x="1311839" y="422290"/>
                  <a:pt x="1297271" y="485043"/>
                </a:cubicBezTo>
                <a:cubicBezTo>
                  <a:pt x="1282703" y="547796"/>
                  <a:pt x="1098454" y="600411"/>
                  <a:pt x="1040183" y="649261"/>
                </a:cubicBezTo>
                <a:cubicBezTo>
                  <a:pt x="981912" y="698111"/>
                  <a:pt x="882180" y="668520"/>
                  <a:pt x="831754" y="709772"/>
                </a:cubicBezTo>
                <a:cubicBezTo>
                  <a:pt x="781328" y="751024"/>
                  <a:pt x="728661" y="841864"/>
                  <a:pt x="670391" y="849708"/>
                </a:cubicBezTo>
                <a:cubicBezTo>
                  <a:pt x="612121" y="857552"/>
                  <a:pt x="552728" y="777919"/>
                  <a:pt x="482131" y="756838"/>
                </a:cubicBezTo>
                <a:cubicBezTo>
                  <a:pt x="411534" y="735757"/>
                  <a:pt x="147364" y="806315"/>
                  <a:pt x="92455" y="773818"/>
                </a:cubicBezTo>
                <a:cubicBezTo>
                  <a:pt x="37546" y="741321"/>
                  <a:pt x="227758" y="559158"/>
                  <a:pt x="213190" y="508066"/>
                </a:cubicBezTo>
                <a:cubicBezTo>
                  <a:pt x="198622" y="456974"/>
                  <a:pt x="-37168" y="462746"/>
                  <a:pt x="5053" y="416669"/>
                </a:cubicBezTo>
                <a:close/>
              </a:path>
            </a:pathLst>
          </a:custGeom>
          <a:solidFill>
            <a:schemeClr val="accent2">
              <a:lumMod val="20000"/>
              <a:lumOff val="80000"/>
            </a:schemeClr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4" name="Picture 303" descr="A red and yellow star&#10;&#10;Description automatically generated with medium confidence">
            <a:extLst>
              <a:ext uri="{FF2B5EF4-FFF2-40B4-BE49-F238E27FC236}">
                <a16:creationId xmlns:a16="http://schemas.microsoft.com/office/drawing/2014/main" id="{AC375A77-AE49-022E-8602-C0FE17B2AA2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81092" y="7013850"/>
            <a:ext cx="613506" cy="631660"/>
          </a:xfrm>
          <a:prstGeom prst="rect">
            <a:avLst/>
          </a:prstGeom>
        </p:spPr>
      </p:pic>
      <p:pic>
        <p:nvPicPr>
          <p:cNvPr id="305" name="Picture 304" descr="A red and yellow star&#10;&#10;Description automatically generated with medium confidence">
            <a:extLst>
              <a:ext uri="{FF2B5EF4-FFF2-40B4-BE49-F238E27FC236}">
                <a16:creationId xmlns:a16="http://schemas.microsoft.com/office/drawing/2014/main" id="{ED88B7AA-36D0-2AAA-A54A-0EC5DC96F28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74688" y="6883378"/>
            <a:ext cx="613506" cy="631660"/>
          </a:xfrm>
          <a:prstGeom prst="rect">
            <a:avLst/>
          </a:prstGeom>
        </p:spPr>
      </p:pic>
      <p:pic>
        <p:nvPicPr>
          <p:cNvPr id="306" name="Picture 305" descr="A monkey and a mouse&#10;&#10;Description automatically generated">
            <a:extLst>
              <a:ext uri="{FF2B5EF4-FFF2-40B4-BE49-F238E27FC236}">
                <a16:creationId xmlns:a16="http://schemas.microsoft.com/office/drawing/2014/main" id="{2A1DABF3-A69D-CAA3-4F8E-5F2C02CC214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1873" y="2290246"/>
            <a:ext cx="1276387" cy="1201977"/>
          </a:xfrm>
          <a:prstGeom prst="rect">
            <a:avLst/>
          </a:prstGeom>
        </p:spPr>
      </p:pic>
      <p:pic>
        <p:nvPicPr>
          <p:cNvPr id="307" name="Picture 306" descr="A monkey and a mouse&#10;&#10;Description automatically generated">
            <a:extLst>
              <a:ext uri="{FF2B5EF4-FFF2-40B4-BE49-F238E27FC236}">
                <a16:creationId xmlns:a16="http://schemas.microsoft.com/office/drawing/2014/main" id="{8E013F36-97A5-D54C-10D3-83B608DE568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8338" y="1500319"/>
            <a:ext cx="1543973" cy="1032813"/>
          </a:xfrm>
          <a:prstGeom prst="rect">
            <a:avLst/>
          </a:prstGeom>
        </p:spPr>
      </p:pic>
      <p:cxnSp>
        <p:nvCxnSpPr>
          <p:cNvPr id="308" name="Straight Arrow Connector 307">
            <a:extLst>
              <a:ext uri="{FF2B5EF4-FFF2-40B4-BE49-F238E27FC236}">
                <a16:creationId xmlns:a16="http://schemas.microsoft.com/office/drawing/2014/main" id="{00A8B624-2F76-2771-BECF-45A2877EAFC0}"/>
              </a:ext>
            </a:extLst>
          </p:cNvPr>
          <p:cNvCxnSpPr>
            <a:cxnSpLocks/>
          </p:cNvCxnSpPr>
          <p:nvPr/>
        </p:nvCxnSpPr>
        <p:spPr>
          <a:xfrm flipV="1">
            <a:off x="1338926" y="2805771"/>
            <a:ext cx="286659" cy="240126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9" name="Straight Arrow Connector 308">
            <a:extLst>
              <a:ext uri="{FF2B5EF4-FFF2-40B4-BE49-F238E27FC236}">
                <a16:creationId xmlns:a16="http://schemas.microsoft.com/office/drawing/2014/main" id="{ABC7F66D-BBD3-4FFE-181A-3D684B92234E}"/>
              </a:ext>
            </a:extLst>
          </p:cNvPr>
          <p:cNvCxnSpPr>
            <a:cxnSpLocks/>
          </p:cNvCxnSpPr>
          <p:nvPr/>
        </p:nvCxnSpPr>
        <p:spPr>
          <a:xfrm>
            <a:off x="1230667" y="2266918"/>
            <a:ext cx="304837" cy="178321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37" name="Picture 336">
            <a:extLst>
              <a:ext uri="{FF2B5EF4-FFF2-40B4-BE49-F238E27FC236}">
                <a16:creationId xmlns:a16="http://schemas.microsoft.com/office/drawing/2014/main" id="{23EAA9F4-90B8-1CB3-1349-1DD76C7C62D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7496" y="6402993"/>
            <a:ext cx="1433388" cy="1479199"/>
          </a:xfrm>
          <a:prstGeom prst="rect">
            <a:avLst/>
          </a:prstGeom>
        </p:spPr>
      </p:pic>
      <p:pic>
        <p:nvPicPr>
          <p:cNvPr id="338" name="Picture 337">
            <a:extLst>
              <a:ext uri="{FF2B5EF4-FFF2-40B4-BE49-F238E27FC236}">
                <a16:creationId xmlns:a16="http://schemas.microsoft.com/office/drawing/2014/main" id="{95EDE1B7-2122-421B-7124-3FC930930E5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730" y="6876047"/>
            <a:ext cx="687776" cy="709758"/>
          </a:xfrm>
          <a:prstGeom prst="rect">
            <a:avLst/>
          </a:prstGeom>
        </p:spPr>
      </p:pic>
      <p:pic>
        <p:nvPicPr>
          <p:cNvPr id="340" name="Picture 339">
            <a:extLst>
              <a:ext uri="{FF2B5EF4-FFF2-40B4-BE49-F238E27FC236}">
                <a16:creationId xmlns:a16="http://schemas.microsoft.com/office/drawing/2014/main" id="{30634963-C43B-AE42-AC13-42394E25AD2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7438" y="1958628"/>
            <a:ext cx="498403" cy="514333"/>
          </a:xfrm>
          <a:prstGeom prst="rect">
            <a:avLst/>
          </a:prstGeom>
        </p:spPr>
      </p:pic>
      <p:pic>
        <p:nvPicPr>
          <p:cNvPr id="341" name="Picture 340">
            <a:extLst>
              <a:ext uri="{FF2B5EF4-FFF2-40B4-BE49-F238E27FC236}">
                <a16:creationId xmlns:a16="http://schemas.microsoft.com/office/drawing/2014/main" id="{0A718693-789F-847B-F89B-43266676696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34" b="57412"/>
          <a:stretch/>
        </p:blipFill>
        <p:spPr>
          <a:xfrm>
            <a:off x="6054222" y="2523810"/>
            <a:ext cx="203178" cy="219042"/>
          </a:xfrm>
          <a:prstGeom prst="rect">
            <a:avLst/>
          </a:prstGeom>
        </p:spPr>
      </p:pic>
      <p:pic>
        <p:nvPicPr>
          <p:cNvPr id="342" name="Picture 341">
            <a:extLst>
              <a:ext uri="{FF2B5EF4-FFF2-40B4-BE49-F238E27FC236}">
                <a16:creationId xmlns:a16="http://schemas.microsoft.com/office/drawing/2014/main" id="{95ED06AF-9989-51E6-2388-28ABC3D545E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50" t="-1733" r="-1905" b="79042"/>
          <a:stretch/>
        </p:blipFill>
        <p:spPr>
          <a:xfrm>
            <a:off x="6006650" y="2396451"/>
            <a:ext cx="111416" cy="116701"/>
          </a:xfrm>
          <a:prstGeom prst="rect">
            <a:avLst/>
          </a:prstGeom>
        </p:spPr>
      </p:pic>
      <p:pic>
        <p:nvPicPr>
          <p:cNvPr id="344" name="Picture 343">
            <a:extLst>
              <a:ext uri="{FF2B5EF4-FFF2-40B4-BE49-F238E27FC236}">
                <a16:creationId xmlns:a16="http://schemas.microsoft.com/office/drawing/2014/main" id="{35308727-DE81-F73F-2465-110339D224C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67" t="4822" r="44786" b="63170"/>
          <a:stretch/>
        </p:blipFill>
        <p:spPr>
          <a:xfrm>
            <a:off x="5416029" y="2695881"/>
            <a:ext cx="215548" cy="164623"/>
          </a:xfrm>
          <a:prstGeom prst="rect">
            <a:avLst/>
          </a:prstGeom>
        </p:spPr>
      </p:pic>
      <p:sp>
        <p:nvSpPr>
          <p:cNvPr id="345" name="TextBox 344">
            <a:extLst>
              <a:ext uri="{FF2B5EF4-FFF2-40B4-BE49-F238E27FC236}">
                <a16:creationId xmlns:a16="http://schemas.microsoft.com/office/drawing/2014/main" id="{AB3D010E-A823-876A-156F-3833E261CC3B}"/>
              </a:ext>
            </a:extLst>
          </p:cNvPr>
          <p:cNvSpPr txBox="1"/>
          <p:nvPr/>
        </p:nvSpPr>
        <p:spPr>
          <a:xfrm>
            <a:off x="5789345" y="2874704"/>
            <a:ext cx="1378904" cy="2460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99" b="1" dirty="0">
                <a:latin typeface="Arial" panose="020B0604020202020204" pitchFamily="34" charset="0"/>
                <a:cs typeface="Arial" panose="020B0604020202020204" pitchFamily="34" charset="0"/>
              </a:rPr>
              <a:t>Reproductive aging</a:t>
            </a:r>
          </a:p>
        </p:txBody>
      </p:sp>
      <p:pic>
        <p:nvPicPr>
          <p:cNvPr id="347" name="Picture 346" descr="A diagram of a cell&#10;&#10;Description automatically generated">
            <a:extLst>
              <a:ext uri="{FF2B5EF4-FFF2-40B4-BE49-F238E27FC236}">
                <a16:creationId xmlns:a16="http://schemas.microsoft.com/office/drawing/2014/main" id="{8B5522F2-5AD6-282D-54A1-A09BFD9F5CE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65057" y="2391875"/>
            <a:ext cx="477435" cy="399179"/>
          </a:xfrm>
          <a:prstGeom prst="rect">
            <a:avLst/>
          </a:prstGeom>
        </p:spPr>
      </p:pic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EF0A6DB-C41E-7BE6-DDEF-FE37E9849032}"/>
              </a:ext>
            </a:extLst>
          </p:cNvPr>
          <p:cNvCxnSpPr>
            <a:cxnSpLocks/>
          </p:cNvCxnSpPr>
          <p:nvPr/>
        </p:nvCxnSpPr>
        <p:spPr>
          <a:xfrm flipH="1" flipV="1">
            <a:off x="2367925" y="3447506"/>
            <a:ext cx="1315785" cy="3185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9F72293-F256-20C4-6588-64BFD6BB0F2A}"/>
              </a:ext>
            </a:extLst>
          </p:cNvPr>
          <p:cNvCxnSpPr>
            <a:cxnSpLocks/>
          </p:cNvCxnSpPr>
          <p:nvPr/>
        </p:nvCxnSpPr>
        <p:spPr>
          <a:xfrm>
            <a:off x="3674357" y="3209293"/>
            <a:ext cx="0" cy="238213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51E33540-0F24-4870-418D-35A853FC30BB}"/>
              </a:ext>
            </a:extLst>
          </p:cNvPr>
          <p:cNvCxnSpPr>
            <a:cxnSpLocks/>
          </p:cNvCxnSpPr>
          <p:nvPr/>
        </p:nvCxnSpPr>
        <p:spPr>
          <a:xfrm flipH="1">
            <a:off x="1975897" y="2238503"/>
            <a:ext cx="437212" cy="250878"/>
          </a:xfrm>
          <a:prstGeom prst="line">
            <a:avLst/>
          </a:prstGeom>
          <a:ln w="12700">
            <a:prstDash val="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3AA63BC-4900-8440-0931-CED022134D40}"/>
              </a:ext>
            </a:extLst>
          </p:cNvPr>
          <p:cNvCxnSpPr>
            <a:cxnSpLocks/>
          </p:cNvCxnSpPr>
          <p:nvPr/>
        </p:nvCxnSpPr>
        <p:spPr>
          <a:xfrm flipH="1" flipV="1">
            <a:off x="1967165" y="2745226"/>
            <a:ext cx="341753" cy="205741"/>
          </a:xfrm>
          <a:prstGeom prst="line">
            <a:avLst/>
          </a:prstGeom>
          <a:ln w="12700">
            <a:prstDash val="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D7C7E9C-CEA3-10FD-5E52-18F6652B9C59}"/>
              </a:ext>
            </a:extLst>
          </p:cNvPr>
          <p:cNvCxnSpPr>
            <a:cxnSpLocks/>
          </p:cNvCxnSpPr>
          <p:nvPr/>
        </p:nvCxnSpPr>
        <p:spPr>
          <a:xfrm flipH="1">
            <a:off x="1901248" y="5795832"/>
            <a:ext cx="4172942" cy="4137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59" name="Picture 58">
            <a:extLst>
              <a:ext uri="{FF2B5EF4-FFF2-40B4-BE49-F238E27FC236}">
                <a16:creationId xmlns:a16="http://schemas.microsoft.com/office/drawing/2014/main" id="{B7E54467-13AA-83B3-6706-F9CF55C0826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502" y="3819588"/>
            <a:ext cx="2658860" cy="1465357"/>
          </a:xfrm>
          <a:prstGeom prst="rect">
            <a:avLst/>
          </a:prstGeom>
        </p:spPr>
      </p:pic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92A75010-F25D-042E-9293-55EABEC1CB99}"/>
              </a:ext>
            </a:extLst>
          </p:cNvPr>
          <p:cNvCxnSpPr>
            <a:cxnSpLocks/>
          </p:cNvCxnSpPr>
          <p:nvPr/>
        </p:nvCxnSpPr>
        <p:spPr>
          <a:xfrm>
            <a:off x="1901115" y="5497913"/>
            <a:ext cx="0" cy="299987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E713670B-63AD-E94B-88C2-C8C94E43224D}"/>
              </a:ext>
            </a:extLst>
          </p:cNvPr>
          <p:cNvSpPr txBox="1"/>
          <p:nvPr/>
        </p:nvSpPr>
        <p:spPr>
          <a:xfrm>
            <a:off x="838948" y="5270078"/>
            <a:ext cx="2645387" cy="246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99" b="1" dirty="0">
                <a:latin typeface="Arial" panose="020B0604020202020204" pitchFamily="34" charset="0"/>
                <a:cs typeface="Arial" panose="020B0604020202020204" pitchFamily="34" charset="0"/>
              </a:rPr>
              <a:t>Multi-Nucleated Giant Cell (MNGC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4702DEB-774E-C869-1B85-64A964BAE1C4}"/>
              </a:ext>
            </a:extLst>
          </p:cNvPr>
          <p:cNvSpPr txBox="1"/>
          <p:nvPr/>
        </p:nvSpPr>
        <p:spPr>
          <a:xfrm>
            <a:off x="117894" y="137778"/>
            <a:ext cx="2240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raphical Abstract</a:t>
            </a:r>
          </a:p>
        </p:txBody>
      </p:sp>
    </p:spTree>
    <p:extLst>
      <p:ext uri="{BB962C8B-B14F-4D97-AF65-F5344CB8AC3E}">
        <p14:creationId xmlns:p14="http://schemas.microsoft.com/office/powerpoint/2010/main" val="3214345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926</TotalTime>
  <Words>572</Words>
  <Application>Microsoft Office PowerPoint</Application>
  <PresentationFormat>Custom</PresentationFormat>
  <Paragraphs>12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ubrey Koch Converse</dc:creator>
  <cp:lastModifiedBy>Aubrey Koch Converse</cp:lastModifiedBy>
  <cp:revision>43</cp:revision>
  <cp:lastPrinted>2024-10-07T19:09:58Z</cp:lastPrinted>
  <dcterms:created xsi:type="dcterms:W3CDTF">2024-08-08T18:30:32Z</dcterms:created>
  <dcterms:modified xsi:type="dcterms:W3CDTF">2024-12-03T19:02:35Z</dcterms:modified>
</cp:coreProperties>
</file>